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322" r:id="rId5"/>
    <p:sldId id="324" r:id="rId6"/>
    <p:sldId id="325" r:id="rId7"/>
    <p:sldId id="326" r:id="rId8"/>
    <p:sldId id="283" r:id="rId9"/>
    <p:sldId id="285" r:id="rId10"/>
    <p:sldId id="286" r:id="rId11"/>
    <p:sldId id="288" r:id="rId12"/>
    <p:sldId id="289" r:id="rId13"/>
    <p:sldId id="291" r:id="rId14"/>
    <p:sldId id="292" r:id="rId15"/>
    <p:sldId id="287" r:id="rId16"/>
    <p:sldId id="290" r:id="rId17"/>
    <p:sldId id="293" r:id="rId18"/>
    <p:sldId id="294" r:id="rId19"/>
    <p:sldId id="296" r:id="rId20"/>
    <p:sldId id="297" r:id="rId21"/>
    <p:sldId id="298" r:id="rId22"/>
    <p:sldId id="299" r:id="rId23"/>
    <p:sldId id="300" r:id="rId24"/>
    <p:sldId id="301" r:id="rId25"/>
    <p:sldId id="302" r:id="rId26"/>
    <p:sldId id="303" r:id="rId27"/>
    <p:sldId id="320" r:id="rId28"/>
    <p:sldId id="304" r:id="rId29"/>
    <p:sldId id="305" r:id="rId30"/>
    <p:sldId id="306" r:id="rId31"/>
    <p:sldId id="308" r:id="rId32"/>
    <p:sldId id="309" r:id="rId33"/>
    <p:sldId id="310" r:id="rId34"/>
    <p:sldId id="311" r:id="rId35"/>
    <p:sldId id="312" r:id="rId36"/>
    <p:sldId id="321" r:id="rId37"/>
    <p:sldId id="313" r:id="rId38"/>
    <p:sldId id="314" r:id="rId39"/>
    <p:sldId id="315" r:id="rId40"/>
    <p:sldId id="316" r:id="rId41"/>
    <p:sldId id="317" r:id="rId42"/>
    <p:sldId id="318" r:id="rId43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98223D5-76D5-4914-A0AD-B4EDDD3D84ED}">
          <p14:sldIdLst>
            <p14:sldId id="322"/>
            <p14:sldId id="324"/>
            <p14:sldId id="325"/>
            <p14:sldId id="326"/>
            <p14:sldId id="283"/>
            <p14:sldId id="285"/>
            <p14:sldId id="286"/>
            <p14:sldId id="288"/>
            <p14:sldId id="289"/>
            <p14:sldId id="291"/>
            <p14:sldId id="292"/>
            <p14:sldId id="287"/>
            <p14:sldId id="290"/>
            <p14:sldId id="293"/>
            <p14:sldId id="294"/>
            <p14:sldId id="296"/>
            <p14:sldId id="297"/>
            <p14:sldId id="298"/>
            <p14:sldId id="299"/>
            <p14:sldId id="300"/>
            <p14:sldId id="301"/>
            <p14:sldId id="302"/>
            <p14:sldId id="303"/>
            <p14:sldId id="320"/>
            <p14:sldId id="304"/>
            <p14:sldId id="305"/>
            <p14:sldId id="306"/>
            <p14:sldId id="308"/>
            <p14:sldId id="309"/>
            <p14:sldId id="310"/>
            <p14:sldId id="311"/>
            <p14:sldId id="312"/>
            <p14:sldId id="321"/>
            <p14:sldId id="313"/>
            <p14:sldId id="314"/>
            <p14:sldId id="315"/>
            <p14:sldId id="316"/>
            <p14:sldId id="317"/>
            <p14:sldId id="31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960" userDrawn="1">
          <p15:clr>
            <a:srgbClr val="A4A3A4"/>
          </p15:clr>
        </p15:guide>
        <p15:guide id="3" pos="1344" userDrawn="1">
          <p15:clr>
            <a:srgbClr val="A4A3A4"/>
          </p15:clr>
        </p15:guide>
        <p15:guide id="4" pos="1549" userDrawn="1">
          <p15:clr>
            <a:srgbClr val="A4A3A4"/>
          </p15:clr>
        </p15:guide>
        <p15:guide id="5" pos="1508" userDrawn="1">
          <p15:clr>
            <a:srgbClr val="A4A3A4"/>
          </p15:clr>
        </p15:guide>
        <p15:guide id="6" pos="1495" userDrawn="1">
          <p15:clr>
            <a:srgbClr val="A4A3A4"/>
          </p15:clr>
        </p15:guide>
        <p15:guide id="7" pos="1440" userDrawn="1">
          <p15:clr>
            <a:srgbClr val="A4A3A4"/>
          </p15:clr>
        </p15:guide>
        <p15:guide id="8" pos="4944" userDrawn="1">
          <p15:clr>
            <a:srgbClr val="A4A3A4"/>
          </p15:clr>
        </p15:guide>
        <p15:guide id="9" pos="1651" userDrawn="1">
          <p15:clr>
            <a:srgbClr val="A4A3A4"/>
          </p15:clr>
        </p15:guide>
        <p15:guide id="10" pos="1575" userDrawn="1">
          <p15:clr>
            <a:srgbClr val="A4A3A4"/>
          </p15:clr>
        </p15:guide>
        <p15:guide id="11" pos="1056" userDrawn="1">
          <p15:clr>
            <a:srgbClr val="A4A3A4"/>
          </p15:clr>
        </p15:guide>
        <p15:guide id="12" pos="4184" userDrawn="1">
          <p15:clr>
            <a:srgbClr val="A4A3A4"/>
          </p15:clr>
        </p15:guide>
        <p15:guide id="13" pos="4260" userDrawn="1">
          <p15:clr>
            <a:srgbClr val="A4A3A4"/>
          </p15:clr>
        </p15:guide>
        <p15:guide id="14" pos="4336" userDrawn="1">
          <p15:clr>
            <a:srgbClr val="A4A3A4"/>
          </p15:clr>
        </p15:guide>
        <p15:guide id="15" pos="1408" userDrawn="1">
          <p15:clr>
            <a:srgbClr val="A4A3A4"/>
          </p15:clr>
        </p15:guide>
        <p15:guide id="16" pos="1008" userDrawn="1">
          <p15:clr>
            <a:srgbClr val="A4A3A4"/>
          </p15:clr>
        </p15:guide>
        <p15:guide id="17" pos="1459" userDrawn="1">
          <p15:clr>
            <a:srgbClr val="A4A3A4"/>
          </p15:clr>
        </p15:guide>
        <p15:guide id="18" pos="1551" userDrawn="1">
          <p15:clr>
            <a:srgbClr val="A4A3A4"/>
          </p15:clr>
        </p15:guide>
        <p15:guide id="19" pos="3264" userDrawn="1">
          <p15:clr>
            <a:srgbClr val="A4A3A4"/>
          </p15:clr>
        </p15:guide>
        <p15:guide id="20" orient="horz" pos="2712" userDrawn="1">
          <p15:clr>
            <a:srgbClr val="A4A3A4"/>
          </p15:clr>
        </p15:guide>
        <p15:guide id="21" orient="horz" pos="792" userDrawn="1">
          <p15:clr>
            <a:srgbClr val="A4A3A4"/>
          </p15:clr>
        </p15:guide>
        <p15:guide id="22" orient="horz" pos="779" userDrawn="1">
          <p15:clr>
            <a:srgbClr val="A4A3A4"/>
          </p15:clr>
        </p15:guide>
        <p15:guide id="23" orient="horz" pos="2976" userDrawn="1">
          <p15:clr>
            <a:srgbClr val="A4A3A4"/>
          </p15:clr>
        </p15:guide>
        <p15:guide id="24" orient="horz" pos="702" userDrawn="1">
          <p15:clr>
            <a:srgbClr val="A4A3A4"/>
          </p15:clr>
        </p15:guide>
        <p15:guide id="25" orient="horz" pos="6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452FF"/>
    <a:srgbClr val="00B050"/>
    <a:srgbClr val="E28CFF"/>
    <a:srgbClr val="FFC000"/>
    <a:srgbClr val="9900CC"/>
    <a:srgbClr val="FF0000"/>
    <a:srgbClr val="0000FF"/>
    <a:srgbClr val="FF0066"/>
    <a:srgbClr val="FF3399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41" autoAdjust="0"/>
    <p:restoredTop sz="95300" autoAdjust="0"/>
  </p:normalViewPr>
  <p:slideViewPr>
    <p:cSldViewPr snapToGrid="0">
      <p:cViewPr varScale="1">
        <p:scale>
          <a:sx n="67" d="100"/>
          <a:sy n="67" d="100"/>
        </p:scale>
        <p:origin x="72" y="816"/>
      </p:cViewPr>
      <p:guideLst>
        <p:guide orient="horz" pos="624"/>
        <p:guide pos="960"/>
        <p:guide pos="1344"/>
        <p:guide pos="1549"/>
        <p:guide pos="1508"/>
        <p:guide pos="1495"/>
        <p:guide pos="1440"/>
        <p:guide pos="4944"/>
        <p:guide pos="1651"/>
        <p:guide pos="1575"/>
        <p:guide pos="1056"/>
        <p:guide pos="4184"/>
        <p:guide pos="4260"/>
        <p:guide pos="4336"/>
        <p:guide pos="1408"/>
        <p:guide pos="1008"/>
        <p:guide pos="1459"/>
        <p:guide pos="1551"/>
        <p:guide pos="3264"/>
        <p:guide orient="horz" pos="2712"/>
        <p:guide orient="horz" pos="792"/>
        <p:guide orient="horz" pos="779"/>
        <p:guide orient="horz" pos="2976"/>
        <p:guide orient="horz" pos="702"/>
        <p:guide orient="horz" pos="6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41" Type="http://schemas.openxmlformats.org/officeDocument/2006/relationships/slide" Target="slides/slide37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998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61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771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73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759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950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826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535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545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066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64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AB96D-82FA-434A-925E-091D78F0FCD2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33969-BD82-48E3-8CB5-2BA37D31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151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gi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g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g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g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g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g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gi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gif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g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e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gi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gi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g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gi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gi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gi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3.gif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gi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gi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eg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gif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gi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gi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gi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gi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gi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gi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gi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gi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g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g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g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D124F0E-3D0B-41B2-B296-0584FB3A9609}"/>
              </a:ext>
            </a:extLst>
          </p:cNvPr>
          <p:cNvGrpSpPr/>
          <p:nvPr/>
        </p:nvGrpSpPr>
        <p:grpSpPr>
          <a:xfrm>
            <a:off x="30912" y="763570"/>
            <a:ext cx="8178342" cy="2937599"/>
            <a:chOff x="891513" y="704125"/>
            <a:chExt cx="8178342" cy="2937599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CB2CA0BF-CEBC-48C1-9094-24E01F30ECCF}"/>
                </a:ext>
              </a:extLst>
            </p:cNvPr>
            <p:cNvGrpSpPr/>
            <p:nvPr/>
          </p:nvGrpSpPr>
          <p:grpSpPr>
            <a:xfrm>
              <a:off x="5301018" y="705448"/>
              <a:ext cx="3768837" cy="2927978"/>
              <a:chOff x="5301018" y="705448"/>
              <a:chExt cx="3768837" cy="2927978"/>
            </a:xfrm>
          </p:grpSpPr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2FD5C45C-3EB9-4557-A2DD-995EC024C577}"/>
                  </a:ext>
                </a:extLst>
              </p:cNvPr>
              <p:cNvGrpSpPr/>
              <p:nvPr/>
            </p:nvGrpSpPr>
            <p:grpSpPr>
              <a:xfrm>
                <a:off x="5301018" y="1030102"/>
                <a:ext cx="3751904" cy="2603324"/>
                <a:chOff x="5322287" y="1756742"/>
                <a:chExt cx="3751903" cy="2603323"/>
              </a:xfrm>
            </p:grpSpPr>
            <p:grpSp>
              <p:nvGrpSpPr>
                <p:cNvPr id="53" name="Group 52">
                  <a:extLst>
                    <a:ext uri="{FF2B5EF4-FFF2-40B4-BE49-F238E27FC236}">
                      <a16:creationId xmlns:a16="http://schemas.microsoft.com/office/drawing/2014/main" id="{F60F648E-22A2-4660-B51F-A57B8ACD4F5A}"/>
                    </a:ext>
                  </a:extLst>
                </p:cNvPr>
                <p:cNvGrpSpPr/>
                <p:nvPr/>
              </p:nvGrpSpPr>
              <p:grpSpPr>
                <a:xfrm>
                  <a:off x="5322287" y="2415680"/>
                  <a:ext cx="3751903" cy="1944385"/>
                  <a:chOff x="5322287" y="2415680"/>
                  <a:chExt cx="3751903" cy="1944385"/>
                </a:xfrm>
              </p:grpSpPr>
              <p:pic>
                <p:nvPicPr>
                  <p:cNvPr id="55" name="Picture 54" descr="First PCR soy arab bsa PEG samples.tif">
                    <a:extLst>
                      <a:ext uri="{FF2B5EF4-FFF2-40B4-BE49-F238E27FC236}">
                        <a16:creationId xmlns:a16="http://schemas.microsoft.com/office/drawing/2014/main" id="{2180FBB2-F215-4621-A2EB-91843A8405EB}"/>
                      </a:ext>
                    </a:extLst>
                  </p:cNvPr>
                  <p:cNvPicPr/>
                  <p:nvPr/>
                </p:nvPicPr>
                <p:blipFill rotWithShape="1">
                  <a:blip r:embed="rId2" cstate="print"/>
                  <a:srcRect l="20800" t="28538" r="23164" b="12050"/>
                  <a:stretch/>
                </p:blipFill>
                <p:spPr>
                  <a:xfrm>
                    <a:off x="5986428" y="2415680"/>
                    <a:ext cx="3087762" cy="1944385"/>
                  </a:xfrm>
                  <a:prstGeom prst="rect">
                    <a:avLst/>
                  </a:prstGeom>
                </p:spPr>
              </p:pic>
              <p:cxnSp>
                <p:nvCxnSpPr>
                  <p:cNvPr id="57" name="Straight Connector 56">
                    <a:extLst>
                      <a:ext uri="{FF2B5EF4-FFF2-40B4-BE49-F238E27FC236}">
                        <a16:creationId xmlns:a16="http://schemas.microsoft.com/office/drawing/2014/main" id="{AF10D190-445F-4A33-B030-116E6F40FE92}"/>
                      </a:ext>
                    </a:extLst>
                  </p:cNvPr>
                  <p:cNvCxnSpPr/>
                  <p:nvPr/>
                </p:nvCxnSpPr>
                <p:spPr>
                  <a:xfrm>
                    <a:off x="5764257" y="3490927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Straight Connector 57">
                    <a:extLst>
                      <a:ext uri="{FF2B5EF4-FFF2-40B4-BE49-F238E27FC236}">
                        <a16:creationId xmlns:a16="http://schemas.microsoft.com/office/drawing/2014/main" id="{925C4B56-2021-42B8-8EA3-3BDA60E365B6}"/>
                      </a:ext>
                    </a:extLst>
                  </p:cNvPr>
                  <p:cNvCxnSpPr/>
                  <p:nvPr/>
                </p:nvCxnSpPr>
                <p:spPr>
                  <a:xfrm>
                    <a:off x="5765337" y="3089088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>
                    <a:extLst>
                      <a:ext uri="{FF2B5EF4-FFF2-40B4-BE49-F238E27FC236}">
                        <a16:creationId xmlns:a16="http://schemas.microsoft.com/office/drawing/2014/main" id="{414C9E30-E43E-4715-AB80-944F6222DDEA}"/>
                      </a:ext>
                    </a:extLst>
                  </p:cNvPr>
                  <p:cNvCxnSpPr/>
                  <p:nvPr/>
                </p:nvCxnSpPr>
                <p:spPr>
                  <a:xfrm>
                    <a:off x="5772849" y="3257789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Straight Connector 59">
                    <a:extLst>
                      <a:ext uri="{FF2B5EF4-FFF2-40B4-BE49-F238E27FC236}">
                        <a16:creationId xmlns:a16="http://schemas.microsoft.com/office/drawing/2014/main" id="{4B44B50B-AA00-4EC9-9C38-EAFB03B4123B}"/>
                      </a:ext>
                    </a:extLst>
                  </p:cNvPr>
                  <p:cNvCxnSpPr/>
                  <p:nvPr/>
                </p:nvCxnSpPr>
                <p:spPr>
                  <a:xfrm>
                    <a:off x="5755675" y="3666111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Straight Connector 60">
                    <a:extLst>
                      <a:ext uri="{FF2B5EF4-FFF2-40B4-BE49-F238E27FC236}">
                        <a16:creationId xmlns:a16="http://schemas.microsoft.com/office/drawing/2014/main" id="{B64812D5-D09D-422B-BA1C-6663DBFA01EF}"/>
                      </a:ext>
                    </a:extLst>
                  </p:cNvPr>
                  <p:cNvCxnSpPr/>
                  <p:nvPr/>
                </p:nvCxnSpPr>
                <p:spPr>
                  <a:xfrm>
                    <a:off x="5766411" y="3818961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Straight Connector 61">
                    <a:extLst>
                      <a:ext uri="{FF2B5EF4-FFF2-40B4-BE49-F238E27FC236}">
                        <a16:creationId xmlns:a16="http://schemas.microsoft.com/office/drawing/2014/main" id="{AF2EF6AF-A6C0-46AC-BB95-A1EFA8A27179}"/>
                      </a:ext>
                    </a:extLst>
                  </p:cNvPr>
                  <p:cNvCxnSpPr/>
                  <p:nvPr/>
                </p:nvCxnSpPr>
                <p:spPr>
                  <a:xfrm>
                    <a:off x="5764269" y="4000539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AAE0B047-C573-4DF1-8E10-1A4205D87662}"/>
                      </a:ext>
                    </a:extLst>
                  </p:cNvPr>
                  <p:cNvSpPr txBox="1"/>
                  <p:nvPr/>
                </p:nvSpPr>
                <p:spPr>
                  <a:xfrm>
                    <a:off x="5324438" y="2949502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2000</a:t>
                    </a: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6B017593-FEB7-4174-9398-514D10619A92}"/>
                      </a:ext>
                    </a:extLst>
                  </p:cNvPr>
                  <p:cNvSpPr txBox="1"/>
                  <p:nvPr/>
                </p:nvSpPr>
                <p:spPr>
                  <a:xfrm>
                    <a:off x="5324438" y="3111645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500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D2321707-2399-434B-AD62-8D5C060B5684}"/>
                      </a:ext>
                    </a:extLst>
                  </p:cNvPr>
                  <p:cNvSpPr txBox="1"/>
                  <p:nvPr/>
                </p:nvSpPr>
                <p:spPr>
                  <a:xfrm>
                    <a:off x="5322287" y="3351221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000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B4163A82-8F52-44B7-ABE1-C6A017C6A3E8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555" y="3527887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700</a:t>
                    </a: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E9742C41-3448-42CF-A544-E9FC878145D5}"/>
                      </a:ext>
                    </a:extLst>
                  </p:cNvPr>
                  <p:cNvSpPr txBox="1"/>
                  <p:nvPr/>
                </p:nvSpPr>
                <p:spPr>
                  <a:xfrm>
                    <a:off x="5403848" y="3674307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500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47BD0A6D-CB97-4538-B273-67BA728F00FC}"/>
                      </a:ext>
                    </a:extLst>
                  </p:cNvPr>
                  <p:cNvSpPr txBox="1"/>
                  <p:nvPr/>
                </p:nvSpPr>
                <p:spPr>
                  <a:xfrm>
                    <a:off x="5407282" y="3865110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300</a:t>
                    </a:r>
                  </a:p>
                </p:txBody>
              </p:sp>
            </p:grp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C2778F88-63DA-42F4-8744-D911798F06FB}"/>
                    </a:ext>
                  </a:extLst>
                </p:cNvPr>
                <p:cNvSpPr txBox="1"/>
                <p:nvPr/>
              </p:nvSpPr>
              <p:spPr>
                <a:xfrm>
                  <a:off x="5399555" y="1756742"/>
                  <a:ext cx="31451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B</a:t>
                  </a:r>
                </a:p>
              </p:txBody>
            </p:sp>
          </p:grp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3839734-0980-4A1C-8663-05415D6C70C7}"/>
                  </a:ext>
                </a:extLst>
              </p:cNvPr>
              <p:cNvSpPr txBox="1"/>
              <p:nvPr/>
            </p:nvSpPr>
            <p:spPr>
              <a:xfrm>
                <a:off x="6197397" y="705448"/>
                <a:ext cx="2872458" cy="409023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sz="1400" dirty="0"/>
                  <a:t>Amplicons from </a:t>
                </a:r>
                <a:r>
                  <a:rPr lang="en-US" sz="14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PEG purified</a:t>
                </a:r>
                <a:r>
                  <a:rPr lang="en-US" sz="1400" dirty="0">
                    <a:solidFill>
                      <a:schemeClr val="bg1">
                        <a:lumMod val="50000"/>
                      </a:schemeClr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 </a:t>
                </a:r>
                <a:r>
                  <a:rPr lang="en-US" sz="1400" dirty="0"/>
                  <a:t>phage lysate using F1-T7_ x R2-T7 primers.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0E89B0AA-CCE1-4A25-9D85-CC770A34BD44}"/>
                </a:ext>
              </a:extLst>
            </p:cNvPr>
            <p:cNvGrpSpPr/>
            <p:nvPr/>
          </p:nvGrpSpPr>
          <p:grpSpPr>
            <a:xfrm>
              <a:off x="891513" y="704125"/>
              <a:ext cx="3781141" cy="2937599"/>
              <a:chOff x="891513" y="704125"/>
              <a:chExt cx="3781141" cy="2937599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153A9B96-FA7D-4BED-A2E8-B4C956875322}"/>
                  </a:ext>
                </a:extLst>
              </p:cNvPr>
              <p:cNvGrpSpPr/>
              <p:nvPr/>
            </p:nvGrpSpPr>
            <p:grpSpPr>
              <a:xfrm>
                <a:off x="891513" y="1030423"/>
                <a:ext cx="3781141" cy="2611301"/>
                <a:chOff x="890499" y="1977921"/>
                <a:chExt cx="3781141" cy="2611301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98DCD4C2-CEB8-46F4-94DE-8486429410A0}"/>
                    </a:ext>
                  </a:extLst>
                </p:cNvPr>
                <p:cNvGrpSpPr/>
                <p:nvPr/>
              </p:nvGrpSpPr>
              <p:grpSpPr>
                <a:xfrm>
                  <a:off x="890499" y="2006209"/>
                  <a:ext cx="3781141" cy="2583013"/>
                  <a:chOff x="890499" y="2006209"/>
                  <a:chExt cx="3781141" cy="2583013"/>
                </a:xfrm>
              </p:grpSpPr>
              <p:pic>
                <p:nvPicPr>
                  <p:cNvPr id="13" name="Picture 12" descr="First PCR soy arab bsa without PEG II.2.tif">
                    <a:extLst>
                      <a:ext uri="{FF2B5EF4-FFF2-40B4-BE49-F238E27FC236}">
                        <a16:creationId xmlns:a16="http://schemas.microsoft.com/office/drawing/2014/main" id="{FF5AF2F8-7984-4128-B095-7E18ACC4DECD}"/>
                      </a:ext>
                    </a:extLst>
                  </p:cNvPr>
                  <p:cNvPicPr/>
                  <p:nvPr/>
                </p:nvPicPr>
                <p:blipFill rotWithShape="1">
                  <a:blip r:embed="rId3" cstate="print"/>
                  <a:srcRect l="18934" t="30766" r="18401" b="11396"/>
                  <a:stretch/>
                </p:blipFill>
                <p:spPr>
                  <a:xfrm>
                    <a:off x="1583607" y="2636016"/>
                    <a:ext cx="3088033" cy="1953206"/>
                  </a:xfrm>
                  <a:prstGeom prst="rect">
                    <a:avLst/>
                  </a:prstGeom>
                </p:spPr>
              </p:pic>
              <p:grpSp>
                <p:nvGrpSpPr>
                  <p:cNvPr id="14" name="Group 13">
                    <a:extLst>
                      <a:ext uri="{FF2B5EF4-FFF2-40B4-BE49-F238E27FC236}">
                        <a16:creationId xmlns:a16="http://schemas.microsoft.com/office/drawing/2014/main" id="{3CAC2CC1-B3B5-4128-A356-ABF8E7C2BC4A}"/>
                      </a:ext>
                    </a:extLst>
                  </p:cNvPr>
                  <p:cNvGrpSpPr/>
                  <p:nvPr/>
                </p:nvGrpSpPr>
                <p:grpSpPr>
                  <a:xfrm>
                    <a:off x="1458372" y="2006209"/>
                    <a:ext cx="3164364" cy="628308"/>
                    <a:chOff x="768838" y="2947594"/>
                    <a:chExt cx="3164364" cy="628308"/>
                  </a:xfrm>
                </p:grpSpPr>
                <p:grpSp>
                  <p:nvGrpSpPr>
                    <p:cNvPr id="28" name="Group 27">
                      <a:extLst>
                        <a:ext uri="{FF2B5EF4-FFF2-40B4-BE49-F238E27FC236}">
                          <a16:creationId xmlns:a16="http://schemas.microsoft.com/office/drawing/2014/main" id="{5E98A211-5C56-45CB-95CB-85067E25A35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32849" y="2947594"/>
                      <a:ext cx="1112805" cy="246221"/>
                      <a:chOff x="1132849" y="2245704"/>
                      <a:chExt cx="1112805" cy="246221"/>
                    </a:xfrm>
                  </p:grpSpPr>
                  <p:sp>
                    <p:nvSpPr>
                      <p:cNvPr id="49" name="TextBox 48">
                        <a:extLst>
                          <a:ext uri="{FF2B5EF4-FFF2-40B4-BE49-F238E27FC236}">
                            <a16:creationId xmlns:a16="http://schemas.microsoft.com/office/drawing/2014/main" id="{3C158D68-69BA-42BE-8158-7CC1E47BDA4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32849" y="2245704"/>
                        <a:ext cx="11128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/>
                          <a:t>Glyma04g009900</a:t>
                        </a:r>
                      </a:p>
                    </p:txBody>
                  </p:sp>
                  <p:cxnSp>
                    <p:nvCxnSpPr>
                      <p:cNvPr id="50" name="Straight Connector 49">
                        <a:extLst>
                          <a:ext uri="{FF2B5EF4-FFF2-40B4-BE49-F238E27FC236}">
                            <a16:creationId xmlns:a16="http://schemas.microsoft.com/office/drawing/2014/main" id="{64B220B3-D003-48A4-B97C-6E16C1B5471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331847" y="2468693"/>
                        <a:ext cx="73152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29" name="Group 28">
                      <a:extLst>
                        <a:ext uri="{FF2B5EF4-FFF2-40B4-BE49-F238E27FC236}">
                          <a16:creationId xmlns:a16="http://schemas.microsoft.com/office/drawing/2014/main" id="{B80098A6-27E3-4562-810D-8D9B768419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178146" y="2947995"/>
                      <a:ext cx="901209" cy="246221"/>
                      <a:chOff x="1036487" y="2245704"/>
                      <a:chExt cx="901209" cy="246221"/>
                    </a:xfrm>
                  </p:grpSpPr>
                  <p:sp>
                    <p:nvSpPr>
                      <p:cNvPr id="47" name="TextBox 46">
                        <a:extLst>
                          <a:ext uri="{FF2B5EF4-FFF2-40B4-BE49-F238E27FC236}">
                            <a16:creationId xmlns:a16="http://schemas.microsoft.com/office/drawing/2014/main" id="{2F8D7904-790A-4BFF-8DD4-8EC252E0009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6487" y="2245704"/>
                        <a:ext cx="901209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/>
                          <a:t>AT2G21490.1</a:t>
                        </a:r>
                      </a:p>
                    </p:txBody>
                  </p:sp>
                  <p:cxnSp>
                    <p:nvCxnSpPr>
                      <p:cNvPr id="48" name="Straight Connector 47">
                        <a:extLst>
                          <a:ext uri="{FF2B5EF4-FFF2-40B4-BE49-F238E27FC236}">
                            <a16:creationId xmlns:a16="http://schemas.microsoft.com/office/drawing/2014/main" id="{F629D05A-6890-42E8-AADE-B91FE0C6117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103259" y="2468693"/>
                        <a:ext cx="73152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30" name="Group 29">
                      <a:extLst>
                        <a:ext uri="{FF2B5EF4-FFF2-40B4-BE49-F238E27FC236}">
                          <a16:creationId xmlns:a16="http://schemas.microsoft.com/office/drawing/2014/main" id="{2D8F8763-D28B-4862-A9BF-7E098F91BB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50596" y="2950022"/>
                      <a:ext cx="731520" cy="246221"/>
                      <a:chOff x="864864" y="2245704"/>
                      <a:chExt cx="731520" cy="246221"/>
                    </a:xfrm>
                  </p:grpSpPr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1ADC2945-605B-4992-B2C0-542C64C2ACF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29547" y="2245704"/>
                        <a:ext cx="39466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/>
                          <a:t>BSA</a:t>
                        </a:r>
                      </a:p>
                    </p:txBody>
                  </p:sp>
                  <p:cxnSp>
                    <p:nvCxnSpPr>
                      <p:cNvPr id="46" name="Straight Connector 45">
                        <a:extLst>
                          <a:ext uri="{FF2B5EF4-FFF2-40B4-BE49-F238E27FC236}">
                            <a16:creationId xmlns:a16="http://schemas.microsoft.com/office/drawing/2014/main" id="{191A9971-B98A-4A3B-BA3D-3A33C5414D4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864864" y="2465427"/>
                        <a:ext cx="73152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31" name="Group 30">
                      <a:extLst>
                        <a:ext uri="{FF2B5EF4-FFF2-40B4-BE49-F238E27FC236}">
                          <a16:creationId xmlns:a16="http://schemas.microsoft.com/office/drawing/2014/main" id="{B78841D9-976D-45D4-BAEB-EE30DA09FC0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68838" y="3157046"/>
                      <a:ext cx="3164364" cy="418856"/>
                      <a:chOff x="768838" y="3157046"/>
                      <a:chExt cx="3164364" cy="418856"/>
                    </a:xfrm>
                  </p:grpSpPr>
                  <p:sp>
                    <p:nvSpPr>
                      <p:cNvPr id="32" name="TextBox 31">
                        <a:extLst>
                          <a:ext uri="{FF2B5EF4-FFF2-40B4-BE49-F238E27FC236}">
                            <a16:creationId xmlns:a16="http://schemas.microsoft.com/office/drawing/2014/main" id="{18E3CF4E-3E29-4492-8C2E-1B42CCD7505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17380" y="3157046"/>
                        <a:ext cx="729687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Replicate</a:t>
                        </a:r>
                      </a:p>
                    </p:txBody>
                  </p:sp>
                  <p:sp>
                    <p:nvSpPr>
                      <p:cNvPr id="33" name="TextBox 32">
                        <a:extLst>
                          <a:ext uri="{FF2B5EF4-FFF2-40B4-BE49-F238E27FC236}">
                            <a16:creationId xmlns:a16="http://schemas.microsoft.com/office/drawing/2014/main" id="{5DF309BE-F897-479B-BEFB-24C743AF8A8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46001" y="3162394"/>
                        <a:ext cx="729687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Replicate</a:t>
                        </a:r>
                      </a:p>
                    </p:txBody>
                  </p:sp>
                  <p:sp>
                    <p:nvSpPr>
                      <p:cNvPr id="34" name="TextBox 33">
                        <a:extLst>
                          <a:ext uri="{FF2B5EF4-FFF2-40B4-BE49-F238E27FC236}">
                            <a16:creationId xmlns:a16="http://schemas.microsoft.com/office/drawing/2014/main" id="{9D52CE90-6509-4B73-A5BC-8205B74B7D1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57021" y="3160247"/>
                        <a:ext cx="729687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Replicate</a:t>
                        </a:r>
                      </a:p>
                    </p:txBody>
                  </p:sp>
                  <p:sp>
                    <p:nvSpPr>
                      <p:cNvPr id="35" name="TextBox 34">
                        <a:extLst>
                          <a:ext uri="{FF2B5EF4-FFF2-40B4-BE49-F238E27FC236}">
                            <a16:creationId xmlns:a16="http://schemas.microsoft.com/office/drawing/2014/main" id="{A203C3B3-3C61-44F7-804C-38068102E3A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68838" y="3314292"/>
                        <a:ext cx="559769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MWM</a:t>
                        </a:r>
                      </a:p>
                    </p:txBody>
                  </p:sp>
                  <p:sp>
                    <p:nvSpPr>
                      <p:cNvPr id="36" name="TextBox 35">
                        <a:extLst>
                          <a:ext uri="{FF2B5EF4-FFF2-40B4-BE49-F238E27FC236}">
                            <a16:creationId xmlns:a16="http://schemas.microsoft.com/office/drawing/2014/main" id="{86A4B7E7-3711-4C0C-9F3F-4BA45FEFB5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51311" y="3307872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1</a:t>
                        </a:r>
                      </a:p>
                    </p:txBody>
                  </p:sp>
                  <p:sp>
                    <p:nvSpPr>
                      <p:cNvPr id="37" name="TextBox 36">
                        <a:extLst>
                          <a:ext uri="{FF2B5EF4-FFF2-40B4-BE49-F238E27FC236}">
                            <a16:creationId xmlns:a16="http://schemas.microsoft.com/office/drawing/2014/main" id="{46767813-E864-4238-AADB-078E2A24545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58965" y="3303441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2</a:t>
                        </a:r>
                      </a:p>
                    </p:txBody>
                  </p:sp>
                  <p:sp>
                    <p:nvSpPr>
                      <p:cNvPr id="38" name="TextBox 37">
                        <a:extLst>
                          <a:ext uri="{FF2B5EF4-FFF2-40B4-BE49-F238E27FC236}">
                            <a16:creationId xmlns:a16="http://schemas.microsoft.com/office/drawing/2014/main" id="{AC8914C9-8DAA-4D30-99C4-7ED1A87A4BA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64866" y="3303441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3</a:t>
                        </a:r>
                      </a:p>
                    </p:txBody>
                  </p:sp>
                  <p:sp>
                    <p:nvSpPr>
                      <p:cNvPr id="39" name="TextBox 38">
                        <a:extLst>
                          <a:ext uri="{FF2B5EF4-FFF2-40B4-BE49-F238E27FC236}">
                            <a16:creationId xmlns:a16="http://schemas.microsoft.com/office/drawing/2014/main" id="{B626429C-C15E-48F2-9A26-595D16C0747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73312" y="3305729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1</a:t>
                        </a:r>
                      </a:p>
                    </p:txBody>
                  </p:sp>
                  <p:sp>
                    <p:nvSpPr>
                      <p:cNvPr id="40" name="TextBox 39">
                        <a:extLst>
                          <a:ext uri="{FF2B5EF4-FFF2-40B4-BE49-F238E27FC236}">
                            <a16:creationId xmlns:a16="http://schemas.microsoft.com/office/drawing/2014/main" id="{3800E6C2-F605-4DE7-8141-64CA314B4AD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67907" y="3307737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2</a:t>
                        </a:r>
                      </a:p>
                    </p:txBody>
                  </p:sp>
                  <p:sp>
                    <p:nvSpPr>
                      <p:cNvPr id="41" name="TextBox 40">
                        <a:extLst>
                          <a:ext uri="{FF2B5EF4-FFF2-40B4-BE49-F238E27FC236}">
                            <a16:creationId xmlns:a16="http://schemas.microsoft.com/office/drawing/2014/main" id="{693D5E08-7BCD-41C3-91EB-E769FB3BB71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70548" y="3307737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3</a:t>
                        </a:r>
                      </a:p>
                    </p:txBody>
                  </p:sp>
                  <p:sp>
                    <p:nvSpPr>
                      <p:cNvPr id="42" name="TextBox 41">
                        <a:extLst>
                          <a:ext uri="{FF2B5EF4-FFF2-40B4-BE49-F238E27FC236}">
                            <a16:creationId xmlns:a16="http://schemas.microsoft.com/office/drawing/2014/main" id="{0B1E0B8C-4EA8-43B5-97F5-8C2A7F83EB3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69551" y="3310028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1</a:t>
                        </a:r>
                      </a:p>
                    </p:txBody>
                  </p:sp>
                  <p:sp>
                    <p:nvSpPr>
                      <p:cNvPr id="43" name="TextBox 42">
                        <a:extLst>
                          <a:ext uri="{FF2B5EF4-FFF2-40B4-BE49-F238E27FC236}">
                            <a16:creationId xmlns:a16="http://schemas.microsoft.com/office/drawing/2014/main" id="{60945646-F762-4682-98AB-914C3E21D35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377025" y="3305596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2</a:t>
                        </a:r>
                      </a:p>
                    </p:txBody>
                  </p:sp>
                  <p:sp>
                    <p:nvSpPr>
                      <p:cNvPr id="44" name="TextBox 43">
                        <a:extLst>
                          <a:ext uri="{FF2B5EF4-FFF2-40B4-BE49-F238E27FC236}">
                            <a16:creationId xmlns:a16="http://schemas.microsoft.com/office/drawing/2014/main" id="{24ECDFC0-621B-4DE9-87F0-7E072BA1D46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676400" y="3305596"/>
                        <a:ext cx="2568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/>
                          <a:t>3</a:t>
                        </a:r>
                      </a:p>
                    </p:txBody>
                  </p:sp>
                </p:grpSp>
              </p:grpSp>
              <p:grpSp>
                <p:nvGrpSpPr>
                  <p:cNvPr id="15" name="Group 14">
                    <a:extLst>
                      <a:ext uri="{FF2B5EF4-FFF2-40B4-BE49-F238E27FC236}">
                        <a16:creationId xmlns:a16="http://schemas.microsoft.com/office/drawing/2014/main" id="{604D73A4-A9F5-4668-8976-893145B38F38}"/>
                      </a:ext>
                    </a:extLst>
                  </p:cNvPr>
                  <p:cNvGrpSpPr/>
                  <p:nvPr/>
                </p:nvGrpSpPr>
                <p:grpSpPr>
                  <a:xfrm>
                    <a:off x="890499" y="3173272"/>
                    <a:ext cx="701700" cy="1139819"/>
                    <a:chOff x="890499" y="3173272"/>
                    <a:chExt cx="701700" cy="1139819"/>
                  </a:xfrm>
                </p:grpSpPr>
                <p:cxnSp>
                  <p:nvCxnSpPr>
                    <p:cNvPr id="16" name="Straight Connector 15">
                      <a:extLst>
                        <a:ext uri="{FF2B5EF4-FFF2-40B4-BE49-F238E27FC236}">
                          <a16:creationId xmlns:a16="http://schemas.microsoft.com/office/drawing/2014/main" id="{E5EC0D07-C362-4135-B1D6-4AE113D4081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32469" y="3662157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Straight Connector 16">
                      <a:extLst>
                        <a:ext uri="{FF2B5EF4-FFF2-40B4-BE49-F238E27FC236}">
                          <a16:creationId xmlns:a16="http://schemas.microsoft.com/office/drawing/2014/main" id="{5A0D67BA-1F41-45FE-A677-3E95F688205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33549" y="3312857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Straight Connector 17">
                      <a:extLst>
                        <a:ext uri="{FF2B5EF4-FFF2-40B4-BE49-F238E27FC236}">
                          <a16:creationId xmlns:a16="http://schemas.microsoft.com/office/drawing/2014/main" id="{EEE86FE4-5B35-4635-9153-AA371032C0C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41061" y="3457916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" name="Straight Connector 18">
                      <a:extLst>
                        <a:ext uri="{FF2B5EF4-FFF2-40B4-BE49-F238E27FC236}">
                          <a16:creationId xmlns:a16="http://schemas.microsoft.com/office/drawing/2014/main" id="{FBE3E6C4-91B4-4145-AA04-99A9BD65240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23887" y="3828828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Straight Connector 19">
                      <a:extLst>
                        <a:ext uri="{FF2B5EF4-FFF2-40B4-BE49-F238E27FC236}">
                          <a16:creationId xmlns:a16="http://schemas.microsoft.com/office/drawing/2014/main" id="{EA94DDF6-931C-4D61-9A5B-ABE6604EF50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34623" y="3981554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Straight Connector 20">
                      <a:extLst>
                        <a:ext uri="{FF2B5EF4-FFF2-40B4-BE49-F238E27FC236}">
                          <a16:creationId xmlns:a16="http://schemas.microsoft.com/office/drawing/2014/main" id="{C6067C12-1E88-4EEE-A44B-EC67603F3B7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32481" y="4171521"/>
                      <a:ext cx="251138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7F2E28F4-7705-4A52-98DF-78EF6B9AD9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2650" y="3173272"/>
                      <a:ext cx="49885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2000</a:t>
                      </a:r>
                    </a:p>
                  </p:txBody>
                </p:sp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430ABDD1-14FC-4179-88FE-D090122D145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2650" y="3311772"/>
                      <a:ext cx="49885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500</a:t>
                      </a:r>
                    </a:p>
                  </p:txBody>
                </p: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FAE67773-50C8-42F3-A4C5-F1A2B48FFE9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0499" y="3522451"/>
                      <a:ext cx="49885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1000</a:t>
                      </a:r>
                    </a:p>
                  </p:txBody>
                </p:sp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73FAEE2F-12AD-437D-B4BA-E14FE8A053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7767" y="3690604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700</a:t>
                      </a:r>
                    </a:p>
                  </p:txBody>
                </p:sp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70BE06AD-47FB-42E5-A918-9F0339BF84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2060" y="3836901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500</a:t>
                      </a:r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3BB8D282-C4C4-48EF-9E75-4DC9EBC5D7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5494" y="4036092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/>
                        <a:t>300</a:t>
                      </a:r>
                    </a:p>
                  </p:txBody>
                </p:sp>
              </p:grpSp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507CF282-6078-4987-937E-8F806C2AE9C9}"/>
                    </a:ext>
                  </a:extLst>
                </p:cNvPr>
                <p:cNvSpPr txBox="1"/>
                <p:nvPr/>
              </p:nvSpPr>
              <p:spPr>
                <a:xfrm>
                  <a:off x="977862" y="1977921"/>
                  <a:ext cx="3241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A</a:t>
                  </a:r>
                </a:p>
              </p:txBody>
            </p: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DDA8C26-D3AA-4C2D-ACCE-E2D0C81439E3}"/>
                  </a:ext>
                </a:extLst>
              </p:cNvPr>
              <p:cNvSpPr txBox="1"/>
              <p:nvPr/>
            </p:nvSpPr>
            <p:spPr>
              <a:xfrm>
                <a:off x="2024771" y="704125"/>
                <a:ext cx="2339835" cy="409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sz="1400" dirty="0"/>
                  <a:t>Amplicons from phage lysate using F1-T7_ x R2-T7 primers.</a:t>
                </a:r>
              </a:p>
            </p:txBody>
          </p:sp>
        </p:grp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5F130D52-A809-4EA0-9C62-716F5598E35B}"/>
              </a:ext>
            </a:extLst>
          </p:cNvPr>
          <p:cNvSpPr txBox="1"/>
          <p:nvPr/>
        </p:nvSpPr>
        <p:spPr>
          <a:xfrm>
            <a:off x="91722" y="373594"/>
            <a:ext cx="287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26CE626-F17B-48DC-A049-23D7CE4D71DF}"/>
              </a:ext>
            </a:extLst>
          </p:cNvPr>
          <p:cNvSpPr txBox="1"/>
          <p:nvPr/>
        </p:nvSpPr>
        <p:spPr>
          <a:xfrm>
            <a:off x="96624" y="15377"/>
            <a:ext cx="2233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CF6B2EB-5FFF-40F6-9F83-6A73D772DDCD}"/>
              </a:ext>
            </a:extLst>
          </p:cNvPr>
          <p:cNvSpPr txBox="1"/>
          <p:nvPr/>
        </p:nvSpPr>
        <p:spPr>
          <a:xfrm>
            <a:off x="3177580" y="436426"/>
            <a:ext cx="2788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ep one limited PCR round</a:t>
            </a:r>
          </a:p>
        </p:txBody>
      </p:sp>
      <p:grpSp>
        <p:nvGrpSpPr>
          <p:cNvPr id="95" name="Group 94">
            <a:extLst>
              <a:ext uri="{FF2B5EF4-FFF2-40B4-BE49-F238E27FC236}">
                <a16:creationId xmlns:a16="http://schemas.microsoft.com/office/drawing/2014/main" id="{85407770-7482-4989-A833-1E6C555BAC3C}"/>
              </a:ext>
            </a:extLst>
          </p:cNvPr>
          <p:cNvGrpSpPr/>
          <p:nvPr/>
        </p:nvGrpSpPr>
        <p:grpSpPr>
          <a:xfrm>
            <a:off x="-415" y="4024840"/>
            <a:ext cx="8844789" cy="2356953"/>
            <a:chOff x="50662" y="1572120"/>
            <a:chExt cx="8844789" cy="2356953"/>
          </a:xfrm>
        </p:grpSpPr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F8EEFF84-44F4-476D-84EC-FCEA6B349EAA}"/>
                </a:ext>
              </a:extLst>
            </p:cNvPr>
            <p:cNvGrpSpPr/>
            <p:nvPr/>
          </p:nvGrpSpPr>
          <p:grpSpPr>
            <a:xfrm>
              <a:off x="50662" y="1590980"/>
              <a:ext cx="4509120" cy="2338093"/>
              <a:chOff x="50662" y="987863"/>
              <a:chExt cx="4509120" cy="2338093"/>
            </a:xfrm>
          </p:grpSpPr>
          <p:grpSp>
            <p:nvGrpSpPr>
              <p:cNvPr id="140" name="Group 139">
                <a:extLst>
                  <a:ext uri="{FF2B5EF4-FFF2-40B4-BE49-F238E27FC236}">
                    <a16:creationId xmlns:a16="http://schemas.microsoft.com/office/drawing/2014/main" id="{E4479E61-9E27-4AAB-8DAC-DC30AB6EE7CB}"/>
                  </a:ext>
                </a:extLst>
              </p:cNvPr>
              <p:cNvGrpSpPr/>
              <p:nvPr/>
            </p:nvGrpSpPr>
            <p:grpSpPr>
              <a:xfrm>
                <a:off x="50662" y="1170390"/>
                <a:ext cx="4509120" cy="2155566"/>
                <a:chOff x="50660" y="1170388"/>
                <a:chExt cx="4509121" cy="2155565"/>
              </a:xfrm>
            </p:grpSpPr>
            <p:pic>
              <p:nvPicPr>
                <p:cNvPr id="142" name="Picture 141" descr="Second PCR soy arab bsa without PEG.tif">
                  <a:extLst>
                    <a:ext uri="{FF2B5EF4-FFF2-40B4-BE49-F238E27FC236}">
                      <a16:creationId xmlns:a16="http://schemas.microsoft.com/office/drawing/2014/main" id="{901199EB-624F-4376-8669-E57FF7F0CC28}"/>
                    </a:ext>
                  </a:extLst>
                </p:cNvPr>
                <p:cNvPicPr/>
                <p:nvPr/>
              </p:nvPicPr>
              <p:blipFill rotWithShape="1">
                <a:blip r:embed="rId4" cstate="print"/>
                <a:srcRect l="8121" t="22327" r="16338" b="34461"/>
                <a:stretch/>
              </p:blipFill>
              <p:spPr>
                <a:xfrm>
                  <a:off x="780540" y="1815652"/>
                  <a:ext cx="3779241" cy="1510301"/>
                </a:xfrm>
                <a:prstGeom prst="rect">
                  <a:avLst/>
                </a:prstGeom>
              </p:spPr>
            </p:pic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13E35E80-8594-4BFC-8EAC-96753AFA3080}"/>
                    </a:ext>
                  </a:extLst>
                </p:cNvPr>
                <p:cNvGrpSpPr/>
                <p:nvPr/>
              </p:nvGrpSpPr>
              <p:grpSpPr>
                <a:xfrm>
                  <a:off x="634874" y="1282107"/>
                  <a:ext cx="1429925" cy="560203"/>
                  <a:chOff x="634874" y="1282107"/>
                  <a:chExt cx="1429925" cy="560203"/>
                </a:xfrm>
              </p:grpSpPr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6B2FAFED-9FEE-4E50-A730-4BDBF84B31CC}"/>
                      </a:ext>
                    </a:extLst>
                  </p:cNvPr>
                  <p:cNvSpPr txBox="1"/>
                  <p:nvPr/>
                </p:nvSpPr>
                <p:spPr>
                  <a:xfrm>
                    <a:off x="634874" y="1591074"/>
                    <a:ext cx="52610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MWM</a:t>
                    </a:r>
                  </a:p>
                </p:txBody>
              </p:sp>
              <p:grpSp>
                <p:nvGrpSpPr>
                  <p:cNvPr id="176" name="Group 175">
                    <a:extLst>
                      <a:ext uri="{FF2B5EF4-FFF2-40B4-BE49-F238E27FC236}">
                        <a16:creationId xmlns:a16="http://schemas.microsoft.com/office/drawing/2014/main" id="{DE860957-F25C-4239-9F5F-89E66BA89CF5}"/>
                      </a:ext>
                    </a:extLst>
                  </p:cNvPr>
                  <p:cNvGrpSpPr/>
                  <p:nvPr/>
                </p:nvGrpSpPr>
                <p:grpSpPr>
                  <a:xfrm>
                    <a:off x="951994" y="1282107"/>
                    <a:ext cx="1112805" cy="560203"/>
                    <a:chOff x="951994" y="1282107"/>
                    <a:chExt cx="1112805" cy="560203"/>
                  </a:xfrm>
                </p:grpSpPr>
                <p:grpSp>
                  <p:nvGrpSpPr>
                    <p:cNvPr id="177" name="Group 176">
                      <a:extLst>
                        <a:ext uri="{FF2B5EF4-FFF2-40B4-BE49-F238E27FC236}">
                          <a16:creationId xmlns:a16="http://schemas.microsoft.com/office/drawing/2014/main" id="{F8058B5E-C20A-460B-A2DE-F03AB3656C6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1994" y="1282107"/>
                      <a:ext cx="1112805" cy="246221"/>
                      <a:chOff x="1128890" y="2694215"/>
                      <a:chExt cx="1112805" cy="246221"/>
                    </a:xfrm>
                  </p:grpSpPr>
                  <p:sp>
                    <p:nvSpPr>
                      <p:cNvPr id="182" name="TextBox 181">
                        <a:extLst>
                          <a:ext uri="{FF2B5EF4-FFF2-40B4-BE49-F238E27FC236}">
                            <a16:creationId xmlns:a16="http://schemas.microsoft.com/office/drawing/2014/main" id="{F54DE0F7-FDCB-4AE2-971C-348D2BCA069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28890" y="2694215"/>
                        <a:ext cx="11128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/>
                          <a:t>Glyma04g009900</a:t>
                        </a:r>
                      </a:p>
                    </p:txBody>
                  </p:sp>
                  <p:cxnSp>
                    <p:nvCxnSpPr>
                      <p:cNvPr id="183" name="Straight Connector 182">
                        <a:extLst>
                          <a:ext uri="{FF2B5EF4-FFF2-40B4-BE49-F238E27FC236}">
                            <a16:creationId xmlns:a16="http://schemas.microsoft.com/office/drawing/2014/main" id="{9B09F17C-998F-4D7A-978E-43D30DFAC4B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358849" y="2918702"/>
                        <a:ext cx="73152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id="{B8EF6A46-5E87-4A06-B329-44AFB996FAE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9967" y="1480966"/>
                      <a:ext cx="67839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Replicate</a:t>
                      </a:r>
                    </a:p>
                  </p:txBody>
                </p:sp>
                <p:sp>
                  <p:nvSpPr>
                    <p:cNvPr id="179" name="TextBox 178">
                      <a:extLst>
                        <a:ext uri="{FF2B5EF4-FFF2-40B4-BE49-F238E27FC236}">
                          <a16:creationId xmlns:a16="http://schemas.microsoft.com/office/drawing/2014/main" id="{0964B5FF-C7CB-4081-AE8F-7AAFF76A417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18205" y="1596089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1</a:t>
                      </a:r>
                    </a:p>
                  </p:txBody>
                </p:sp>
                <p:sp>
                  <p:nvSpPr>
                    <p:cNvPr id="180" name="TextBox 179">
                      <a:extLst>
                        <a:ext uri="{FF2B5EF4-FFF2-40B4-BE49-F238E27FC236}">
                          <a16:creationId xmlns:a16="http://schemas.microsoft.com/office/drawing/2014/main" id="{41AFB6BA-983F-49D5-8AB2-70524A467A8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28286" y="1594569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2</a:t>
                      </a:r>
                    </a:p>
                  </p:txBody>
                </p:sp>
                <p:sp>
                  <p:nvSpPr>
                    <p:cNvPr id="181" name="TextBox 180">
                      <a:extLst>
                        <a:ext uri="{FF2B5EF4-FFF2-40B4-BE49-F238E27FC236}">
                          <a16:creationId xmlns:a16="http://schemas.microsoft.com/office/drawing/2014/main" id="{6F98D7C1-F4C7-4C1C-9214-ADEF1EE8889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33112" y="1594569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3</a:t>
                      </a:r>
                    </a:p>
                  </p:txBody>
                </p:sp>
              </p:grpSp>
            </p:grpSp>
            <p:grpSp>
              <p:nvGrpSpPr>
                <p:cNvPr id="144" name="Group 143">
                  <a:extLst>
                    <a:ext uri="{FF2B5EF4-FFF2-40B4-BE49-F238E27FC236}">
                      <a16:creationId xmlns:a16="http://schemas.microsoft.com/office/drawing/2014/main" id="{0EFAF63F-F751-4A89-8CCD-7F6CE192C3F9}"/>
                    </a:ext>
                  </a:extLst>
                </p:cNvPr>
                <p:cNvGrpSpPr/>
                <p:nvPr/>
              </p:nvGrpSpPr>
              <p:grpSpPr>
                <a:xfrm>
                  <a:off x="2307820" y="1278950"/>
                  <a:ext cx="901209" cy="566137"/>
                  <a:chOff x="2307820" y="1278950"/>
                  <a:chExt cx="901209" cy="566137"/>
                </a:xfrm>
              </p:grpSpPr>
              <p:grpSp>
                <p:nvGrpSpPr>
                  <p:cNvPr id="168" name="Group 167">
                    <a:extLst>
                      <a:ext uri="{FF2B5EF4-FFF2-40B4-BE49-F238E27FC236}">
                        <a16:creationId xmlns:a16="http://schemas.microsoft.com/office/drawing/2014/main" id="{FA9DEE88-39BA-4326-9EFA-35DA89C56985}"/>
                      </a:ext>
                    </a:extLst>
                  </p:cNvPr>
                  <p:cNvGrpSpPr/>
                  <p:nvPr/>
                </p:nvGrpSpPr>
                <p:grpSpPr>
                  <a:xfrm>
                    <a:off x="2307820" y="1278950"/>
                    <a:ext cx="901209" cy="246221"/>
                    <a:chOff x="1028904" y="2690657"/>
                    <a:chExt cx="901209" cy="246221"/>
                  </a:xfrm>
                </p:grpSpPr>
                <p:sp>
                  <p:nvSpPr>
                    <p:cNvPr id="173" name="TextBox 172">
                      <a:extLst>
                        <a:ext uri="{FF2B5EF4-FFF2-40B4-BE49-F238E27FC236}">
                          <a16:creationId xmlns:a16="http://schemas.microsoft.com/office/drawing/2014/main" id="{6355AEDD-CA2D-47A8-A97F-1F3860FEDC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28904" y="2690657"/>
                      <a:ext cx="90120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AT2G21490.1</a:t>
                      </a:r>
                    </a:p>
                  </p:txBody>
                </p:sp>
                <p:cxnSp>
                  <p:nvCxnSpPr>
                    <p:cNvPr id="174" name="Straight Connector 173">
                      <a:extLst>
                        <a:ext uri="{FF2B5EF4-FFF2-40B4-BE49-F238E27FC236}">
                          <a16:creationId xmlns:a16="http://schemas.microsoft.com/office/drawing/2014/main" id="{62FFC0FA-B19D-4E50-AA27-39DCF9CEDEE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17559" y="2915144"/>
                      <a:ext cx="73152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69" name="TextBox 168">
                    <a:extLst>
                      <a:ext uri="{FF2B5EF4-FFF2-40B4-BE49-F238E27FC236}">
                        <a16:creationId xmlns:a16="http://schemas.microsoft.com/office/drawing/2014/main" id="{48802BF5-EBC2-4C55-ACC5-8B93CAFBA49A}"/>
                      </a:ext>
                    </a:extLst>
                  </p:cNvPr>
                  <p:cNvSpPr txBox="1"/>
                  <p:nvPr/>
                </p:nvSpPr>
                <p:spPr>
                  <a:xfrm>
                    <a:off x="2408937" y="1481699"/>
                    <a:ext cx="67839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Replicate</a:t>
                    </a:r>
                  </a:p>
                </p:txBody>
              </p:sp>
              <p:sp>
                <p:nvSpPr>
                  <p:cNvPr id="170" name="TextBox 169">
                    <a:extLst>
                      <a:ext uri="{FF2B5EF4-FFF2-40B4-BE49-F238E27FC236}">
                        <a16:creationId xmlns:a16="http://schemas.microsoft.com/office/drawing/2014/main" id="{820FB586-6A77-4061-9B13-B442A747CCD5}"/>
                      </a:ext>
                    </a:extLst>
                  </p:cNvPr>
                  <p:cNvSpPr txBox="1"/>
                  <p:nvPr/>
                </p:nvSpPr>
                <p:spPr>
                  <a:xfrm>
                    <a:off x="2335137" y="1596858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1</a:t>
                    </a:r>
                  </a:p>
                </p:txBody>
              </p:sp>
              <p:sp>
                <p:nvSpPr>
                  <p:cNvPr id="171" name="TextBox 170">
                    <a:extLst>
                      <a:ext uri="{FF2B5EF4-FFF2-40B4-BE49-F238E27FC236}">
                        <a16:creationId xmlns:a16="http://schemas.microsoft.com/office/drawing/2014/main" id="{733A4B72-DF72-47D9-AC3F-5453DD108316}"/>
                      </a:ext>
                    </a:extLst>
                  </p:cNvPr>
                  <p:cNvSpPr txBox="1"/>
                  <p:nvPr/>
                </p:nvSpPr>
                <p:spPr>
                  <a:xfrm>
                    <a:off x="2645218" y="1598866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2</a:t>
                    </a:r>
                  </a:p>
                </p:txBody>
              </p:sp>
              <p:sp>
                <p:nvSpPr>
                  <p:cNvPr id="172" name="TextBox 171">
                    <a:extLst>
                      <a:ext uri="{FF2B5EF4-FFF2-40B4-BE49-F238E27FC236}">
                        <a16:creationId xmlns:a16="http://schemas.microsoft.com/office/drawing/2014/main" id="{F944223B-2EC2-44F0-9E76-4E9E6D09D9B4}"/>
                      </a:ext>
                    </a:extLst>
                  </p:cNvPr>
                  <p:cNvSpPr txBox="1"/>
                  <p:nvPr/>
                </p:nvSpPr>
                <p:spPr>
                  <a:xfrm>
                    <a:off x="2937344" y="1598864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3</a:t>
                    </a:r>
                  </a:p>
                </p:txBody>
              </p:sp>
            </p:grpSp>
            <p:grpSp>
              <p:nvGrpSpPr>
                <p:cNvPr id="145" name="Group 144">
                  <a:extLst>
                    <a:ext uri="{FF2B5EF4-FFF2-40B4-BE49-F238E27FC236}">
                      <a16:creationId xmlns:a16="http://schemas.microsoft.com/office/drawing/2014/main" id="{A106B2C0-4F37-49D2-85A5-CDF4616C5C86}"/>
                    </a:ext>
                  </a:extLst>
                </p:cNvPr>
                <p:cNvGrpSpPr/>
                <p:nvPr/>
              </p:nvGrpSpPr>
              <p:grpSpPr>
                <a:xfrm>
                  <a:off x="50660" y="2207095"/>
                  <a:ext cx="701700" cy="965908"/>
                  <a:chOff x="890499" y="3714178"/>
                  <a:chExt cx="701700" cy="965908"/>
                </a:xfrm>
              </p:grpSpPr>
              <p:cxnSp>
                <p:nvCxnSpPr>
                  <p:cNvPr id="156" name="Straight Connector 155">
                    <a:extLst>
                      <a:ext uri="{FF2B5EF4-FFF2-40B4-BE49-F238E27FC236}">
                        <a16:creationId xmlns:a16="http://schemas.microsoft.com/office/drawing/2014/main" id="{EBB33D84-AE2A-4FFD-9609-1D229E02A95F}"/>
                      </a:ext>
                    </a:extLst>
                  </p:cNvPr>
                  <p:cNvCxnSpPr/>
                  <p:nvPr/>
                </p:nvCxnSpPr>
                <p:spPr>
                  <a:xfrm>
                    <a:off x="1332469" y="4130132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7" name="Straight Connector 156">
                    <a:extLst>
                      <a:ext uri="{FF2B5EF4-FFF2-40B4-BE49-F238E27FC236}">
                        <a16:creationId xmlns:a16="http://schemas.microsoft.com/office/drawing/2014/main" id="{C86CC248-898E-422B-A61A-801B2B49FADE}"/>
                      </a:ext>
                    </a:extLst>
                  </p:cNvPr>
                  <p:cNvCxnSpPr/>
                  <p:nvPr/>
                </p:nvCxnSpPr>
                <p:spPr>
                  <a:xfrm>
                    <a:off x="1333549" y="3853761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8" name="Straight Connector 157">
                    <a:extLst>
                      <a:ext uri="{FF2B5EF4-FFF2-40B4-BE49-F238E27FC236}">
                        <a16:creationId xmlns:a16="http://schemas.microsoft.com/office/drawing/2014/main" id="{206E1185-5384-4226-9EB5-F13612DDC05C}"/>
                      </a:ext>
                    </a:extLst>
                  </p:cNvPr>
                  <p:cNvCxnSpPr/>
                  <p:nvPr/>
                </p:nvCxnSpPr>
                <p:spPr>
                  <a:xfrm>
                    <a:off x="1341061" y="3970769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Straight Connector 158">
                    <a:extLst>
                      <a:ext uri="{FF2B5EF4-FFF2-40B4-BE49-F238E27FC236}">
                        <a16:creationId xmlns:a16="http://schemas.microsoft.com/office/drawing/2014/main" id="{C2C1177F-B805-41C2-B095-E1055C8FC306}"/>
                      </a:ext>
                    </a:extLst>
                  </p:cNvPr>
                  <p:cNvCxnSpPr/>
                  <p:nvPr/>
                </p:nvCxnSpPr>
                <p:spPr>
                  <a:xfrm>
                    <a:off x="1323887" y="4263143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0" name="Straight Connector 159">
                    <a:extLst>
                      <a:ext uri="{FF2B5EF4-FFF2-40B4-BE49-F238E27FC236}">
                        <a16:creationId xmlns:a16="http://schemas.microsoft.com/office/drawing/2014/main" id="{AAF8CF6D-F262-4390-8750-8684A6CB19FC}"/>
                      </a:ext>
                    </a:extLst>
                  </p:cNvPr>
                  <p:cNvCxnSpPr/>
                  <p:nvPr/>
                </p:nvCxnSpPr>
                <p:spPr>
                  <a:xfrm>
                    <a:off x="1334623" y="4382209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1" name="Straight Connector 160">
                    <a:extLst>
                      <a:ext uri="{FF2B5EF4-FFF2-40B4-BE49-F238E27FC236}">
                        <a16:creationId xmlns:a16="http://schemas.microsoft.com/office/drawing/2014/main" id="{D5881C39-111D-45B9-B992-C38D6CF6FC54}"/>
                      </a:ext>
                    </a:extLst>
                  </p:cNvPr>
                  <p:cNvCxnSpPr/>
                  <p:nvPr/>
                </p:nvCxnSpPr>
                <p:spPr>
                  <a:xfrm>
                    <a:off x="1332481" y="4538516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C1DEB5C3-17F3-4001-A2EE-438F64A8521A}"/>
                      </a:ext>
                    </a:extLst>
                  </p:cNvPr>
                  <p:cNvSpPr txBox="1"/>
                  <p:nvPr/>
                </p:nvSpPr>
                <p:spPr>
                  <a:xfrm>
                    <a:off x="892650" y="3714178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2000</a:t>
                    </a:r>
                  </a:p>
                </p:txBody>
              </p:sp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1664D805-20F1-4D96-AB09-9D3431BF036A}"/>
                      </a:ext>
                    </a:extLst>
                  </p:cNvPr>
                  <p:cNvSpPr txBox="1"/>
                  <p:nvPr/>
                </p:nvSpPr>
                <p:spPr>
                  <a:xfrm>
                    <a:off x="892650" y="3830235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500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EAAF6C7E-8E94-4412-8C25-4A58CEADF4AB}"/>
                      </a:ext>
                    </a:extLst>
                  </p:cNvPr>
                  <p:cNvSpPr txBox="1"/>
                  <p:nvPr/>
                </p:nvSpPr>
                <p:spPr>
                  <a:xfrm>
                    <a:off x="890499" y="3990425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000</a:t>
                    </a:r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EC4F82D4-9792-42E9-9E3D-9A572D0512F4}"/>
                      </a:ext>
                    </a:extLst>
                  </p:cNvPr>
                  <p:cNvSpPr txBox="1"/>
                  <p:nvPr/>
                </p:nvSpPr>
                <p:spPr>
                  <a:xfrm>
                    <a:off x="967767" y="4124919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700</a:t>
                    </a:r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5BD1D639-171E-4A7F-8DCF-ADEB9923CA90}"/>
                      </a:ext>
                    </a:extLst>
                  </p:cNvPr>
                  <p:cNvSpPr txBox="1"/>
                  <p:nvPr/>
                </p:nvSpPr>
                <p:spPr>
                  <a:xfrm>
                    <a:off x="972060" y="4243166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500</a:t>
                    </a:r>
                  </a:p>
                </p:txBody>
              </p:sp>
              <p:sp>
                <p:nvSpPr>
                  <p:cNvPr id="167" name="TextBox 166">
                    <a:extLst>
                      <a:ext uri="{FF2B5EF4-FFF2-40B4-BE49-F238E27FC236}">
                        <a16:creationId xmlns:a16="http://schemas.microsoft.com/office/drawing/2014/main" id="{4DA5C2EF-61A8-4FE6-97E3-F812382BA781}"/>
                      </a:ext>
                    </a:extLst>
                  </p:cNvPr>
                  <p:cNvSpPr txBox="1"/>
                  <p:nvPr/>
                </p:nvSpPr>
                <p:spPr>
                  <a:xfrm>
                    <a:off x="975494" y="4403087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300</a:t>
                    </a:r>
                  </a:p>
                </p:txBody>
              </p:sp>
            </p:grp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4E2C616B-18C8-4AD8-92A3-E8AA6485A7F1}"/>
                    </a:ext>
                  </a:extLst>
                </p:cNvPr>
                <p:cNvGrpSpPr/>
                <p:nvPr/>
              </p:nvGrpSpPr>
              <p:grpSpPr>
                <a:xfrm>
                  <a:off x="3212081" y="1276897"/>
                  <a:ext cx="1313094" cy="568679"/>
                  <a:chOff x="3212081" y="1276897"/>
                  <a:chExt cx="1313094" cy="568679"/>
                </a:xfrm>
              </p:grpSpPr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E3442127-EDEA-481E-9FF4-E10221E55215}"/>
                      </a:ext>
                    </a:extLst>
                  </p:cNvPr>
                  <p:cNvGrpSpPr/>
                  <p:nvPr/>
                </p:nvGrpSpPr>
                <p:grpSpPr>
                  <a:xfrm>
                    <a:off x="3665519" y="1276897"/>
                    <a:ext cx="859656" cy="566049"/>
                    <a:chOff x="3665519" y="1276897"/>
                    <a:chExt cx="859656" cy="566049"/>
                  </a:xfrm>
                </p:grpSpPr>
                <p:sp>
                  <p:nvSpPr>
                    <p:cNvPr id="150" name="TextBox 149">
                      <a:extLst>
                        <a:ext uri="{FF2B5EF4-FFF2-40B4-BE49-F238E27FC236}">
                          <a16:creationId xmlns:a16="http://schemas.microsoft.com/office/drawing/2014/main" id="{1DA30C1A-3599-44E5-BFD8-FA2A5D255F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94563" y="1276897"/>
                      <a:ext cx="3946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BSA</a:t>
                      </a:r>
                    </a:p>
                  </p:txBody>
                </p:sp>
                <p:cxnSp>
                  <p:nvCxnSpPr>
                    <p:cNvPr id="151" name="Straight Connector 150">
                      <a:extLst>
                        <a:ext uri="{FF2B5EF4-FFF2-40B4-BE49-F238E27FC236}">
                          <a16:creationId xmlns:a16="http://schemas.microsoft.com/office/drawing/2014/main" id="{1297CAAF-34F2-4552-89F4-B20C8127FBE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733040" y="1501800"/>
                      <a:ext cx="73152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2" name="TextBox 151">
                      <a:extLst>
                        <a:ext uri="{FF2B5EF4-FFF2-40B4-BE49-F238E27FC236}">
                          <a16:creationId xmlns:a16="http://schemas.microsoft.com/office/drawing/2014/main" id="{501DE1D1-3325-4170-AC23-7F3FE925B8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32206" y="1482131"/>
                      <a:ext cx="67839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Replicate</a:t>
                      </a:r>
                    </a:p>
                  </p:txBody>
                </p:sp>
                <p:sp>
                  <p:nvSpPr>
                    <p:cNvPr id="153" name="TextBox 152">
                      <a:extLst>
                        <a:ext uri="{FF2B5EF4-FFF2-40B4-BE49-F238E27FC236}">
                          <a16:creationId xmlns:a16="http://schemas.microsoft.com/office/drawing/2014/main" id="{180F9E14-526D-415F-B634-440D4A922F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65519" y="1592419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1</a:t>
                      </a:r>
                    </a:p>
                  </p:txBody>
                </p:sp>
                <p:sp>
                  <p:nvSpPr>
                    <p:cNvPr id="154" name="TextBox 153">
                      <a:extLst>
                        <a:ext uri="{FF2B5EF4-FFF2-40B4-BE49-F238E27FC236}">
                          <a16:creationId xmlns:a16="http://schemas.microsoft.com/office/drawing/2014/main" id="{E7194206-92A8-4A66-95F3-0B8C46811F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5727" y="1596725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2</a:t>
                      </a:r>
                    </a:p>
                  </p:txBody>
                </p:sp>
                <p:sp>
                  <p:nvSpPr>
                    <p:cNvPr id="155" name="TextBox 154">
                      <a:extLst>
                        <a:ext uri="{FF2B5EF4-FFF2-40B4-BE49-F238E27FC236}">
                          <a16:creationId xmlns:a16="http://schemas.microsoft.com/office/drawing/2014/main" id="{F001E5BE-10BA-462D-A37C-70C9D3D355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74785" y="1596725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3</a:t>
                      </a:r>
                    </a:p>
                  </p:txBody>
                </p:sp>
              </p:grpSp>
              <p:sp>
                <p:nvSpPr>
                  <p:cNvPr id="149" name="TextBox 148">
                    <a:extLst>
                      <a:ext uri="{FF2B5EF4-FFF2-40B4-BE49-F238E27FC236}">
                        <a16:creationId xmlns:a16="http://schemas.microsoft.com/office/drawing/2014/main" id="{54DC67F9-0600-43A0-8E83-D41C4B6AB003}"/>
                      </a:ext>
                    </a:extLst>
                  </p:cNvPr>
                  <p:cNvSpPr txBox="1"/>
                  <p:nvPr/>
                </p:nvSpPr>
                <p:spPr>
                  <a:xfrm>
                    <a:off x="3212081" y="1599355"/>
                    <a:ext cx="52610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MWM</a:t>
                    </a:r>
                  </a:p>
                </p:txBody>
              </p:sp>
            </p:grp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F4696AD0-B944-44FA-BA97-9F92559471BD}"/>
                    </a:ext>
                  </a:extLst>
                </p:cNvPr>
                <p:cNvSpPr txBox="1"/>
                <p:nvPr/>
              </p:nvSpPr>
              <p:spPr>
                <a:xfrm>
                  <a:off x="127628" y="1170388"/>
                  <a:ext cx="3064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C</a:t>
                  </a:r>
                </a:p>
              </p:txBody>
            </p:sp>
          </p:grp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050DB1FE-EAD8-4ED6-ADEF-E0C0B09FAA43}"/>
                  </a:ext>
                </a:extLst>
              </p:cNvPr>
              <p:cNvSpPr txBox="1"/>
              <p:nvPr/>
            </p:nvSpPr>
            <p:spPr>
              <a:xfrm>
                <a:off x="969831" y="987863"/>
                <a:ext cx="3584810" cy="409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1400" dirty="0"/>
                  <a:t>Gel-purified amplicons from step one (in panel A)  amplified using PE-2F x PE2R primers.</a:t>
                </a:r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6A350A25-EAFE-4530-976A-5697835BAFC6}"/>
                </a:ext>
              </a:extLst>
            </p:cNvPr>
            <p:cNvGrpSpPr/>
            <p:nvPr/>
          </p:nvGrpSpPr>
          <p:grpSpPr>
            <a:xfrm>
              <a:off x="4509704" y="1572120"/>
              <a:ext cx="4385747" cy="2356694"/>
              <a:chOff x="4509704" y="969003"/>
              <a:chExt cx="4385747" cy="2356694"/>
            </a:xfrm>
          </p:grpSpPr>
          <p:grpSp>
            <p:nvGrpSpPr>
              <p:cNvPr id="98" name="Group 97">
                <a:extLst>
                  <a:ext uri="{FF2B5EF4-FFF2-40B4-BE49-F238E27FC236}">
                    <a16:creationId xmlns:a16="http://schemas.microsoft.com/office/drawing/2014/main" id="{A4AB7515-1051-4ABE-B815-967DF64ACD9A}"/>
                  </a:ext>
                </a:extLst>
              </p:cNvPr>
              <p:cNvGrpSpPr/>
              <p:nvPr/>
            </p:nvGrpSpPr>
            <p:grpSpPr>
              <a:xfrm>
                <a:off x="4509704" y="1170390"/>
                <a:ext cx="4385747" cy="2155307"/>
                <a:chOff x="4493364" y="325442"/>
                <a:chExt cx="4385746" cy="2155306"/>
              </a:xfrm>
            </p:grpSpPr>
            <p:pic>
              <p:nvPicPr>
                <p:cNvPr id="100" name="Picture 99" descr="Second PCR soy arab bsa PEG samples II.2.tif">
                  <a:extLst>
                    <a:ext uri="{FF2B5EF4-FFF2-40B4-BE49-F238E27FC236}">
                      <a16:creationId xmlns:a16="http://schemas.microsoft.com/office/drawing/2014/main" id="{A1E9B613-C035-409E-B1E3-4E6FEBD74F57}"/>
                    </a:ext>
                  </a:extLst>
                </p:cNvPr>
                <p:cNvPicPr/>
                <p:nvPr/>
              </p:nvPicPr>
              <p:blipFill rotWithShape="1">
                <a:blip r:embed="rId5" cstate="print"/>
                <a:srcRect l="11652" t="24478" r="6443" b="19795"/>
                <a:stretch/>
              </p:blipFill>
              <p:spPr>
                <a:xfrm>
                  <a:off x="5104367" y="974996"/>
                  <a:ext cx="3774743" cy="1505752"/>
                </a:xfrm>
                <a:prstGeom prst="rect">
                  <a:avLst/>
                </a:prstGeom>
              </p:spPr>
            </p:pic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BB5A5E97-E991-4343-92A8-19504A43A92D}"/>
                    </a:ext>
                  </a:extLst>
                </p:cNvPr>
                <p:cNvGrpSpPr/>
                <p:nvPr/>
              </p:nvGrpSpPr>
              <p:grpSpPr>
                <a:xfrm>
                  <a:off x="4987382" y="433833"/>
                  <a:ext cx="1425607" cy="564212"/>
                  <a:chOff x="4987381" y="-1887339"/>
                  <a:chExt cx="1425607" cy="564212"/>
                </a:xfrm>
              </p:grpSpPr>
              <p:sp>
                <p:nvSpPr>
                  <p:cNvPr id="131" name="TextBox 130">
                    <a:extLst>
                      <a:ext uri="{FF2B5EF4-FFF2-40B4-BE49-F238E27FC236}">
                        <a16:creationId xmlns:a16="http://schemas.microsoft.com/office/drawing/2014/main" id="{0222C7D0-AA5E-44E8-A88F-38E4D5AF2AA0}"/>
                      </a:ext>
                    </a:extLst>
                  </p:cNvPr>
                  <p:cNvSpPr txBox="1"/>
                  <p:nvPr/>
                </p:nvSpPr>
                <p:spPr>
                  <a:xfrm>
                    <a:off x="4987381" y="-1571297"/>
                    <a:ext cx="52610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MWM</a:t>
                    </a:r>
                  </a:p>
                </p:txBody>
              </p:sp>
              <p:grpSp>
                <p:nvGrpSpPr>
                  <p:cNvPr id="132" name="Group 131">
                    <a:extLst>
                      <a:ext uri="{FF2B5EF4-FFF2-40B4-BE49-F238E27FC236}">
                        <a16:creationId xmlns:a16="http://schemas.microsoft.com/office/drawing/2014/main" id="{D224E5C5-A157-4969-80BF-EBE47E3FA005}"/>
                      </a:ext>
                    </a:extLst>
                  </p:cNvPr>
                  <p:cNvGrpSpPr/>
                  <p:nvPr/>
                </p:nvGrpSpPr>
                <p:grpSpPr>
                  <a:xfrm>
                    <a:off x="5300183" y="-1887339"/>
                    <a:ext cx="1112805" cy="564212"/>
                    <a:chOff x="5300183" y="-1887339"/>
                    <a:chExt cx="1112805" cy="564212"/>
                  </a:xfrm>
                </p:grpSpPr>
                <p:grpSp>
                  <p:nvGrpSpPr>
                    <p:cNvPr id="133" name="Group 132">
                      <a:extLst>
                        <a:ext uri="{FF2B5EF4-FFF2-40B4-BE49-F238E27FC236}">
                          <a16:creationId xmlns:a16="http://schemas.microsoft.com/office/drawing/2014/main" id="{E287FFEE-ABAF-4688-A1D3-863D1E2A1B6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00183" y="-1887339"/>
                      <a:ext cx="1112805" cy="246221"/>
                      <a:chOff x="5477079" y="-475231"/>
                      <a:chExt cx="1112805" cy="246221"/>
                    </a:xfrm>
                  </p:grpSpPr>
                  <p:sp>
                    <p:nvSpPr>
                      <p:cNvPr id="138" name="TextBox 137">
                        <a:extLst>
                          <a:ext uri="{FF2B5EF4-FFF2-40B4-BE49-F238E27FC236}">
                            <a16:creationId xmlns:a16="http://schemas.microsoft.com/office/drawing/2014/main" id="{7435DC1A-A6B9-4DB4-8B14-0E3DBCE0B98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77079" y="-475231"/>
                        <a:ext cx="11128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/>
                          <a:t>Glyma04g009900</a:t>
                        </a:r>
                      </a:p>
                    </p:txBody>
                  </p:sp>
                  <p:cxnSp>
                    <p:nvCxnSpPr>
                      <p:cNvPr id="139" name="Straight Connector 138">
                        <a:extLst>
                          <a:ext uri="{FF2B5EF4-FFF2-40B4-BE49-F238E27FC236}">
                            <a16:creationId xmlns:a16="http://schemas.microsoft.com/office/drawing/2014/main" id="{A5723D14-5015-4EB3-B734-700EB184C7B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703220" y="-247474"/>
                        <a:ext cx="73152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34" name="TextBox 133">
                      <a:extLst>
                        <a:ext uri="{FF2B5EF4-FFF2-40B4-BE49-F238E27FC236}">
                          <a16:creationId xmlns:a16="http://schemas.microsoft.com/office/drawing/2014/main" id="{038FEA04-0E21-4DDD-A5BC-B0B3C7EB19F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36286" y="-1687762"/>
                      <a:ext cx="67839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Replicate</a:t>
                      </a:r>
                    </a:p>
                  </p:txBody>
                </p:sp>
                <p:sp>
                  <p:nvSpPr>
                    <p:cNvPr id="135" name="TextBox 134">
                      <a:extLst>
                        <a:ext uri="{FF2B5EF4-FFF2-40B4-BE49-F238E27FC236}">
                          <a16:creationId xmlns:a16="http://schemas.microsoft.com/office/drawing/2014/main" id="{685D11D0-1F3E-4A09-89F8-668E8DF0414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68317" y="-1570740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1</a:t>
                      </a:r>
                    </a:p>
                  </p:txBody>
                </p:sp>
                <p:sp>
                  <p:nvSpPr>
                    <p:cNvPr id="136" name="TextBox 135">
                      <a:extLst>
                        <a:ext uri="{FF2B5EF4-FFF2-40B4-BE49-F238E27FC236}">
                          <a16:creationId xmlns:a16="http://schemas.microsoft.com/office/drawing/2014/main" id="{D220E39D-8C38-4503-A8DF-98D72BBAF4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75665" y="-1569348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2</a:t>
                      </a:r>
                    </a:p>
                  </p:txBody>
                </p:sp>
                <p:sp>
                  <p:nvSpPr>
                    <p:cNvPr id="137" name="TextBox 136">
                      <a:extLst>
                        <a:ext uri="{FF2B5EF4-FFF2-40B4-BE49-F238E27FC236}">
                          <a16:creationId xmlns:a16="http://schemas.microsoft.com/office/drawing/2014/main" id="{ECF89510-47E0-4DD8-BF69-12E0DCA264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81708" y="-1569348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3</a:t>
                      </a:r>
                    </a:p>
                  </p:txBody>
                </p:sp>
              </p:grpSp>
            </p:grp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1AA8E091-567C-4846-BE6A-66942B161665}"/>
                    </a:ext>
                  </a:extLst>
                </p:cNvPr>
                <p:cNvGrpSpPr/>
                <p:nvPr/>
              </p:nvGrpSpPr>
              <p:grpSpPr>
                <a:xfrm>
                  <a:off x="6654861" y="434234"/>
                  <a:ext cx="901209" cy="562284"/>
                  <a:chOff x="6654860" y="-1886938"/>
                  <a:chExt cx="901209" cy="562284"/>
                </a:xfrm>
              </p:grpSpPr>
              <p:grpSp>
                <p:nvGrpSpPr>
                  <p:cNvPr id="124" name="Group 123">
                    <a:extLst>
                      <a:ext uri="{FF2B5EF4-FFF2-40B4-BE49-F238E27FC236}">
                        <a16:creationId xmlns:a16="http://schemas.microsoft.com/office/drawing/2014/main" id="{EBF84BD5-5373-480E-8D4C-CBCE9DEDE48C}"/>
                      </a:ext>
                    </a:extLst>
                  </p:cNvPr>
                  <p:cNvGrpSpPr/>
                  <p:nvPr/>
                </p:nvGrpSpPr>
                <p:grpSpPr>
                  <a:xfrm>
                    <a:off x="6654860" y="-1886938"/>
                    <a:ext cx="901209" cy="246221"/>
                    <a:chOff x="5375944" y="-475231"/>
                    <a:chExt cx="901209" cy="246221"/>
                  </a:xfrm>
                </p:grpSpPr>
                <p:sp>
                  <p:nvSpPr>
                    <p:cNvPr id="129" name="TextBox 128">
                      <a:extLst>
                        <a:ext uri="{FF2B5EF4-FFF2-40B4-BE49-F238E27FC236}">
                          <a16:creationId xmlns:a16="http://schemas.microsoft.com/office/drawing/2014/main" id="{8FE75F20-24AF-4B40-B155-6C96197D70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5944" y="-475231"/>
                      <a:ext cx="90120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AT2G21490.1</a:t>
                      </a:r>
                    </a:p>
                  </p:txBody>
                </p:sp>
                <p:cxnSp>
                  <p:nvCxnSpPr>
                    <p:cNvPr id="130" name="Straight Connector 129">
                      <a:extLst>
                        <a:ext uri="{FF2B5EF4-FFF2-40B4-BE49-F238E27FC236}">
                          <a16:creationId xmlns:a16="http://schemas.microsoft.com/office/drawing/2014/main" id="{F1D9283B-6486-425E-809A-1BCC69018E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454161" y="-247474"/>
                      <a:ext cx="73152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5" name="TextBox 124">
                    <a:extLst>
                      <a:ext uri="{FF2B5EF4-FFF2-40B4-BE49-F238E27FC236}">
                        <a16:creationId xmlns:a16="http://schemas.microsoft.com/office/drawing/2014/main" id="{2417CCAF-605D-47D4-9499-93FC733AF332}"/>
                      </a:ext>
                    </a:extLst>
                  </p:cNvPr>
                  <p:cNvSpPr txBox="1"/>
                  <p:nvPr/>
                </p:nvSpPr>
                <p:spPr>
                  <a:xfrm>
                    <a:off x="6753277" y="-1686226"/>
                    <a:ext cx="67839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Replicate</a:t>
                    </a:r>
                  </a:p>
                </p:txBody>
              </p:sp>
              <p:sp>
                <p:nvSpPr>
                  <p:cNvPr id="126" name="TextBox 125">
                    <a:extLst>
                      <a:ext uri="{FF2B5EF4-FFF2-40B4-BE49-F238E27FC236}">
                        <a16:creationId xmlns:a16="http://schemas.microsoft.com/office/drawing/2014/main" id="{1751D9D8-E0A2-45C5-A299-A153A30CB6AE}"/>
                      </a:ext>
                    </a:extLst>
                  </p:cNvPr>
                  <p:cNvSpPr txBox="1"/>
                  <p:nvPr/>
                </p:nvSpPr>
                <p:spPr>
                  <a:xfrm>
                    <a:off x="6681806" y="-1572883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1</a:t>
                    </a:r>
                  </a:p>
                </p:txBody>
              </p:sp>
              <p:sp>
                <p:nvSpPr>
                  <p:cNvPr id="127" name="TextBox 126">
                    <a:extLst>
                      <a:ext uri="{FF2B5EF4-FFF2-40B4-BE49-F238E27FC236}">
                        <a16:creationId xmlns:a16="http://schemas.microsoft.com/office/drawing/2014/main" id="{35D8845B-36C5-48F4-852B-DDE285CC741A}"/>
                      </a:ext>
                    </a:extLst>
                  </p:cNvPr>
                  <p:cNvSpPr txBox="1"/>
                  <p:nvPr/>
                </p:nvSpPr>
                <p:spPr>
                  <a:xfrm>
                    <a:off x="6992197" y="-1570875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2</a:t>
                    </a:r>
                  </a:p>
                </p:txBody>
              </p:sp>
              <p:sp>
                <p:nvSpPr>
                  <p:cNvPr id="128" name="TextBox 127">
                    <a:extLst>
                      <a:ext uri="{FF2B5EF4-FFF2-40B4-BE49-F238E27FC236}">
                        <a16:creationId xmlns:a16="http://schemas.microsoft.com/office/drawing/2014/main" id="{6F0EA235-74D4-4A47-B7A5-1528C31EA9DB}"/>
                      </a:ext>
                    </a:extLst>
                  </p:cNvPr>
                  <p:cNvSpPr txBox="1"/>
                  <p:nvPr/>
                </p:nvSpPr>
                <p:spPr>
                  <a:xfrm>
                    <a:off x="7287827" y="-1570877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3</a:t>
                    </a:r>
                  </a:p>
                </p:txBody>
              </p:sp>
            </p:grpSp>
            <p:grpSp>
              <p:nvGrpSpPr>
                <p:cNvPr id="103" name="Group 102">
                  <a:extLst>
                    <a:ext uri="{FF2B5EF4-FFF2-40B4-BE49-F238E27FC236}">
                      <a16:creationId xmlns:a16="http://schemas.microsoft.com/office/drawing/2014/main" id="{156610FB-4A7B-4340-9B75-16336DB64A7E}"/>
                    </a:ext>
                  </a:extLst>
                </p:cNvPr>
                <p:cNvGrpSpPr/>
                <p:nvPr/>
              </p:nvGrpSpPr>
              <p:grpSpPr>
                <a:xfrm>
                  <a:off x="7909108" y="436261"/>
                  <a:ext cx="882330" cy="562546"/>
                  <a:chOff x="8004969" y="-1884911"/>
                  <a:chExt cx="882330" cy="562546"/>
                </a:xfrm>
              </p:grpSpPr>
              <p:sp>
                <p:nvSpPr>
                  <p:cNvPr id="118" name="TextBox 117">
                    <a:extLst>
                      <a:ext uri="{FF2B5EF4-FFF2-40B4-BE49-F238E27FC236}">
                        <a16:creationId xmlns:a16="http://schemas.microsoft.com/office/drawing/2014/main" id="{9E55BF9C-1F67-4269-A1A3-75BBDAD2896C}"/>
                      </a:ext>
                    </a:extLst>
                  </p:cNvPr>
                  <p:cNvSpPr txBox="1"/>
                  <p:nvPr/>
                </p:nvSpPr>
                <p:spPr>
                  <a:xfrm>
                    <a:off x="8251568" y="-1884911"/>
                    <a:ext cx="39466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BSA</a:t>
                    </a:r>
                  </a:p>
                </p:txBody>
              </p:sp>
              <p:cxnSp>
                <p:nvCxnSpPr>
                  <p:cNvPr id="119" name="Straight Connector 118">
                    <a:extLst>
                      <a:ext uri="{FF2B5EF4-FFF2-40B4-BE49-F238E27FC236}">
                        <a16:creationId xmlns:a16="http://schemas.microsoft.com/office/drawing/2014/main" id="{A04A77A6-58D0-46B3-A911-2AFC815E7F90}"/>
                      </a:ext>
                    </a:extLst>
                  </p:cNvPr>
                  <p:cNvCxnSpPr/>
                  <p:nvPr/>
                </p:nvCxnSpPr>
                <p:spPr>
                  <a:xfrm>
                    <a:off x="8083709" y="-1668384"/>
                    <a:ext cx="73152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0" name="TextBox 119">
                    <a:extLst>
                      <a:ext uri="{FF2B5EF4-FFF2-40B4-BE49-F238E27FC236}">
                        <a16:creationId xmlns:a16="http://schemas.microsoft.com/office/drawing/2014/main" id="{967A85D5-223A-4E34-9105-ED04E02C3FB7}"/>
                      </a:ext>
                    </a:extLst>
                  </p:cNvPr>
                  <p:cNvSpPr txBox="1"/>
                  <p:nvPr/>
                </p:nvSpPr>
                <p:spPr>
                  <a:xfrm>
                    <a:off x="8097860" y="-1688366"/>
                    <a:ext cx="67839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Replicate</a:t>
                    </a:r>
                  </a:p>
                </p:txBody>
              </p:sp>
              <p:sp>
                <p:nvSpPr>
                  <p:cNvPr id="121" name="TextBox 120">
                    <a:extLst>
                      <a:ext uri="{FF2B5EF4-FFF2-40B4-BE49-F238E27FC236}">
                        <a16:creationId xmlns:a16="http://schemas.microsoft.com/office/drawing/2014/main" id="{CCF35072-4B2A-4AAE-9E6D-30C367C57776}"/>
                      </a:ext>
                    </a:extLst>
                  </p:cNvPr>
                  <p:cNvSpPr txBox="1"/>
                  <p:nvPr/>
                </p:nvSpPr>
                <p:spPr>
                  <a:xfrm>
                    <a:off x="8004969" y="-1568586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1</a:t>
                    </a:r>
                  </a:p>
                </p:txBody>
              </p:sp>
              <p:sp>
                <p:nvSpPr>
                  <p:cNvPr id="122" name="TextBox 121">
                    <a:extLst>
                      <a:ext uri="{FF2B5EF4-FFF2-40B4-BE49-F238E27FC236}">
                        <a16:creationId xmlns:a16="http://schemas.microsoft.com/office/drawing/2014/main" id="{F0683EAA-28B3-4655-83CE-89A598BDCC54}"/>
                      </a:ext>
                    </a:extLst>
                  </p:cNvPr>
                  <p:cNvSpPr txBox="1"/>
                  <p:nvPr/>
                </p:nvSpPr>
                <p:spPr>
                  <a:xfrm>
                    <a:off x="8334423" y="-1573016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2</a:t>
                    </a:r>
                  </a:p>
                </p:txBody>
              </p:sp>
              <p:sp>
                <p:nvSpPr>
                  <p:cNvPr id="123" name="TextBox 122">
                    <a:extLst>
                      <a:ext uri="{FF2B5EF4-FFF2-40B4-BE49-F238E27FC236}">
                        <a16:creationId xmlns:a16="http://schemas.microsoft.com/office/drawing/2014/main" id="{87ABC2F3-3A47-4C71-B0C5-03D4577ACE3A}"/>
                      </a:ext>
                    </a:extLst>
                  </p:cNvPr>
                  <p:cNvSpPr txBox="1"/>
                  <p:nvPr/>
                </p:nvSpPr>
                <p:spPr>
                  <a:xfrm>
                    <a:off x="8636909" y="-1570104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3</a:t>
                    </a:r>
                  </a:p>
                </p:txBody>
              </p:sp>
            </p:grpSp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9DE94B00-61C3-4344-B657-90E7629878A8}"/>
                    </a:ext>
                  </a:extLst>
                </p:cNvPr>
                <p:cNvGrpSpPr/>
                <p:nvPr/>
              </p:nvGrpSpPr>
              <p:grpSpPr>
                <a:xfrm>
                  <a:off x="4493364" y="1361455"/>
                  <a:ext cx="701700" cy="970520"/>
                  <a:chOff x="5332245" y="68801"/>
                  <a:chExt cx="701700" cy="970520"/>
                </a:xfrm>
              </p:grpSpPr>
              <p:cxnSp>
                <p:nvCxnSpPr>
                  <p:cNvPr id="106" name="Straight Connector 105">
                    <a:extLst>
                      <a:ext uri="{FF2B5EF4-FFF2-40B4-BE49-F238E27FC236}">
                        <a16:creationId xmlns:a16="http://schemas.microsoft.com/office/drawing/2014/main" id="{915DE0F9-1009-4126-A92E-0483DF3C78C6}"/>
                      </a:ext>
                    </a:extLst>
                  </p:cNvPr>
                  <p:cNvCxnSpPr/>
                  <p:nvPr/>
                </p:nvCxnSpPr>
                <p:spPr>
                  <a:xfrm>
                    <a:off x="5774215" y="485441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Straight Connector 106">
                    <a:extLst>
                      <a:ext uri="{FF2B5EF4-FFF2-40B4-BE49-F238E27FC236}">
                        <a16:creationId xmlns:a16="http://schemas.microsoft.com/office/drawing/2014/main" id="{18E72307-C903-46B5-BA2F-A4E072AD7307}"/>
                      </a:ext>
                    </a:extLst>
                  </p:cNvPr>
                  <p:cNvCxnSpPr/>
                  <p:nvPr/>
                </p:nvCxnSpPr>
                <p:spPr>
                  <a:xfrm>
                    <a:off x="5775296" y="208384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Straight Connector 107">
                    <a:extLst>
                      <a:ext uri="{FF2B5EF4-FFF2-40B4-BE49-F238E27FC236}">
                        <a16:creationId xmlns:a16="http://schemas.microsoft.com/office/drawing/2014/main" id="{798B7E95-0338-4F94-AA72-5FB3766E1542}"/>
                      </a:ext>
                    </a:extLst>
                  </p:cNvPr>
                  <p:cNvCxnSpPr/>
                  <p:nvPr/>
                </p:nvCxnSpPr>
                <p:spPr>
                  <a:xfrm>
                    <a:off x="5782807" y="327653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Straight Connector 108">
                    <a:extLst>
                      <a:ext uri="{FF2B5EF4-FFF2-40B4-BE49-F238E27FC236}">
                        <a16:creationId xmlns:a16="http://schemas.microsoft.com/office/drawing/2014/main" id="{E1CE8719-0BC8-4344-BFD9-C73CFC6E6861}"/>
                      </a:ext>
                    </a:extLst>
                  </p:cNvPr>
                  <p:cNvCxnSpPr/>
                  <p:nvPr/>
                </p:nvCxnSpPr>
                <p:spPr>
                  <a:xfrm>
                    <a:off x="5765633" y="618721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Straight Connector 109">
                    <a:extLst>
                      <a:ext uri="{FF2B5EF4-FFF2-40B4-BE49-F238E27FC236}">
                        <a16:creationId xmlns:a16="http://schemas.microsoft.com/office/drawing/2014/main" id="{C8E14B9C-9CFC-4D07-829A-656619826972}"/>
                      </a:ext>
                    </a:extLst>
                  </p:cNvPr>
                  <p:cNvCxnSpPr/>
                  <p:nvPr/>
                </p:nvCxnSpPr>
                <p:spPr>
                  <a:xfrm>
                    <a:off x="5776369" y="741935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Straight Connector 110">
                    <a:extLst>
                      <a:ext uri="{FF2B5EF4-FFF2-40B4-BE49-F238E27FC236}">
                        <a16:creationId xmlns:a16="http://schemas.microsoft.com/office/drawing/2014/main" id="{5232A196-0BAD-4510-971D-507FC59374FF}"/>
                      </a:ext>
                    </a:extLst>
                  </p:cNvPr>
                  <p:cNvCxnSpPr/>
                  <p:nvPr/>
                </p:nvCxnSpPr>
                <p:spPr>
                  <a:xfrm>
                    <a:off x="5774227" y="891593"/>
                    <a:ext cx="2511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2" name="TextBox 111">
                    <a:extLst>
                      <a:ext uri="{FF2B5EF4-FFF2-40B4-BE49-F238E27FC236}">
                        <a16:creationId xmlns:a16="http://schemas.microsoft.com/office/drawing/2014/main" id="{EE3C23B9-AB81-4513-A5F1-017D0C37934D}"/>
                      </a:ext>
                    </a:extLst>
                  </p:cNvPr>
                  <p:cNvSpPr txBox="1"/>
                  <p:nvPr/>
                </p:nvSpPr>
                <p:spPr>
                  <a:xfrm>
                    <a:off x="5334396" y="68801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2000</a:t>
                    </a:r>
                  </a:p>
                </p:txBody>
              </p: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16E9D5EB-AC50-466F-977A-273FF67995CE}"/>
                      </a:ext>
                    </a:extLst>
                  </p:cNvPr>
                  <p:cNvSpPr txBox="1"/>
                  <p:nvPr/>
                </p:nvSpPr>
                <p:spPr>
                  <a:xfrm>
                    <a:off x="5334396" y="196355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500</a:t>
                    </a:r>
                  </a:p>
                </p:txBody>
              </p: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94F28847-7C4A-40CF-A818-091E50610412}"/>
                      </a:ext>
                    </a:extLst>
                  </p:cNvPr>
                  <p:cNvSpPr txBox="1"/>
                  <p:nvPr/>
                </p:nvSpPr>
                <p:spPr>
                  <a:xfrm>
                    <a:off x="5332245" y="358050"/>
                    <a:ext cx="49885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1000</a:t>
                    </a: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57124026-AA60-4672-9CF6-1D9F084117CF}"/>
                      </a:ext>
                    </a:extLst>
                  </p:cNvPr>
                  <p:cNvSpPr txBox="1"/>
                  <p:nvPr/>
                </p:nvSpPr>
                <p:spPr>
                  <a:xfrm>
                    <a:off x="5409513" y="498970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700</a:t>
                    </a:r>
                  </a:p>
                </p:txBody>
              </p:sp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F5273F7B-4D1C-4794-844E-3B05EAB34FB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806" y="609050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500</a:t>
                    </a:r>
                  </a:p>
                </p:txBody>
              </p:sp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D8CAC9C1-01CD-4BCE-B80F-5ECB3262AF51}"/>
                      </a:ext>
                    </a:extLst>
                  </p:cNvPr>
                  <p:cNvSpPr txBox="1"/>
                  <p:nvPr/>
                </p:nvSpPr>
                <p:spPr>
                  <a:xfrm>
                    <a:off x="5417240" y="762322"/>
                    <a:ext cx="42030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/>
                      <a:t>300</a:t>
                    </a:r>
                  </a:p>
                </p:txBody>
              </p:sp>
            </p:grp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359344FD-0B2B-49A7-8ADB-9AF03C0DA0D0}"/>
                    </a:ext>
                  </a:extLst>
                </p:cNvPr>
                <p:cNvSpPr txBox="1"/>
                <p:nvPr/>
              </p:nvSpPr>
              <p:spPr>
                <a:xfrm>
                  <a:off x="4880169" y="325442"/>
                  <a:ext cx="33054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D</a:t>
                  </a:r>
                </a:p>
              </p:txBody>
            </p:sp>
          </p:grp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BE6C8702-EE65-4D9D-8AA3-A931AC84DD32}"/>
                  </a:ext>
                </a:extLst>
              </p:cNvPr>
              <p:cNvSpPr txBox="1"/>
              <p:nvPr/>
            </p:nvSpPr>
            <p:spPr>
              <a:xfrm>
                <a:off x="5301657" y="969003"/>
                <a:ext cx="3593793" cy="4090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1400" dirty="0"/>
                  <a:t>Gel-purified amplicons from step one (in panel B) amplified using PE-2F x PE2R primers.</a:t>
                </a:r>
              </a:p>
            </p:txBody>
          </p:sp>
        </p:grpSp>
      </p:grpSp>
      <p:sp>
        <p:nvSpPr>
          <p:cNvPr id="199" name="TextBox 198">
            <a:extLst>
              <a:ext uri="{FF2B5EF4-FFF2-40B4-BE49-F238E27FC236}">
                <a16:creationId xmlns:a16="http://schemas.microsoft.com/office/drawing/2014/main" id="{5F2C347B-8624-4456-BF57-142C30AF74B0}"/>
              </a:ext>
            </a:extLst>
          </p:cNvPr>
          <p:cNvSpPr txBox="1"/>
          <p:nvPr/>
        </p:nvSpPr>
        <p:spPr>
          <a:xfrm>
            <a:off x="5322143" y="1121656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Glyma04g009900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8A54CF16-F076-4F39-A46F-422B08413187}"/>
              </a:ext>
            </a:extLst>
          </p:cNvPr>
          <p:cNvSpPr txBox="1"/>
          <p:nvPr/>
        </p:nvSpPr>
        <p:spPr>
          <a:xfrm>
            <a:off x="6367440" y="1122057"/>
            <a:ext cx="9012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T2G21490.1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DD0FECB4-FC62-4C38-8AA0-B243D84D69A7}"/>
              </a:ext>
            </a:extLst>
          </p:cNvPr>
          <p:cNvSpPr txBox="1"/>
          <p:nvPr/>
        </p:nvSpPr>
        <p:spPr>
          <a:xfrm>
            <a:off x="7504573" y="1124084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BSA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A0C4E0DE-DB2D-4AAE-A193-DA8D180DCDC6}"/>
              </a:ext>
            </a:extLst>
          </p:cNvPr>
          <p:cNvSpPr txBox="1"/>
          <p:nvPr/>
        </p:nvSpPr>
        <p:spPr>
          <a:xfrm>
            <a:off x="5506674" y="1331108"/>
            <a:ext cx="7296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Replicate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725832A7-BDC3-4FDA-8BFE-389CB8357B2B}"/>
              </a:ext>
            </a:extLst>
          </p:cNvPr>
          <p:cNvSpPr txBox="1"/>
          <p:nvPr/>
        </p:nvSpPr>
        <p:spPr>
          <a:xfrm>
            <a:off x="6435295" y="1336456"/>
            <a:ext cx="7296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Replicate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7B3026A4-AB1A-42D1-BF63-032A2D22195C}"/>
              </a:ext>
            </a:extLst>
          </p:cNvPr>
          <p:cNvSpPr txBox="1"/>
          <p:nvPr/>
        </p:nvSpPr>
        <p:spPr>
          <a:xfrm>
            <a:off x="7346315" y="1334309"/>
            <a:ext cx="7296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Replicate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D5991735-D9FD-4E3A-9F4E-C5B2048A1A8C}"/>
              </a:ext>
            </a:extLst>
          </p:cNvPr>
          <p:cNvSpPr txBox="1"/>
          <p:nvPr/>
        </p:nvSpPr>
        <p:spPr>
          <a:xfrm>
            <a:off x="4958132" y="1488354"/>
            <a:ext cx="5597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WM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C5DC00E7-FCE7-4472-810D-25FAF3CE0FD1}"/>
              </a:ext>
            </a:extLst>
          </p:cNvPr>
          <p:cNvSpPr txBox="1"/>
          <p:nvPr/>
        </p:nvSpPr>
        <p:spPr>
          <a:xfrm>
            <a:off x="5440605" y="148193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1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111C8375-3057-42CE-AB74-0D7124F1156E}"/>
              </a:ext>
            </a:extLst>
          </p:cNvPr>
          <p:cNvSpPr txBox="1"/>
          <p:nvPr/>
        </p:nvSpPr>
        <p:spPr>
          <a:xfrm>
            <a:off x="5748259" y="1477503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2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68A7E09A-3748-404B-B35A-635152762940}"/>
              </a:ext>
            </a:extLst>
          </p:cNvPr>
          <p:cNvSpPr txBox="1"/>
          <p:nvPr/>
        </p:nvSpPr>
        <p:spPr>
          <a:xfrm>
            <a:off x="6054160" y="1477503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3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77BA2289-4994-473B-B85D-11A8E1C1BB2B}"/>
              </a:ext>
            </a:extLst>
          </p:cNvPr>
          <p:cNvSpPr txBox="1"/>
          <p:nvPr/>
        </p:nvSpPr>
        <p:spPr>
          <a:xfrm>
            <a:off x="6362606" y="1479791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1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9329A3A5-06B0-4A68-86BD-85ADE5C4EDD6}"/>
              </a:ext>
            </a:extLst>
          </p:cNvPr>
          <p:cNvSpPr txBox="1"/>
          <p:nvPr/>
        </p:nvSpPr>
        <p:spPr>
          <a:xfrm>
            <a:off x="6657201" y="1481799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2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05B37FF1-B806-41E9-BE39-B4700197B1E9}"/>
              </a:ext>
            </a:extLst>
          </p:cNvPr>
          <p:cNvSpPr txBox="1"/>
          <p:nvPr/>
        </p:nvSpPr>
        <p:spPr>
          <a:xfrm>
            <a:off x="6959842" y="1481799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3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A968C15D-9632-4273-A909-7142BB4F9AFF}"/>
              </a:ext>
            </a:extLst>
          </p:cNvPr>
          <p:cNvSpPr txBox="1"/>
          <p:nvPr/>
        </p:nvSpPr>
        <p:spPr>
          <a:xfrm>
            <a:off x="7258845" y="1484090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1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EBF9A87E-9C61-40C1-8D5B-41B746466BCE}"/>
              </a:ext>
            </a:extLst>
          </p:cNvPr>
          <p:cNvSpPr txBox="1"/>
          <p:nvPr/>
        </p:nvSpPr>
        <p:spPr>
          <a:xfrm>
            <a:off x="7566319" y="1479658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2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72DC93EE-321B-462B-99E3-96E24F9C7C57}"/>
              </a:ext>
            </a:extLst>
          </p:cNvPr>
          <p:cNvSpPr txBox="1"/>
          <p:nvPr/>
        </p:nvSpPr>
        <p:spPr>
          <a:xfrm>
            <a:off x="7865694" y="1479658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3</a:t>
            </a:r>
          </a:p>
        </p:txBody>
      </p: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33243367-A1C3-431F-9368-F922BCEC1EF8}"/>
              </a:ext>
            </a:extLst>
          </p:cNvPr>
          <p:cNvCxnSpPr/>
          <p:nvPr/>
        </p:nvCxnSpPr>
        <p:spPr>
          <a:xfrm>
            <a:off x="5504841" y="1341145"/>
            <a:ext cx="7315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A1CC2C53-BF66-4EEC-BEFC-54DF1CADC4AF}"/>
              </a:ext>
            </a:extLst>
          </p:cNvPr>
          <p:cNvCxnSpPr/>
          <p:nvPr/>
        </p:nvCxnSpPr>
        <p:spPr>
          <a:xfrm>
            <a:off x="6433462" y="1341145"/>
            <a:ext cx="7315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E9A0914D-9157-4F2D-9011-00208C7093D7}"/>
              </a:ext>
            </a:extLst>
          </p:cNvPr>
          <p:cNvCxnSpPr/>
          <p:nvPr/>
        </p:nvCxnSpPr>
        <p:spPr>
          <a:xfrm>
            <a:off x="7332299" y="1338519"/>
            <a:ext cx="7315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649772B9-40B9-4D31-98C3-6176C6FC52A8}"/>
              </a:ext>
            </a:extLst>
          </p:cNvPr>
          <p:cNvSpPr txBox="1"/>
          <p:nvPr/>
        </p:nvSpPr>
        <p:spPr>
          <a:xfrm>
            <a:off x="3298898" y="3748489"/>
            <a:ext cx="2786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ep two limited PCR round</a:t>
            </a:r>
          </a:p>
        </p:txBody>
      </p:sp>
    </p:spTree>
    <p:extLst>
      <p:ext uri="{BB962C8B-B14F-4D97-AF65-F5344CB8AC3E}">
        <p14:creationId xmlns:p14="http://schemas.microsoft.com/office/powerpoint/2010/main" val="27379048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3969A7F-28EC-42A0-AF8D-2792B7610A5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97" y="3175302"/>
            <a:ext cx="8540496" cy="246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A9D226F-B69C-44C7-8C20-D38D58A3E76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113" y="3044332"/>
            <a:ext cx="8540496" cy="24638"/>
          </a:xfrm>
          <a:prstGeom prst="rect">
            <a:avLst/>
          </a:prstGeom>
        </p:spPr>
      </p:pic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DF1722EA-438D-4C45-A2EA-8B49CE3195E8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93" t="11014" r="4975" b="11902"/>
          <a:stretch/>
        </p:blipFill>
        <p:spPr>
          <a:xfrm>
            <a:off x="401145" y="655982"/>
            <a:ext cx="8651523" cy="3524250"/>
          </a:xfrm>
          <a:prstGeom prst="rect">
            <a:avLst/>
          </a:prstGeom>
        </p:spPr>
      </p:pic>
      <p:sp>
        <p:nvSpPr>
          <p:cNvPr id="231" name="TextBox 230">
            <a:extLst>
              <a:ext uri="{FF2B5EF4-FFF2-40B4-BE49-F238E27FC236}">
                <a16:creationId xmlns:a16="http://schemas.microsoft.com/office/drawing/2014/main" id="{260D0E5C-706F-4FF0-8746-20D3F475925B}"/>
              </a:ext>
            </a:extLst>
          </p:cNvPr>
          <p:cNvSpPr txBox="1"/>
          <p:nvPr/>
        </p:nvSpPr>
        <p:spPr>
          <a:xfrm>
            <a:off x="-77911" y="254461"/>
            <a:ext cx="6123599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AT1G70320: UBIQUITIN-PROTEIN LIGASE 2; 3658 amino acids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27375DE-0BE7-4A29-95B2-4C4D7BB29E39}"/>
              </a:ext>
            </a:extLst>
          </p:cNvPr>
          <p:cNvSpPr txBox="1"/>
          <p:nvPr/>
        </p:nvSpPr>
        <p:spPr>
          <a:xfrm>
            <a:off x="198052" y="1218841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2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317B04D6-7657-4F34-A595-3B510AB1F16E}"/>
              </a:ext>
            </a:extLst>
          </p:cNvPr>
          <p:cNvSpPr txBox="1"/>
          <p:nvPr/>
        </p:nvSpPr>
        <p:spPr>
          <a:xfrm>
            <a:off x="121431" y="1576777"/>
            <a:ext cx="464229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1.5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7B31341E-CBBB-447D-9D2C-7CA4E3703C10}"/>
              </a:ext>
            </a:extLst>
          </p:cNvPr>
          <p:cNvSpPr txBox="1"/>
          <p:nvPr/>
        </p:nvSpPr>
        <p:spPr>
          <a:xfrm>
            <a:off x="193133" y="1893711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1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6CC67E57-6938-4197-BB82-D9A3C121FD62}"/>
              </a:ext>
            </a:extLst>
          </p:cNvPr>
          <p:cNvSpPr txBox="1"/>
          <p:nvPr/>
        </p:nvSpPr>
        <p:spPr>
          <a:xfrm>
            <a:off x="122191" y="2258908"/>
            <a:ext cx="464229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0.5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FF7D61E6-87CC-40F2-AF3D-4E5BB6EAE4FA}"/>
              </a:ext>
            </a:extLst>
          </p:cNvPr>
          <p:cNvSpPr txBox="1"/>
          <p:nvPr/>
        </p:nvSpPr>
        <p:spPr>
          <a:xfrm>
            <a:off x="191226" y="2597944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0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68698889-D2C5-4ADB-A8BC-34D556B8C496}"/>
              </a:ext>
            </a:extLst>
          </p:cNvPr>
          <p:cNvSpPr txBox="1"/>
          <p:nvPr/>
        </p:nvSpPr>
        <p:spPr>
          <a:xfrm>
            <a:off x="70199" y="2941019"/>
            <a:ext cx="515525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0.5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B40C9032-1B63-49DC-9778-7A48C6A8F367}"/>
              </a:ext>
            </a:extLst>
          </p:cNvPr>
          <p:cNvSpPr txBox="1"/>
          <p:nvPr/>
        </p:nvSpPr>
        <p:spPr>
          <a:xfrm>
            <a:off x="138912" y="3299221"/>
            <a:ext cx="385149" cy="297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1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D85A3D30-7297-4021-BD7F-87209A81379C}"/>
              </a:ext>
            </a:extLst>
          </p:cNvPr>
          <p:cNvSpPr txBox="1"/>
          <p:nvPr/>
        </p:nvSpPr>
        <p:spPr>
          <a:xfrm>
            <a:off x="119146" y="881683"/>
            <a:ext cx="515525" cy="297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2.5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13536D16-058C-4DC2-A0CC-E831C536FE61}"/>
              </a:ext>
            </a:extLst>
          </p:cNvPr>
          <p:cNvSpPr txBox="1"/>
          <p:nvPr/>
        </p:nvSpPr>
        <p:spPr>
          <a:xfrm>
            <a:off x="324876" y="4093139"/>
            <a:ext cx="27122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0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8C282AB0-EDE9-4B3F-9317-1F532881BC30}"/>
              </a:ext>
            </a:extLst>
          </p:cNvPr>
          <p:cNvSpPr txBox="1"/>
          <p:nvPr/>
        </p:nvSpPr>
        <p:spPr>
          <a:xfrm>
            <a:off x="1401516" y="4096005"/>
            <a:ext cx="44435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500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AC9CD7D3-0E94-4D74-83EF-2F5827E3B4C4}"/>
              </a:ext>
            </a:extLst>
          </p:cNvPr>
          <p:cNvSpPr txBox="1"/>
          <p:nvPr/>
        </p:nvSpPr>
        <p:spPr>
          <a:xfrm rot="16200000">
            <a:off x="-776254" y="2109838"/>
            <a:ext cx="1833323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33"/>
              </a:lnSpc>
            </a:pPr>
            <a:r>
              <a:rPr lang="en-US" sz="1600" dirty="0"/>
              <a:t>Hydrophilicity index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531F24F5-A0B8-4CB4-88B6-92334840F476}"/>
              </a:ext>
            </a:extLst>
          </p:cNvPr>
          <p:cNvSpPr txBox="1"/>
          <p:nvPr/>
        </p:nvSpPr>
        <p:spPr>
          <a:xfrm>
            <a:off x="3518778" y="4315126"/>
            <a:ext cx="2524474" cy="338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rotein length (amino acids)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AB9FBE55-EBF6-4176-AC07-3C19B00016DD}"/>
              </a:ext>
            </a:extLst>
          </p:cNvPr>
          <p:cNvSpPr txBox="1"/>
          <p:nvPr/>
        </p:nvSpPr>
        <p:spPr>
          <a:xfrm>
            <a:off x="23857" y="5680121"/>
            <a:ext cx="512833" cy="205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60960" tIns="0" rIns="60960" bIns="0" rtlCol="0">
            <a:spAutoFit/>
          </a:bodyPr>
          <a:lstStyle/>
          <a:p>
            <a:r>
              <a:rPr lang="en-US" sz="1333" dirty="0">
                <a:solidFill>
                  <a:schemeClr val="accent6">
                    <a:lumMod val="75000"/>
                  </a:schemeClr>
                </a:solidFill>
              </a:rPr>
              <a:t>Rep 2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93FB5C87-2E0F-407F-A1E0-B5FFFA709DCF}"/>
              </a:ext>
            </a:extLst>
          </p:cNvPr>
          <p:cNvSpPr txBox="1"/>
          <p:nvPr/>
        </p:nvSpPr>
        <p:spPr>
          <a:xfrm>
            <a:off x="-9843" y="5996976"/>
            <a:ext cx="57438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accent4">
                    <a:lumMod val="50000"/>
                  </a:schemeClr>
                </a:solidFill>
              </a:rPr>
              <a:t>Rep 3</a:t>
            </a:r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76960ACD-A54D-4697-BC7F-7550072E877B}"/>
              </a:ext>
            </a:extLst>
          </p:cNvPr>
          <p:cNvSpPr/>
          <p:nvPr/>
        </p:nvSpPr>
        <p:spPr>
          <a:xfrm>
            <a:off x="2510707" y="6046935"/>
            <a:ext cx="320040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6FD794FB-0584-42B1-A29E-0FCC91E3401E}"/>
              </a:ext>
            </a:extLst>
          </p:cNvPr>
          <p:cNvSpPr txBox="1"/>
          <p:nvPr/>
        </p:nvSpPr>
        <p:spPr>
          <a:xfrm>
            <a:off x="356536" y="5371530"/>
            <a:ext cx="4858126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Binding region from Glyma04g009900 replicates</a:t>
            </a:r>
          </a:p>
        </p:txBody>
      </p:sp>
      <p:sp>
        <p:nvSpPr>
          <p:cNvPr id="253" name="Rectangle 252">
            <a:extLst>
              <a:ext uri="{FF2B5EF4-FFF2-40B4-BE49-F238E27FC236}">
                <a16:creationId xmlns:a16="http://schemas.microsoft.com/office/drawing/2014/main" id="{2451F93B-2472-4E30-B102-3B07D2746539}"/>
              </a:ext>
            </a:extLst>
          </p:cNvPr>
          <p:cNvSpPr/>
          <p:nvPr/>
        </p:nvSpPr>
        <p:spPr>
          <a:xfrm>
            <a:off x="2515469" y="5705313"/>
            <a:ext cx="210312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509CC5A8-CC0A-4C6F-A04A-94C489C61234}"/>
              </a:ext>
            </a:extLst>
          </p:cNvPr>
          <p:cNvSpPr txBox="1"/>
          <p:nvPr/>
        </p:nvSpPr>
        <p:spPr>
          <a:xfrm>
            <a:off x="2576426" y="5776754"/>
            <a:ext cx="35939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3</a:t>
            </a:r>
          </a:p>
        </p:txBody>
      </p:sp>
      <p:sp>
        <p:nvSpPr>
          <p:cNvPr id="255" name="Rectangle 254">
            <a:extLst>
              <a:ext uri="{FF2B5EF4-FFF2-40B4-BE49-F238E27FC236}">
                <a16:creationId xmlns:a16="http://schemas.microsoft.com/office/drawing/2014/main" id="{505D75FF-2114-4A6A-BDD3-8A9BAD955226}"/>
              </a:ext>
            </a:extLst>
          </p:cNvPr>
          <p:cNvSpPr/>
          <p:nvPr/>
        </p:nvSpPr>
        <p:spPr>
          <a:xfrm>
            <a:off x="2510707" y="5867376"/>
            <a:ext cx="146304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E02A03CD-01C2-4541-B492-31CED09EDF31}"/>
              </a:ext>
            </a:extLst>
          </p:cNvPr>
          <p:cNvSpPr txBox="1"/>
          <p:nvPr/>
        </p:nvSpPr>
        <p:spPr>
          <a:xfrm>
            <a:off x="2646645" y="5611650"/>
            <a:ext cx="44595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18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6E63DC9A-4FCA-47BA-B5C4-9B896D62EF45}"/>
              </a:ext>
            </a:extLst>
          </p:cNvPr>
          <p:cNvSpPr txBox="1"/>
          <p:nvPr/>
        </p:nvSpPr>
        <p:spPr>
          <a:xfrm>
            <a:off x="2741802" y="5941802"/>
            <a:ext cx="44595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18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DBD43DA8-6A76-46D9-996E-B00464B16920}"/>
              </a:ext>
            </a:extLst>
          </p:cNvPr>
          <p:cNvSpPr txBox="1"/>
          <p:nvPr/>
        </p:nvSpPr>
        <p:spPr>
          <a:xfrm>
            <a:off x="353717" y="4557190"/>
            <a:ext cx="4268733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Binding region from AT2G21490 replicates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2D46BD0B-32BA-4DF6-B920-F1A2E7EB1032}"/>
              </a:ext>
            </a:extLst>
          </p:cNvPr>
          <p:cNvSpPr txBox="1"/>
          <p:nvPr/>
        </p:nvSpPr>
        <p:spPr>
          <a:xfrm>
            <a:off x="-9671" y="4742251"/>
            <a:ext cx="57438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accent1">
                    <a:lumMod val="50000"/>
                  </a:schemeClr>
                </a:solidFill>
              </a:rPr>
              <a:t>Rep 1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0A7028B0-6976-439C-AAEE-E05D4E7ED419}"/>
              </a:ext>
            </a:extLst>
          </p:cNvPr>
          <p:cNvSpPr txBox="1"/>
          <p:nvPr/>
        </p:nvSpPr>
        <p:spPr>
          <a:xfrm>
            <a:off x="20370" y="5100219"/>
            <a:ext cx="512833" cy="205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60960" tIns="0" rIns="60960" bIns="0" rtlCol="0">
            <a:spAutoFit/>
          </a:bodyPr>
          <a:lstStyle/>
          <a:p>
            <a:r>
              <a:rPr lang="en-US" sz="1333" dirty="0">
                <a:solidFill>
                  <a:schemeClr val="accent6">
                    <a:lumMod val="75000"/>
                  </a:schemeClr>
                </a:solidFill>
              </a:rPr>
              <a:t>Rep 2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C7302551-ADF7-4C45-991A-BFE4E52C6CC0}"/>
              </a:ext>
            </a:extLst>
          </p:cNvPr>
          <p:cNvSpPr txBox="1"/>
          <p:nvPr/>
        </p:nvSpPr>
        <p:spPr>
          <a:xfrm>
            <a:off x="-9843" y="5227697"/>
            <a:ext cx="57438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accent4">
                    <a:lumMod val="50000"/>
                  </a:schemeClr>
                </a:solidFill>
              </a:rPr>
              <a:t>Rep 3</a:t>
            </a:r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4EEEFEFA-B45E-4EE1-8D74-3DC29B4E7AC2}"/>
              </a:ext>
            </a:extLst>
          </p:cNvPr>
          <p:cNvSpPr/>
          <p:nvPr/>
        </p:nvSpPr>
        <p:spPr>
          <a:xfrm>
            <a:off x="2511428" y="4899538"/>
            <a:ext cx="320040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7C8BFC50-B2EE-4C6D-A67D-D1555144E235}"/>
              </a:ext>
            </a:extLst>
          </p:cNvPr>
          <p:cNvSpPr txBox="1"/>
          <p:nvPr/>
        </p:nvSpPr>
        <p:spPr>
          <a:xfrm>
            <a:off x="2741802" y="4802159"/>
            <a:ext cx="44595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18</a:t>
            </a:r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47FB02D5-95D1-45F6-8248-5A6FB1433ADF}"/>
              </a:ext>
            </a:extLst>
          </p:cNvPr>
          <p:cNvSpPr/>
          <p:nvPr/>
        </p:nvSpPr>
        <p:spPr>
          <a:xfrm>
            <a:off x="2515859" y="5059497"/>
            <a:ext cx="146304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74" name="Rectangle 273">
            <a:extLst>
              <a:ext uri="{FF2B5EF4-FFF2-40B4-BE49-F238E27FC236}">
                <a16:creationId xmlns:a16="http://schemas.microsoft.com/office/drawing/2014/main" id="{1BD01AFB-87C9-434D-833F-33B76F25A60D}"/>
              </a:ext>
            </a:extLst>
          </p:cNvPr>
          <p:cNvSpPr/>
          <p:nvPr/>
        </p:nvSpPr>
        <p:spPr>
          <a:xfrm>
            <a:off x="6812137" y="5100027"/>
            <a:ext cx="173736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C382A876-7E66-43CD-A500-32E846143E07}"/>
              </a:ext>
            </a:extLst>
          </p:cNvPr>
          <p:cNvSpPr txBox="1"/>
          <p:nvPr/>
        </p:nvSpPr>
        <p:spPr>
          <a:xfrm>
            <a:off x="6912988" y="4999652"/>
            <a:ext cx="44595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12</a:t>
            </a:r>
          </a:p>
        </p:txBody>
      </p:sp>
      <p:sp>
        <p:nvSpPr>
          <p:cNvPr id="284" name="Rectangle 283">
            <a:extLst>
              <a:ext uri="{FF2B5EF4-FFF2-40B4-BE49-F238E27FC236}">
                <a16:creationId xmlns:a16="http://schemas.microsoft.com/office/drawing/2014/main" id="{5169CF11-60C7-41B7-87FE-1FEA54D3A269}"/>
              </a:ext>
            </a:extLst>
          </p:cNvPr>
          <p:cNvSpPr/>
          <p:nvPr/>
        </p:nvSpPr>
        <p:spPr>
          <a:xfrm>
            <a:off x="6809756" y="5279660"/>
            <a:ext cx="182880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FE192AA-DF98-4E9C-91A0-3A8C462594B1}"/>
              </a:ext>
            </a:extLst>
          </p:cNvPr>
          <p:cNvSpPr txBox="1"/>
          <p:nvPr/>
        </p:nvSpPr>
        <p:spPr>
          <a:xfrm>
            <a:off x="191848" y="547596"/>
            <a:ext cx="364731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3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5EBB84A2-740A-47E0-B872-324A2C5654E5}"/>
              </a:ext>
            </a:extLst>
          </p:cNvPr>
          <p:cNvSpPr txBox="1"/>
          <p:nvPr/>
        </p:nvSpPr>
        <p:spPr>
          <a:xfrm>
            <a:off x="71192" y="3641075"/>
            <a:ext cx="484345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1.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C1808B4-924E-4D85-81EC-78FAE7881B9E}"/>
              </a:ext>
            </a:extLst>
          </p:cNvPr>
          <p:cNvSpPr txBox="1"/>
          <p:nvPr/>
        </p:nvSpPr>
        <p:spPr>
          <a:xfrm>
            <a:off x="2540585" y="4098965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100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2CBE4AA6-7300-490B-947F-4CDE80528FF0}"/>
              </a:ext>
            </a:extLst>
          </p:cNvPr>
          <p:cNvSpPr txBox="1"/>
          <p:nvPr/>
        </p:nvSpPr>
        <p:spPr>
          <a:xfrm>
            <a:off x="3713150" y="4107189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1500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ABEB38F1-E0F4-48AD-BD72-D0E2214FA77B}"/>
              </a:ext>
            </a:extLst>
          </p:cNvPr>
          <p:cNvSpPr txBox="1"/>
          <p:nvPr/>
        </p:nvSpPr>
        <p:spPr>
          <a:xfrm>
            <a:off x="4873238" y="4098965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2000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F032DC2D-38D7-4DDF-A001-A30FCE5D25CC}"/>
              </a:ext>
            </a:extLst>
          </p:cNvPr>
          <p:cNvSpPr txBox="1"/>
          <p:nvPr/>
        </p:nvSpPr>
        <p:spPr>
          <a:xfrm>
            <a:off x="6050199" y="4105197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250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035FE6C2-83A5-4473-BE07-F983B2AF5C94}"/>
              </a:ext>
            </a:extLst>
          </p:cNvPr>
          <p:cNvSpPr txBox="1"/>
          <p:nvPr/>
        </p:nvSpPr>
        <p:spPr>
          <a:xfrm>
            <a:off x="7217312" y="4107189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3000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FC755165-85F7-4EFF-992B-1767560531D9}"/>
              </a:ext>
            </a:extLst>
          </p:cNvPr>
          <p:cNvSpPr txBox="1"/>
          <p:nvPr/>
        </p:nvSpPr>
        <p:spPr>
          <a:xfrm>
            <a:off x="8392733" y="4102598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35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9A9466C-9306-493D-B54D-3ABF7D48E1C3}"/>
              </a:ext>
            </a:extLst>
          </p:cNvPr>
          <p:cNvSpPr txBox="1"/>
          <p:nvPr/>
        </p:nvSpPr>
        <p:spPr>
          <a:xfrm>
            <a:off x="150640" y="3969361"/>
            <a:ext cx="363513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2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C82ADEA3-5051-4EDF-A2CF-15D20CE77B8E}"/>
              </a:ext>
            </a:extLst>
          </p:cNvPr>
          <p:cNvSpPr txBox="1"/>
          <p:nvPr/>
        </p:nvSpPr>
        <p:spPr>
          <a:xfrm>
            <a:off x="7640754" y="624881"/>
            <a:ext cx="14488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Hopp</a:t>
            </a:r>
            <a:r>
              <a:rPr lang="en-US" sz="1600" dirty="0"/>
              <a:t> &amp; Woods</a:t>
            </a:r>
          </a:p>
        </p:txBody>
      </p: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3D165928-33DE-4171-994A-A042D0D8B678}"/>
              </a:ext>
            </a:extLst>
          </p:cNvPr>
          <p:cNvCxnSpPr>
            <a:cxnSpLocks/>
            <a:endCxn id="288" idx="1"/>
          </p:cNvCxnSpPr>
          <p:nvPr/>
        </p:nvCxnSpPr>
        <p:spPr>
          <a:xfrm>
            <a:off x="7335972" y="794158"/>
            <a:ext cx="304782" cy="0"/>
          </a:xfrm>
          <a:prstGeom prst="line">
            <a:avLst/>
          </a:prstGeom>
          <a:ln w="19050">
            <a:solidFill>
              <a:srgbClr val="D45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D1B81ECD-56BB-468F-8B2D-6A5539E917C4}"/>
              </a:ext>
            </a:extLst>
          </p:cNvPr>
          <p:cNvSpPr txBox="1"/>
          <p:nvPr/>
        </p:nvSpPr>
        <p:spPr>
          <a:xfrm>
            <a:off x="1207536" y="3617676"/>
            <a:ext cx="1232516" cy="5572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dirty="0"/>
              <a:t>DUF913 family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C44FAB3-A895-495F-9B87-C18397BA698B}"/>
              </a:ext>
            </a:extLst>
          </p:cNvPr>
          <p:cNvSpPr txBox="1"/>
          <p:nvPr/>
        </p:nvSpPr>
        <p:spPr>
          <a:xfrm>
            <a:off x="7429606" y="3198950"/>
            <a:ext cx="1917363" cy="10188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dirty="0"/>
              <a:t>HECT-domain (ubiquitin-transferase) domai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B83DBEF-3863-478E-A546-503098E389FB}"/>
              </a:ext>
            </a:extLst>
          </p:cNvPr>
          <p:cNvSpPr txBox="1"/>
          <p:nvPr/>
        </p:nvSpPr>
        <p:spPr>
          <a:xfrm>
            <a:off x="407395" y="3632484"/>
            <a:ext cx="1025545" cy="5572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dirty="0"/>
              <a:t>DUF908 family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1D79875-5737-4B2C-B8E7-B16957A6F7AE}"/>
              </a:ext>
            </a:extLst>
          </p:cNvPr>
          <p:cNvSpPr txBox="1"/>
          <p:nvPr/>
        </p:nvSpPr>
        <p:spPr>
          <a:xfrm>
            <a:off x="2985005" y="3632207"/>
            <a:ext cx="1120110" cy="5572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dirty="0"/>
              <a:t>UBA/TS-N doma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C9A244B-5263-4081-8B62-E52B47DCE5AB}"/>
              </a:ext>
            </a:extLst>
          </p:cNvPr>
          <p:cNvSpPr txBox="1"/>
          <p:nvPr/>
        </p:nvSpPr>
        <p:spPr>
          <a:xfrm>
            <a:off x="5711902" y="3628570"/>
            <a:ext cx="1805863" cy="5572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dirty="0"/>
              <a:t>Ubiquitin binding region motif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E28BA41-D0B6-4E1C-83EA-150CE569D293}"/>
              </a:ext>
            </a:extLst>
          </p:cNvPr>
          <p:cNvSpPr/>
          <p:nvPr/>
        </p:nvSpPr>
        <p:spPr>
          <a:xfrm>
            <a:off x="8279606" y="2710368"/>
            <a:ext cx="726282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38ED758-9AE8-49F3-B9B6-E6A16BFD3725}"/>
              </a:ext>
            </a:extLst>
          </p:cNvPr>
          <p:cNvSpPr/>
          <p:nvPr/>
        </p:nvSpPr>
        <p:spPr>
          <a:xfrm>
            <a:off x="664370" y="2710368"/>
            <a:ext cx="278606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6FBE3A2-22D3-4B66-8D6A-2FAB467069B0}"/>
              </a:ext>
            </a:extLst>
          </p:cNvPr>
          <p:cNvSpPr/>
          <p:nvPr/>
        </p:nvSpPr>
        <p:spPr>
          <a:xfrm>
            <a:off x="1435893" y="2711607"/>
            <a:ext cx="816769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595DAE52-0821-4453-9A15-17A9457D9B4F}"/>
              </a:ext>
            </a:extLst>
          </p:cNvPr>
          <p:cNvSpPr/>
          <p:nvPr/>
        </p:nvSpPr>
        <p:spPr>
          <a:xfrm>
            <a:off x="935833" y="2711214"/>
            <a:ext cx="364330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8E7749FB-4068-42A2-BD3F-472621D91643}"/>
              </a:ext>
            </a:extLst>
          </p:cNvPr>
          <p:cNvSpPr/>
          <p:nvPr/>
        </p:nvSpPr>
        <p:spPr>
          <a:xfrm>
            <a:off x="3436144" y="2710365"/>
            <a:ext cx="90487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B14E45B0-9754-4EFC-8494-107938945CB9}"/>
              </a:ext>
            </a:extLst>
          </p:cNvPr>
          <p:cNvSpPr/>
          <p:nvPr/>
        </p:nvSpPr>
        <p:spPr>
          <a:xfrm>
            <a:off x="6505576" y="2709484"/>
            <a:ext cx="71438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897E1BF2-DAE8-4D14-A085-DB8494A782E0}"/>
              </a:ext>
            </a:extLst>
          </p:cNvPr>
          <p:cNvSpPr/>
          <p:nvPr/>
        </p:nvSpPr>
        <p:spPr>
          <a:xfrm>
            <a:off x="6596069" y="2710628"/>
            <a:ext cx="73812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E216C3C-0D94-4BA6-9D3A-42D518A9F8FF}"/>
              </a:ext>
            </a:extLst>
          </p:cNvPr>
          <p:cNvSpPr/>
          <p:nvPr/>
        </p:nvSpPr>
        <p:spPr>
          <a:xfrm>
            <a:off x="6679414" y="2711779"/>
            <a:ext cx="76192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D15EE97A-F546-465B-8286-EC9DA8C065F4}"/>
              </a:ext>
            </a:extLst>
          </p:cNvPr>
          <p:cNvSpPr/>
          <p:nvPr/>
        </p:nvSpPr>
        <p:spPr>
          <a:xfrm>
            <a:off x="459720" y="2709791"/>
            <a:ext cx="8565217" cy="1066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671B13F-1420-4924-8C9B-724D2D60EFAA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0</a:t>
            </a:r>
          </a:p>
        </p:txBody>
      </p:sp>
    </p:spTree>
    <p:extLst>
      <p:ext uri="{BB962C8B-B14F-4D97-AF65-F5344CB8AC3E}">
        <p14:creationId xmlns:p14="http://schemas.microsoft.com/office/powerpoint/2010/main" val="25451913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F28280BA-0067-405E-A03C-812C76729021}"/>
              </a:ext>
            </a:extLst>
          </p:cNvPr>
          <p:cNvGrpSpPr/>
          <p:nvPr/>
        </p:nvGrpSpPr>
        <p:grpSpPr>
          <a:xfrm>
            <a:off x="-63822" y="283960"/>
            <a:ext cx="9790126" cy="5547890"/>
            <a:chOff x="-63822" y="283960"/>
            <a:chExt cx="9790126" cy="5547890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E99F476-05FF-476A-923B-EA3527AE9AE7}"/>
                </a:ext>
              </a:extLst>
            </p:cNvPr>
            <p:cNvSpPr txBox="1"/>
            <p:nvPr/>
          </p:nvSpPr>
          <p:spPr>
            <a:xfrm>
              <a:off x="393669" y="3260087"/>
              <a:ext cx="9331572" cy="1231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ALSKVLRRTQRLRLGACSAVFSKDIQLGGERSFDSNSIASTKREAVPRFYEISSLSNRALSSSAGTKSDQEEDDLEDGFSELEGSKSGQGSTSSDEDEGKLSADEEEEEELDLIETDVSRKTVEKKQSELFKTIVSAPGLSIGSALDKWVEEGNEITRVEIAKAMLQLRRRRMYGRALQMSEWLEANKKIEMTERDYASRLDLTVKIRGLEKGEACMQKIPKSFKGEVLYRTLLANCVAAGNVKKSELVFNKMKDLGFPLSGFTCDQMLLLHKRIDRKKIADVLLLMEKENIKPSLLTYKILIDVKGATNDISGMEQILETMKDEGVELDFQTQALTARHYSGAGLKDKAEKVLKEMEGESLEANRRAFKDLLSIYASLGREDEVKRIWKICESKPYFEESLAAIQAFGKLNKVQEAEAIFEKIVKMDRRASSSTYSVLLRVYVDHKMLSKGKDLVKRMAESGCRIEATTWDALIKLYVEAGE</a:t>
              </a:r>
              <a:r>
                <a:rPr lang="en-US" sz="1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EKADSLLDKASKQSHTKLMMNSFMYIMDEYSKRGDVHNTEKIFLKMREAGYTSRLRQFQALMQ</a:t>
              </a:r>
              <a:r>
                <a:rPr lang="en-US" sz="1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YINAKSPAYGMRDRLKADNIFPNKSMAAQLAQGDPFKKTAISDILD</a:t>
              </a:r>
              <a:endParaRPr lang="en-US" sz="18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00016B5-2F08-4786-A5B0-0985C156FF27}"/>
                </a:ext>
              </a:extLst>
            </p:cNvPr>
            <p:cNvSpPr txBox="1"/>
            <p:nvPr/>
          </p:nvSpPr>
          <p:spPr>
            <a:xfrm>
              <a:off x="394733" y="3011779"/>
              <a:ext cx="9331571" cy="12150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ALSKVLRRTQRLRLGACSAVFSKDIQLGGERSFDSNSIASTKREAVPRFYEISSLSNRALSSSAGTKSDQEEDDLEDGFSELEGSKSGQGSTSSDEDEGKLSADEEEEEELDLIETDVSRKTVEKKQSELFKTIVSAPGLSIGSALDKWVEEGNEITRVEIAKAMLQLRRRRMYGRALQMSEWLEANKKIEMTERDYASRLDLTVKIRGLEKGEACMQKIPKSFKGEVLYRTLLANCVAAGNVKKSEL</a:t>
              </a:r>
              <a:r>
                <a:rPr lang="en-US" sz="18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FNKMKDLGFPLSGFTCDQMLLLHKRIDRKKIADVLLLMEKENIKPSLLTYKILIDVKG</a:t>
              </a:r>
              <a:r>
                <a:rPr lang="en-US" sz="1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NDISGMEQILETMKDEGVELDFQTQALTARHYSGAGLKDKAEKVLKEMEGESLEANRRAFKDLLSIYASLGREDEVKRIWKICESKPYFEESLAAIQAFGKLNKVQEAEAIFEKIVKMDRRASSSTYSVLLRVYVDHKMLSKGKDLVKRMAESGCRIEATTWDALIKLYVEAGE</a:t>
              </a:r>
              <a:r>
                <a:rPr lang="en-US" sz="1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EKADSLLDKASKQSHTKLMMNSFMYIMDEYSKRGDVHNTEKIFLKMREAGYTSRLRQFQALMQ</a:t>
              </a:r>
              <a:r>
                <a:rPr lang="en-US" sz="1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YINAKSPAYGMRDRLKADNIFPNKSMAAQLAQGDPFKKTAISDILD</a:t>
              </a:r>
              <a:endParaRPr lang="en-US" sz="18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8EA9C4C2-7579-4AD5-8F02-D5FC30E27F4A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21" t="11284" r="4759" b="11841"/>
            <a:stretch/>
          </p:blipFill>
          <p:spPr>
            <a:xfrm>
              <a:off x="408774" y="715991"/>
              <a:ext cx="8651819" cy="3514725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83960"/>
              <a:ext cx="7831952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1G80270.1, .2, .3, .4 or .5: PENTATRICOPEPTIDE REPEAT 596; 596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04807" y="100413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129218" y="144159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191704" y="189110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138313" y="2310770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197045" y="272479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79315" y="3164226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133102" y="3598440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115022" y="599007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341493" y="4150223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670982" y="4157209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92223" y="2310926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17965" y="4303398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1860" y="537226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34540" y="5626729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377648" y="5153556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8249405" y="5525828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4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8239880" y="5358572"/>
              <a:ext cx="359393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372961" y="4551166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3721" y="4749546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38202" y="5012396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244677" y="4736088"/>
              <a:ext cx="532518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54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C6A08A1-E439-4B38-BC6D-EDDAA2F95175}"/>
                </a:ext>
              </a:extLst>
            </p:cNvPr>
            <p:cNvSpPr txBox="1"/>
            <p:nvPr/>
          </p:nvSpPr>
          <p:spPr>
            <a:xfrm>
              <a:off x="8250719" y="490034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75413" y="4027988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118732" y="415047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545899" y="414528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988878" y="414820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412674" y="415199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635536" y="679292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330754" y="848569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7411434" y="4835863"/>
              <a:ext cx="91440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7CB854E6-2EBD-410F-B2ED-DE4EC9A2F6DA}"/>
                </a:ext>
              </a:extLst>
            </p:cNvPr>
            <p:cNvSpPr/>
            <p:nvPr/>
          </p:nvSpPr>
          <p:spPr>
            <a:xfrm>
              <a:off x="7409244" y="4998043"/>
              <a:ext cx="914400" cy="106672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0A9669E2-6966-44B4-949F-B7089592DB12}"/>
                </a:ext>
              </a:extLst>
            </p:cNvPr>
            <p:cNvSpPr/>
            <p:nvPr/>
          </p:nvSpPr>
          <p:spPr>
            <a:xfrm>
              <a:off x="7410143" y="5457261"/>
              <a:ext cx="91440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DE003FB2-D8FF-4BD9-AAE4-AE6C74A3E07A}"/>
                </a:ext>
              </a:extLst>
            </p:cNvPr>
            <p:cNvSpPr/>
            <p:nvPr/>
          </p:nvSpPr>
          <p:spPr>
            <a:xfrm>
              <a:off x="7407953" y="5619441"/>
              <a:ext cx="914400" cy="106672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647C140-B325-4400-929A-25C37D07F5D7}"/>
                </a:ext>
              </a:extLst>
            </p:cNvPr>
            <p:cNvSpPr/>
            <p:nvPr/>
          </p:nvSpPr>
          <p:spPr>
            <a:xfrm>
              <a:off x="4057650" y="2848265"/>
              <a:ext cx="845343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6AE4FC1C-CF3E-4F0E-BAD7-7123A699C31B}"/>
                </a:ext>
              </a:extLst>
            </p:cNvPr>
            <p:cNvSpPr/>
            <p:nvPr/>
          </p:nvSpPr>
          <p:spPr>
            <a:xfrm>
              <a:off x="474007" y="2845522"/>
              <a:ext cx="8534262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A814AD6-DFBD-4296-82CD-B799ECD05D29}"/>
                </a:ext>
              </a:extLst>
            </p:cNvPr>
            <p:cNvSpPr txBox="1"/>
            <p:nvPr/>
          </p:nvSpPr>
          <p:spPr>
            <a:xfrm>
              <a:off x="2409086" y="3850475"/>
              <a:ext cx="44470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Pentatricopeptide repeat domain (3) family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B6A681A0-D357-40D2-98FA-7D5AE0E9313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1</a:t>
            </a:r>
          </a:p>
        </p:txBody>
      </p:sp>
    </p:spTree>
    <p:extLst>
      <p:ext uri="{BB962C8B-B14F-4D97-AF65-F5344CB8AC3E}">
        <p14:creationId xmlns:p14="http://schemas.microsoft.com/office/powerpoint/2010/main" val="7412419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TextBox 104">
            <a:extLst>
              <a:ext uri="{FF2B5EF4-FFF2-40B4-BE49-F238E27FC236}">
                <a16:creationId xmlns:a16="http://schemas.microsoft.com/office/drawing/2014/main" id="{FB296758-D08C-449B-9564-0401BC896858}"/>
              </a:ext>
            </a:extLst>
          </p:cNvPr>
          <p:cNvSpPr txBox="1"/>
          <p:nvPr/>
        </p:nvSpPr>
        <p:spPr>
          <a:xfrm>
            <a:off x="493921" y="3178400"/>
            <a:ext cx="9072298" cy="186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580" dirty="0">
                <a:effectLst/>
                <a:highlight>
                  <a:srgbClr val="D3D3D3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DLRD</a:t>
            </a:r>
            <a:r>
              <a:rPr lang="en-US" sz="580" dirty="0">
                <a:effectLst/>
                <a:highlight>
                  <a:srgbClr val="008B8B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GNPI</a:t>
            </a:r>
            <a:r>
              <a:rPr lang="en-US" sz="580" dirty="0">
                <a:effectLst/>
                <a:highlight>
                  <a:srgbClr val="D3D3D3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LTDTQGNPI</a:t>
            </a:r>
            <a:r>
              <a:rPr lang="en-US" sz="580" dirty="0">
                <a:effectLst/>
                <a:highlight>
                  <a:srgbClr val="808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VDLTDEHGNPMYLTGVVSSTPQHKESTTSDIAEHPTSTVGETHPAAAPAGAGAATAATATGVSAGTGATTTGQQHHGSLEEHLRRSGSSSSSSSEDDGQGGRRKKSIKEKIKEKFGSGKHKDEQTPATATTTGPATTDQPHEKKGILEKIKDKLPGHH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NHNHP</a:t>
            </a:r>
            <a:endParaRPr lang="en-US" sz="58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5031E10-E0D0-4E93-9E62-802F41C9D72F}"/>
              </a:ext>
            </a:extLst>
          </p:cNvPr>
          <p:cNvSpPr txBox="1"/>
          <p:nvPr/>
        </p:nvSpPr>
        <p:spPr>
          <a:xfrm>
            <a:off x="497392" y="2940753"/>
            <a:ext cx="8954425" cy="188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580" dirty="0">
                <a:effectLst/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DLRD</a:t>
            </a:r>
            <a:r>
              <a:rPr lang="en-US" sz="580" dirty="0">
                <a:effectLst/>
                <a:highlight>
                  <a:srgbClr val="0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GNPI</a:t>
            </a:r>
            <a:r>
              <a:rPr lang="en-US" sz="580" dirty="0">
                <a:effectLst/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LTDTQGNPIVDLT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EHGNPMYLTGVVSSTPQHKESTTSDIAEHPTSTVG</a:t>
            </a:r>
            <a:r>
              <a:rPr lang="en-US" sz="580" dirty="0">
                <a:effectLst/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AP</a:t>
            </a:r>
            <a:r>
              <a:rPr lang="en-US" sz="580" dirty="0">
                <a:effectLst/>
                <a:highlight>
                  <a:srgbClr val="0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GAATAATATGVSAGTGATTT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QQHHG</a:t>
            </a:r>
            <a:r>
              <a:rPr lang="en-US" sz="580" dirty="0">
                <a:effectLst/>
                <a:highlight>
                  <a:srgbClr val="0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580" dirty="0">
                <a:effectLst/>
                <a:highlight>
                  <a:srgbClr val="808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HLRRSGSSSSSSS</a:t>
            </a:r>
            <a:r>
              <a:rPr lang="en-US" sz="58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DG</a:t>
            </a:r>
            <a:r>
              <a:rPr lang="en-US" sz="580" dirty="0">
                <a:effectLst/>
                <a:highlight>
                  <a:srgbClr val="FF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Q</a:t>
            </a:r>
            <a:r>
              <a:rPr lang="en-US" sz="580" dirty="0">
                <a:effectLst/>
                <a:highlight>
                  <a:srgbClr val="0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580" dirty="0">
                <a:effectLst/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580" dirty="0">
                <a:effectLst/>
                <a:highlight>
                  <a:srgbClr val="8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KSI</a:t>
            </a:r>
            <a:r>
              <a:rPr lang="en-US" sz="580" dirty="0">
                <a:effectLst/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00808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58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FGSGKHKDEQTPATA</a:t>
            </a:r>
            <a:r>
              <a:rPr lang="en-US" sz="580" dirty="0">
                <a:effectLst/>
                <a:highlight>
                  <a:srgbClr val="FF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G</a:t>
            </a:r>
            <a:r>
              <a:rPr lang="en-US" sz="580" dirty="0">
                <a:effectLst/>
                <a:highlight>
                  <a:srgbClr val="808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TDQPHEKKGILEKIKDKLP</a:t>
            </a:r>
            <a:r>
              <a:rPr lang="en-US" sz="580" dirty="0">
                <a:effectLst/>
                <a:highlight>
                  <a:srgbClr val="8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HHNHNHP</a:t>
            </a:r>
            <a:endParaRPr lang="en-US" sz="58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01C1AF5-4267-4722-8C3D-B3DF0B28A868}"/>
              </a:ext>
            </a:extLst>
          </p:cNvPr>
          <p:cNvSpPr txBox="1"/>
          <p:nvPr/>
        </p:nvSpPr>
        <p:spPr>
          <a:xfrm>
            <a:off x="493522" y="3269355"/>
            <a:ext cx="9690235" cy="1815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MADLR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EKGNP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IHL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DTQGNP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IVDL</a:t>
            </a:r>
            <a:r>
              <a:rPr lang="en-US" sz="58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DEHGNP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MYLTGVVSSTP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QHKESTTSD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IAEHPTSTVGETHPAAAPAGAGAATAATATGVSAGTGATTTG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QQHH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EEHLRR</a:t>
            </a:r>
            <a:r>
              <a:rPr lang="en-US" sz="58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GSSSSSSS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EDD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Q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GGRR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K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KE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IKEK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FGSG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KHKDEQT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PATATTTGPATTDQPH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KKGI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LE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IK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US" sz="58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LPG</a:t>
            </a:r>
            <a:r>
              <a:rPr lang="en-US" sz="580" b="1" dirty="0">
                <a:solidFill>
                  <a:srgbClr val="FFC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HHNHNH</a:t>
            </a:r>
            <a:r>
              <a:rPr lang="en-US" sz="58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P</a:t>
            </a:r>
            <a:endParaRPr lang="en-US" sz="580" dirty="0"/>
          </a:p>
        </p:txBody>
      </p:sp>
      <p:pic>
        <p:nvPicPr>
          <p:cNvPr id="60" name="Picture 59" descr="Chart, line chart&#10;&#10;Description automatically generated">
            <a:extLst>
              <a:ext uri="{FF2B5EF4-FFF2-40B4-BE49-F238E27FC236}">
                <a16:creationId xmlns:a16="http://schemas.microsoft.com/office/drawing/2014/main" id="{D41309D9-BB23-46D0-BD39-4E25CA6CD36E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32" t="10694" r="4562" b="11871"/>
          <a:stretch/>
        </p:blipFill>
        <p:spPr>
          <a:xfrm>
            <a:off x="497972" y="587661"/>
            <a:ext cx="8386948" cy="3557016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10D2BB19-7843-4530-8BF2-C77E8CADDA1C}"/>
              </a:ext>
            </a:extLst>
          </p:cNvPr>
          <p:cNvSpPr txBox="1"/>
          <p:nvPr/>
        </p:nvSpPr>
        <p:spPr>
          <a:xfrm>
            <a:off x="-53465" y="228487"/>
            <a:ext cx="5020450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67" dirty="0"/>
              <a:t>AT2G21490: DEHYDRIN, LEA14; 185 amino acid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6E996B4-88A2-4F7D-B061-6FB5E0AC83CD}"/>
              </a:ext>
            </a:extLst>
          </p:cNvPr>
          <p:cNvSpPr txBox="1"/>
          <p:nvPr/>
        </p:nvSpPr>
        <p:spPr>
          <a:xfrm>
            <a:off x="290510" y="974477"/>
            <a:ext cx="25039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586BB31-8743-4C67-A481-85A051C22039}"/>
              </a:ext>
            </a:extLst>
          </p:cNvPr>
          <p:cNvSpPr txBox="1"/>
          <p:nvPr/>
        </p:nvSpPr>
        <p:spPr>
          <a:xfrm>
            <a:off x="234966" y="1473096"/>
            <a:ext cx="560169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.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A4936BD-846A-4B72-A19D-8B77B15011D7}"/>
              </a:ext>
            </a:extLst>
          </p:cNvPr>
          <p:cNvSpPr txBox="1"/>
          <p:nvPr/>
        </p:nvSpPr>
        <p:spPr>
          <a:xfrm>
            <a:off x="291670" y="1956513"/>
            <a:ext cx="25039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4C9FA24-F4D4-45E3-A326-10D85AC56D80}"/>
              </a:ext>
            </a:extLst>
          </p:cNvPr>
          <p:cNvSpPr txBox="1"/>
          <p:nvPr/>
        </p:nvSpPr>
        <p:spPr>
          <a:xfrm>
            <a:off x="234733" y="2460886"/>
            <a:ext cx="52532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0.5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0E49952-B820-4CAA-876D-65817BA3EBF9}"/>
              </a:ext>
            </a:extLst>
          </p:cNvPr>
          <p:cNvSpPr txBox="1"/>
          <p:nvPr/>
        </p:nvSpPr>
        <p:spPr>
          <a:xfrm>
            <a:off x="180648" y="3459416"/>
            <a:ext cx="49008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-0.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B07FEB8-B4E8-4221-A942-7C08ADFA7201}"/>
              </a:ext>
            </a:extLst>
          </p:cNvPr>
          <p:cNvSpPr txBox="1"/>
          <p:nvPr/>
        </p:nvSpPr>
        <p:spPr>
          <a:xfrm>
            <a:off x="278116" y="3943890"/>
            <a:ext cx="471251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-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C408218-F262-48A5-9B12-EBECF3841F8A}"/>
              </a:ext>
            </a:extLst>
          </p:cNvPr>
          <p:cNvSpPr txBox="1"/>
          <p:nvPr/>
        </p:nvSpPr>
        <p:spPr>
          <a:xfrm>
            <a:off x="227855" y="505556"/>
            <a:ext cx="52532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2.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6542A67-B810-484C-852F-9A4A8FCFAA09}"/>
              </a:ext>
            </a:extLst>
          </p:cNvPr>
          <p:cNvSpPr txBox="1"/>
          <p:nvPr/>
        </p:nvSpPr>
        <p:spPr>
          <a:xfrm>
            <a:off x="286507" y="2954298"/>
            <a:ext cx="274434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236BA89-962B-4A1B-B737-C675D5D3887C}"/>
              </a:ext>
            </a:extLst>
          </p:cNvPr>
          <p:cNvSpPr txBox="1"/>
          <p:nvPr/>
        </p:nvSpPr>
        <p:spPr>
          <a:xfrm rot="16200000">
            <a:off x="-707235" y="2086671"/>
            <a:ext cx="1833323" cy="242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sz="1600" dirty="0"/>
              <a:t>Hydrophilicity index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10CE261-B7D2-4B11-B817-5CA2B62B472A}"/>
              </a:ext>
            </a:extLst>
          </p:cNvPr>
          <p:cNvSpPr txBox="1"/>
          <p:nvPr/>
        </p:nvSpPr>
        <p:spPr>
          <a:xfrm>
            <a:off x="3458649" y="5953179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45119D7-D3FE-450C-9EEC-982773ED0F68}"/>
              </a:ext>
            </a:extLst>
          </p:cNvPr>
          <p:cNvSpPr txBox="1"/>
          <p:nvPr/>
        </p:nvSpPr>
        <p:spPr>
          <a:xfrm>
            <a:off x="8428149" y="5926839"/>
            <a:ext cx="445956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3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D225E8B-97EC-481A-A02E-CF594022A8F1}"/>
              </a:ext>
            </a:extLst>
          </p:cNvPr>
          <p:cNvSpPr txBox="1"/>
          <p:nvPr/>
        </p:nvSpPr>
        <p:spPr>
          <a:xfrm>
            <a:off x="3672966" y="6149088"/>
            <a:ext cx="445956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1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242E1AA-D933-4CB1-8404-0C9BA04981BF}"/>
              </a:ext>
            </a:extLst>
          </p:cNvPr>
          <p:cNvSpPr txBox="1"/>
          <p:nvPr/>
        </p:nvSpPr>
        <p:spPr>
          <a:xfrm>
            <a:off x="4966985" y="6312746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EE7645A-98F6-41A3-941C-2CC1C701BA1C}"/>
              </a:ext>
            </a:extLst>
          </p:cNvPr>
          <p:cNvSpPr txBox="1"/>
          <p:nvPr/>
        </p:nvSpPr>
        <p:spPr>
          <a:xfrm>
            <a:off x="8737677" y="6101681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67ED25F-3687-4DB0-8F8B-D5AA370348DB}"/>
              </a:ext>
            </a:extLst>
          </p:cNvPr>
          <p:cNvSpPr txBox="1"/>
          <p:nvPr/>
        </p:nvSpPr>
        <p:spPr>
          <a:xfrm>
            <a:off x="8736833" y="4711094"/>
            <a:ext cx="445956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2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D835CA9-6059-415E-83F0-7CB77EA29448}"/>
              </a:ext>
            </a:extLst>
          </p:cNvPr>
          <p:cNvSpPr txBox="1"/>
          <p:nvPr/>
        </p:nvSpPr>
        <p:spPr>
          <a:xfrm>
            <a:off x="4652570" y="4725933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FBD865-2FB2-4493-B88C-DFBB7DA903ED}"/>
              </a:ext>
            </a:extLst>
          </p:cNvPr>
          <p:cNvSpPr txBox="1"/>
          <p:nvPr/>
        </p:nvSpPr>
        <p:spPr>
          <a:xfrm>
            <a:off x="3450576" y="5002380"/>
            <a:ext cx="445956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7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8C3DD52-D96D-4E08-8B8C-CF499C24A4D4}"/>
              </a:ext>
            </a:extLst>
          </p:cNvPr>
          <p:cNvSpPr txBox="1"/>
          <p:nvPr/>
        </p:nvSpPr>
        <p:spPr>
          <a:xfrm>
            <a:off x="6458429" y="5031360"/>
            <a:ext cx="445956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3DD8BA-630B-45B9-9496-BC9E9B6C967D}"/>
              </a:ext>
            </a:extLst>
          </p:cNvPr>
          <p:cNvSpPr txBox="1"/>
          <p:nvPr/>
        </p:nvSpPr>
        <p:spPr>
          <a:xfrm>
            <a:off x="8736787" y="5176311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78D6DE3-F466-40DF-86FF-2CF4B6C9BC93}"/>
              </a:ext>
            </a:extLst>
          </p:cNvPr>
          <p:cNvSpPr txBox="1"/>
          <p:nvPr/>
        </p:nvSpPr>
        <p:spPr>
          <a:xfrm>
            <a:off x="8736787" y="5349813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A641C54-99CA-4171-81BE-EC636C809A74}"/>
              </a:ext>
            </a:extLst>
          </p:cNvPr>
          <p:cNvSpPr txBox="1"/>
          <p:nvPr/>
        </p:nvSpPr>
        <p:spPr>
          <a:xfrm>
            <a:off x="3300082" y="5285493"/>
            <a:ext cx="359394" cy="29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0" dirty="0"/>
              <a:t>X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407D4C8-B370-4071-84C9-9F43D8E83BF2}"/>
              </a:ext>
            </a:extLst>
          </p:cNvPr>
          <p:cNvSpPr txBox="1"/>
          <p:nvPr/>
        </p:nvSpPr>
        <p:spPr>
          <a:xfrm>
            <a:off x="436995" y="4074852"/>
            <a:ext cx="274434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247A637-6AE8-4A56-A368-6C06A98AE24A}"/>
              </a:ext>
            </a:extLst>
          </p:cNvPr>
          <p:cNvSpPr txBox="1"/>
          <p:nvPr/>
        </p:nvSpPr>
        <p:spPr>
          <a:xfrm>
            <a:off x="1238645" y="4065987"/>
            <a:ext cx="364202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2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EE70889-8A08-42D7-8056-C1FC67EB18D8}"/>
              </a:ext>
            </a:extLst>
          </p:cNvPr>
          <p:cNvSpPr txBox="1"/>
          <p:nvPr/>
        </p:nvSpPr>
        <p:spPr>
          <a:xfrm>
            <a:off x="2133390" y="4064594"/>
            <a:ext cx="364202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4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0280146-3E86-4F07-A03F-7D9922DB06A7}"/>
              </a:ext>
            </a:extLst>
          </p:cNvPr>
          <p:cNvSpPr txBox="1"/>
          <p:nvPr/>
        </p:nvSpPr>
        <p:spPr>
          <a:xfrm>
            <a:off x="3030639" y="4074852"/>
            <a:ext cx="364202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6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DABB3FC-F6DB-463E-8A56-CACEB1447CCA}"/>
              </a:ext>
            </a:extLst>
          </p:cNvPr>
          <p:cNvSpPr txBox="1"/>
          <p:nvPr/>
        </p:nvSpPr>
        <p:spPr>
          <a:xfrm>
            <a:off x="3947394" y="4064594"/>
            <a:ext cx="364202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8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BE0ACB4-9A64-4BB1-A80C-467FF2ED5E15}"/>
              </a:ext>
            </a:extLst>
          </p:cNvPr>
          <p:cNvSpPr txBox="1"/>
          <p:nvPr/>
        </p:nvSpPr>
        <p:spPr>
          <a:xfrm>
            <a:off x="4792970" y="4062045"/>
            <a:ext cx="45397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889BBC5-6319-4B80-A839-9DD2BA9F9DAB}"/>
              </a:ext>
            </a:extLst>
          </p:cNvPr>
          <p:cNvSpPr txBox="1"/>
          <p:nvPr/>
        </p:nvSpPr>
        <p:spPr>
          <a:xfrm>
            <a:off x="5694175" y="4062701"/>
            <a:ext cx="45397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2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202E134-F16F-4CB0-824C-A1E214AA571D}"/>
              </a:ext>
            </a:extLst>
          </p:cNvPr>
          <p:cNvSpPr txBox="1"/>
          <p:nvPr/>
        </p:nvSpPr>
        <p:spPr>
          <a:xfrm>
            <a:off x="6589653" y="4062045"/>
            <a:ext cx="45397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4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DDFAA44-6BB1-4C2F-A2DD-CFBBDE6894BE}"/>
              </a:ext>
            </a:extLst>
          </p:cNvPr>
          <p:cNvSpPr txBox="1"/>
          <p:nvPr/>
        </p:nvSpPr>
        <p:spPr>
          <a:xfrm>
            <a:off x="7479334" y="4074666"/>
            <a:ext cx="45397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6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4A9068A-D3DE-43E7-B467-61C54069B55E}"/>
              </a:ext>
            </a:extLst>
          </p:cNvPr>
          <p:cNvSpPr txBox="1"/>
          <p:nvPr/>
        </p:nvSpPr>
        <p:spPr>
          <a:xfrm>
            <a:off x="8378455" y="4065613"/>
            <a:ext cx="453970" cy="303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70" dirty="0"/>
              <a:t>1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A55958E-F0EF-4329-8D6A-C8978C134159}"/>
              </a:ext>
            </a:extLst>
          </p:cNvPr>
          <p:cNvSpPr txBox="1"/>
          <p:nvPr/>
        </p:nvSpPr>
        <p:spPr>
          <a:xfrm>
            <a:off x="3525877" y="4284889"/>
            <a:ext cx="2524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rotein length (amino acids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CF855FD-31FB-48B4-9BEF-E4DD48E4FE50}"/>
              </a:ext>
            </a:extLst>
          </p:cNvPr>
          <p:cNvSpPr txBox="1"/>
          <p:nvPr/>
        </p:nvSpPr>
        <p:spPr>
          <a:xfrm>
            <a:off x="478203" y="4479562"/>
            <a:ext cx="4206023" cy="66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67" dirty="0"/>
              <a:t>Binding region from AT2G21490 replicates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261A6CA-651B-4AF9-B7F6-E2F90299065A}"/>
              </a:ext>
            </a:extLst>
          </p:cNvPr>
          <p:cNvSpPr txBox="1"/>
          <p:nvPr/>
        </p:nvSpPr>
        <p:spPr>
          <a:xfrm>
            <a:off x="477937" y="5564410"/>
            <a:ext cx="4858126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67" dirty="0"/>
              <a:t>Binding region from Glyma04g009900 replicate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B689DD3-7A62-4375-8FF4-B6DB5FF96B25}"/>
              </a:ext>
            </a:extLst>
          </p:cNvPr>
          <p:cNvSpPr txBox="1"/>
          <p:nvPr/>
        </p:nvSpPr>
        <p:spPr>
          <a:xfrm>
            <a:off x="7419780" y="581860"/>
            <a:ext cx="14488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Hopp</a:t>
            </a:r>
            <a:r>
              <a:rPr lang="en-US" sz="1600" dirty="0"/>
              <a:t> &amp; Woods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989090C-1C6C-4E79-8617-F88ECDB378A1}"/>
              </a:ext>
            </a:extLst>
          </p:cNvPr>
          <p:cNvCxnSpPr>
            <a:cxnSpLocks/>
            <a:endCxn id="79" idx="1"/>
          </p:cNvCxnSpPr>
          <p:nvPr/>
        </p:nvCxnSpPr>
        <p:spPr>
          <a:xfrm>
            <a:off x="7114998" y="751137"/>
            <a:ext cx="304782" cy="0"/>
          </a:xfrm>
          <a:prstGeom prst="line">
            <a:avLst/>
          </a:prstGeom>
          <a:ln w="19050">
            <a:solidFill>
              <a:srgbClr val="D45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B6D960A3-9EF2-4985-98E7-AD10B29BE75E}"/>
              </a:ext>
            </a:extLst>
          </p:cNvPr>
          <p:cNvSpPr txBox="1"/>
          <p:nvPr/>
        </p:nvSpPr>
        <p:spPr>
          <a:xfrm>
            <a:off x="44216" y="4693512"/>
            <a:ext cx="574388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>
                <a:solidFill>
                  <a:schemeClr val="accent1">
                    <a:lumMod val="50000"/>
                  </a:schemeClr>
                </a:solidFill>
              </a:rPr>
              <a:t>Rep 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15EBE1C-AA7A-4CDC-B565-B9B18F7B28B8}"/>
              </a:ext>
            </a:extLst>
          </p:cNvPr>
          <p:cNvSpPr txBox="1"/>
          <p:nvPr/>
        </p:nvSpPr>
        <p:spPr>
          <a:xfrm>
            <a:off x="43791" y="5748162"/>
            <a:ext cx="574388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>
                <a:solidFill>
                  <a:schemeClr val="accent1">
                    <a:lumMod val="50000"/>
                  </a:schemeClr>
                </a:solidFill>
              </a:rPr>
              <a:t>Rep 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38E9E3F-F13D-42FB-B57E-C60AEB850426}"/>
              </a:ext>
            </a:extLst>
          </p:cNvPr>
          <p:cNvSpPr txBox="1"/>
          <p:nvPr/>
        </p:nvSpPr>
        <p:spPr>
          <a:xfrm>
            <a:off x="70802" y="5040007"/>
            <a:ext cx="512833" cy="205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60960" tIns="0" rIns="60960" bIns="0" rtlCol="0">
            <a:spAutoFit/>
          </a:bodyPr>
          <a:lstStyle/>
          <a:p>
            <a:r>
              <a:rPr lang="en-US" sz="1333" dirty="0">
                <a:solidFill>
                  <a:schemeClr val="accent6">
                    <a:lumMod val="75000"/>
                  </a:schemeClr>
                </a:solidFill>
              </a:rPr>
              <a:t>Rep 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98A0783-9A90-4BFE-9681-CA2F394C98A6}"/>
              </a:ext>
            </a:extLst>
          </p:cNvPr>
          <p:cNvSpPr txBox="1"/>
          <p:nvPr/>
        </p:nvSpPr>
        <p:spPr>
          <a:xfrm>
            <a:off x="75048" y="5999270"/>
            <a:ext cx="512833" cy="205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60960" tIns="0" rIns="60960" bIns="0" rtlCol="0">
            <a:spAutoFit/>
          </a:bodyPr>
          <a:lstStyle/>
          <a:p>
            <a:r>
              <a:rPr lang="en-US" sz="1333" dirty="0">
                <a:solidFill>
                  <a:schemeClr val="accent6">
                    <a:lumMod val="75000"/>
                  </a:schemeClr>
                </a:solidFill>
              </a:rPr>
              <a:t>Rep 2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3FADEE4-3130-48FE-B7C1-7F1D5C4CC5B7}"/>
              </a:ext>
            </a:extLst>
          </p:cNvPr>
          <p:cNvSpPr txBox="1"/>
          <p:nvPr/>
        </p:nvSpPr>
        <p:spPr>
          <a:xfrm>
            <a:off x="42065" y="5273751"/>
            <a:ext cx="574388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>
                <a:solidFill>
                  <a:schemeClr val="accent4">
                    <a:lumMod val="50000"/>
                  </a:schemeClr>
                </a:solidFill>
              </a:rPr>
              <a:t>Rep 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A63C7CB-ACF6-4DAB-A6EF-559160851A6F}"/>
              </a:ext>
            </a:extLst>
          </p:cNvPr>
          <p:cNvSpPr txBox="1"/>
          <p:nvPr/>
        </p:nvSpPr>
        <p:spPr>
          <a:xfrm>
            <a:off x="43327" y="6152552"/>
            <a:ext cx="574388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>
                <a:solidFill>
                  <a:schemeClr val="accent4">
                    <a:lumMod val="50000"/>
                  </a:schemeClr>
                </a:solidFill>
              </a:rPr>
              <a:t>Rep 3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B7574DCB-FEA6-4192-A02A-FFE93662D827}"/>
              </a:ext>
            </a:extLst>
          </p:cNvPr>
          <p:cNvSpPr/>
          <p:nvPr/>
        </p:nvSpPr>
        <p:spPr>
          <a:xfrm>
            <a:off x="638542" y="5088098"/>
            <a:ext cx="2880360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F7B0E66B-4CBE-488F-9B45-7D128C4C398E}"/>
              </a:ext>
            </a:extLst>
          </p:cNvPr>
          <p:cNvSpPr/>
          <p:nvPr/>
        </p:nvSpPr>
        <p:spPr>
          <a:xfrm>
            <a:off x="6547876" y="4814238"/>
            <a:ext cx="2265129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BA0BA601-305D-447B-8DFB-B5E71121F8F0}"/>
              </a:ext>
            </a:extLst>
          </p:cNvPr>
          <p:cNvSpPr/>
          <p:nvPr/>
        </p:nvSpPr>
        <p:spPr>
          <a:xfrm>
            <a:off x="592652" y="5372469"/>
            <a:ext cx="2788920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7A8AB26E-F00D-4669-8F7B-2348542C62CC}"/>
              </a:ext>
            </a:extLst>
          </p:cNvPr>
          <p:cNvSpPr/>
          <p:nvPr/>
        </p:nvSpPr>
        <p:spPr>
          <a:xfrm>
            <a:off x="1745668" y="4815877"/>
            <a:ext cx="2980944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9C0900D8-18A7-4530-8B41-2837E507F05D}"/>
              </a:ext>
            </a:extLst>
          </p:cNvPr>
          <p:cNvSpPr/>
          <p:nvPr/>
        </p:nvSpPr>
        <p:spPr>
          <a:xfrm>
            <a:off x="5123024" y="4973395"/>
            <a:ext cx="2354079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2FD5B7FF-B052-4FC0-AC57-15FBD8CAB304}"/>
              </a:ext>
            </a:extLst>
          </p:cNvPr>
          <p:cNvSpPr/>
          <p:nvPr/>
        </p:nvSpPr>
        <p:spPr>
          <a:xfrm>
            <a:off x="5751389" y="5113450"/>
            <a:ext cx="787523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66C48168-2AB8-4573-8880-796DAB43EB13}"/>
              </a:ext>
            </a:extLst>
          </p:cNvPr>
          <p:cNvSpPr/>
          <p:nvPr/>
        </p:nvSpPr>
        <p:spPr>
          <a:xfrm>
            <a:off x="5927599" y="5281406"/>
            <a:ext cx="2880645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2AC54B4A-3AB8-4F44-ABCA-931E982EC29A}"/>
              </a:ext>
            </a:extLst>
          </p:cNvPr>
          <p:cNvSpPr/>
          <p:nvPr/>
        </p:nvSpPr>
        <p:spPr>
          <a:xfrm>
            <a:off x="7305370" y="5438262"/>
            <a:ext cx="1502873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2C8CD11A-739B-49C8-A95A-5AFC1B6A7458}"/>
              </a:ext>
            </a:extLst>
          </p:cNvPr>
          <p:cNvSpPr/>
          <p:nvPr/>
        </p:nvSpPr>
        <p:spPr>
          <a:xfrm>
            <a:off x="1123383" y="5529896"/>
            <a:ext cx="5335045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BC41CB1B-307C-48C5-95DF-F535FDA79FF5}"/>
              </a:ext>
            </a:extLst>
          </p:cNvPr>
          <p:cNvSpPr/>
          <p:nvPr/>
        </p:nvSpPr>
        <p:spPr>
          <a:xfrm>
            <a:off x="6058950" y="5683100"/>
            <a:ext cx="2749293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7BAFF80C-48B5-420D-BCA4-B1B91D1A7BFB}"/>
              </a:ext>
            </a:extLst>
          </p:cNvPr>
          <p:cNvSpPr/>
          <p:nvPr/>
        </p:nvSpPr>
        <p:spPr>
          <a:xfrm>
            <a:off x="5078091" y="5854047"/>
            <a:ext cx="2446659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170E4723-9923-48D1-A143-1074D5EAAA8B}"/>
              </a:ext>
            </a:extLst>
          </p:cNvPr>
          <p:cNvSpPr/>
          <p:nvPr/>
        </p:nvSpPr>
        <p:spPr>
          <a:xfrm>
            <a:off x="6105222" y="6015999"/>
            <a:ext cx="2395728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EEB4A066-FA39-4C59-AC2F-E3CAB8AB4FFC}"/>
              </a:ext>
            </a:extLst>
          </p:cNvPr>
          <p:cNvSpPr/>
          <p:nvPr/>
        </p:nvSpPr>
        <p:spPr>
          <a:xfrm>
            <a:off x="638084" y="6050573"/>
            <a:ext cx="2880360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318FA3F7-2D5F-43E7-B605-1D38816A1658}"/>
              </a:ext>
            </a:extLst>
          </p:cNvPr>
          <p:cNvSpPr/>
          <p:nvPr/>
        </p:nvSpPr>
        <p:spPr>
          <a:xfrm>
            <a:off x="859352" y="6241118"/>
            <a:ext cx="2888736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D60A6D1F-8FB1-4A3E-8E3D-706E906ECDE6}"/>
              </a:ext>
            </a:extLst>
          </p:cNvPr>
          <p:cNvSpPr/>
          <p:nvPr/>
        </p:nvSpPr>
        <p:spPr>
          <a:xfrm>
            <a:off x="5967821" y="6198910"/>
            <a:ext cx="2840422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7433D013-DF68-4241-A9FE-837D4E4A3CC5}"/>
              </a:ext>
            </a:extLst>
          </p:cNvPr>
          <p:cNvSpPr/>
          <p:nvPr/>
        </p:nvSpPr>
        <p:spPr>
          <a:xfrm>
            <a:off x="1123383" y="6414637"/>
            <a:ext cx="3910580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7D3B13D0-A08E-435C-977A-9C2DC894F0CC}"/>
              </a:ext>
            </a:extLst>
          </p:cNvPr>
          <p:cNvSpPr/>
          <p:nvPr/>
        </p:nvSpPr>
        <p:spPr>
          <a:xfrm>
            <a:off x="1123382" y="6582650"/>
            <a:ext cx="5335045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E61A5873-F2E5-43A4-94BF-3CD5D0D609FF}"/>
              </a:ext>
            </a:extLst>
          </p:cNvPr>
          <p:cNvSpPr/>
          <p:nvPr/>
        </p:nvSpPr>
        <p:spPr>
          <a:xfrm>
            <a:off x="1562100" y="3075966"/>
            <a:ext cx="7024688" cy="10667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1E0933DB-9B64-47C4-8A3B-C7BB5BB3A6EB}"/>
              </a:ext>
            </a:extLst>
          </p:cNvPr>
          <p:cNvSpPr/>
          <p:nvPr/>
        </p:nvSpPr>
        <p:spPr>
          <a:xfrm>
            <a:off x="571639" y="3071743"/>
            <a:ext cx="8241367" cy="1066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808586F-FE7E-4C74-BD9D-F3B51B37C2EA}"/>
              </a:ext>
            </a:extLst>
          </p:cNvPr>
          <p:cNvSpPr txBox="1"/>
          <p:nvPr/>
        </p:nvSpPr>
        <p:spPr>
          <a:xfrm>
            <a:off x="3810496" y="3750244"/>
            <a:ext cx="19552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Dehydrin family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513A09E3-AEA3-41EF-A77D-04B39EF66A26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2</a:t>
            </a:r>
          </a:p>
        </p:txBody>
      </p:sp>
    </p:spTree>
    <p:extLst>
      <p:ext uri="{BB962C8B-B14F-4D97-AF65-F5344CB8AC3E}">
        <p14:creationId xmlns:p14="http://schemas.microsoft.com/office/powerpoint/2010/main" val="18541004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3F9A7B7-2E25-6949-7C3A-6E7A37D022EA}"/>
              </a:ext>
            </a:extLst>
          </p:cNvPr>
          <p:cNvSpPr txBox="1"/>
          <p:nvPr/>
        </p:nvSpPr>
        <p:spPr>
          <a:xfrm>
            <a:off x="909730" y="3532350"/>
            <a:ext cx="8991559" cy="233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87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TLITDHVCSLSAGDRVDSLLDALSRLRGTLRLKTKM</a:t>
            </a:r>
            <a:r>
              <a:rPr lang="en-US" sz="87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DTGKGSSV</a:t>
            </a:r>
            <a:r>
              <a:rPr lang="en-US" sz="87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CNDSCGCPSPCPGGNSCRCR</a:t>
            </a:r>
            <a:r>
              <a:rPr lang="en-US" sz="87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RE</a:t>
            </a:r>
            <a:r>
              <a:rPr lang="en-US" sz="87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SAGDQGHMVCPCGEHCGCNPCNCPKTQTQ</a:t>
            </a:r>
            <a:r>
              <a:rPr lang="en-US" sz="87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87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SAKGCTC</a:t>
            </a:r>
            <a:r>
              <a:rPr lang="en-US" sz="870" dirty="0"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E</a:t>
            </a:r>
            <a:r>
              <a:rPr lang="en-US" sz="87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CTCASCA</a:t>
            </a:r>
            <a:r>
              <a:rPr lang="en-US" sz="87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endParaRPr lang="en-US" sz="87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4CE15BB-8943-4831-86DF-5CE26AD8B7B2}"/>
              </a:ext>
            </a:extLst>
          </p:cNvPr>
          <p:cNvGrpSpPr/>
          <p:nvPr/>
        </p:nvGrpSpPr>
        <p:grpSpPr>
          <a:xfrm>
            <a:off x="-41503" y="266850"/>
            <a:ext cx="9807810" cy="6069146"/>
            <a:chOff x="-41503" y="266850"/>
            <a:chExt cx="9807810" cy="6069146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209785B-4433-403B-B919-B0FA03F89F4C}"/>
                </a:ext>
              </a:extLst>
            </p:cNvPr>
            <p:cNvSpPr txBox="1"/>
            <p:nvPr/>
          </p:nvSpPr>
          <p:spPr>
            <a:xfrm>
              <a:off x="504380" y="3277971"/>
              <a:ext cx="9261927" cy="1652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</a:t>
              </a:r>
              <a:r>
                <a:rPr lang="en-US" sz="4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YASRFLSRSKQLQGGLV</a:t>
              </a:r>
              <a:r>
                <a:rPr lang="en-US" sz="4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LQQQHAIPVRAF</a:t>
              </a:r>
              <a:r>
                <a:rPr lang="en-US" sz="4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KEAARPTFKGDEMLKGVFFDIKNKFQAAVDILRKEKITLDPEDPAAVKQYANVMKTIRQKADMFSESQRIKHDIDTETQDIPDARAYLLKLQEIRTRRGLTDELGAEAMMFEALEKVEKDIKKPLLRSDKKGMDLLVAEFEKGNKKLGIRKEDLPKYEENLELSMAKAQLDELKSDAVEAMESQKK</a:t>
              </a:r>
              <a:r>
                <a:rPr lang="en-US" sz="4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EEFQDEEMPDVKSLDIRNFI</a:t>
              </a:r>
              <a:endParaRPr lang="en-US" sz="4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B324CB8-09CB-48DB-9756-D002F4BCD185}"/>
                </a:ext>
              </a:extLst>
            </p:cNvPr>
            <p:cNvSpPr txBox="1"/>
            <p:nvPr/>
          </p:nvSpPr>
          <p:spPr>
            <a:xfrm>
              <a:off x="506762" y="3098226"/>
              <a:ext cx="9090599" cy="1652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</a:t>
              </a:r>
              <a:r>
                <a:rPr lang="en-US" sz="4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YASRFLSRSKQLQGGLV</a:t>
              </a:r>
              <a:r>
                <a:rPr lang="en-US" sz="4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LQQQHAIPVRAFAKEAARPTFKGDEMLKGVFFDIKNKFQAAVDILRKEKITLDPEDPAAVKQY</a:t>
              </a:r>
              <a:r>
                <a:rPr lang="en-US" sz="4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VMKTIRQKADMFSE</a:t>
              </a:r>
              <a:r>
                <a:rPr lang="en-US" sz="4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QR</a:t>
              </a:r>
              <a:r>
                <a:rPr lang="en-US" sz="4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KHDIDTETQDIPDARAYLLKLQEIRTRRG</a:t>
              </a:r>
              <a:r>
                <a:rPr lang="en-US" sz="4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TDELGAEAMMFEALEKVEKDIKKPLLRSDKKGMDLLVAEFEKGNKKLGIRKEDLPKYEENLELSMAKAQLDELKSDAVEAMESQKKKEEFQDEEMPDVKSLDIRNFI</a:t>
              </a:r>
              <a:endParaRPr lang="en-US" sz="4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41503" y="266850"/>
              <a:ext cx="6635021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2G21870.1: MALE GAMETOPHYTE DEFECTIVE 1; 240 amino acids</a:t>
              </a: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6954E900-A6A7-4CFA-BD68-9A56E7F79D5D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09" t="11065" r="4562" b="11828"/>
            <a:stretch/>
          </p:blipFill>
          <p:spPr>
            <a:xfrm>
              <a:off x="502656" y="716780"/>
              <a:ext cx="8550648" cy="3525292"/>
            </a:xfrm>
            <a:prstGeom prst="rect">
              <a:avLst/>
            </a:prstGeom>
          </p:spPr>
        </p:pic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322154" y="107957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243840" y="157079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322154" y="208466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41354" y="255905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321326" y="305250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01500" y="3546710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281570" y="4042280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251292" y="603346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450820" y="4154692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138443" y="4158759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75308" y="2334072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670806" y="4303383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87699" y="549666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118413" y="5752602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90730" y="589595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1261273" y="5636392"/>
              <a:ext cx="39502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94430" y="5292091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670568" y="5804357"/>
              <a:ext cx="348386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>
              <a:off x="5134642" y="5535312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2</a:t>
              </a:r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1E2ABE54-58ED-4271-8F76-43AA3F9F1919}"/>
                </a:ext>
              </a:extLst>
            </p:cNvPr>
            <p:cNvSpPr/>
            <p:nvPr/>
          </p:nvSpPr>
          <p:spPr>
            <a:xfrm>
              <a:off x="1261273" y="6129347"/>
              <a:ext cx="395020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5134220" y="6038542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2</a:t>
              </a:r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B6C7952F-CBF3-43EE-87BC-2A1429C154B5}"/>
                </a:ext>
              </a:extLst>
            </p:cNvPr>
            <p:cNvSpPr/>
            <p:nvPr/>
          </p:nvSpPr>
          <p:spPr>
            <a:xfrm>
              <a:off x="1261273" y="5978614"/>
              <a:ext cx="227685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98191" y="4545284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19437" y="4853313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87699" y="512792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1261273" y="4886084"/>
              <a:ext cx="223113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CBE04FC4-979A-4662-A436-AE5681E9E219}"/>
                </a:ext>
              </a:extLst>
            </p:cNvPr>
            <p:cNvSpPr/>
            <p:nvPr/>
          </p:nvSpPr>
          <p:spPr>
            <a:xfrm>
              <a:off x="1264699" y="5044502"/>
              <a:ext cx="394106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C6A08A1-E439-4B38-BC6D-EDDAA2F95175}"/>
                </a:ext>
              </a:extLst>
            </p:cNvPr>
            <p:cNvSpPr txBox="1"/>
            <p:nvPr/>
          </p:nvSpPr>
          <p:spPr>
            <a:xfrm>
              <a:off x="5134220" y="4956181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669558" y="5228576"/>
              <a:ext cx="349300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850816" y="415155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5611782" y="416721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7368858" y="416149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604446" y="691335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299664" y="860612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E721313-C9D3-4C3C-8ABA-E2D74CD39C0E}"/>
                </a:ext>
              </a:extLst>
            </p:cNvPr>
            <p:cNvSpPr txBox="1"/>
            <p:nvPr/>
          </p:nvSpPr>
          <p:spPr>
            <a:xfrm>
              <a:off x="1946316" y="3869972"/>
              <a:ext cx="59924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Mitochondrial ATP synthase subunit family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BF828211-D1FC-492C-AFD7-95774F301D59}"/>
                </a:ext>
              </a:extLst>
            </p:cNvPr>
            <p:cNvSpPr/>
            <p:nvPr/>
          </p:nvSpPr>
          <p:spPr>
            <a:xfrm>
              <a:off x="1714499" y="3168930"/>
              <a:ext cx="6531769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B08C0D14-3FA2-4F37-A346-58C06CF1C6DA}"/>
                </a:ext>
              </a:extLst>
            </p:cNvPr>
            <p:cNvSpPr/>
            <p:nvPr/>
          </p:nvSpPr>
          <p:spPr>
            <a:xfrm>
              <a:off x="590687" y="3169374"/>
              <a:ext cx="839138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31BC8AD2-36A1-4657-AEE9-61AA3FFDD8CB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FA01DA0-0BBF-843F-FA75-B23A587CDA48}"/>
              </a:ext>
            </a:extLst>
          </p:cNvPr>
          <p:cNvSpPr txBox="1"/>
          <p:nvPr/>
        </p:nvSpPr>
        <p:spPr>
          <a:xfrm>
            <a:off x="586434" y="6438396"/>
            <a:ext cx="48190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2G21870.2 (220 aa).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A37C99A-0257-B72F-A600-0AEC7550178D}"/>
              </a:ext>
            </a:extLst>
          </p:cNvPr>
          <p:cNvSpPr/>
          <p:nvPr/>
        </p:nvSpPr>
        <p:spPr>
          <a:xfrm>
            <a:off x="8280572" y="6424512"/>
            <a:ext cx="704088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0D7790-722C-F162-0E94-72516BFD7670}"/>
              </a:ext>
            </a:extLst>
          </p:cNvPr>
          <p:cNvSpPr txBox="1"/>
          <p:nvPr/>
        </p:nvSpPr>
        <p:spPr>
          <a:xfrm>
            <a:off x="6113016" y="6141582"/>
            <a:ext cx="299665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20 aa deletion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243245398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A835DB6-ADB0-40EF-A801-FCB0F5317533}"/>
              </a:ext>
            </a:extLst>
          </p:cNvPr>
          <p:cNvGrpSpPr/>
          <p:nvPr/>
        </p:nvGrpSpPr>
        <p:grpSpPr>
          <a:xfrm>
            <a:off x="-63822" y="283960"/>
            <a:ext cx="9597098" cy="5410365"/>
            <a:chOff x="-63822" y="283960"/>
            <a:chExt cx="9597098" cy="5410365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E289131-A1BA-4791-B370-E3EC3603421A}"/>
                </a:ext>
              </a:extLst>
            </p:cNvPr>
            <p:cNvSpPr txBox="1"/>
            <p:nvPr/>
          </p:nvSpPr>
          <p:spPr>
            <a:xfrm>
              <a:off x="747473" y="2971403"/>
              <a:ext cx="8785803" cy="1292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TKKRKLESESNETSEPTEKQQQQCEKEDPEIRNVDNQRDDDEQVVEQDTLKEMHEEEAKGEDNIEAETSSGSGNQGNEDDDEEEPIEDLLEPFSKDQLLILLKEAAERHRDVANRIRIVADEDLVHRK</a:t>
              </a:r>
              <a:r>
                <a:rPr lang="en-US" sz="2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IFVHGLGWDTKADSLIDAFKQYGEIEDCKCVVDKVSGQSKGYGFILFKSRSGARNALKQPQK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KIGTRMTACQLASIGPVQGNPVVAPAQHFNPENVQRK</a:t>
              </a:r>
              <a:r>
                <a:rPr lang="en-US" sz="2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IYVSNVSADIDPQKLLEFFSRFGEIEEGPLGLDKATGRPKGFALFVYRSLESAKKALEEPHKTFEGHVLH</a:t>
              </a:r>
              <a:r>
                <a:rPr lang="en-US" sz="2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CHKANDGPKQVKQHQHNHN</a:t>
              </a:r>
              <a:r>
                <a:rPr lang="en-US" sz="2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SHNQ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NSRYQRNDNNGYGAPGGHGHFIAGNNQAVQAFNPAIGQALTALLASQGAGLGLNQAFGQALLGTLGTASPGAVGGMPSGYGTQANISPGVYPGYGAQAGYQGGYQTQQPGQGGAGRGQHGAGYGGPYMGR</a:t>
              </a:r>
              <a:endParaRPr lang="en-US" sz="230" dirty="0"/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26CC34B-70F3-4375-B6E0-C2CFC5095F15}"/>
                </a:ext>
              </a:extLst>
            </p:cNvPr>
            <p:cNvSpPr txBox="1"/>
            <p:nvPr/>
          </p:nvSpPr>
          <p:spPr>
            <a:xfrm>
              <a:off x="748603" y="2862262"/>
              <a:ext cx="8739429" cy="1284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TKKRKLESESNETSEPTEKQQQQCEKEDPEIRNVDNQRDDDEQVVEQDTLKEMHEEEAKGEDNIEAETSSGSGNQGNEDDDEEEPIEDLLEPFSKDQLLILLKEAAERHRDVANRIRIVADEDLVHRKIFVHGLGWDTKADSLIDAFKQYGEIEDCKCVVDKVSGQSKGYGFILFKSRSGARNALKQPQKKIGTRMTACQLASIGPVQGNPVVAPAQHFNPENVQRKIYVSNVSADIDPQKLLEFFSRFGEI</a:t>
              </a:r>
              <a:r>
                <a:rPr lang="en-US" sz="2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EEGPLGLDKATGRPKGFALFVYRSLESAKKALEEPHKTFEGHVLHCHKANDGPKQVKQHQHNHN</a:t>
              </a:r>
              <a:r>
                <a:rPr lang="en-US" sz="2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SHNQ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NSRYQRNDNNGYGAPGGHGHFIAGNNQAVQAFNPAIGQALTALLASQGAGLGLNQAFGQALLGTLGTASPGAVGGMPSGYGTQANISPGVYPGYGAQAGYQGGYQTQQPGQGGAGRGQHGAGYGGPYMGR</a:t>
              </a:r>
              <a:endParaRPr lang="en-US" sz="230" dirty="0"/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08137C7E-029D-46EC-BA1D-27B811825D34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19" t="10820" r="4679" b="11506"/>
            <a:stretch/>
          </p:blipFill>
          <p:spPr>
            <a:xfrm>
              <a:off x="768763" y="702232"/>
              <a:ext cx="8010474" cy="3551276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83960"/>
              <a:ext cx="9004000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2G</a:t>
              </a:r>
              <a:r>
                <a:rPr lang="en-US" sz="18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1060.1, .2 or .3</a:t>
              </a:r>
              <a:r>
                <a:rPr lang="en-US" sz="1867" dirty="0"/>
                <a:t>: </a:t>
              </a:r>
              <a:r>
                <a:rPr lang="en-US" dirty="0">
                  <a:latin typeface="Calibri" panose="020F0502020204030204" pitchFamily="34" charset="0"/>
                  <a:cs typeface="Times New Roman" panose="02020603050405020304" pitchFamily="18" charset="0"/>
                </a:rPr>
                <a:t>RNA-BINDING (RRM/RBD/RNP MOTIFS) family protein; 4</a:t>
              </a:r>
              <a:r>
                <a:rPr lang="en-US" sz="1867" dirty="0"/>
                <a:t>51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557513" y="103732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93385" y="146167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552549" y="186931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86073" y="232514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56423" y="275081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435154" y="3189521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513760" y="3624472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492745" y="610699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702229" y="4153754"/>
              <a:ext cx="27122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350423" y="4157506"/>
              <a:ext cx="444352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458903" y="2287671"/>
              <a:ext cx="1833323" cy="271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353415" y="4329922"/>
              <a:ext cx="2524474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365891" y="5432510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738186" y="5134148"/>
              <a:ext cx="4858126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5139426" y="5483209"/>
              <a:ext cx="117957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 flipH="1">
              <a:off x="6251736" y="5396871"/>
              <a:ext cx="51283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734552" y="4605390"/>
              <a:ext cx="4598024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344167" y="4828540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337961" y="4992461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5136416" y="4949313"/>
              <a:ext cx="111556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5134664" y="5104321"/>
              <a:ext cx="118872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6242992" y="5015229"/>
              <a:ext cx="359393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434210" y="4039128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4099468" y="4153982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7625669" y="4163324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8495826" y="4165121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4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09996" y="705986"/>
              <a:ext cx="15146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005214" y="875263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7C4BFD75-EA0A-4447-A95D-7F07B408C6F6}"/>
                </a:ext>
              </a:extLst>
            </p:cNvPr>
            <p:cNvSpPr txBox="1"/>
            <p:nvPr/>
          </p:nvSpPr>
          <p:spPr>
            <a:xfrm>
              <a:off x="5855006" y="4166579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98568E51-B60F-4F02-8EDB-1369594590F7}"/>
                </a:ext>
              </a:extLst>
            </p:cNvPr>
            <p:cNvSpPr txBox="1"/>
            <p:nvPr/>
          </p:nvSpPr>
          <p:spPr>
            <a:xfrm>
              <a:off x="6736395" y="4161334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72066E32-923D-4B9A-B2A2-BB080E34FEDC}"/>
                </a:ext>
              </a:extLst>
            </p:cNvPr>
            <p:cNvSpPr txBox="1"/>
            <p:nvPr/>
          </p:nvSpPr>
          <p:spPr>
            <a:xfrm>
              <a:off x="4990616" y="4161334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9331D8D-02E7-4721-A1C0-0C3306A27A2B}"/>
                </a:ext>
              </a:extLst>
            </p:cNvPr>
            <p:cNvSpPr txBox="1"/>
            <p:nvPr/>
          </p:nvSpPr>
          <p:spPr>
            <a:xfrm>
              <a:off x="3232671" y="4159519"/>
              <a:ext cx="444352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D9950A28-610C-4823-9055-CB9BB8E87896}"/>
                </a:ext>
              </a:extLst>
            </p:cNvPr>
            <p:cNvSpPr txBox="1"/>
            <p:nvPr/>
          </p:nvSpPr>
          <p:spPr>
            <a:xfrm>
              <a:off x="1510175" y="4156863"/>
              <a:ext cx="357790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0E725C1-2DAF-4700-A869-C75A0E398308}"/>
                </a:ext>
              </a:extLst>
            </p:cNvPr>
            <p:cNvSpPr txBox="1"/>
            <p:nvPr/>
          </p:nvSpPr>
          <p:spPr>
            <a:xfrm>
              <a:off x="2427708" y="3864145"/>
              <a:ext cx="436478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RRM1 (RNA recognition motif) family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15CF7824-785F-4AA0-9B36-9D425C248D10}"/>
                </a:ext>
              </a:extLst>
            </p:cNvPr>
            <p:cNvSpPr/>
            <p:nvPr/>
          </p:nvSpPr>
          <p:spPr>
            <a:xfrm>
              <a:off x="3090863" y="2855403"/>
              <a:ext cx="1083468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5939CFF9-3BBC-4C96-838A-F5FE305EFB11}"/>
                </a:ext>
              </a:extLst>
            </p:cNvPr>
            <p:cNvSpPr/>
            <p:nvPr/>
          </p:nvSpPr>
          <p:spPr>
            <a:xfrm>
              <a:off x="4819649" y="2857392"/>
              <a:ext cx="1223963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BF9C3C24-E45B-40A4-8592-22A6F83CE10F}"/>
                </a:ext>
              </a:extLst>
            </p:cNvPr>
            <p:cNvSpPr/>
            <p:nvPr/>
          </p:nvSpPr>
          <p:spPr>
            <a:xfrm>
              <a:off x="833582" y="2852665"/>
              <a:ext cx="7893700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1704380D-A8B7-46B3-A3AC-788A74E42944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4</a:t>
            </a:r>
          </a:p>
        </p:txBody>
      </p:sp>
    </p:spTree>
    <p:extLst>
      <p:ext uri="{BB962C8B-B14F-4D97-AF65-F5344CB8AC3E}">
        <p14:creationId xmlns:p14="http://schemas.microsoft.com/office/powerpoint/2010/main" val="37765789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B0A8443-1084-49AB-932A-0F0FACF9D70B}"/>
              </a:ext>
            </a:extLst>
          </p:cNvPr>
          <p:cNvGrpSpPr/>
          <p:nvPr/>
        </p:nvGrpSpPr>
        <p:grpSpPr>
          <a:xfrm>
            <a:off x="-54297" y="283960"/>
            <a:ext cx="10028591" cy="5886738"/>
            <a:chOff x="-54297" y="283960"/>
            <a:chExt cx="10028591" cy="5886738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6252F88-1F0B-4DBC-A5A3-3C216943083D}"/>
                </a:ext>
              </a:extLst>
            </p:cNvPr>
            <p:cNvSpPr txBox="1"/>
            <p:nvPr/>
          </p:nvSpPr>
          <p:spPr>
            <a:xfrm>
              <a:off x="760590" y="3154452"/>
              <a:ext cx="9213704" cy="23326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8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LITDHVCSLSAGDRVDSLLDALSRLRGTLRLKTKM</a:t>
              </a:r>
              <a:r>
                <a:rPr lang="en-US" sz="8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DTGKGSSV</a:t>
              </a:r>
              <a:r>
                <a:rPr lang="en-US" sz="8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87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CNDSCGCPSPCPGGNSCRCRMREASAGDQGHMVCPCGEHCGCNPCNCPKTQTQTSAKGCTCGEGCTCASCA</a:t>
              </a:r>
              <a:r>
                <a:rPr lang="en-US" sz="8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endParaRPr lang="en-US" sz="8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37CB2DD-7B9A-44C2-B83B-55C5DC18DFA9}"/>
                </a:ext>
              </a:extLst>
            </p:cNvPr>
            <p:cNvSpPr txBox="1"/>
            <p:nvPr/>
          </p:nvSpPr>
          <p:spPr>
            <a:xfrm>
              <a:off x="759242" y="2598026"/>
              <a:ext cx="8991559" cy="23326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8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LITDHVCSLSAGDRVDSLLDALSRLRGTLRLKTKM</a:t>
              </a:r>
              <a:r>
                <a:rPr lang="en-US" sz="8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DTGKGSSV</a:t>
              </a:r>
              <a:r>
                <a:rPr lang="en-US" sz="8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GCNDSCGCPSPCPGGNSCRCR</a:t>
              </a:r>
              <a:r>
                <a:rPr lang="en-US" sz="87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E</a:t>
              </a:r>
              <a:r>
                <a:rPr lang="en-US" sz="8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SAGDQGHMVCPCGEHCGCNPCNCPKTQTQ</a:t>
              </a:r>
              <a:r>
                <a:rPr lang="en-US" sz="8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8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AKGCTC</a:t>
              </a:r>
              <a:r>
                <a:rPr lang="en-US" sz="87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E</a:t>
              </a:r>
              <a:r>
                <a:rPr lang="en-US" sz="8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CTCASCA</a:t>
              </a:r>
              <a:r>
                <a:rPr lang="en-US" sz="8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endParaRPr lang="en-US" sz="8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1A25FDBD-627F-4D91-A0D9-A397637699CD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43" t="10569" r="4826" b="11924"/>
            <a:stretch/>
          </p:blipFill>
          <p:spPr>
            <a:xfrm>
              <a:off x="759242" y="677987"/>
              <a:ext cx="8137107" cy="3543611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4297" y="283960"/>
              <a:ext cx="784099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2G42000.2: ARABIDOPSIS THALIANA METALLOTHIONEIN 4A; 120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76187" y="605351"/>
              <a:ext cx="464229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81452" y="1937025"/>
              <a:ext cx="464229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4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541026" y="91835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36716" y="298639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2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52579" y="262470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429461" y="3326830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4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28562" y="3682095"/>
              <a:ext cx="501633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6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469747" y="1264518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8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707199" y="4139575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8628111" y="4153953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2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40437" y="2403736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58818" y="4324055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347650" y="572343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738150" y="5530364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C2F98FBF-DA76-4FFF-A746-27A705A0BA3A}"/>
                </a:ext>
              </a:extLst>
            </p:cNvPr>
            <p:cNvSpPr/>
            <p:nvPr/>
          </p:nvSpPr>
          <p:spPr>
            <a:xfrm>
              <a:off x="3916031" y="5878017"/>
              <a:ext cx="493776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B6C7952F-CBF3-43EE-87BC-2A1429C154B5}"/>
                </a:ext>
              </a:extLst>
            </p:cNvPr>
            <p:cNvSpPr/>
            <p:nvPr/>
          </p:nvSpPr>
          <p:spPr>
            <a:xfrm>
              <a:off x="3916031" y="6060970"/>
              <a:ext cx="43434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734618" y="4576202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341201" y="477771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372841" y="5030422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341138" y="5164506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3916031" y="4914554"/>
              <a:ext cx="492861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764991" y="4815275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0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3916031" y="5074109"/>
              <a:ext cx="167335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3319542" y="5262235"/>
              <a:ext cx="553212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8776938" y="515611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3319501" y="5437941"/>
              <a:ext cx="43434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482938" y="1601451"/>
              <a:ext cx="462048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6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416406" y="4018050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8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1936537" y="4139148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7293008" y="415395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3281959" y="4153954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4645485" y="4157152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5990907" y="4146654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65963" y="664034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61181" y="833311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9B59F06-704E-4A41-85A7-2B9BFE57A53B}"/>
                </a:ext>
              </a:extLst>
            </p:cNvPr>
            <p:cNvSpPr txBox="1"/>
            <p:nvPr/>
          </p:nvSpPr>
          <p:spPr>
            <a:xfrm>
              <a:off x="488455" y="2284414"/>
              <a:ext cx="464229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79C7B24-F004-459A-88F0-EB27C68AAFA6}"/>
                </a:ext>
              </a:extLst>
            </p:cNvPr>
            <p:cNvSpPr txBox="1"/>
            <p:nvPr/>
          </p:nvSpPr>
          <p:spPr>
            <a:xfrm>
              <a:off x="4921833" y="3604988"/>
              <a:ext cx="3462925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 err="1"/>
                <a:t>Metallothio</a:t>
              </a:r>
              <a:r>
                <a:rPr lang="en-US" dirty="0"/>
                <a:t> PEC (Plant PEC family metallothionein) family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B53FF724-53EF-42F8-BCC3-B1E7E4D89EFB}"/>
                </a:ext>
              </a:extLst>
            </p:cNvPr>
            <p:cNvSpPr/>
            <p:nvPr/>
          </p:nvSpPr>
          <p:spPr>
            <a:xfrm>
              <a:off x="3988593" y="2747636"/>
              <a:ext cx="4795837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4EA3804F-CF28-44F6-8CDE-DE7A7414D2E2}"/>
                </a:ext>
              </a:extLst>
            </p:cNvPr>
            <p:cNvSpPr/>
            <p:nvPr/>
          </p:nvSpPr>
          <p:spPr>
            <a:xfrm>
              <a:off x="840725" y="2746675"/>
              <a:ext cx="8012764" cy="1097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840AB7AC-D7A7-4917-B555-F15E1ACFBEBA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7867ED-9B99-B461-D804-181C81DA1355}"/>
              </a:ext>
            </a:extLst>
          </p:cNvPr>
          <p:cNvSpPr txBox="1"/>
          <p:nvPr/>
        </p:nvSpPr>
        <p:spPr>
          <a:xfrm>
            <a:off x="727509" y="6522326"/>
            <a:ext cx="4714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2G42000.1 (84 aa)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E8E41FD-FDD2-7549-ED07-4593C2176406}"/>
              </a:ext>
            </a:extLst>
          </p:cNvPr>
          <p:cNvSpPr/>
          <p:nvPr/>
        </p:nvSpPr>
        <p:spPr>
          <a:xfrm>
            <a:off x="845486" y="6402883"/>
            <a:ext cx="2395728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1BF00D9-A036-6DA4-81E5-63259B68F2A5}"/>
              </a:ext>
            </a:extLst>
          </p:cNvPr>
          <p:cNvSpPr txBox="1"/>
          <p:nvPr/>
        </p:nvSpPr>
        <p:spPr>
          <a:xfrm>
            <a:off x="759242" y="6159774"/>
            <a:ext cx="299665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36 aa deletion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287764113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D23FC13-5679-4797-A8A9-1A0D7E787028}"/>
              </a:ext>
            </a:extLst>
          </p:cNvPr>
          <p:cNvGrpSpPr/>
          <p:nvPr/>
        </p:nvGrpSpPr>
        <p:grpSpPr>
          <a:xfrm>
            <a:off x="-24910" y="254776"/>
            <a:ext cx="9747362" cy="5555489"/>
            <a:chOff x="-24910" y="254776"/>
            <a:chExt cx="9747362" cy="5555489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9691637-8B4A-45C5-A90D-A882914F0C66}"/>
                </a:ext>
              </a:extLst>
            </p:cNvPr>
            <p:cNvSpPr txBox="1"/>
            <p:nvPr/>
          </p:nvSpPr>
          <p:spPr>
            <a:xfrm>
              <a:off x="507960" y="2858698"/>
              <a:ext cx="9214492" cy="1409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RVSPKTVDDAVKALVKEGNEKSRTEKPQL</a:t>
              </a:r>
              <a:r>
                <a:rPr lang="en-US" sz="30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EEDGFFYLVVALKKIPQRNFTNAYRIPLPHPLINTTEDSPELCLIIDDRPESGLTEEDAKKNIKSENIPITKVVKLSKLKSDYGSFESKRKLCDSYDMFFSDRRVIPMLPKLIGKKFFQSKKTPVAIDLKHMNWKEQIEKACGAAMFFMRTGSCSAIKVAKLSMESDDIVENVTATLNGVVDVLPSRWKYIRSLHLKLSES</a:t>
              </a:r>
              <a:r>
                <a:rPr lang="en-US" sz="30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SLPLYQTVPYLQLKIDPLGVEE</a:t>
              </a:r>
              <a:r>
                <a:rPr lang="en-US" sz="3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NGEGLAKSDVDDSSSKSVKTKKKNGKIHEVRYMDSNVSETLGDDEFDRSVGEDEVA</a:t>
              </a:r>
              <a:r>
                <a:rPr lang="en-US" sz="3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DLNASGDKKKRKKMSSSKSAVSGKPDI</a:t>
              </a:r>
              <a:r>
                <a:rPr lang="en-US" sz="30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</a:t>
              </a:r>
              <a:r>
                <a:rPr lang="en-US" sz="3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KNGQKSKKLKKDIDESGGGFKAKTKRR</a:t>
              </a:r>
              <a:endParaRPr lang="en-US" sz="3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52974AE-4041-4EFA-B323-A3C0F1BE2A2E}"/>
                </a:ext>
              </a:extLst>
            </p:cNvPr>
            <p:cNvSpPr txBox="1"/>
            <p:nvPr/>
          </p:nvSpPr>
          <p:spPr>
            <a:xfrm>
              <a:off x="504471" y="3324794"/>
              <a:ext cx="8910031" cy="1409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RVSPKTVDDAVKALVKEGNEKSRTEKPQLLEEDGFFYLVVALKKIPQRNFTNAYRIPLPHPLINTTEDSPELCLIIDDRPESGLTEEDAKKNIKSENIPITKVVKLSKLKSDYGSFESKRKLCDSYDMFFSDRRVIPMLPKLIGKKFFQSKKTPVAIDLKHMNWKEQIEKACGAAMFFMRTGSCSAIKV</a:t>
              </a:r>
              <a:r>
                <a:rPr lang="en-US" sz="30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KLSMESDDIVENVTATLNGVVDVLPSRWKYIRSLHLKLSESLSLPLYQTVPYLQLKIDPLGVEE</a:t>
              </a:r>
              <a:r>
                <a:rPr lang="en-US" sz="3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NGEGLAKSDVDDSSSKSVKTKKKNGKIHEVRYMDSNVSETLGDDEFDRSVGEDEVA</a:t>
              </a:r>
              <a:r>
                <a:rPr lang="en-US" sz="3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DLNASGDKKKRKKMSSSKSAVSGKPDI</a:t>
              </a:r>
              <a:r>
                <a:rPr lang="en-US" sz="30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</a:t>
              </a:r>
              <a:r>
                <a:rPr lang="en-US" sz="3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KNGQKSKKLKKDIDESGGGFKAKTKRR</a:t>
              </a:r>
              <a:endParaRPr lang="en-US" sz="3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130A4262-2F22-46E6-A466-5C945DED68A2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35" t="10967" r="4490" b="11491"/>
            <a:stretch/>
          </p:blipFill>
          <p:spPr>
            <a:xfrm>
              <a:off x="537362" y="715752"/>
              <a:ext cx="8415178" cy="3545223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24910" y="254776"/>
              <a:ext cx="6806800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2G42650: RIBOSOMAL PROTEIN L1P/L10e family; 372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326693" y="98152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261504" y="137552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310918" y="177297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54471" y="214452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313971" y="252708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04824" y="2900838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269350" y="3265038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251152" y="620955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460274" y="4158195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589955" y="4169161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92345" y="2352982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46061" y="4317045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126668" y="549332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81769" y="5176513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86390" y="4570257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93739" y="4778540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26668" y="5027120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968C584B-562E-43FF-B33B-E3B34B614107}"/>
                </a:ext>
              </a:extLst>
            </p:cNvPr>
            <p:cNvSpPr txBox="1"/>
            <p:nvPr/>
          </p:nvSpPr>
          <p:spPr>
            <a:xfrm>
              <a:off x="8781346" y="4750041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6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8791709" y="4914628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271581" y="4025553"/>
              <a:ext cx="364731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195657" y="3661755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4809809" y="416358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7038433" y="416439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8154664" y="416227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923221" y="416217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3696477" y="416603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1501349" y="415953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6403785" y="726088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099003" y="895365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7574576" y="4845150"/>
              <a:ext cx="128930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7574576" y="5020031"/>
              <a:ext cx="128016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4838263" y="5519202"/>
              <a:ext cx="339242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505D75FF-2114-4A6A-BDD3-8A9BAD955226}"/>
                </a:ext>
              </a:extLst>
            </p:cNvPr>
            <p:cNvSpPr/>
            <p:nvPr/>
          </p:nvSpPr>
          <p:spPr>
            <a:xfrm>
              <a:off x="4838263" y="5703593"/>
              <a:ext cx="143560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6B6F372-5914-41F3-B8F2-2E15CE485976}"/>
                </a:ext>
              </a:extLst>
            </p:cNvPr>
            <p:cNvSpPr txBox="1"/>
            <p:nvPr/>
          </p:nvSpPr>
          <p:spPr>
            <a:xfrm>
              <a:off x="1670516" y="3847842"/>
              <a:ext cx="34629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Ribosomal L1 (L1p/L10e) family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F02A5E83-D7D4-4A91-BF69-DA90B779C1F9}"/>
                </a:ext>
              </a:extLst>
            </p:cNvPr>
            <p:cNvSpPr/>
            <p:nvPr/>
          </p:nvSpPr>
          <p:spPr>
            <a:xfrm>
              <a:off x="1288257" y="2618083"/>
              <a:ext cx="4488656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BD49E35-BB52-4485-B359-CF33D185649E}"/>
                </a:ext>
              </a:extLst>
            </p:cNvPr>
            <p:cNvSpPr/>
            <p:nvPr/>
          </p:nvSpPr>
          <p:spPr>
            <a:xfrm>
              <a:off x="588307" y="2615956"/>
              <a:ext cx="8286612" cy="1097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9DD89D88-5E75-4999-B69B-AEBDD048D0D1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6</a:t>
            </a:r>
          </a:p>
        </p:txBody>
      </p:sp>
    </p:spTree>
    <p:extLst>
      <p:ext uri="{BB962C8B-B14F-4D97-AF65-F5344CB8AC3E}">
        <p14:creationId xmlns:p14="http://schemas.microsoft.com/office/powerpoint/2010/main" val="277415925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B7EEFD3B-341B-4701-898F-2EA78A3A8121}"/>
              </a:ext>
            </a:extLst>
          </p:cNvPr>
          <p:cNvGrpSpPr/>
          <p:nvPr/>
        </p:nvGrpSpPr>
        <p:grpSpPr>
          <a:xfrm>
            <a:off x="-77269" y="283960"/>
            <a:ext cx="9756389" cy="5441578"/>
            <a:chOff x="-77269" y="283960"/>
            <a:chExt cx="9756389" cy="5441578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FB734D1-E459-4DA7-AC15-49F50E6D06F5}"/>
                </a:ext>
              </a:extLst>
            </p:cNvPr>
            <p:cNvSpPr txBox="1"/>
            <p:nvPr/>
          </p:nvSpPr>
          <p:spPr>
            <a:xfrm>
              <a:off x="674059" y="3215002"/>
              <a:ext cx="9005061" cy="1442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DKK</a:t>
              </a:r>
              <a:r>
                <a:rPr lang="en-US" sz="32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RIGINGFGRIGRLVARVVLQRDDVELVAVNDPFITTEYMTYMFKYDSVHGQWKHNELKIKDEKTLLFGEKPVTVFGIRNPEDIPWAEAGADYVVESTGVFTDK</a:t>
              </a:r>
              <a:r>
                <a:rPr lang="en-US" sz="3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KAAAHLKGGAKKVVISAPSKDAPMFVVGVNEHEYKSDLDIVSNASCTTNC</a:t>
              </a:r>
              <a:r>
                <a:rPr lang="en-US" sz="32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PLAKVINDRFGIVEGLMTTVHSITATQKTVDGPSMKDWRGGRAASFNIIPSSTGAAKAVGKVLPALNGKLTGMSFRVPTVDVSVVDLTVRLEKAATYDEIKKAIKEESEGKLKGILGYTEDDVVSTDFVGDNRSSIFDAKAGIALSDKFVKLVSWY</a:t>
              </a:r>
              <a:r>
                <a:rPr lang="en-US" sz="3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NEWGYSSRVVDLIVHMSKA</a:t>
              </a:r>
              <a:endParaRPr lang="en-US" sz="32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5106766-ADF0-4CE9-BC1A-B13FE23EA6C4}"/>
                </a:ext>
              </a:extLst>
            </p:cNvPr>
            <p:cNvSpPr txBox="1"/>
            <p:nvPr/>
          </p:nvSpPr>
          <p:spPr>
            <a:xfrm>
              <a:off x="672988" y="2967954"/>
              <a:ext cx="8786993" cy="1415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32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ADKKIRIGINGFGRIGRLVARVVLQRDDVELVAVNDPFITTEYMTYMFKYDSVHGQWKHNELKIKDEKTLLFGEKPVTVFGIRNPEDIPWAEAGADYVVESTGVFTDKDKAAAHLKGGAKKVVISAPSKDAPMFVVGVNEHEYKSDLDIVSNASCTTNCLAPLAKVINDRFGIVEG</a:t>
              </a:r>
              <a:r>
                <a:rPr lang="en-US" sz="32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L</a:t>
              </a:r>
              <a:r>
                <a:rPr lang="en-US" sz="32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M</a:t>
              </a:r>
              <a:r>
                <a:rPr lang="en-US" sz="32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TTVHSITATQKTVDGPSMKDWRGGRAASFNIIPSSTGAAKAVGKVLPALNGKLTGMSFRVPTVDVSVVDLTVRLEKAATYDEIKKAIKEESEGKLKG</a:t>
              </a:r>
              <a:r>
                <a:rPr lang="en-US" sz="32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ILGYTEDDVVSTDFVGDNRSSIFDAKAGIALSDKFVKLVSWYDNEWGYSSRVVDLIVHMSKA</a:t>
              </a:r>
              <a:endParaRPr lang="en-US" sz="320" dirty="0"/>
            </a:p>
          </p:txBody>
        </p:sp>
        <p:pic>
          <p:nvPicPr>
            <p:cNvPr id="5" name="Picture 4" descr="Chart&#10;&#10;Description automatically generated">
              <a:extLst>
                <a:ext uri="{FF2B5EF4-FFF2-40B4-BE49-F238E27FC236}">
                  <a16:creationId xmlns:a16="http://schemas.microsoft.com/office/drawing/2014/main" id="{34ED5EE0-BE6B-41F6-8270-8955DAE6BDAC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92" t="11251" r="4428" b="11980"/>
            <a:stretch/>
          </p:blipFill>
          <p:spPr>
            <a:xfrm>
              <a:off x="700254" y="754340"/>
              <a:ext cx="8200133" cy="3509879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77269" y="283960"/>
              <a:ext cx="9393982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04120: GLYCERALDEHYDE-3-PHOSPHATE DEHYDROGENASE C SUBUNIT 1; 338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71232" y="63172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99033" y="120291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71232" y="177608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02946" y="2363463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72961" y="290714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61840" y="3510479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56015" y="4057568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22333" y="4184906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906644" y="4181189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22032" y="2377645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320474" y="4368367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194878" y="5420760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4983421" y="5526461"/>
              <a:ext cx="23500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50825" y="5207089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7255096" y="5428083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52516" y="4632530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16545" y="492282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188975" y="506919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4985866" y="4917269"/>
              <a:ext cx="234086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5000517" y="5109948"/>
              <a:ext cx="2340864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7265513" y="501628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5301719" y="418112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7686025" y="4185307"/>
              <a:ext cx="45102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6476882" y="418530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1740003" y="4180604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4095734" y="418665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42583" y="717370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37801" y="886647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32F390E-5727-48C2-B7E6-9C95DF03EACB}"/>
                </a:ext>
              </a:extLst>
            </p:cNvPr>
            <p:cNvSpPr txBox="1"/>
            <p:nvPr/>
          </p:nvSpPr>
          <p:spPr>
            <a:xfrm>
              <a:off x="447069" y="3513068"/>
              <a:ext cx="4258740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 err="1"/>
                <a:t>Gp</a:t>
              </a:r>
              <a:r>
                <a:rPr lang="en-US" dirty="0"/>
                <a:t> dh N (Glyceraldehyde 3-phosphate dehydrogenase, NAD binding domain) family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BDE939D-6CA2-41B1-A2EE-2F31C038B876}"/>
                </a:ext>
              </a:extLst>
            </p:cNvPr>
            <p:cNvSpPr txBox="1"/>
            <p:nvPr/>
          </p:nvSpPr>
          <p:spPr>
            <a:xfrm>
              <a:off x="4487280" y="3716497"/>
              <a:ext cx="4156511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 err="1"/>
                <a:t>Gp</a:t>
              </a:r>
              <a:r>
                <a:rPr lang="en-US" dirty="0"/>
                <a:t> dh C (Glyceraldehyde 3-phosphate dehydrogenase, C-terminal domain) family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FE5F5CFA-D538-493E-BFFB-E6B8ACD022C8}"/>
                </a:ext>
              </a:extLst>
            </p:cNvPr>
            <p:cNvSpPr/>
            <p:nvPr/>
          </p:nvSpPr>
          <p:spPr>
            <a:xfrm>
              <a:off x="883443" y="3033940"/>
              <a:ext cx="2478882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4B29C6CD-AE49-4FC8-A1CC-91751ED63302}"/>
                </a:ext>
              </a:extLst>
            </p:cNvPr>
            <p:cNvSpPr/>
            <p:nvPr/>
          </p:nvSpPr>
          <p:spPr>
            <a:xfrm>
              <a:off x="4576762" y="3034277"/>
              <a:ext cx="3762375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8DD8271-FBA8-4A16-A278-6A1951E39A49}"/>
                </a:ext>
              </a:extLst>
            </p:cNvPr>
            <p:cNvSpPr/>
            <p:nvPr/>
          </p:nvSpPr>
          <p:spPr>
            <a:xfrm>
              <a:off x="757376" y="3028386"/>
              <a:ext cx="8060393" cy="1097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9DB7F657-0053-47AA-8B9A-706D59EF457D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7</a:t>
            </a:r>
          </a:p>
        </p:txBody>
      </p:sp>
    </p:spTree>
    <p:extLst>
      <p:ext uri="{BB962C8B-B14F-4D97-AF65-F5344CB8AC3E}">
        <p14:creationId xmlns:p14="http://schemas.microsoft.com/office/powerpoint/2010/main" val="136678160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BB182C27-AAFF-4A13-855D-DFEBED845120}"/>
              </a:ext>
            </a:extLst>
          </p:cNvPr>
          <p:cNvGrpSpPr/>
          <p:nvPr/>
        </p:nvGrpSpPr>
        <p:grpSpPr>
          <a:xfrm>
            <a:off x="-53465" y="302270"/>
            <a:ext cx="9270083" cy="5440393"/>
            <a:chOff x="-53465" y="302270"/>
            <a:chExt cx="9270083" cy="544039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6A5CB81-0243-4291-AC6A-42F75BC8CE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3033" b="-25542"/>
            <a:stretch/>
          </p:blipFill>
          <p:spPr>
            <a:xfrm>
              <a:off x="779644" y="3019176"/>
              <a:ext cx="8070518" cy="7952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A2C2E33-CBE7-46E0-9C9F-FB647BD66B6B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3217" b="1803"/>
            <a:stretch/>
          </p:blipFill>
          <p:spPr>
            <a:xfrm>
              <a:off x="778668" y="3065587"/>
              <a:ext cx="8058151" cy="68343"/>
            </a:xfrm>
            <a:prstGeom prst="rect">
              <a:avLst/>
            </a:prstGeom>
          </p:spPr>
        </p:pic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D22F5AC6-9F7F-4A86-9AEB-28D9798A91B6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74" t="10688" r="4507" b="11863"/>
            <a:stretch/>
          </p:blipFill>
          <p:spPr>
            <a:xfrm>
              <a:off x="734098" y="733992"/>
              <a:ext cx="8172832" cy="3541012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3465" y="302270"/>
              <a:ext cx="5125634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13290: VARICOSE-RELATED; 1340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56531" y="105860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05548" y="143167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84817" y="192273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96783" y="233822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64839" y="279619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35266" y="3203005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10567" y="3653520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396675" y="685307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33792" y="419784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50039" y="2070673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85131" y="4369445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313540" y="526917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314417" y="5437210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8440629" y="5356632"/>
              <a:ext cx="23774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74733" y="5058978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8A0873A-F8FD-4145-9021-3ACE4A37BAE7}"/>
                </a:ext>
              </a:extLst>
            </p:cNvPr>
            <p:cNvSpPr txBox="1"/>
            <p:nvPr/>
          </p:nvSpPr>
          <p:spPr>
            <a:xfrm>
              <a:off x="8599141" y="5445209"/>
              <a:ext cx="617477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00+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78315" y="4675567"/>
              <a:ext cx="420602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317583" y="489410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8444185" y="5019398"/>
              <a:ext cx="237744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8599604" y="4923505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60311" y="4046625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1759736" y="420067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5363047" y="419809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2950405" y="419831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722375" y="4198048"/>
              <a:ext cx="530915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2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4159961" y="419224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6520728" y="4196337"/>
              <a:ext cx="530915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57497" y="726920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52715" y="896197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D291C22-A3A3-44EB-82EA-F0A26E5D2A99}"/>
                </a:ext>
              </a:extLst>
            </p:cNvPr>
            <p:cNvSpPr txBox="1"/>
            <p:nvPr/>
          </p:nvSpPr>
          <p:spPr>
            <a:xfrm>
              <a:off x="8592154" y="5259241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4DC38771-9B33-4D46-9CBE-34E4BD914953}"/>
                </a:ext>
              </a:extLst>
            </p:cNvPr>
            <p:cNvSpPr/>
            <p:nvPr/>
          </p:nvSpPr>
          <p:spPr>
            <a:xfrm>
              <a:off x="8445282" y="5543477"/>
              <a:ext cx="237744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5B5046D-46F2-43A7-AB48-1B80BDB18557}"/>
                </a:ext>
              </a:extLst>
            </p:cNvPr>
            <p:cNvSpPr txBox="1"/>
            <p:nvPr/>
          </p:nvSpPr>
          <p:spPr>
            <a:xfrm>
              <a:off x="865234" y="3724350"/>
              <a:ext cx="3897266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WD40 region of Ge1, enhancer of mRNA-</a:t>
              </a:r>
              <a:r>
                <a:rPr lang="en-US" dirty="0" err="1"/>
                <a:t>decapping</a:t>
              </a:r>
              <a:r>
                <a:rPr lang="en-US" dirty="0"/>
                <a:t> protein repeat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8DC653B8-6695-4D18-8F13-2CAB69404BD6}"/>
                </a:ext>
              </a:extLst>
            </p:cNvPr>
            <p:cNvSpPr/>
            <p:nvPr/>
          </p:nvSpPr>
          <p:spPr>
            <a:xfrm>
              <a:off x="1785358" y="2889703"/>
              <a:ext cx="1891291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C50A8BC5-F7F1-44E8-BCFD-1EC8AB1EB60D}"/>
                </a:ext>
              </a:extLst>
            </p:cNvPr>
            <p:cNvSpPr/>
            <p:nvPr/>
          </p:nvSpPr>
          <p:spPr>
            <a:xfrm>
              <a:off x="771662" y="2890771"/>
              <a:ext cx="8060393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0A856AAC-74F4-48C1-822D-37A42E52A420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8</a:t>
            </a:r>
          </a:p>
        </p:txBody>
      </p:sp>
    </p:spTree>
    <p:extLst>
      <p:ext uri="{BB962C8B-B14F-4D97-AF65-F5344CB8AC3E}">
        <p14:creationId xmlns:p14="http://schemas.microsoft.com/office/powerpoint/2010/main" val="102620584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6FD4637-4269-411F-A773-B493F87E4C49}"/>
              </a:ext>
            </a:extLst>
          </p:cNvPr>
          <p:cNvGrpSpPr/>
          <p:nvPr/>
        </p:nvGrpSpPr>
        <p:grpSpPr>
          <a:xfrm>
            <a:off x="-63822" y="256801"/>
            <a:ext cx="9579015" cy="6247269"/>
            <a:chOff x="-63822" y="256801"/>
            <a:chExt cx="9579015" cy="6247269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63945B9-3201-480A-A52E-21CEE7A742BC}"/>
                </a:ext>
              </a:extLst>
            </p:cNvPr>
            <p:cNvSpPr txBox="1"/>
            <p:nvPr/>
          </p:nvSpPr>
          <p:spPr>
            <a:xfrm>
              <a:off x="487370" y="3563507"/>
              <a:ext cx="9027822" cy="17819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5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VS</a:t>
              </a:r>
              <a:r>
                <a:rPr lang="en-US" sz="5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KIQKRLAASVMKCGKGKVWLDPNESGDISMANSRQNIRKLVKDGFIIRKPTKIHSRSRARALNEAKRKGRHSGYGKRKGTREARLPTKILWMRRMRVLRRFLSKYRESKKIDRHMYHDMYMKVKGNVFKNKRVLMESIHKMK</a:t>
              </a:r>
              <a:r>
                <a:rPr lang="en-US" sz="5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EKAREKTLADQF</a:t>
              </a:r>
              <a:r>
                <a:rPr lang="en-US" sz="5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</a:t>
              </a:r>
              <a:r>
                <a:rPr lang="en-US" sz="5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IKNKASRERKFARREERLAQGPGGG</a:t>
              </a:r>
              <a:r>
                <a:rPr lang="en-US" sz="5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TTTPAGAPQQPEVTKKKSKK</a:t>
              </a:r>
              <a:endParaRPr lang="en-US" sz="5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1B7B0BC6-8F47-4167-BD4A-6E73B455BF2E}"/>
                </a:ext>
              </a:extLst>
            </p:cNvPr>
            <p:cNvSpPr txBox="1"/>
            <p:nvPr/>
          </p:nvSpPr>
          <p:spPr>
            <a:xfrm>
              <a:off x="487371" y="3079585"/>
              <a:ext cx="9027822" cy="17819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5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VSLKIQ</a:t>
              </a:r>
              <a:r>
                <a:rPr lang="en-US" sz="53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LAASVMKCGKGKVWLDPNES</a:t>
              </a:r>
              <a:r>
                <a:rPr lang="en-US" sz="5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DISMANSRQNIRKLVKD</a:t>
              </a:r>
              <a:r>
                <a:rPr lang="en-US" sz="5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IIRKPTKIHSRSRARALNEAK</a:t>
              </a:r>
              <a:r>
                <a:rPr lang="en-US" sz="5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</a:t>
              </a:r>
              <a:r>
                <a:rPr lang="en-US" sz="53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</a:t>
              </a:r>
              <a:r>
                <a:rPr lang="en-US" sz="5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RHSGYGKRKGTREARLPTKIL</a:t>
              </a:r>
              <a:r>
                <a:rPr lang="en-US" sz="5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WMRRMRVLRRFLSK</a:t>
              </a:r>
              <a:r>
                <a:rPr lang="en-US" sz="53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Y</a:t>
              </a:r>
              <a:r>
                <a:rPr lang="en-US" sz="5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S</a:t>
              </a:r>
              <a:r>
                <a:rPr lang="en-US" sz="5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KIDRHMYHDMYMKVKGNVFKNKRVLMESIHKMKAEKAREKTLADQF</a:t>
              </a:r>
              <a:r>
                <a:rPr lang="en-US" sz="5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</a:t>
              </a:r>
              <a:r>
                <a:rPr lang="en-US" sz="5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IKNKASRERKFARREERLAQGPGGG</a:t>
              </a:r>
              <a:r>
                <a:rPr lang="en-US" sz="5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TTTPAGAPQQPEVTKKKSKK</a:t>
              </a:r>
              <a:endParaRPr lang="en-US" sz="5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18C91352-5810-4AB5-A3CB-F3AFA0F82482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76" t="11338" r="4693" b="11563"/>
            <a:stretch/>
          </p:blipFill>
          <p:spPr>
            <a:xfrm>
              <a:off x="480602" y="719188"/>
              <a:ext cx="8463373" cy="3525022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56801"/>
              <a:ext cx="610115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16780: RIBOSOMAL PROTEIN LIKE 19B; 209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70873" y="606291"/>
              <a:ext cx="304783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216957" y="1278000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56508" y="196637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13695" y="265069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56811" y="336296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165976" y="4017128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443033" y="4148457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4308511" y="4155950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20569" y="2318101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83323" y="4314581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68392" y="548750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71799" y="620661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2443657" y="5612977"/>
              <a:ext cx="25786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1730081" y="6317896"/>
              <a:ext cx="523951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80463" y="5276487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>
              <a:off x="4948255" y="5515300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7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77869" y="4608234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69339" y="481524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02728" y="508088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2443657" y="4950798"/>
              <a:ext cx="25786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CBE04FC4-979A-4662-A436-AE5681E9E219}"/>
                </a:ext>
              </a:extLst>
            </p:cNvPr>
            <p:cNvSpPr/>
            <p:nvPr/>
          </p:nvSpPr>
          <p:spPr>
            <a:xfrm>
              <a:off x="2446982" y="5141556"/>
              <a:ext cx="558698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C6A08A1-E439-4B38-BC6D-EDDAA2F95175}"/>
                </a:ext>
              </a:extLst>
            </p:cNvPr>
            <p:cNvSpPr txBox="1"/>
            <p:nvPr/>
          </p:nvSpPr>
          <p:spPr>
            <a:xfrm>
              <a:off x="7962881" y="5044760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99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8317668" y="415535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2363561" y="4148095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6309438" y="415242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5880581" y="683231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5575799" y="852508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2AE20749-F001-4442-95C9-CC842C57BBEA}"/>
                </a:ext>
              </a:extLst>
            </p:cNvPr>
            <p:cNvSpPr/>
            <p:nvPr/>
          </p:nvSpPr>
          <p:spPr>
            <a:xfrm>
              <a:off x="859237" y="5789357"/>
              <a:ext cx="25786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2DBEEEA4-893B-4B90-B36C-28B39A0907B3}"/>
                </a:ext>
              </a:extLst>
            </p:cNvPr>
            <p:cNvSpPr/>
            <p:nvPr/>
          </p:nvSpPr>
          <p:spPr>
            <a:xfrm>
              <a:off x="1730081" y="6133268"/>
              <a:ext cx="25786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8B8EE0DC-F953-4E64-8DDE-235234B1F5D9}"/>
                </a:ext>
              </a:extLst>
            </p:cNvPr>
            <p:cNvSpPr/>
            <p:nvPr/>
          </p:nvSpPr>
          <p:spPr>
            <a:xfrm>
              <a:off x="855427" y="5958811"/>
              <a:ext cx="405079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4670047-B92D-4E9B-838B-BD79E38BBF05}"/>
                </a:ext>
              </a:extLst>
            </p:cNvPr>
            <p:cNvSpPr txBox="1"/>
            <p:nvPr/>
          </p:nvSpPr>
          <p:spPr>
            <a:xfrm>
              <a:off x="2124799" y="3867961"/>
              <a:ext cx="33646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Ribosomal protein L19e family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C9A0E86-302A-4E8E-B2BC-17DAE4A349B0}"/>
                </a:ext>
              </a:extLst>
            </p:cNvPr>
            <p:cNvSpPr/>
            <p:nvPr/>
          </p:nvSpPr>
          <p:spPr>
            <a:xfrm>
              <a:off x="697705" y="3456126"/>
              <a:ext cx="5674519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28B3FA10-C364-4863-B6AA-B4D1B54E8EBC}"/>
                </a:ext>
              </a:extLst>
            </p:cNvPr>
            <p:cNvSpPr/>
            <p:nvPr/>
          </p:nvSpPr>
          <p:spPr>
            <a:xfrm>
              <a:off x="571635" y="3453178"/>
              <a:ext cx="8315554" cy="1097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558906EE-AEB5-484B-81D1-0162333B864B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9</a:t>
            </a:r>
          </a:p>
        </p:txBody>
      </p:sp>
    </p:spTree>
    <p:extLst>
      <p:ext uri="{BB962C8B-B14F-4D97-AF65-F5344CB8AC3E}">
        <p14:creationId xmlns:p14="http://schemas.microsoft.com/office/powerpoint/2010/main" val="2587222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190AA5C7-C15A-4AE4-8BB6-AD95D51678B2}"/>
              </a:ext>
            </a:extLst>
          </p:cNvPr>
          <p:cNvSpPr txBox="1"/>
          <p:nvPr/>
        </p:nvSpPr>
        <p:spPr>
          <a:xfrm>
            <a:off x="49990" y="76553"/>
            <a:ext cx="287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9EDB289-088F-42F6-A8E7-77EBF480CEEC}"/>
              </a:ext>
            </a:extLst>
          </p:cNvPr>
          <p:cNvGrpSpPr/>
          <p:nvPr/>
        </p:nvGrpSpPr>
        <p:grpSpPr>
          <a:xfrm>
            <a:off x="2114590" y="228884"/>
            <a:ext cx="7029410" cy="6446978"/>
            <a:chOff x="2114590" y="228884"/>
            <a:chExt cx="7029410" cy="6446978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FD6C492A-47FD-4C24-A462-74552F69A961}"/>
                </a:ext>
              </a:extLst>
            </p:cNvPr>
            <p:cNvGrpSpPr/>
            <p:nvPr/>
          </p:nvGrpSpPr>
          <p:grpSpPr>
            <a:xfrm>
              <a:off x="2142779" y="228884"/>
              <a:ext cx="7001221" cy="6446978"/>
              <a:chOff x="2286000" y="272952"/>
              <a:chExt cx="7001221" cy="6446978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F800A4FE-133A-45C3-8ECF-FF8ED1E01A26}"/>
                  </a:ext>
                </a:extLst>
              </p:cNvPr>
              <p:cNvGrpSpPr/>
              <p:nvPr/>
            </p:nvGrpSpPr>
            <p:grpSpPr>
              <a:xfrm>
                <a:off x="2286000" y="3527266"/>
                <a:ext cx="6858000" cy="1465404"/>
                <a:chOff x="2286000" y="3020486"/>
                <a:chExt cx="6858000" cy="1465404"/>
              </a:xfrm>
            </p:grpSpPr>
            <p:pic>
              <p:nvPicPr>
                <p:cNvPr id="26" name="Picture 25" descr="A picture containing table&#10;&#10;Description automatically generated">
                  <a:extLst>
                    <a:ext uri="{FF2B5EF4-FFF2-40B4-BE49-F238E27FC236}">
                      <a16:creationId xmlns:a16="http://schemas.microsoft.com/office/drawing/2014/main" id="{7F35207E-4D01-4737-A699-E6C68F9CA11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9078" b="40959"/>
                <a:stretch/>
              </p:blipFill>
              <p:spPr>
                <a:xfrm>
                  <a:off x="2286000" y="3337702"/>
                  <a:ext cx="6858000" cy="1075593"/>
                </a:xfrm>
                <a:prstGeom prst="rect">
                  <a:avLst/>
                </a:prstGeom>
              </p:spPr>
            </p:pic>
            <p:pic>
              <p:nvPicPr>
                <p:cNvPr id="30" name="Picture 29" descr="A picture containing table&#10;&#10;Description automatically generated">
                  <a:extLst>
                    <a:ext uri="{FF2B5EF4-FFF2-40B4-BE49-F238E27FC236}">
                      <a16:creationId xmlns:a16="http://schemas.microsoft.com/office/drawing/2014/main" id="{23D69CDC-7DE4-46C1-ADA7-36828350A0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79488" b="15768"/>
                <a:stretch/>
              </p:blipFill>
              <p:spPr>
                <a:xfrm>
                  <a:off x="2286000" y="4358210"/>
                  <a:ext cx="6858000" cy="127680"/>
                </a:xfrm>
                <a:prstGeom prst="rect">
                  <a:avLst/>
                </a:prstGeom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DB04F34D-A429-4BC2-8F96-2B8B743539E3}"/>
                    </a:ext>
                  </a:extLst>
                </p:cNvPr>
                <p:cNvSpPr txBox="1"/>
                <p:nvPr/>
              </p:nvSpPr>
              <p:spPr>
                <a:xfrm>
                  <a:off x="2286000" y="3020486"/>
                  <a:ext cx="395037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C) </a:t>
                  </a:r>
                  <a:r>
                    <a:rPr lang="en-US" dirty="0"/>
                    <a:t>Tags start in the 5’ UTR of AT3G04920</a:t>
                  </a: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53BADF11-113D-4DE3-8575-A1054C3AA595}"/>
                    </a:ext>
                  </a:extLst>
                </p:cNvPr>
                <p:cNvSpPr/>
                <p:nvPr/>
              </p:nvSpPr>
              <p:spPr>
                <a:xfrm>
                  <a:off x="3096011" y="4172788"/>
                  <a:ext cx="945357" cy="313102"/>
                </a:xfrm>
                <a:prstGeom prst="rect">
                  <a:avLst/>
                </a:prstGeom>
                <a:noFill/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2A48E966-3D97-43B6-9252-EAABF9BF86E6}"/>
                  </a:ext>
                </a:extLst>
              </p:cNvPr>
              <p:cNvGrpSpPr/>
              <p:nvPr/>
            </p:nvGrpSpPr>
            <p:grpSpPr>
              <a:xfrm>
                <a:off x="2286000" y="5029893"/>
                <a:ext cx="7001221" cy="1690037"/>
                <a:chOff x="0" y="5785628"/>
                <a:chExt cx="7001221" cy="1690037"/>
              </a:xfrm>
            </p:grpSpPr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49067F05-3108-4367-B591-7909B9C29861}"/>
                    </a:ext>
                  </a:extLst>
                </p:cNvPr>
                <p:cNvGrpSpPr/>
                <p:nvPr/>
              </p:nvGrpSpPr>
              <p:grpSpPr>
                <a:xfrm>
                  <a:off x="0" y="5785628"/>
                  <a:ext cx="7001221" cy="1690037"/>
                  <a:chOff x="0" y="3045342"/>
                  <a:chExt cx="7001221" cy="1690037"/>
                </a:xfrm>
              </p:grpSpPr>
              <p:pic>
                <p:nvPicPr>
                  <p:cNvPr id="22" name="Picture 21" descr="A screenshot of a computer&#10;&#10;Description automatically generated with low confidence">
                    <a:extLst>
                      <a:ext uri="{FF2B5EF4-FFF2-40B4-BE49-F238E27FC236}">
                        <a16:creationId xmlns:a16="http://schemas.microsoft.com/office/drawing/2014/main" id="{272798EA-B435-4CC2-8C16-669C0C5B3E7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78990"/>
                  <a:stretch/>
                </p:blipFill>
                <p:spPr>
                  <a:xfrm>
                    <a:off x="0" y="3761629"/>
                    <a:ext cx="6858000" cy="973750"/>
                  </a:xfrm>
                  <a:prstGeom prst="rect">
                    <a:avLst/>
                  </a:prstGeom>
                </p:spPr>
              </p:pic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40235A3F-D4D2-4BDD-A41B-43A8AB5CE55B}"/>
                      </a:ext>
                    </a:extLst>
                  </p:cNvPr>
                  <p:cNvSpPr txBox="1"/>
                  <p:nvPr/>
                </p:nvSpPr>
                <p:spPr>
                  <a:xfrm>
                    <a:off x="285262" y="3045342"/>
                    <a:ext cx="6715959" cy="78803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1800"/>
                      </a:lnSpc>
                    </a:pPr>
                    <a:r>
                      <a:rPr lang="en-US" dirty="0"/>
                      <a:t>Extracted paired-end sequences of the virus coat protein and 5’ UTR of AT3G04920. This example is in frame. Virus: 1</a:t>
                    </a:r>
                    <a:r>
                      <a:rPr lang="en-US" baseline="30000" dirty="0"/>
                      <a:t>st</a:t>
                    </a:r>
                    <a:r>
                      <a:rPr lang="en-US" dirty="0"/>
                      <a:t> frame, </a:t>
                    </a:r>
                    <a:r>
                      <a:rPr lang="en-US" i="1" dirty="0"/>
                      <a:t>A. thaliana </a:t>
                    </a:r>
                    <a:r>
                      <a:rPr lang="en-US" dirty="0"/>
                      <a:t>protein: 1</a:t>
                    </a:r>
                    <a:r>
                      <a:rPr lang="en-US" baseline="30000" dirty="0"/>
                      <a:t>st</a:t>
                    </a:r>
                    <a:r>
                      <a:rPr lang="en-US" dirty="0"/>
                      <a:t> frame. However, there is a stop codon in the frame </a:t>
                    </a:r>
                    <a:r>
                      <a:rPr lang="en-US" dirty="0">
                        <a:solidFill>
                          <a:srgbClr val="FF0000"/>
                        </a:solidFill>
                      </a:rPr>
                      <a:t>* </a:t>
                    </a:r>
                    <a:r>
                      <a:rPr lang="en-US" dirty="0"/>
                      <a:t>.</a:t>
                    </a:r>
                  </a:p>
                </p:txBody>
              </p:sp>
              <p:sp>
                <p:nvSpPr>
                  <p:cNvPr id="24" name="Rectangle 23">
                    <a:extLst>
                      <a:ext uri="{FF2B5EF4-FFF2-40B4-BE49-F238E27FC236}">
                        <a16:creationId xmlns:a16="http://schemas.microsoft.com/office/drawing/2014/main" id="{3D264213-9BB3-49CC-8270-99E215C005A2}"/>
                      </a:ext>
                    </a:extLst>
                  </p:cNvPr>
                  <p:cNvSpPr/>
                  <p:nvPr/>
                </p:nvSpPr>
                <p:spPr>
                  <a:xfrm>
                    <a:off x="4924913" y="4193002"/>
                    <a:ext cx="182880" cy="121476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5" name="Rectangle 24">
                    <a:extLst>
                      <a:ext uri="{FF2B5EF4-FFF2-40B4-BE49-F238E27FC236}">
                        <a16:creationId xmlns:a16="http://schemas.microsoft.com/office/drawing/2014/main" id="{F58CBA8D-7650-41E6-BC8D-4423AEF078C5}"/>
                      </a:ext>
                    </a:extLst>
                  </p:cNvPr>
                  <p:cNvSpPr/>
                  <p:nvPr/>
                </p:nvSpPr>
                <p:spPr>
                  <a:xfrm>
                    <a:off x="5857933" y="4202669"/>
                    <a:ext cx="945357" cy="121476"/>
                  </a:xfrm>
                  <a:prstGeom prst="rect">
                    <a:avLst/>
                  </a:pr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019B095C-7A3E-43AD-80D2-C972DE8F3CC6}"/>
                    </a:ext>
                  </a:extLst>
                </p:cNvPr>
                <p:cNvSpPr/>
                <p:nvPr/>
              </p:nvSpPr>
              <p:spPr>
                <a:xfrm>
                  <a:off x="1139229" y="6934409"/>
                  <a:ext cx="3749040" cy="121476"/>
                </a:xfrm>
                <a:prstGeom prst="rect">
                  <a:avLst/>
                </a:prstGeom>
                <a:noFill/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C60F65B0-0291-43B8-8A2C-10BD2E990530}"/>
                  </a:ext>
                </a:extLst>
              </p:cNvPr>
              <p:cNvGrpSpPr/>
              <p:nvPr/>
            </p:nvGrpSpPr>
            <p:grpSpPr>
              <a:xfrm>
                <a:off x="2311638" y="272952"/>
                <a:ext cx="6495235" cy="3240128"/>
                <a:chOff x="25638" y="768702"/>
                <a:chExt cx="6495235" cy="3240128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EB33E61E-4DD4-416E-8276-0EA428C19D2D}"/>
                    </a:ext>
                  </a:extLst>
                </p:cNvPr>
                <p:cNvGrpSpPr/>
                <p:nvPr/>
              </p:nvGrpSpPr>
              <p:grpSpPr>
                <a:xfrm>
                  <a:off x="25638" y="768702"/>
                  <a:ext cx="6495235" cy="3240128"/>
                  <a:chOff x="25638" y="136312"/>
                  <a:chExt cx="6495235" cy="3240128"/>
                </a:xfrm>
              </p:grpSpPr>
              <p:grpSp>
                <p:nvGrpSpPr>
                  <p:cNvPr id="9" name="Group 8">
                    <a:extLst>
                      <a:ext uri="{FF2B5EF4-FFF2-40B4-BE49-F238E27FC236}">
                        <a16:creationId xmlns:a16="http://schemas.microsoft.com/office/drawing/2014/main" id="{4487C73D-FC6E-498D-A9F6-EED545304605}"/>
                      </a:ext>
                    </a:extLst>
                  </p:cNvPr>
                  <p:cNvGrpSpPr/>
                  <p:nvPr/>
                </p:nvGrpSpPr>
                <p:grpSpPr>
                  <a:xfrm>
                    <a:off x="25638" y="136312"/>
                    <a:ext cx="6495235" cy="3240128"/>
                    <a:chOff x="25638" y="136312"/>
                    <a:chExt cx="6495235" cy="3240128"/>
                  </a:xfrm>
                </p:grpSpPr>
                <p:grpSp>
                  <p:nvGrpSpPr>
                    <p:cNvPr id="11" name="Group 10">
                      <a:extLst>
                        <a:ext uri="{FF2B5EF4-FFF2-40B4-BE49-F238E27FC236}">
                          <a16:creationId xmlns:a16="http://schemas.microsoft.com/office/drawing/2014/main" id="{6E226848-1083-4229-9C59-22F622751B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638" y="136312"/>
                      <a:ext cx="6495235" cy="3240128"/>
                      <a:chOff x="25638" y="136312"/>
                      <a:chExt cx="6495235" cy="3240128"/>
                    </a:xfrm>
                  </p:grpSpPr>
                  <p:grpSp>
                    <p:nvGrpSpPr>
                      <p:cNvPr id="13" name="Group 12">
                        <a:extLst>
                          <a:ext uri="{FF2B5EF4-FFF2-40B4-BE49-F238E27FC236}">
                            <a16:creationId xmlns:a16="http://schemas.microsoft.com/office/drawing/2014/main" id="{3A25ED56-3303-4EF8-83F4-DDBF1ED2AE6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638" y="136312"/>
                        <a:ext cx="6469597" cy="3240128"/>
                        <a:chOff x="25638" y="136312"/>
                        <a:chExt cx="6469597" cy="3240128"/>
                      </a:xfrm>
                    </p:grpSpPr>
                    <p:grpSp>
                      <p:nvGrpSpPr>
                        <p:cNvPr id="15" name="Group 14">
                          <a:extLst>
                            <a:ext uri="{FF2B5EF4-FFF2-40B4-BE49-F238E27FC236}">
                              <a16:creationId xmlns:a16="http://schemas.microsoft.com/office/drawing/2014/main" id="{7FD3D7E3-6886-4963-AF59-909C6CD48B9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5638" y="454542"/>
                          <a:ext cx="6469597" cy="2921898"/>
                          <a:chOff x="25638" y="87071"/>
                          <a:chExt cx="6469597" cy="2921898"/>
                        </a:xfrm>
                      </p:grpSpPr>
                      <p:pic>
                        <p:nvPicPr>
                          <p:cNvPr id="17" name="Picture 16" descr="A picture containing table&#10;&#10;Description automatically generated">
                            <a:extLst>
                              <a:ext uri="{FF2B5EF4-FFF2-40B4-BE49-F238E27FC236}">
                                <a16:creationId xmlns:a16="http://schemas.microsoft.com/office/drawing/2014/main" id="{4948975E-BBA7-48C5-A05A-9020294C6BBD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 rotWithShape="1"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r="80526" b="49312"/>
                          <a:stretch/>
                        </p:blipFill>
                        <p:spPr>
                          <a:xfrm>
                            <a:off x="4023225" y="87071"/>
                            <a:ext cx="2155386" cy="1939929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18" name="Picture 17" descr="A screenshot of a computer&#10;&#10;Description automatically generated with low confidence">
                            <a:extLst>
                              <a:ext uri="{FF2B5EF4-FFF2-40B4-BE49-F238E27FC236}">
                                <a16:creationId xmlns:a16="http://schemas.microsoft.com/office/drawing/2014/main" id="{F0EC322F-54D1-4FFA-9045-ABA08733E9B8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 rotWithShape="1"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13707" r="25988" b="72745"/>
                          <a:stretch/>
                        </p:blipFill>
                        <p:spPr>
                          <a:xfrm>
                            <a:off x="25638" y="1997902"/>
                            <a:ext cx="6469597" cy="1011067"/>
                          </a:xfrm>
                          <a:prstGeom prst="rect">
                            <a:avLst/>
                          </a:prstGeom>
                        </p:spPr>
                      </p:pic>
                      <p:sp>
                        <p:nvSpPr>
                          <p:cNvPr id="19" name="Rectangle 18">
                            <a:extLst>
                              <a:ext uri="{FF2B5EF4-FFF2-40B4-BE49-F238E27FC236}">
                                <a16:creationId xmlns:a16="http://schemas.microsoft.com/office/drawing/2014/main" id="{24E569E4-90D3-40A2-B62B-E788281AD1C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896742" y="649483"/>
                            <a:ext cx="210312" cy="1938528"/>
                          </a:xfrm>
                          <a:prstGeom prst="rect">
                            <a:avLst/>
                          </a:prstGeom>
                          <a:noFill/>
                          <a:ln w="19050">
                            <a:solidFill>
                              <a:srgbClr val="00B05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6" name="TextBox 15">
                          <a:extLst>
                            <a:ext uri="{FF2B5EF4-FFF2-40B4-BE49-F238E27FC236}">
                              <a16:creationId xmlns:a16="http://schemas.microsoft.com/office/drawing/2014/main" id="{5EA36B47-2306-4D7E-8FCC-7A3ED939882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540696" y="136312"/>
                          <a:ext cx="478565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r>
                            <a:rPr lang="en-US" b="1" dirty="0"/>
                            <a:t>A) </a:t>
                          </a:r>
                          <a:endParaRPr lang="en-US" dirty="0"/>
                        </a:p>
                      </p:txBody>
                    </p:sp>
                  </p:grpSp>
                  <p:sp>
                    <p:nvSpPr>
                      <p:cNvPr id="14" name="Rectangle 13">
                        <a:extLst>
                          <a:ext uri="{FF2B5EF4-FFF2-40B4-BE49-F238E27FC236}">
                            <a16:creationId xmlns:a16="http://schemas.microsoft.com/office/drawing/2014/main" id="{F21D06CC-79BE-49D5-B958-920721B9AC3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435341" y="2832707"/>
                        <a:ext cx="4085532" cy="9144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00B05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12" name="TextBox 11">
                      <a:extLst>
                        <a:ext uri="{FF2B5EF4-FFF2-40B4-BE49-F238E27FC236}">
                          <a16:creationId xmlns:a16="http://schemas.microsoft.com/office/drawing/2014/main" id="{2552A9E2-4AE8-4C3B-813D-DF072E76C0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9930" y="1315975"/>
                      <a:ext cx="55413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b="1" dirty="0"/>
                        <a:t>B) </a:t>
                      </a:r>
                      <a:endParaRPr lang="en-US" dirty="0"/>
                    </a:p>
                  </p:txBody>
                </p:sp>
              </p:grp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F853424A-6DDF-4C2A-9509-B757697C65E9}"/>
                      </a:ext>
                    </a:extLst>
                  </p:cNvPr>
                  <p:cNvSpPr txBox="1"/>
                  <p:nvPr/>
                </p:nvSpPr>
                <p:spPr>
                  <a:xfrm>
                    <a:off x="2841253" y="144479"/>
                    <a:ext cx="3679620" cy="3693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dirty="0"/>
                      <a:t>Tags start in the 5’ UTR of AT1G70600</a:t>
                    </a:r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7F43A87B-A925-4C09-94BF-DAFD5D6F762D}"/>
                    </a:ext>
                  </a:extLst>
                </p:cNvPr>
                <p:cNvSpPr txBox="1"/>
                <p:nvPr/>
              </p:nvSpPr>
              <p:spPr>
                <a:xfrm>
                  <a:off x="457671" y="1944482"/>
                  <a:ext cx="3595935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dirty="0"/>
                    <a:t>Extracted paired-end sequences of the virus coat protein and 5’ UTR of AT1G70600. This example is in frame.</a:t>
                  </a:r>
                </a:p>
              </p:txBody>
            </p:sp>
          </p:grp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BD7D1F6-79DA-B3F2-0486-E794050184B6}"/>
                </a:ext>
              </a:extLst>
            </p:cNvPr>
            <p:cNvSpPr txBox="1"/>
            <p:nvPr/>
          </p:nvSpPr>
          <p:spPr>
            <a:xfrm>
              <a:off x="2114590" y="4932268"/>
              <a:ext cx="42931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/>
                <a:t>D) </a:t>
              </a:r>
              <a:endParaRPr lang="en-US" dirty="0"/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0F91CA7-C3FC-4180-B0F0-2E6EAE67E1FB}"/>
                </a:ext>
              </a:extLst>
            </p:cNvPr>
            <p:cNvSpPr/>
            <p:nvPr/>
          </p:nvSpPr>
          <p:spPr>
            <a:xfrm>
              <a:off x="8327086" y="5462784"/>
              <a:ext cx="164624" cy="2210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739769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992BB50-DDDD-4630-BFDD-04C35FABDB92}"/>
              </a:ext>
            </a:extLst>
          </p:cNvPr>
          <p:cNvGrpSpPr/>
          <p:nvPr/>
        </p:nvGrpSpPr>
        <p:grpSpPr>
          <a:xfrm>
            <a:off x="-38041" y="146368"/>
            <a:ext cx="9676987" cy="5906010"/>
            <a:chOff x="-38041" y="430891"/>
            <a:chExt cx="9676987" cy="5906010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7DEAC23-B362-4B9A-AD5F-ACEE670AD4EE}"/>
                </a:ext>
              </a:extLst>
            </p:cNvPr>
            <p:cNvSpPr txBox="1"/>
            <p:nvPr/>
          </p:nvSpPr>
          <p:spPr>
            <a:xfrm>
              <a:off x="751708" y="2837321"/>
              <a:ext cx="8887238" cy="1367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6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MSSSRELQYLEYTYRNNRPTTGLLNSIFMTTVNTAARSLVSVASTASTPEIPSRRWSASDHLSFASGLLTTAAENALVPAKASSSSSTSSTALVKYSGSSDLGMMICDGVDEPSVNSLGRALCHALALMNEIPVTS</a:t>
              </a:r>
              <a:r>
                <a:rPr lang="en-US" sz="26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RKYQFAMGMAEKIM</a:t>
              </a:r>
              <a:r>
                <a:rPr lang="en-US" sz="2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EDN</a:t>
              </a:r>
              <a:r>
                <a:rPr lang="en-US" sz="260" dirty="0">
                  <a:effectLst/>
                  <a:highlight>
                    <a:srgbClr val="C0C0C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A</a:t>
              </a:r>
              <a:r>
                <a:rPr lang="en-US" sz="2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QSGHVDLL</a:t>
              </a:r>
              <a:r>
                <a:rPr lang="en-US" sz="2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D</a:t>
              </a:r>
              <a:r>
                <a:rPr lang="en-US" sz="2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VNRAALASSFARTTARLQDCLKRSRTADEPFGGLPLRVVSALPLGGYVASYVRGLSACINTVRSLADMTGNLLSQTRRRESAVVRAGGI</a:t>
              </a:r>
              <a:r>
                <a:rPr lang="en-US" sz="2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Q</a:t>
              </a:r>
              <a:r>
                <a:rPr lang="en-US" sz="2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ENEAELAV</a:t>
              </a:r>
              <a:r>
                <a:rPr lang="en-US" sz="26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EKLAEELLWMTEKLRRYGAVAEGIKRWSYASGLASLSLTAAPRVQGLMVKISALLIGELARD</a:t>
              </a:r>
              <a:r>
                <a:rPr lang="en-US" sz="2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STQVPGQVTFRLLANWLPLFSHARNGLAFPVLTGYERVEVERAIDKAI</a:t>
              </a:r>
              <a:r>
                <a:rPr lang="en-US" sz="2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S</a:t>
              </a:r>
              <a:r>
                <a:rPr lang="en-US" sz="2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TLPALDQEILLTNWLQDFSVSASEWPNLQPAYDRWCHSTR</a:t>
              </a:r>
              <a:r>
                <a:rPr lang="en-US" sz="26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QLFM</a:t>
              </a:r>
              <a:endParaRPr lang="en-US" sz="260" dirty="0"/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191A6FCA-F955-46AE-8CC4-74FB7AD89E19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96" t="11049" r="4642" b="11716"/>
            <a:stretch/>
          </p:blipFill>
          <p:spPr>
            <a:xfrm>
              <a:off x="765661" y="752199"/>
              <a:ext cx="8068368" cy="3531142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38041" y="430891"/>
              <a:ext cx="597727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19920.1: BTB/POZ DOMAIN PROTEIN; 416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514897" y="68782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81834" y="112169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514210" y="159581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78160" y="2092453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23735" y="261228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426864" y="3090954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89492" y="3574593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708051" y="4195493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508928" y="4188267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10245" y="2390583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17504" y="4367660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178625" y="577244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3930122" y="5773777"/>
              <a:ext cx="173736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724196" y="5483553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727438" y="4574176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180078" y="4784932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11363" y="5027546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177320" y="5195686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6999527" y="4777972"/>
              <a:ext cx="169164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610424" y="4688213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71</a:t>
              </a:r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6998196" y="4945899"/>
              <a:ext cx="93268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9" name="Rectangle 278">
              <a:extLst>
                <a:ext uri="{FF2B5EF4-FFF2-40B4-BE49-F238E27FC236}">
                  <a16:creationId xmlns:a16="http://schemas.microsoft.com/office/drawing/2014/main" id="{F274DA5E-3DD4-46C9-AAAC-5399892470E0}"/>
                </a:ext>
              </a:extLst>
            </p:cNvPr>
            <p:cNvSpPr/>
            <p:nvPr/>
          </p:nvSpPr>
          <p:spPr>
            <a:xfrm>
              <a:off x="848427" y="5068043"/>
              <a:ext cx="257860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1DFE38B-62B4-4C18-A728-F8B9C09E5EFD}"/>
                </a:ext>
              </a:extLst>
            </p:cNvPr>
            <p:cNvSpPr txBox="1"/>
            <p:nvPr/>
          </p:nvSpPr>
          <p:spPr>
            <a:xfrm>
              <a:off x="3354984" y="4975702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3700603" y="5282203"/>
              <a:ext cx="212140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5742888" y="519139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9</a:t>
              </a:r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3759600" y="5444437"/>
              <a:ext cx="20574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429189" y="4065673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4416551" y="419055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6339883" y="418904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8251396" y="419055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385160" y="418991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3455822" y="418954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1601057" y="419486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85171" y="741059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080389" y="910336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E2C3F91-587D-4F90-89D8-A15813C1E5C5}"/>
                </a:ext>
              </a:extLst>
            </p:cNvPr>
            <p:cNvSpPr txBox="1"/>
            <p:nvPr/>
          </p:nvSpPr>
          <p:spPr>
            <a:xfrm>
              <a:off x="7299365" y="418936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D81D5AD-2E26-4550-99F6-E8E3132AA6A6}"/>
                </a:ext>
              </a:extLst>
            </p:cNvPr>
            <p:cNvSpPr txBox="1"/>
            <p:nvPr/>
          </p:nvSpPr>
          <p:spPr>
            <a:xfrm>
              <a:off x="5743934" y="534993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A1283BFC-D2A9-4923-8894-44AEBEDBA171}"/>
                </a:ext>
              </a:extLst>
            </p:cNvPr>
            <p:cNvSpPr/>
            <p:nvPr/>
          </p:nvSpPr>
          <p:spPr>
            <a:xfrm>
              <a:off x="3700603" y="5952077"/>
              <a:ext cx="21214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1AB58B09-EE75-4B5F-AD56-B0C028EBBF38}"/>
                </a:ext>
              </a:extLst>
            </p:cNvPr>
            <p:cNvSpPr/>
            <p:nvPr/>
          </p:nvSpPr>
          <p:spPr>
            <a:xfrm>
              <a:off x="3700603" y="6128485"/>
              <a:ext cx="196596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3C89451-96AB-40AD-B4E6-DE5E8BAAA996}"/>
                </a:ext>
              </a:extLst>
            </p:cNvPr>
            <p:cNvSpPr txBox="1"/>
            <p:nvPr/>
          </p:nvSpPr>
          <p:spPr>
            <a:xfrm>
              <a:off x="5588806" y="5680403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78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25A0A863-0A40-44D5-995E-4650E52E8B95}"/>
                </a:ext>
              </a:extLst>
            </p:cNvPr>
            <p:cNvSpPr txBox="1"/>
            <p:nvPr/>
          </p:nvSpPr>
          <p:spPr>
            <a:xfrm>
              <a:off x="5744609" y="5867366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D91945B-8B47-4E61-9E18-359C7584038A}"/>
                </a:ext>
              </a:extLst>
            </p:cNvPr>
            <p:cNvSpPr txBox="1"/>
            <p:nvPr/>
          </p:nvSpPr>
          <p:spPr>
            <a:xfrm>
              <a:off x="5596338" y="6039447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029FD143-8FEB-4D16-BFD8-F1787D7F30D6}"/>
                </a:ext>
              </a:extLst>
            </p:cNvPr>
            <p:cNvSpPr/>
            <p:nvPr/>
          </p:nvSpPr>
          <p:spPr>
            <a:xfrm>
              <a:off x="830086" y="2705207"/>
              <a:ext cx="7947202" cy="1097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A52938D7-7ADE-424C-9EF0-C527C1894F5C}"/>
              </a:ext>
            </a:extLst>
          </p:cNvPr>
          <p:cNvSpPr txBox="1"/>
          <p:nvPr/>
        </p:nvSpPr>
        <p:spPr>
          <a:xfrm>
            <a:off x="10104" y="-49887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0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CD9DBB7-547B-233C-3E6F-C879A49CC8CB}"/>
              </a:ext>
            </a:extLst>
          </p:cNvPr>
          <p:cNvSpPr/>
          <p:nvPr/>
        </p:nvSpPr>
        <p:spPr>
          <a:xfrm>
            <a:off x="2736916" y="2418362"/>
            <a:ext cx="5925312" cy="109728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0E5588F-6BC9-D5C3-99CC-EFEE51D14505}"/>
              </a:ext>
            </a:extLst>
          </p:cNvPr>
          <p:cNvSpPr txBox="1"/>
          <p:nvPr/>
        </p:nvSpPr>
        <p:spPr>
          <a:xfrm>
            <a:off x="4860903" y="3448363"/>
            <a:ext cx="17876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BTB/POZ domain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6F9BDF-9BC0-3570-A2FB-4A47BC04AC3D}"/>
              </a:ext>
            </a:extLst>
          </p:cNvPr>
          <p:cNvSpPr txBox="1"/>
          <p:nvPr/>
        </p:nvSpPr>
        <p:spPr>
          <a:xfrm>
            <a:off x="1204" y="6241514"/>
            <a:ext cx="9139334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Except for the indistinguishable (filled in gap region between the forward and reverse reads) tag from</a:t>
            </a:r>
            <a:endParaRPr lang="en-US" dirty="0">
              <a:solidFill>
                <a:schemeClr val="bg1">
                  <a:lumMod val="50000"/>
                </a:schemeClr>
              </a:solidFill>
            </a:endParaRPr>
          </a:p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At Rep2, all other binding regions are valid for AT3G19920.2 (457 aa). </a:t>
            </a:r>
            <a:endParaRPr lang="en-US" dirty="0">
              <a:solidFill>
                <a:schemeClr val="bg1">
                  <a:lumMod val="50000"/>
                </a:schemeClr>
              </a:solidFill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0C9B0A7-8CA2-B7CD-C5BB-F29B6FBB29CB}"/>
              </a:ext>
            </a:extLst>
          </p:cNvPr>
          <p:cNvGrpSpPr/>
          <p:nvPr/>
        </p:nvGrpSpPr>
        <p:grpSpPr>
          <a:xfrm>
            <a:off x="1699317" y="5942093"/>
            <a:ext cx="4640566" cy="363393"/>
            <a:chOff x="1699317" y="5942093"/>
            <a:chExt cx="4640566" cy="363393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297F5DE9-A615-0525-1075-24157ADA0D36}"/>
                </a:ext>
              </a:extLst>
            </p:cNvPr>
            <p:cNvSpPr/>
            <p:nvPr/>
          </p:nvSpPr>
          <p:spPr>
            <a:xfrm>
              <a:off x="2025795" y="6195758"/>
              <a:ext cx="18288" cy="10972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0F20CFC-9873-1F68-E23C-07865ED943E2}"/>
                </a:ext>
              </a:extLst>
            </p:cNvPr>
            <p:cNvSpPr txBox="1"/>
            <p:nvPr/>
          </p:nvSpPr>
          <p:spPr>
            <a:xfrm>
              <a:off x="1699317" y="5942093"/>
              <a:ext cx="464056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bg1">
                      <a:lumMod val="50000"/>
                    </a:schemeClr>
                  </a:solidFill>
                </a:rPr>
                <a:t>Site of 41 aa insertion and 1 aa change due to alternative splicin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208880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6C66DE70-D9CB-491F-AF5F-E2DEB7ED12FE}"/>
              </a:ext>
            </a:extLst>
          </p:cNvPr>
          <p:cNvGrpSpPr/>
          <p:nvPr/>
        </p:nvGrpSpPr>
        <p:grpSpPr>
          <a:xfrm>
            <a:off x="-57179" y="248239"/>
            <a:ext cx="10122723" cy="5835050"/>
            <a:chOff x="-57179" y="248239"/>
            <a:chExt cx="10122723" cy="583505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5A52F82-0DD6-4EB7-BA93-8C8A4A056383}"/>
                </a:ext>
              </a:extLst>
            </p:cNvPr>
            <p:cNvSpPr txBox="1"/>
            <p:nvPr/>
          </p:nvSpPr>
          <p:spPr>
            <a:xfrm>
              <a:off x="720868" y="2620875"/>
              <a:ext cx="9344676" cy="1377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LFTSTHTPNLQTKPLLKS</a:t>
              </a:r>
              <a:r>
                <a:rPr lang="en-US" sz="28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</a:t>
              </a:r>
              <a:r>
                <a:rPr lang="en-US" sz="28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SSQSSCWFCNSLPKTQFPKLRLSNGSS</a:t>
              </a:r>
              <a:r>
                <a:rPr lang="en-US" sz="2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HG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RIQALLRNETPSEGEDNNGFGFFPGDIFSLSQEKLGSNSN</a:t>
              </a:r>
              <a:r>
                <a:rPr lang="en-US" sz="28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en-US" sz="28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HSVIDVEASLAHPQGGGGNRAGLFRTPISGGVQNATSAHALPRPAL</a:t>
              </a:r>
              <a:r>
                <a:rPr lang="en-US" sz="28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VRNLLEQARFAHLCTVMSKMHHRREGYPFGSLVDFAPDRMGHPIFLFSPLAIHTRNLLNEPRCSLVVQIPGWSGLSNARVTLFGDVYPLSEDEQEWAHKQYIAKHPHGPSEQWGNFHYFRMQNISDIYFIGGFGTVAWVDVKEYE</a:t>
              </a:r>
              <a:r>
                <a:rPr lang="en-US" sz="2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LQPDKIAVDGGERNLKELNAIFSKPLRELLSTESEVDDAALISIDSKGIDVRVRQGAQFNIQRLAFEEGHGVETLEEAKSALWKVLEKVKLNLQK</a:t>
              </a:r>
              <a:endParaRPr lang="en-US" sz="28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2A9710B-3C05-4F54-AC9B-05B220AC088E}"/>
                </a:ext>
              </a:extLst>
            </p:cNvPr>
            <p:cNvSpPr txBox="1"/>
            <p:nvPr/>
          </p:nvSpPr>
          <p:spPr>
            <a:xfrm>
              <a:off x="721934" y="2537224"/>
              <a:ext cx="9244947" cy="1409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LFTSTHTPNLQTKPLLKS</a:t>
              </a:r>
              <a:r>
                <a:rPr lang="en-US" sz="28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</a:t>
              </a:r>
              <a:r>
                <a:rPr lang="en-US" sz="28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28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SSQSSCWFCNSLPKTQFPKLRLSNGSS</a:t>
              </a:r>
              <a:r>
                <a:rPr lang="en-US" sz="2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HG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RIQALLRNETPSEGEDNNGFGFFPGDIFSLSQEKLGSNSN</a:t>
              </a:r>
              <a:r>
                <a:rPr lang="en-US" sz="28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en-US" sz="28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28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HSVIDVEASLAHPQGGGGNRAGLFRTPISGGVQNATSAHALPRPALAVRNLLEQARFAHLCTVMSKMHHRREGYPFGSLVDFAPDRMGHPIFLFSPLAIHTR</a:t>
              </a:r>
              <a:r>
                <a:rPr lang="en-US" sz="28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LLNEPRCSLVVQIPGWSGLSNARVTLFGDVYPLSEDEQEWAHKQYIAKHPHGPSEQWGNFHYFRMQNISDIYFIGGFGTVAWVDVKEYEGLQPDKIAVDGGERNLKELNAIFSKPLRELLSTESEVDDAALISIDSKGIDVRVRQGAQFNIQRLAFEEGHGVETLEEAKSALWKVLEKVKLNLQK</a:t>
              </a:r>
              <a:endParaRPr lang="en-US" sz="28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20C469A7-DFFE-4515-A2C7-B2C2B302AB08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73" t="10846" r="4689" b="11498"/>
            <a:stretch/>
          </p:blipFill>
          <p:spPr>
            <a:xfrm>
              <a:off x="732088" y="661073"/>
              <a:ext cx="8130925" cy="3550485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7179" y="248239"/>
              <a:ext cx="8371779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21140: PYRIDOXAMINE 5-PHOSPHATE OXIDASE family protein; 387 amino acids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96797" y="59495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83814" y="111380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25372" y="168406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01699" y="226472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67458" y="2829992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23120" y="3433599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70821" y="410813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631885" y="4100083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06409" y="234924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97939" y="4280268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284721" y="582143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95959" y="5511268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505D75FF-2114-4A6A-BDD3-8A9BAD955226}"/>
                </a:ext>
              </a:extLst>
            </p:cNvPr>
            <p:cNvSpPr/>
            <p:nvPr/>
          </p:nvSpPr>
          <p:spPr>
            <a:xfrm>
              <a:off x="1251186" y="5881441"/>
              <a:ext cx="153619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>
              <a:off x="2718527" y="5785835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95429" y="4509200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255042" y="470126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83765" y="4952306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251741" y="510290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1925541" y="4845922"/>
              <a:ext cx="303580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4885878" y="4741477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814750" y="5021141"/>
              <a:ext cx="106984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1DFE38B-62B4-4C18-A728-F8B9C09E5EFD}"/>
                </a:ext>
              </a:extLst>
            </p:cNvPr>
            <p:cNvSpPr txBox="1"/>
            <p:nvPr/>
          </p:nvSpPr>
          <p:spPr>
            <a:xfrm>
              <a:off x="1819071" y="4929615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1248805" y="5217917"/>
              <a:ext cx="158191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2752470" y="5132994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66</a:t>
              </a:r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1287723" y="5397041"/>
              <a:ext cx="154533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73660" y="3975965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4709257" y="409711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6789585" y="410984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753055" y="410450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828343" y="410915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3667197" y="410082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1640759" y="4100323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46417" y="644587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41635" y="813864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81C4F77-54C0-4262-A9E2-78E1E68B3488}"/>
                </a:ext>
              </a:extLst>
            </p:cNvPr>
            <p:cNvSpPr txBox="1"/>
            <p:nvPr/>
          </p:nvSpPr>
          <p:spPr>
            <a:xfrm>
              <a:off x="2749416" y="5294223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00B85CA-1EE7-4572-AED1-8DD069D7F55C}"/>
                </a:ext>
              </a:extLst>
            </p:cNvPr>
            <p:cNvSpPr txBox="1"/>
            <p:nvPr/>
          </p:nvSpPr>
          <p:spPr>
            <a:xfrm>
              <a:off x="3754010" y="3603194"/>
              <a:ext cx="3076426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sz="1800" dirty="0" err="1"/>
                <a:t>Pyrid</a:t>
              </a:r>
              <a:r>
                <a:rPr lang="en-US" sz="1800" dirty="0"/>
                <a:t> oxidase 2 (Pyridoxamine 5’-phosphate oxidase) family</a:t>
              </a:r>
              <a:endParaRPr lang="en-US" dirty="0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E77A975-9E18-42DB-82B8-1973220CA74B}"/>
                </a:ext>
              </a:extLst>
            </p:cNvPr>
            <p:cNvSpPr/>
            <p:nvPr/>
          </p:nvSpPr>
          <p:spPr>
            <a:xfrm>
              <a:off x="3805238" y="2384016"/>
              <a:ext cx="3012281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01247798-ABBD-4394-B939-2D5F14E039F6}"/>
                </a:ext>
              </a:extLst>
            </p:cNvPr>
            <p:cNvSpPr/>
            <p:nvPr/>
          </p:nvSpPr>
          <p:spPr>
            <a:xfrm>
              <a:off x="796597" y="2381336"/>
              <a:ext cx="801164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F4F96DF3-5612-4986-8CD3-69F426FA97B3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1</a:t>
            </a:r>
          </a:p>
        </p:txBody>
      </p:sp>
    </p:spTree>
    <p:extLst>
      <p:ext uri="{BB962C8B-B14F-4D97-AF65-F5344CB8AC3E}">
        <p14:creationId xmlns:p14="http://schemas.microsoft.com/office/powerpoint/2010/main" val="308423502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3B8665E-539B-47FE-8385-47A9F02FA3EE}"/>
              </a:ext>
            </a:extLst>
          </p:cNvPr>
          <p:cNvGrpSpPr/>
          <p:nvPr/>
        </p:nvGrpSpPr>
        <p:grpSpPr>
          <a:xfrm>
            <a:off x="-53466" y="264113"/>
            <a:ext cx="9865983" cy="6109824"/>
            <a:chOff x="-53466" y="264113"/>
            <a:chExt cx="9865983" cy="610982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407008C-289E-4836-9595-91E2C6B3D4C5}"/>
                </a:ext>
              </a:extLst>
            </p:cNvPr>
            <p:cNvSpPr txBox="1"/>
            <p:nvPr/>
          </p:nvSpPr>
          <p:spPr>
            <a:xfrm>
              <a:off x="859795" y="3031804"/>
              <a:ext cx="8952722" cy="11990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QATIFSPRATLFPCKPLLPSHNVNSRRPSIISCSAQSVTADPSPPITDTNKLNKYSSRITEPKSQGGSQAILHGVGLSDDDLL</a:t>
              </a:r>
              <a:r>
                <a:rPr lang="en-US" sz="17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PQIGISSVWYEGNTCNMHLLKLSEAVKEGVENAGMVGFRFNTIGVSDAISMGTRGMCFSLQSRDLIADSIETVMSAQWYDGNISIPGCDKNMPGTIMAMGRLNRPGIMVYGGTIKPGHFQDKTYDIVSAFQSYGEFVSGSISDEQRKTVLHHSCPGAGACGGMYTANTMASAIEAMGMSLPYSSSIPAEDPLKLDECRLAGKYLLELLKMDLKPRDIITPKSLRNAMVSVMALGGSTNAVLHLIAIARSVGLELTLDDFQKVSDAVPFLADLKPSGKYVMEDIHKIGGTPAVLRYLLELGLMDGDCMTVTGQTLAQNLENVPSLTEGQEIIRPLSNPIKETGHIQILRGDLAPDGSVAKITGKEGLYFSGPALVFEGEESMLAAISADPMSFKGTVVVIRGEGPKGGPGMPEMLTPTSAIMGAGLGKECALLTDGRFSGGSHGFVVGHICPEAQEGGPIGLIKNGDIITIDIGKKRIDTQVSPEEMNDRRKKWTAPAYKVNRGVLYKYIKNVQSASDGC</a:t>
              </a:r>
              <a:r>
                <a:rPr lang="en-US" sz="1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TDE</a:t>
              </a:r>
              <a:endParaRPr lang="en-US" sz="1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E3BAC2C-FB99-4235-A21A-9C2451B0FFCB}"/>
                </a:ext>
              </a:extLst>
            </p:cNvPr>
            <p:cNvSpPr txBox="1"/>
            <p:nvPr/>
          </p:nvSpPr>
          <p:spPr>
            <a:xfrm>
              <a:off x="857232" y="2680691"/>
              <a:ext cx="8715393" cy="11990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QATIFSPRATLFPCKPLLPSHNVNSRRPSIISCSAQSVTADPSPPITDTNKLNKYSSRITEPKSQGGSQAILHGVGLSDDDLLKPQIGISSVWYEGNTCNMHLLKLSEAVKEGVENAGMVGFRFNTIGVSDAISMGTRGMCF</a:t>
              </a:r>
              <a:r>
                <a:rPr lang="en-US" sz="17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LQSRDLIADSIETVMSAQWYDGNISIPGCDKNMPGTIMAMGRLNRPGIMVYGGTIKPGHFQDKTYDIVSAFQSYGEFVSGSISDEQRKTVLHHSCPGAGACGG</a:t>
              </a:r>
              <a:r>
                <a:rPr lang="en-US" sz="1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YTANTMASAIEAMGMSLPYSSSIPAEDPLKLDECRLAGKYLLELLKMDLKPRDIITPKSLRNAMVSVMALGGSTNAVLHLIAIARSVGLELTLDDFQKVSDAVPFLADLKPSGKYVMEDIHKIGGTPAVLRYLLELGLMDGDCMTVTGQTLAQNLENVPSLTEGQEIIRPLSNPIKETGHIQILRGDLAPDGSVAKITGKEGLYFSGPALVFEGEESMLAAISADPMSFKGTVV</a:t>
              </a:r>
              <a:r>
                <a:rPr lang="en-US" sz="1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IRG</a:t>
              </a:r>
              <a:r>
                <a:rPr lang="en-US" sz="17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en-US" sz="1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PKGGPGMPEMLTPTSAIMGAGLGKECALLTDGRFSGGSHGFVVGHICPEAQEGGPIGL</a:t>
              </a:r>
              <a:r>
                <a:rPr lang="en-US" sz="17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NGDIITIDIGKKRIDTQVSPE</a:t>
              </a:r>
              <a:r>
                <a:rPr lang="en-US" sz="1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MNDRRKKWTAPAYKVNRGVLYKYIKNVQSASDGCVTDE</a:t>
              </a:r>
              <a:endParaRPr lang="en-US" sz="1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 descr="Graphical user interface&#10;&#10;Description automatically generated">
              <a:extLst>
                <a:ext uri="{FF2B5EF4-FFF2-40B4-BE49-F238E27FC236}">
                  <a16:creationId xmlns:a16="http://schemas.microsoft.com/office/drawing/2014/main" id="{39EEE3A8-22DB-4DCD-AD7F-03DA7206982C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02" t="10482" r="4610" b="11276"/>
            <a:stretch/>
          </p:blipFill>
          <p:spPr>
            <a:xfrm>
              <a:off x="858668" y="674190"/>
              <a:ext cx="7882038" cy="3577213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3466" y="264113"/>
              <a:ext cx="6384005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3G23940.1: DIHYDROXYACID DEHYDRATASE; 608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653480" y="101089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582211" y="144095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649036" y="189260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582662" y="229792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662463" y="274395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533730" y="3161224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617024" y="3582973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582028" y="597494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808527" y="4161046"/>
              <a:ext cx="27122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986054" y="4171774"/>
              <a:ext cx="444352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405411" y="2336889"/>
              <a:ext cx="1833323" cy="271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01893" y="4355708"/>
              <a:ext cx="2524474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324268" y="5450409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351764" y="569390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320986" y="5842816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7081910" y="5997381"/>
              <a:ext cx="109728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841601" y="5253162"/>
              <a:ext cx="4858126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8093505" y="5896714"/>
              <a:ext cx="532518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187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8A0873A-F8FD-4145-9021-3ACE4A37BAE7}"/>
                </a:ext>
              </a:extLst>
            </p:cNvPr>
            <p:cNvSpPr txBox="1"/>
            <p:nvPr/>
          </p:nvSpPr>
          <p:spPr>
            <a:xfrm>
              <a:off x="7822866" y="6076483"/>
              <a:ext cx="359394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C2F98FBF-DA76-4FFF-A746-27A705A0BA3A}"/>
                </a:ext>
              </a:extLst>
            </p:cNvPr>
            <p:cNvSpPr/>
            <p:nvPr/>
          </p:nvSpPr>
          <p:spPr>
            <a:xfrm>
              <a:off x="7081384" y="6163715"/>
              <a:ext cx="82296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838370" y="4552536"/>
              <a:ext cx="4343230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324600" y="4755330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324600" y="4920952"/>
              <a:ext cx="574388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7E2E0FAE-55D3-4451-9C5A-052C4A520375}"/>
                </a:ext>
              </a:extLst>
            </p:cNvPr>
            <p:cNvSpPr txBox="1"/>
            <p:nvPr/>
          </p:nvSpPr>
          <p:spPr>
            <a:xfrm>
              <a:off x="8102558" y="4819458"/>
              <a:ext cx="359394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2B1323B2-DB74-44CC-9874-F13EBB63A30E}"/>
                </a:ext>
              </a:extLst>
            </p:cNvPr>
            <p:cNvSpPr/>
            <p:nvPr/>
          </p:nvSpPr>
          <p:spPr>
            <a:xfrm>
              <a:off x="7081726" y="4907199"/>
              <a:ext cx="110642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2775560" y="5032218"/>
              <a:ext cx="131673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3" name="Rectangle 282">
              <a:extLst>
                <a:ext uri="{FF2B5EF4-FFF2-40B4-BE49-F238E27FC236}">
                  <a16:creationId xmlns:a16="http://schemas.microsoft.com/office/drawing/2014/main" id="{EBC59AA1-394C-4494-A471-DE21A7598D31}"/>
                </a:ext>
              </a:extLst>
            </p:cNvPr>
            <p:cNvSpPr/>
            <p:nvPr/>
          </p:nvSpPr>
          <p:spPr>
            <a:xfrm>
              <a:off x="7131731" y="5236141"/>
              <a:ext cx="105156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7082330" y="5081951"/>
              <a:ext cx="109728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542236" y="4016731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261611" y="4166021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537547" y="4166211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809720" y="4164939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080367" y="4162627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8352291" y="4166442"/>
              <a:ext cx="44435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01110" y="670256"/>
              <a:ext cx="15636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996328" y="839533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50122960-9A19-4C99-91C3-88A07A8976C1}"/>
                </a:ext>
              </a:extLst>
            </p:cNvPr>
            <p:cNvSpPr/>
            <p:nvPr/>
          </p:nvSpPr>
          <p:spPr>
            <a:xfrm>
              <a:off x="7079003" y="5635206"/>
              <a:ext cx="110642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189106B0-7B0E-4B4A-995E-B86D4C9C2C22}"/>
                </a:ext>
              </a:extLst>
            </p:cNvPr>
            <p:cNvSpPr/>
            <p:nvPr/>
          </p:nvSpPr>
          <p:spPr>
            <a:xfrm>
              <a:off x="7080681" y="5805712"/>
              <a:ext cx="110642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50227C9-0011-4695-AB4B-24A08EDF3A17}"/>
                </a:ext>
              </a:extLst>
            </p:cNvPr>
            <p:cNvSpPr txBox="1"/>
            <p:nvPr/>
          </p:nvSpPr>
          <p:spPr>
            <a:xfrm>
              <a:off x="3428270" y="3858952"/>
              <a:ext cx="305400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/>
                <a:t>ILVD EDD (Dehydratase) family</a:t>
              </a:r>
              <a:endParaRPr lang="en-US" dirty="0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66837CD3-6705-45A5-ACE9-4ACB47BB38B3}"/>
                </a:ext>
              </a:extLst>
            </p:cNvPr>
            <p:cNvSpPr/>
            <p:nvPr/>
          </p:nvSpPr>
          <p:spPr>
            <a:xfrm>
              <a:off x="2019299" y="2840145"/>
              <a:ext cx="6603207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8DB0B849-1AD9-4256-8D5E-0ED27E4329E9}"/>
                </a:ext>
              </a:extLst>
            </p:cNvPr>
            <p:cNvSpPr/>
            <p:nvPr/>
          </p:nvSpPr>
          <p:spPr>
            <a:xfrm>
              <a:off x="941857" y="2838539"/>
              <a:ext cx="7737799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514B5257-61C8-44A6-9E2F-FA5C34ED8B79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BDBD86-5E1F-A1CB-48A6-E64E32D4B4A2}"/>
              </a:ext>
            </a:extLst>
          </p:cNvPr>
          <p:cNvSpPr txBox="1"/>
          <p:nvPr/>
        </p:nvSpPr>
        <p:spPr>
          <a:xfrm>
            <a:off x="855462" y="6475731"/>
            <a:ext cx="63840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3G23940.2 (606 aa)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403DE2B-03ED-260F-6445-FAC3050660EE}"/>
              </a:ext>
            </a:extLst>
          </p:cNvPr>
          <p:cNvSpPr/>
          <p:nvPr/>
        </p:nvSpPr>
        <p:spPr>
          <a:xfrm>
            <a:off x="5930093" y="6448878"/>
            <a:ext cx="18288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715AFE-7783-CE5D-F6B9-3448D075C0F0}"/>
              </a:ext>
            </a:extLst>
          </p:cNvPr>
          <p:cNvSpPr txBox="1"/>
          <p:nvPr/>
        </p:nvSpPr>
        <p:spPr>
          <a:xfrm>
            <a:off x="5750722" y="6209486"/>
            <a:ext cx="291009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2 aa deletion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378531788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CE0EA1FD-0418-4EC6-8B67-9342F7AFAF63}"/>
              </a:ext>
            </a:extLst>
          </p:cNvPr>
          <p:cNvGrpSpPr/>
          <p:nvPr/>
        </p:nvGrpSpPr>
        <p:grpSpPr>
          <a:xfrm>
            <a:off x="-63822" y="8980"/>
            <a:ext cx="10291965" cy="6621227"/>
            <a:chOff x="-63822" y="8980"/>
            <a:chExt cx="10291965" cy="6621227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5C7A84E-2630-4049-9DEF-CB9C6FC76A57}"/>
                </a:ext>
              </a:extLst>
            </p:cNvPr>
            <p:cNvGrpSpPr/>
            <p:nvPr/>
          </p:nvGrpSpPr>
          <p:grpSpPr>
            <a:xfrm>
              <a:off x="-63822" y="255385"/>
              <a:ext cx="10291965" cy="6374822"/>
              <a:chOff x="-63822" y="255385"/>
              <a:chExt cx="10291965" cy="6374822"/>
            </a:xfrm>
          </p:grpSpPr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74462E06-D67F-4352-8AE2-F464FF6E75DE}"/>
                  </a:ext>
                </a:extLst>
              </p:cNvPr>
              <p:cNvSpPr txBox="1"/>
              <p:nvPr/>
            </p:nvSpPr>
            <p:spPr>
              <a:xfrm>
                <a:off x="676889" y="2857107"/>
                <a:ext cx="9551254" cy="1215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MGRPKAIPDDDDGELSQFKGFDVDNDFAKRLLHNKEREDLQRYEEKNKQGLFSESEEEPETESEPDSDLGNPESNLKFVDLLIKVKKKDPIIKDKDAKFYEYDDESSEEDEVDKKDTKKKKKKKKMYLKDVQAQHLLEGGPEFVEEDEERKVRTYAEEQKETRKAVTDAWKAEGNESGEDDDFLRVVEKEGDDDVEVDEELAKKMDEYYGDEAEATENQFLKDYLVKQLWKEKEERVPGEEELKELSEDDHEVWD</a:t>
                </a:r>
                <a:r>
                  <a:rPr lang="en-US" sz="170" dirty="0">
                    <a:effectLst/>
                    <a:highlight>
                      <a:srgbClr val="FF0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QEDFEAGRPLDLLNYRHEDENAGD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VMGQSRVVEGSV</a:t>
                </a:r>
                <a:r>
                  <a:rPr lang="en-US" sz="170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</a:t>
                </a:r>
                <a:r>
                  <a:rPr lang="en-US" sz="170" dirty="0">
                    <a:effectLst/>
                    <a:highlight>
                      <a:srgbClr val="80008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</a:t>
                </a:r>
                <a:r>
                  <a:rPr lang="en-US" sz="170" dirty="0">
                    <a:effectLst/>
                    <a:highlight>
                      <a:srgbClr val="0064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</a:t>
                </a:r>
                <a:r>
                  <a:rPr lang="en-US" sz="170" dirty="0">
                    <a:effectLst/>
                    <a:highlight>
                      <a:srgbClr val="FF00FF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RK</a:t>
                </a:r>
                <a:r>
                  <a:rPr lang="en-US" sz="170" dirty="0">
                    <a:effectLst/>
                    <a:highlight>
                      <a:srgbClr val="80808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QRKNKDERMKKEDDVR</a:t>
                </a:r>
                <a:r>
                  <a:rPr lang="en-US" sz="170" dirty="0">
                    <a:effectLst/>
                    <a:highlight>
                      <a:srgbClr val="D3D3D3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EEL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RL</a:t>
                </a:r>
                <a:r>
                  <a:rPr lang="en-US" sz="170" dirty="0">
                    <a:effectLst/>
                    <a:highlight>
                      <a:srgbClr val="FF0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NV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K</a:t>
                </a:r>
                <a:r>
                  <a:rPr lang="en-US" sz="170" dirty="0">
                    <a:effectLst/>
                    <a:highlight>
                      <a:srgbClr val="FF0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EI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EKMKKVLSVAGFKDGEECPLDAK</a:t>
                </a:r>
                <a:r>
                  <a:rPr lang="en-US" sz="170" dirty="0">
                    <a:effectLst/>
                    <a:highlight>
                      <a:srgbClr val="FF00FF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F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DEFDPEEYDKMMK</a:t>
                </a:r>
                <a:r>
                  <a:rPr lang="en-US" sz="170" dirty="0">
                    <a:effectLst/>
                    <a:highlight>
                      <a:srgbClr val="0064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</a:t>
                </a:r>
                <a:r>
                  <a:rPr lang="en-US" sz="170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FDDKYYGEEDSDLNSDEDDDGEKPDFDKEDELLGLPKDWDVTKG</a:t>
                </a:r>
                <a:r>
                  <a:rPr lang="en-US" sz="170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VFAAAREKVLKHKENMLGI</a:t>
                </a:r>
                <a:r>
                  <a:rPr lang="en-US" sz="170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EEEEE</a:t>
                </a:r>
                <a:r>
                  <a:rPr lang="en-US" sz="170" dirty="0">
                    <a:effectLst/>
                    <a:highlight>
                      <a:srgbClr val="D3D3D3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EEE</a:t>
                </a:r>
                <a:r>
                  <a:rPr lang="en-US" sz="170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EDEEEEEVDEEKEAE</a:t>
                </a:r>
                <a:r>
                  <a:rPr lang="en-US" sz="170" dirty="0">
                    <a:effectLst/>
                    <a:highlight>
                      <a:srgbClr val="808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KRK</a:t>
                </a:r>
                <a:r>
                  <a:rPr lang="en-US" sz="170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KRKTSLVQKTKEALMEEYYKLDYEDTIGELRTRF</a:t>
                </a:r>
                <a:r>
                  <a:rPr lang="en-US" sz="170" dirty="0">
                    <a:effectLst/>
                    <a:highlight>
                      <a:srgbClr val="8B0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KY</a:t>
                </a:r>
                <a:r>
                  <a:rPr lang="en-US" sz="170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KVQPNRFELDTGEILTLDDAELNQYVPLKKMAPYVEKDWEVNRHKVKEQKRKIRELWEGKHD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KKSKK</a:t>
                </a:r>
                <a:r>
                  <a:rPr lang="en-US" sz="170" dirty="0">
                    <a:effectLst/>
                    <a:highlight>
                      <a:srgbClr val="808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KK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DVVETK</a:t>
                </a:r>
                <a:r>
                  <a:rPr lang="en-US" sz="170" dirty="0">
                    <a:effectLst/>
                    <a:highlight>
                      <a:srgbClr val="8B0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PTPK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AEAEAEAEAEAEAEAEAEAKLSRKAKRRRRQAEKKLPPSRMAAYGKA</a:t>
                </a:r>
                <a:endParaRPr lang="en-US" sz="17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C76F01DF-9A7B-4325-8B53-DE8CC3431CE8}"/>
                  </a:ext>
                </a:extLst>
              </p:cNvPr>
              <p:cNvSpPr txBox="1"/>
              <p:nvPr/>
            </p:nvSpPr>
            <p:spPr>
              <a:xfrm>
                <a:off x="676889" y="3463212"/>
                <a:ext cx="8833675" cy="119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MGRPKAIPDDDDGELSQFKGFDVDNDFAKRLLHNKEREDLQRYEEKNKQGLFSESEEEPETESEPDSDLGNPESNLKFVDLLIKVKKKDPIIKDKDAKFYEYDDESSEEDEVDKKDTKKKKKKKKMYLKDVQAQHLLEGGPEFVEEDEERKVRTYAEEQKETRKAVTDAWKAEGNESGEDDDFLRVVEKEGDDDVEVDEELAKKMDEYYGDEAEATENQFLKDYLVKQLWKEKEERVPGEEELKELSEDDHEVWDQEDFEAGRPLDLLNYRHEDENAGDTVMGQSRVVEGSVRKKDNARKAQRKNKD</a:t>
                </a:r>
                <a:r>
                  <a:rPr lang="en-US" sz="170" dirty="0">
                    <a:effectLst/>
                    <a:highlight>
                      <a:srgbClr val="808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RMKKEDDVRKEELKRLKNVKKKEIKEKMKKVLSVAGFKDGEECPLDAKDFDDEFDPEEYDKMMKAAFDDKYYGEEDSDLNSDEDDDGEKPDFDKEDEL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LGLPKDWDVTKGGDVFAAAREKVLKHKENMLGIDEEEEEDEEEEEDEEEEEVDEEKEAEGKRKRKRKTSLVQK</a:t>
                </a:r>
                <a:r>
                  <a:rPr lang="en-US" sz="170" dirty="0">
                    <a:effectLst/>
                    <a:highlight>
                      <a:srgbClr val="80800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KEALMEEYYKLDYEDTIGELRTRFKYAKVQPNRFELDTGEILTLDDAELNQYVPLKKMAPYVEKDWEVNRHKVKEQKRKIREL</a:t>
                </a:r>
                <a:r>
                  <a:rPr lang="en-US" sz="170" dirty="0">
                    <a:effectLst/>
                    <a:latin typeface="Courier New" panose="02070309020205020404" pitchFamily="49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WEGKHDEKKSKKRKKNDVVETKPTPKEAEAEAEAEAEAEAEAEAEAKLSRKAKRRRRQAEKKLPPSRMAAYGKA</a:t>
                </a:r>
                <a:endParaRPr lang="en-US" sz="17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" name="Picture 4" descr="Graphical user interface, chart&#10;&#10;Description automatically generated">
                <a:extLst>
                  <a:ext uri="{FF2B5EF4-FFF2-40B4-BE49-F238E27FC236}">
                    <a16:creationId xmlns:a16="http://schemas.microsoft.com/office/drawing/2014/main" id="{9B976BD5-072B-46CD-83F3-DA5631F4681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780" t="10383" r="4717" b="11536"/>
              <a:stretch/>
            </p:blipFill>
            <p:spPr>
              <a:xfrm>
                <a:off x="720598" y="629685"/>
                <a:ext cx="8209090" cy="3569878"/>
              </a:xfrm>
              <a:prstGeom prst="rect">
                <a:avLst/>
              </a:prstGeom>
            </p:spPr>
          </p:pic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260D0E5C-706F-4FF0-8746-20D3F475925B}"/>
                  </a:ext>
                </a:extLst>
              </p:cNvPr>
              <p:cNvSpPr txBox="1"/>
              <p:nvPr/>
            </p:nvSpPr>
            <p:spPr>
              <a:xfrm>
                <a:off x="-63822" y="255385"/>
                <a:ext cx="5213928" cy="379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67" dirty="0"/>
                  <a:t>AT3G24080.1: KRR1 family protein; 638 amino acids</a:t>
                </a: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127375DE-0BE7-4A29-95B2-4C4D7BB29E39}"/>
                  </a:ext>
                </a:extLst>
              </p:cNvPr>
              <p:cNvSpPr txBox="1"/>
              <p:nvPr/>
            </p:nvSpPr>
            <p:spPr>
              <a:xfrm>
                <a:off x="521346" y="1400203"/>
                <a:ext cx="333853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2</a:t>
                </a: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317B04D6-7657-4F34-A595-3B510AB1F16E}"/>
                  </a:ext>
                </a:extLst>
              </p:cNvPr>
              <p:cNvSpPr txBox="1"/>
              <p:nvPr/>
            </p:nvSpPr>
            <p:spPr>
              <a:xfrm>
                <a:off x="448692" y="1841759"/>
                <a:ext cx="464229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1.5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7B31341E-CBBB-447D-9D2C-7CA4E3703C10}"/>
                  </a:ext>
                </a:extLst>
              </p:cNvPr>
              <p:cNvSpPr txBox="1"/>
              <p:nvPr/>
            </p:nvSpPr>
            <p:spPr>
              <a:xfrm>
                <a:off x="530691" y="2226170"/>
                <a:ext cx="333853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1</a:t>
                </a: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6CC67E57-6938-4197-BB82-D9A3C121FD62}"/>
                  </a:ext>
                </a:extLst>
              </p:cNvPr>
              <p:cNvSpPr txBox="1"/>
              <p:nvPr/>
            </p:nvSpPr>
            <p:spPr>
              <a:xfrm>
                <a:off x="411106" y="2663084"/>
                <a:ext cx="464229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0.5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FF7D61E6-87CC-40F2-AF3D-4E5BB6EAE4FA}"/>
                  </a:ext>
                </a:extLst>
              </p:cNvPr>
              <p:cNvSpPr txBox="1"/>
              <p:nvPr/>
            </p:nvSpPr>
            <p:spPr>
              <a:xfrm>
                <a:off x="476295" y="3148624"/>
                <a:ext cx="333853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0</a:t>
                </a: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68698889-D2C5-4ADB-A8BC-34D556B8C496}"/>
                  </a:ext>
                </a:extLst>
              </p:cNvPr>
              <p:cNvSpPr txBox="1"/>
              <p:nvPr/>
            </p:nvSpPr>
            <p:spPr>
              <a:xfrm>
                <a:off x="372946" y="3545273"/>
                <a:ext cx="515525" cy="2974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-0.5</a:t>
                </a: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B40C9032-1B63-49DC-9778-7A48C6A8F367}"/>
                  </a:ext>
                </a:extLst>
              </p:cNvPr>
              <p:cNvSpPr txBox="1"/>
              <p:nvPr/>
            </p:nvSpPr>
            <p:spPr>
              <a:xfrm>
                <a:off x="438135" y="3955950"/>
                <a:ext cx="385149" cy="2974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-1</a:t>
                </a:r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D85A3D30-7297-4021-BD7F-87209A81379C}"/>
                  </a:ext>
                </a:extLst>
              </p:cNvPr>
              <p:cNvSpPr txBox="1"/>
              <p:nvPr/>
            </p:nvSpPr>
            <p:spPr>
              <a:xfrm>
                <a:off x="424242" y="970920"/>
                <a:ext cx="464229" cy="2974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2.5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13536D16-058C-4DC2-A0CC-E831C536FE61}"/>
                  </a:ext>
                </a:extLst>
              </p:cNvPr>
              <p:cNvSpPr txBox="1"/>
              <p:nvPr/>
            </p:nvSpPr>
            <p:spPr>
              <a:xfrm>
                <a:off x="618317" y="4093073"/>
                <a:ext cx="271228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0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8C282AB0-EDE9-4B3F-9317-1F532881BC30}"/>
                  </a:ext>
                </a:extLst>
              </p:cNvPr>
              <p:cNvSpPr txBox="1"/>
              <p:nvPr/>
            </p:nvSpPr>
            <p:spPr>
              <a:xfrm>
                <a:off x="1795026" y="4085920"/>
                <a:ext cx="444352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100</a:t>
                </a: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AC9CD7D3-0E94-4D74-83EF-2F5827E3B4C4}"/>
                  </a:ext>
                </a:extLst>
              </p:cNvPr>
              <p:cNvSpPr txBox="1"/>
              <p:nvPr/>
            </p:nvSpPr>
            <p:spPr>
              <a:xfrm rot="16200000">
                <a:off x="-561133" y="2261173"/>
                <a:ext cx="1833323" cy="2714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333"/>
                  </a:lnSpc>
                </a:pPr>
                <a:r>
                  <a:rPr lang="en-US" sz="1600" dirty="0"/>
                  <a:t>Hydrophilicity index</a:t>
                </a:r>
              </a:p>
            </p:txBody>
          </p: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531F24F5-A0B8-4CB4-88B6-92334840F476}"/>
                  </a:ext>
                </a:extLst>
              </p:cNvPr>
              <p:cNvSpPr txBox="1"/>
              <p:nvPr/>
            </p:nvSpPr>
            <p:spPr>
              <a:xfrm>
                <a:off x="3510552" y="4238473"/>
                <a:ext cx="2524474" cy="338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Protein length (amino acids)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665D3BBA-1258-4163-8642-4A4E98824D38}"/>
                  </a:ext>
                </a:extLst>
              </p:cNvPr>
              <p:cNvSpPr txBox="1"/>
              <p:nvPr/>
            </p:nvSpPr>
            <p:spPr>
              <a:xfrm>
                <a:off x="198566" y="5550554"/>
                <a:ext cx="574388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1">
                        <a:lumMod val="50000"/>
                      </a:schemeClr>
                    </a:solidFill>
                  </a:rPr>
                  <a:t>Rep 1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AB9FBE55-EBF6-4176-AC07-3C19B00016DD}"/>
                  </a:ext>
                </a:extLst>
              </p:cNvPr>
              <p:cNvSpPr txBox="1"/>
              <p:nvPr/>
            </p:nvSpPr>
            <p:spPr>
              <a:xfrm>
                <a:off x="230363" y="5809203"/>
                <a:ext cx="512833" cy="2051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lIns="60960" tIns="0" rIns="60960" bIns="0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6">
                        <a:lumMod val="75000"/>
                      </a:schemeClr>
                    </a:solidFill>
                  </a:rPr>
                  <a:t>Rep 2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93FB5C87-2E0F-407F-A1E0-B5FFFA709DCF}"/>
                  </a:ext>
                </a:extLst>
              </p:cNvPr>
              <p:cNvSpPr txBox="1"/>
              <p:nvPr/>
            </p:nvSpPr>
            <p:spPr>
              <a:xfrm>
                <a:off x="197949" y="5955604"/>
                <a:ext cx="574388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4">
                        <a:lumMod val="50000"/>
                      </a:schemeClr>
                    </a:solidFill>
                  </a:rPr>
                  <a:t>Rep 3</a:t>
                </a:r>
              </a:p>
            </p:txBody>
          </p:sp>
          <p:sp>
            <p:nvSpPr>
              <p:cNvPr id="187" name="Rectangle 186">
                <a:extLst>
                  <a:ext uri="{FF2B5EF4-FFF2-40B4-BE49-F238E27FC236}">
                    <a16:creationId xmlns:a16="http://schemas.microsoft.com/office/drawing/2014/main" id="{F4DBDB1B-473C-4DD2-BFA6-B6765861A4D6}"/>
                  </a:ext>
                </a:extLst>
              </p:cNvPr>
              <p:cNvSpPr/>
              <p:nvPr/>
            </p:nvSpPr>
            <p:spPr>
              <a:xfrm>
                <a:off x="4552803" y="5708242"/>
                <a:ext cx="777240" cy="106672"/>
              </a:xfrm>
              <a:prstGeom prst="rect">
                <a:avLst/>
              </a:prstGeom>
              <a:solidFill>
                <a:schemeClr val="accent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190" name="Rectangle 189">
                <a:extLst>
                  <a:ext uri="{FF2B5EF4-FFF2-40B4-BE49-F238E27FC236}">
                    <a16:creationId xmlns:a16="http://schemas.microsoft.com/office/drawing/2014/main" id="{76960ACD-A54D-4697-BC7F-7550072E877B}"/>
                  </a:ext>
                </a:extLst>
              </p:cNvPr>
              <p:cNvSpPr/>
              <p:nvPr/>
            </p:nvSpPr>
            <p:spPr>
              <a:xfrm>
                <a:off x="4487837" y="6053131"/>
                <a:ext cx="1618488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6FD794FB-0584-42B1-A29E-0FCC91E3401E}"/>
                  </a:ext>
                </a:extLst>
              </p:cNvPr>
              <p:cNvSpPr txBox="1"/>
              <p:nvPr/>
            </p:nvSpPr>
            <p:spPr>
              <a:xfrm>
                <a:off x="657839" y="5367202"/>
                <a:ext cx="4858126" cy="379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67" dirty="0"/>
                  <a:t>Binding region from Glyma04g009900 replicates</a:t>
                </a:r>
              </a:p>
            </p:txBody>
          </p:sp>
          <p:sp>
            <p:nvSpPr>
              <p:cNvPr id="253" name="Rectangle 252">
                <a:extLst>
                  <a:ext uri="{FF2B5EF4-FFF2-40B4-BE49-F238E27FC236}">
                    <a16:creationId xmlns:a16="http://schemas.microsoft.com/office/drawing/2014/main" id="{2451F93B-2472-4E30-B102-3B07D2746539}"/>
                  </a:ext>
                </a:extLst>
              </p:cNvPr>
              <p:cNvSpPr/>
              <p:nvPr/>
            </p:nvSpPr>
            <p:spPr>
              <a:xfrm>
                <a:off x="4812142" y="5870860"/>
                <a:ext cx="1664208" cy="106672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6E63DC9A-4FCA-47BA-B5C4-9B896D62EF45}"/>
                  </a:ext>
                </a:extLst>
              </p:cNvPr>
              <p:cNvSpPr txBox="1"/>
              <p:nvPr/>
            </p:nvSpPr>
            <p:spPr>
              <a:xfrm>
                <a:off x="5443755" y="6115759"/>
                <a:ext cx="445956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10</a:t>
                </a:r>
              </a:p>
            </p:txBody>
          </p:sp>
          <p:sp>
            <p:nvSpPr>
              <p:cNvPr id="258" name="Rectangle 257">
                <a:extLst>
                  <a:ext uri="{FF2B5EF4-FFF2-40B4-BE49-F238E27FC236}">
                    <a16:creationId xmlns:a16="http://schemas.microsoft.com/office/drawing/2014/main" id="{1E2ABE54-58ED-4271-8F76-43AA3F9F1919}"/>
                  </a:ext>
                </a:extLst>
              </p:cNvPr>
              <p:cNvSpPr/>
              <p:nvPr/>
            </p:nvSpPr>
            <p:spPr>
              <a:xfrm>
                <a:off x="4541719" y="6214826"/>
                <a:ext cx="978408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08A0873A-F8FD-4145-9021-3ACE4A37BAE7}"/>
                  </a:ext>
                </a:extLst>
              </p:cNvPr>
              <p:cNvSpPr txBox="1"/>
              <p:nvPr/>
            </p:nvSpPr>
            <p:spPr>
              <a:xfrm>
                <a:off x="6021964" y="5948957"/>
                <a:ext cx="445956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26</a:t>
                </a:r>
              </a:p>
            </p:txBody>
          </p:sp>
          <p:sp>
            <p:nvSpPr>
              <p:cNvPr id="260" name="Rectangle 259">
                <a:extLst>
                  <a:ext uri="{FF2B5EF4-FFF2-40B4-BE49-F238E27FC236}">
                    <a16:creationId xmlns:a16="http://schemas.microsoft.com/office/drawing/2014/main" id="{C2F98FBF-DA76-4FFF-A746-27A705A0BA3A}"/>
                  </a:ext>
                </a:extLst>
              </p:cNvPr>
              <p:cNvSpPr/>
              <p:nvPr/>
            </p:nvSpPr>
            <p:spPr>
              <a:xfrm>
                <a:off x="4019956" y="6368891"/>
                <a:ext cx="978408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4A68FB3A-21D1-4EAB-9A6D-1F1923C345FD}"/>
                  </a:ext>
                </a:extLst>
              </p:cNvPr>
              <p:cNvSpPr txBox="1"/>
              <p:nvPr/>
            </p:nvSpPr>
            <p:spPr>
              <a:xfrm>
                <a:off x="4924857" y="6264878"/>
                <a:ext cx="359394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9</a:t>
                </a:r>
              </a:p>
            </p:txBody>
          </p:sp>
          <p:sp>
            <p:nvSpPr>
              <p:cNvPr id="262" name="Rectangle 261">
                <a:extLst>
                  <a:ext uri="{FF2B5EF4-FFF2-40B4-BE49-F238E27FC236}">
                    <a16:creationId xmlns:a16="http://schemas.microsoft.com/office/drawing/2014/main" id="{B6C7952F-CBF3-43EE-87BC-2A1429C154B5}"/>
                  </a:ext>
                </a:extLst>
              </p:cNvPr>
              <p:cNvSpPr/>
              <p:nvPr/>
            </p:nvSpPr>
            <p:spPr>
              <a:xfrm>
                <a:off x="6688980" y="6043683"/>
                <a:ext cx="1435608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DBD43DA8-6A76-46D9-996E-B00464B16920}"/>
                  </a:ext>
                </a:extLst>
              </p:cNvPr>
              <p:cNvSpPr txBox="1"/>
              <p:nvPr/>
            </p:nvSpPr>
            <p:spPr>
              <a:xfrm>
                <a:off x="656882" y="4455087"/>
                <a:ext cx="4268733" cy="379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67" dirty="0"/>
                  <a:t>Binding region from AT2G21490 replicates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2D46BD0B-32BA-4DF6-B920-F1A2E7EB1032}"/>
                  </a:ext>
                </a:extLst>
              </p:cNvPr>
              <p:cNvSpPr txBox="1"/>
              <p:nvPr/>
            </p:nvSpPr>
            <p:spPr>
              <a:xfrm>
                <a:off x="196566" y="4623765"/>
                <a:ext cx="574388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1">
                        <a:lumMod val="50000"/>
                      </a:schemeClr>
                    </a:solidFill>
                  </a:rPr>
                  <a:t>Rep 1</a:t>
                </a: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0A7028B0-6976-439C-AAEE-E05D4E7ED419}"/>
                  </a:ext>
                </a:extLst>
              </p:cNvPr>
              <p:cNvSpPr txBox="1"/>
              <p:nvPr/>
            </p:nvSpPr>
            <p:spPr>
              <a:xfrm>
                <a:off x="227164" y="4881225"/>
                <a:ext cx="512833" cy="2051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none" lIns="60960" tIns="0" rIns="60960" bIns="0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6">
                        <a:lumMod val="75000"/>
                      </a:schemeClr>
                    </a:solidFill>
                  </a:rPr>
                  <a:t>Rep 2</a:t>
                </a: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C7302551-ADF7-4C45-991A-BFE4E52C6CC0}"/>
                  </a:ext>
                </a:extLst>
              </p:cNvPr>
              <p:cNvSpPr txBox="1"/>
              <p:nvPr/>
            </p:nvSpPr>
            <p:spPr>
              <a:xfrm>
                <a:off x="196386" y="5009261"/>
                <a:ext cx="574388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>
                    <a:solidFill>
                      <a:schemeClr val="accent4">
                        <a:lumMod val="50000"/>
                      </a:schemeClr>
                    </a:solidFill>
                  </a:rPr>
                  <a:t>Rep 3</a:t>
                </a:r>
              </a:p>
            </p:txBody>
          </p:sp>
          <p:sp>
            <p:nvSpPr>
              <p:cNvPr id="268" name="Rectangle 267">
                <a:extLst>
                  <a:ext uri="{FF2B5EF4-FFF2-40B4-BE49-F238E27FC236}">
                    <a16:creationId xmlns:a16="http://schemas.microsoft.com/office/drawing/2014/main" id="{4EEEFEFA-B45E-4EE1-8D74-3DC29B4E7AC2}"/>
                  </a:ext>
                </a:extLst>
              </p:cNvPr>
              <p:cNvSpPr/>
              <p:nvPr/>
            </p:nvSpPr>
            <p:spPr>
              <a:xfrm>
                <a:off x="6686598" y="4783206"/>
                <a:ext cx="1435608" cy="106672"/>
              </a:xfrm>
              <a:prstGeom prst="rect">
                <a:avLst/>
              </a:prstGeom>
              <a:solidFill>
                <a:schemeClr val="accent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72" name="Rectangle 271">
                <a:extLst>
                  <a:ext uri="{FF2B5EF4-FFF2-40B4-BE49-F238E27FC236}">
                    <a16:creationId xmlns:a16="http://schemas.microsoft.com/office/drawing/2014/main" id="{1819BCE4-7A47-440C-AE6E-3AB05D8C6A0D}"/>
                  </a:ext>
                </a:extLst>
              </p:cNvPr>
              <p:cNvSpPr/>
              <p:nvPr/>
            </p:nvSpPr>
            <p:spPr>
              <a:xfrm>
                <a:off x="6692074" y="4943290"/>
                <a:ext cx="1426464" cy="106672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968C584B-562E-43FF-B33B-E3B34B614107}"/>
                  </a:ext>
                </a:extLst>
              </p:cNvPr>
              <p:cNvSpPr txBox="1"/>
              <p:nvPr/>
            </p:nvSpPr>
            <p:spPr>
              <a:xfrm>
                <a:off x="8037458" y="4841063"/>
                <a:ext cx="445956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17</a:t>
                </a:r>
              </a:p>
            </p:txBody>
          </p:sp>
          <p:sp>
            <p:nvSpPr>
              <p:cNvPr id="279" name="Rectangle 278">
                <a:extLst>
                  <a:ext uri="{FF2B5EF4-FFF2-40B4-BE49-F238E27FC236}">
                    <a16:creationId xmlns:a16="http://schemas.microsoft.com/office/drawing/2014/main" id="{F274DA5E-3DD4-46C9-AAAC-5399892470E0}"/>
                  </a:ext>
                </a:extLst>
              </p:cNvPr>
              <p:cNvSpPr/>
              <p:nvPr/>
            </p:nvSpPr>
            <p:spPr>
              <a:xfrm>
                <a:off x="4493676" y="4944646"/>
                <a:ext cx="1600200" cy="106672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41DFE38B-62B4-4C18-A728-F8B9C09E5EFD}"/>
                  </a:ext>
                </a:extLst>
              </p:cNvPr>
              <p:cNvSpPr txBox="1"/>
              <p:nvPr/>
            </p:nvSpPr>
            <p:spPr>
              <a:xfrm>
                <a:off x="6024428" y="4847217"/>
                <a:ext cx="359393" cy="2974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5</a:t>
                </a:r>
              </a:p>
            </p:txBody>
          </p:sp>
          <p:sp>
            <p:nvSpPr>
              <p:cNvPr id="281" name="Rectangle 280">
                <a:extLst>
                  <a:ext uri="{FF2B5EF4-FFF2-40B4-BE49-F238E27FC236}">
                    <a16:creationId xmlns:a16="http://schemas.microsoft.com/office/drawing/2014/main" id="{60FFD7C9-68B4-43DF-9EE6-C57BAA2A9C46}"/>
                  </a:ext>
                </a:extLst>
              </p:cNvPr>
              <p:cNvSpPr/>
              <p:nvPr/>
            </p:nvSpPr>
            <p:spPr>
              <a:xfrm>
                <a:off x="4487837" y="5118125"/>
                <a:ext cx="1618488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83" name="Rectangle 282">
                <a:extLst>
                  <a:ext uri="{FF2B5EF4-FFF2-40B4-BE49-F238E27FC236}">
                    <a16:creationId xmlns:a16="http://schemas.microsoft.com/office/drawing/2014/main" id="{EBC59AA1-394C-4494-A471-DE21A7598D31}"/>
                  </a:ext>
                </a:extLst>
              </p:cNvPr>
              <p:cNvSpPr/>
              <p:nvPr/>
            </p:nvSpPr>
            <p:spPr>
              <a:xfrm>
                <a:off x="4517516" y="5288368"/>
                <a:ext cx="1591056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284" name="Rectangle 283">
                <a:extLst>
                  <a:ext uri="{FF2B5EF4-FFF2-40B4-BE49-F238E27FC236}">
                    <a16:creationId xmlns:a16="http://schemas.microsoft.com/office/drawing/2014/main" id="{5169CF11-60C7-41B7-87FE-1FEA54D3A269}"/>
                  </a:ext>
                </a:extLst>
              </p:cNvPr>
              <p:cNvSpPr/>
              <p:nvPr/>
            </p:nvSpPr>
            <p:spPr>
              <a:xfrm>
                <a:off x="6352516" y="5112937"/>
                <a:ext cx="1655064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8FE192AA-DF98-4E9C-91A0-3A8C462594B1}"/>
                  </a:ext>
                </a:extLst>
              </p:cNvPr>
              <p:cNvSpPr txBox="1"/>
              <p:nvPr/>
            </p:nvSpPr>
            <p:spPr>
              <a:xfrm>
                <a:off x="505964" y="573591"/>
                <a:ext cx="364731" cy="2974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33" dirty="0"/>
                  <a:t>3</a:t>
                </a:r>
              </a:p>
            </p:txBody>
          </p:sp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2C1808B4-924E-4D85-81EC-78FAE7881B9E}"/>
                  </a:ext>
                </a:extLst>
              </p:cNvPr>
              <p:cNvSpPr txBox="1"/>
              <p:nvPr/>
            </p:nvSpPr>
            <p:spPr>
              <a:xfrm>
                <a:off x="3074313" y="4088531"/>
                <a:ext cx="444352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200</a:t>
                </a:r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2CBE4AA6-7300-490B-947F-4CDE80528FF0}"/>
                  </a:ext>
                </a:extLst>
              </p:cNvPr>
              <p:cNvSpPr txBox="1"/>
              <p:nvPr/>
            </p:nvSpPr>
            <p:spPr>
              <a:xfrm>
                <a:off x="4347326" y="4086090"/>
                <a:ext cx="444352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300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ABEB38F1-E0F4-48AD-BD72-D0E2214FA77B}"/>
                  </a:ext>
                </a:extLst>
              </p:cNvPr>
              <p:cNvSpPr txBox="1"/>
              <p:nvPr/>
            </p:nvSpPr>
            <p:spPr>
              <a:xfrm>
                <a:off x="5617088" y="4088757"/>
                <a:ext cx="444352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400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F032DC2D-38D7-4DDF-A001-A30FCE5D25CC}"/>
                  </a:ext>
                </a:extLst>
              </p:cNvPr>
              <p:cNvSpPr txBox="1"/>
              <p:nvPr/>
            </p:nvSpPr>
            <p:spPr>
              <a:xfrm>
                <a:off x="6895410" y="4095615"/>
                <a:ext cx="444352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500</a:t>
                </a: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035FE6C2-83A5-4473-BE07-F983B2AF5C94}"/>
                  </a:ext>
                </a:extLst>
              </p:cNvPr>
              <p:cNvSpPr txBox="1"/>
              <p:nvPr/>
            </p:nvSpPr>
            <p:spPr>
              <a:xfrm>
                <a:off x="8177948" y="4095615"/>
                <a:ext cx="444352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600</a:t>
                </a:r>
              </a:p>
            </p:txBody>
          </p:sp>
          <p:sp>
            <p:nvSpPr>
              <p:cNvPr id="288" name="TextBox 287">
                <a:extLst>
                  <a:ext uri="{FF2B5EF4-FFF2-40B4-BE49-F238E27FC236}">
                    <a16:creationId xmlns:a16="http://schemas.microsoft.com/office/drawing/2014/main" id="{C82ADEA3-5051-4EDF-A2CF-15D20CE77B8E}"/>
                  </a:ext>
                </a:extLst>
              </p:cNvPr>
              <p:cNvSpPr txBox="1"/>
              <p:nvPr/>
            </p:nvSpPr>
            <p:spPr>
              <a:xfrm>
                <a:off x="7517513" y="641038"/>
                <a:ext cx="14488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/>
                  <a:t>Hopp</a:t>
                </a:r>
                <a:r>
                  <a:rPr lang="en-US" sz="1600" dirty="0"/>
                  <a:t> &amp; Woods</a:t>
                </a:r>
              </a:p>
            </p:txBody>
          </p:sp>
          <p:cxnSp>
            <p:nvCxnSpPr>
              <p:cNvPr id="290" name="Straight Connector 289">
                <a:extLst>
                  <a:ext uri="{FF2B5EF4-FFF2-40B4-BE49-F238E27FC236}">
                    <a16:creationId xmlns:a16="http://schemas.microsoft.com/office/drawing/2014/main" id="{3D165928-33DE-4171-994A-A042D0D8B678}"/>
                  </a:ext>
                </a:extLst>
              </p:cNvPr>
              <p:cNvCxnSpPr>
                <a:cxnSpLocks/>
                <a:endCxn id="288" idx="1"/>
              </p:cNvCxnSpPr>
              <p:nvPr/>
            </p:nvCxnSpPr>
            <p:spPr>
              <a:xfrm>
                <a:off x="7212731" y="810315"/>
                <a:ext cx="304782" cy="0"/>
              </a:xfrm>
              <a:prstGeom prst="line">
                <a:avLst/>
              </a:prstGeom>
              <a:ln w="19050">
                <a:solidFill>
                  <a:srgbClr val="D452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E6BF128B-0C18-4B1B-B192-51957CC6722A}"/>
                  </a:ext>
                </a:extLst>
              </p:cNvPr>
              <p:cNvSpPr/>
              <p:nvPr/>
            </p:nvSpPr>
            <p:spPr>
              <a:xfrm>
                <a:off x="7182429" y="6205045"/>
                <a:ext cx="1078992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888C1463-464B-43E2-A700-EFCD33AD0F4E}"/>
                  </a:ext>
                </a:extLst>
              </p:cNvPr>
              <p:cNvSpPr/>
              <p:nvPr/>
            </p:nvSpPr>
            <p:spPr>
              <a:xfrm>
                <a:off x="4594107" y="6520479"/>
                <a:ext cx="923544" cy="109728"/>
              </a:xfrm>
              <a:prstGeom prst="rect">
                <a:avLst/>
              </a:prstGeom>
              <a:solidFill>
                <a:schemeClr val="accent4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EF8BE15A-8AE9-41A8-975F-A87B8C8F4768}"/>
                  </a:ext>
                </a:extLst>
              </p:cNvPr>
              <p:cNvSpPr txBox="1"/>
              <p:nvPr/>
            </p:nvSpPr>
            <p:spPr>
              <a:xfrm>
                <a:off x="8050185" y="5944163"/>
                <a:ext cx="359394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4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924ABB36-6204-4B09-B4FF-4ABDF2F7F35C}"/>
                  </a:ext>
                </a:extLst>
              </p:cNvPr>
              <p:cNvSpPr txBox="1"/>
              <p:nvPr/>
            </p:nvSpPr>
            <p:spPr>
              <a:xfrm>
                <a:off x="8176394" y="6115759"/>
                <a:ext cx="359394" cy="297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dirty="0"/>
                  <a:t>X7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B005D2C6-6BD9-4520-8D5C-EC13563FA7FB}"/>
                  </a:ext>
                </a:extLst>
              </p:cNvPr>
              <p:cNvSpPr txBox="1"/>
              <p:nvPr/>
            </p:nvSpPr>
            <p:spPr>
              <a:xfrm>
                <a:off x="6343843" y="3634478"/>
                <a:ext cx="2321610" cy="55720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1800"/>
                  </a:lnSpc>
                </a:pPr>
                <a:r>
                  <a:rPr lang="en-US" dirty="0"/>
                  <a:t>Kri1 C</a:t>
                </a:r>
                <a:r>
                  <a:rPr lang="en-US" sz="1800" dirty="0"/>
                  <a:t>(KRI1-like family C-terminal) family</a:t>
                </a:r>
                <a:endParaRPr lang="en-US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7CA1D2E7-9EBD-4C4A-B285-0D316D02105D}"/>
                  </a:ext>
                </a:extLst>
              </p:cNvPr>
              <p:cNvSpPr txBox="1"/>
              <p:nvPr/>
            </p:nvSpPr>
            <p:spPr>
              <a:xfrm>
                <a:off x="4495746" y="3626219"/>
                <a:ext cx="1636230" cy="55720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1800"/>
                  </a:lnSpc>
                </a:pPr>
                <a:r>
                  <a:rPr lang="en-US" dirty="0"/>
                  <a:t>Kri1 </a:t>
                </a:r>
                <a:r>
                  <a:rPr lang="en-US" sz="1800" dirty="0"/>
                  <a:t>(KRI1-like) family</a:t>
                </a:r>
                <a:endParaRPr lang="en-US" dirty="0"/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0733A3ED-AC45-4228-89C1-48A8A6DDF406}"/>
                  </a:ext>
                </a:extLst>
              </p:cNvPr>
              <p:cNvSpPr/>
              <p:nvPr/>
            </p:nvSpPr>
            <p:spPr>
              <a:xfrm>
                <a:off x="4679155" y="3231623"/>
                <a:ext cx="1257301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411C5910-E567-460C-ADEC-A0722A357BBC}"/>
                  </a:ext>
                </a:extLst>
              </p:cNvPr>
              <p:cNvSpPr/>
              <p:nvPr/>
            </p:nvSpPr>
            <p:spPr>
              <a:xfrm>
                <a:off x="6862763" y="3232236"/>
                <a:ext cx="1069181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C525D88A-DE45-44BA-A9D8-ED9CA6CFE366}"/>
                  </a:ext>
                </a:extLst>
              </p:cNvPr>
              <p:cNvSpPr/>
              <p:nvPr/>
            </p:nvSpPr>
            <p:spPr>
              <a:xfrm>
                <a:off x="758693" y="3231497"/>
                <a:ext cx="8120988" cy="1066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/>
              </a:p>
            </p:txBody>
          </p:sp>
        </p:grp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37D6EE1-AD0F-423F-8874-3E7546BEF36C}"/>
                </a:ext>
              </a:extLst>
            </p:cNvPr>
            <p:cNvSpPr txBox="1"/>
            <p:nvPr/>
          </p:nvSpPr>
          <p:spPr>
            <a:xfrm>
              <a:off x="10104" y="8980"/>
              <a:ext cx="28033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upplemental Figure 23</a:t>
              </a: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AAEB18EA-51EA-38EB-9CE7-4C0DB346E43F}"/>
              </a:ext>
            </a:extLst>
          </p:cNvPr>
          <p:cNvSpPr/>
          <p:nvPr/>
        </p:nvSpPr>
        <p:spPr>
          <a:xfrm>
            <a:off x="8311889" y="6534605"/>
            <a:ext cx="155448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34F10FE-5403-D727-4047-59A0DCA1C92A}"/>
              </a:ext>
            </a:extLst>
          </p:cNvPr>
          <p:cNvSpPr txBox="1"/>
          <p:nvPr/>
        </p:nvSpPr>
        <p:spPr>
          <a:xfrm>
            <a:off x="6240169" y="6311070"/>
            <a:ext cx="299665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12 aa deletion due to alternative splicin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426F8E-3913-C48E-70E0-B772905063A7}"/>
              </a:ext>
            </a:extLst>
          </p:cNvPr>
          <p:cNvSpPr txBox="1"/>
          <p:nvPr/>
        </p:nvSpPr>
        <p:spPr>
          <a:xfrm>
            <a:off x="697662" y="6571038"/>
            <a:ext cx="78568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3G24080.2, .3 and .4 (630, 628 and 626 aa, respectively).</a:t>
            </a:r>
          </a:p>
        </p:txBody>
      </p:sp>
    </p:spTree>
    <p:extLst>
      <p:ext uri="{BB962C8B-B14F-4D97-AF65-F5344CB8AC3E}">
        <p14:creationId xmlns:p14="http://schemas.microsoft.com/office/powerpoint/2010/main" val="83102132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F2D19F2-7B73-4984-8380-D029950D35A3}"/>
              </a:ext>
            </a:extLst>
          </p:cNvPr>
          <p:cNvGrpSpPr/>
          <p:nvPr/>
        </p:nvGrpSpPr>
        <p:grpSpPr>
          <a:xfrm>
            <a:off x="0" y="270068"/>
            <a:ext cx="10287729" cy="6019218"/>
            <a:chOff x="0" y="1128"/>
            <a:chExt cx="10287729" cy="6019218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65BA73C3-AE3F-4FC4-AF88-0CC60BEF910A}"/>
                </a:ext>
              </a:extLst>
            </p:cNvPr>
            <p:cNvSpPr txBox="1"/>
            <p:nvPr/>
          </p:nvSpPr>
          <p:spPr>
            <a:xfrm>
              <a:off x="708899" y="2787192"/>
              <a:ext cx="8450505" cy="1166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KSLHVAANAGDLAEDCGILGGDADDTVLMDGIDEVGREIWLDDHGGDNNHVHGHQDDDLIVHHDPSIFYGDLPTLPDFPCMSSSSSSSTSPAPVNAIVSSASSSSAASSSTSSAASWAILRSDGEDPTPNQNQYASGNCDDSSGALQSTASMEIPLDSSQGFGCGEGGGDCIDMMETFGYMDLLDSNEFFDTSAIFSQDDDTQNPNLMDQTLERQEDQVVVPMMENNSGGDMQMMNSSLEQDDDLAAVFLEWLKNNKETVSAEDLRKVKIKKATIESAARRLGGGKEAMKQLLKLILEWVQTNHLQRRRTTTTTTNLSYQQSFQQDPFQNPNPNNNNLIPPSDQTCFSPSTWVPPPPQQQAFVSDPGFGYMPAPNYPPQPEFLPLLESPPSWPPPPQSGPMPHQQFPMPPTSQYNQFGDPTGFNGYNMNPYQYPYVPAGQMRDQRLLRLCSSATKEARKKRMARQRRFLSHHHRHNNNNNNNNNNQQNQTQIGETCAAVAPQLNPVATTATGGTWMYWPNVPAVPPQLPPVMETQLPTMDRAGSASAMPRQQVVPDRRQGWKPEKNLRFLL</a:t>
              </a:r>
              <a:r>
                <a:rPr lang="en-US" sz="1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KVLKQSDVGNLGRIVLPKKEAETHLPELEARDGISLAMEDIGTSRVWNMRYRFWPNNKSRMYLLENTGDFVKTNGLQEGDFIVIYSDVKCGKYLI</a:t>
              </a: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GVKVRQPSGQKPEAPPSSAATKRQNKSQRNINNNSPSANVVVASPTSQTVK</a:t>
              </a:r>
              <a:endParaRPr lang="en-US" sz="1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B972ED7-23D9-4131-9D73-4E5F9D5460B4}"/>
                </a:ext>
              </a:extLst>
            </p:cNvPr>
            <p:cNvSpPr txBox="1"/>
            <p:nvPr/>
          </p:nvSpPr>
          <p:spPr>
            <a:xfrm>
              <a:off x="706857" y="2975175"/>
              <a:ext cx="9580872" cy="1154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KSLHVAANAGDLAEDCGILGGDADDTVLMDGIDEVGREIWLDDHGGDNNHVHGHQDDDLIVHHDPSIFYGDLPTLPDFPCMSSSSSSSTSPAPVNAIVSSASSSSAASSSTSSAASWAILRSDGEDPTPNQNQYASGNCDDSSGALQSTASMEIPLDSSQGFGCGEGGGDCIDMMETFGYMDLLDSNEFFDTSAIFSQDDDTQNPNLMDQTLERQEDQVVVPMMENNSGGDMQMMNSSLEQDDDLAAVFLEWLKNNKETVSAEDLRKVKIKKATIESAARRLGGGKEAMKQLLKLILEWVQTNHLQRRRTTTTTTNLSYQQSFQQDPFQNPNPNNNNLIPPSDQTCFSPSTWVPPPPQQQAFVSDPGFGYMPAPNYPPQPEFLPLLESPPSWPPPPQSGPMPHQQFPMPPTSQYNQFGDPTGFNGYNMNPYQYPYVPAGQMRDQRLLRLCSSATKEARKKRMAR</a:t>
              </a:r>
              <a:r>
                <a:rPr lang="en-US" sz="15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QRRFLSHHHRHNNNNNNNNNNQQNQTQ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IGETCAAVAPQLNPVATTATGGTWMYWPNVPAVPPQLPPVMET</a:t>
              </a:r>
              <a:r>
                <a:rPr lang="en-US" sz="1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QLPTMDRAGSASAMPRQQVVPDRRQGWKPEKNLRFLLQKVLKQSDVGNLGRIVLPKKEAETHLP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ELEARDGISLAMEDIGTSRVWNMRYRFWPNNKSRMYLLENTGDFVKTNGLQEGDFIVIYSDVKCGKYLIRGVKVRQPSGQKPEAPPSSA</a:t>
              </a:r>
              <a:r>
                <a:rPr lang="en-US" sz="1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A</a:t>
              </a: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TKRQNKSQRNINNNSPSANVVVASPTSQTVK</a:t>
              </a:r>
              <a:endParaRPr lang="en-US" sz="1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F2766A4-9984-485E-8FEC-78BC0BDA524C}"/>
                </a:ext>
              </a:extLst>
            </p:cNvPr>
            <p:cNvSpPr txBox="1"/>
            <p:nvPr/>
          </p:nvSpPr>
          <p:spPr>
            <a:xfrm>
              <a:off x="707585" y="2891944"/>
              <a:ext cx="9340744" cy="1186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5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MKSLHVAANAGDLAEDCGILGGDADDTVLMDGIDEVGREIWLDDHGGDNNHVHGHQDDDLIVHHDPSIFYGDLPTLPDFPCMSSSSSSSTSPAPVNAIVSSASSSSAASSSTSSAASWAIL</a:t>
              </a:r>
              <a:r>
                <a:rPr lang="en-US" sz="150" dirty="0">
                  <a:solidFill>
                    <a:srgbClr val="000000"/>
                  </a:solidFill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RSDGEDPTPNQNQYASGNCDDSSGA</a:t>
              </a:r>
              <a:r>
                <a:rPr lang="en-US" sz="15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LQSTASMEIPLDSSQGFGCGEGGGDCIDMMETFGYMDLLDSNEFFDTSAIFSQDDDTQNPNLMDQTLERQEDQVVVPMMENNSGGDMQMMNSSLEQDDDLAAVFLEWLKNNKETVSAEDLRKVKIKKATIESAARRLGGGKEAMKQLLKLILEWVQTNHLQRRRTTTTTTNLSYQQS</a:t>
              </a:r>
              <a:r>
                <a:rPr lang="en-US" sz="150" dirty="0">
                  <a:solidFill>
                    <a:srgbClr val="000000"/>
                  </a:solidFill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FQQDPFQNPNPNNNNLIPPSDQTCFSPSTWVPPPPQQ</a:t>
              </a:r>
              <a:r>
                <a:rPr lang="en-US" sz="15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QAFVSDPGFGYMPAPNYPPQPEFLPLLESPPSWPPPPQSGPMPHQQFPMPPTSQYNQFGDPTGFNGYNMNPYQYPYVPAGQMRDQRLLRLCSSATKEARKKRMARQRRFLSHHHRHNNNNNNNNNNQQNQTQIGETCAAVAPQLNPVATTATGGTWMYWPNVPAVPPQLPPVMETQLPTMDRAGSASAMPRQQVVPDRRQGWKPEKNLR</a:t>
              </a:r>
              <a:r>
                <a:rPr lang="en-US" sz="150" dirty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FLLQKVLKQSDVGNLGRIVLPKKEAETHLPELEARDGISLAMEDIGTSRVWNMRYRFWPNNKSRMYLLENTGDFVKTNGLQEGDFIVIYSDVKCGKYLIRGV</a:t>
              </a:r>
              <a:r>
                <a:rPr lang="en-US" sz="15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KVR</a:t>
              </a:r>
              <a:r>
                <a:rPr lang="en-US" sz="150" dirty="0">
                  <a:solidFill>
                    <a:srgbClr val="000000"/>
                  </a:solidFill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QPSGQKPEAPPSSAATKRQNKSQRNINNNSPSANVVVASPTSQTVK</a:t>
              </a:r>
              <a:endParaRPr lang="en-US" sz="15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endParaRPr>
            </a:p>
          </p:txBody>
        </p:sp>
        <p:pic>
          <p:nvPicPr>
            <p:cNvPr id="35" name="Picture 34" descr="Chart&#10;&#10;Description automatically generated">
              <a:extLst>
                <a:ext uri="{FF2B5EF4-FFF2-40B4-BE49-F238E27FC236}">
                  <a16:creationId xmlns:a16="http://schemas.microsoft.com/office/drawing/2014/main" id="{B79D1B0E-1FB6-4903-A1F3-855CB38EE48F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99" t="11253" r="4912" b="12116"/>
            <a:stretch/>
          </p:blipFill>
          <p:spPr>
            <a:xfrm>
              <a:off x="713555" y="636360"/>
              <a:ext cx="8130407" cy="3557016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2669C82-A76D-4C36-9541-1B00A7BE151D}"/>
                </a:ext>
              </a:extLst>
            </p:cNvPr>
            <p:cNvSpPr txBox="1"/>
            <p:nvPr/>
          </p:nvSpPr>
          <p:spPr>
            <a:xfrm>
              <a:off x="0" y="1128"/>
              <a:ext cx="9005607" cy="667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70" dirty="0"/>
                <a:t>AT3G24650: ABA INSENSITIVE 3, ABI3, ABSCISIC ACID INSENSITIVE 3, ATABI3, SIS10, SUGAR INSENSITIVE 10; 720 amino acids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2B4E3B1-390F-460D-9411-AC395211A87C}"/>
                </a:ext>
              </a:extLst>
            </p:cNvPr>
            <p:cNvSpPr txBox="1"/>
            <p:nvPr/>
          </p:nvSpPr>
          <p:spPr>
            <a:xfrm>
              <a:off x="7409383" y="617917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7AD05408-8768-4B19-B704-634F78CCB5F1}"/>
                </a:ext>
              </a:extLst>
            </p:cNvPr>
            <p:cNvCxnSpPr>
              <a:cxnSpLocks/>
              <a:endCxn id="47" idx="1"/>
            </p:cNvCxnSpPr>
            <p:nvPr/>
          </p:nvCxnSpPr>
          <p:spPr>
            <a:xfrm>
              <a:off x="7104601" y="787194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7A7448F-2383-43BF-A708-91709EA14456}"/>
                </a:ext>
              </a:extLst>
            </p:cNvPr>
            <p:cNvSpPr txBox="1"/>
            <p:nvPr/>
          </p:nvSpPr>
          <p:spPr>
            <a:xfrm>
              <a:off x="443198" y="101373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2814688-B875-4B9D-B875-35F3E818A042}"/>
                </a:ext>
              </a:extLst>
            </p:cNvPr>
            <p:cNvSpPr txBox="1"/>
            <p:nvPr/>
          </p:nvSpPr>
          <p:spPr>
            <a:xfrm>
              <a:off x="527117" y="1494614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0C319DC-7045-4001-95AE-D111760F6F0D}"/>
                </a:ext>
              </a:extLst>
            </p:cNvPr>
            <p:cNvSpPr txBox="1"/>
            <p:nvPr/>
          </p:nvSpPr>
          <p:spPr>
            <a:xfrm>
              <a:off x="443198" y="199489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4049704-AF9F-4A72-BE48-F9EB7AC67636}"/>
                </a:ext>
              </a:extLst>
            </p:cNvPr>
            <p:cNvSpPr txBox="1"/>
            <p:nvPr/>
          </p:nvSpPr>
          <p:spPr>
            <a:xfrm>
              <a:off x="508637" y="250062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D8DB1DA-49B4-486C-9F7F-A1C2BB278E26}"/>
                </a:ext>
              </a:extLst>
            </p:cNvPr>
            <p:cNvSpPr txBox="1"/>
            <p:nvPr/>
          </p:nvSpPr>
          <p:spPr>
            <a:xfrm>
              <a:off x="395476" y="3003996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E41E521-F741-4AE5-91A1-D919FA702AB3}"/>
                </a:ext>
              </a:extLst>
            </p:cNvPr>
            <p:cNvSpPr txBox="1"/>
            <p:nvPr/>
          </p:nvSpPr>
          <p:spPr>
            <a:xfrm>
              <a:off x="476391" y="3501157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2B788F6-2141-4D5E-91CF-7D5AEA295CDF}"/>
                </a:ext>
              </a:extLst>
            </p:cNvPr>
            <p:cNvSpPr txBox="1"/>
            <p:nvPr/>
          </p:nvSpPr>
          <p:spPr>
            <a:xfrm>
              <a:off x="653386" y="4124229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94C3888-B2E4-4B67-896E-3DA652A3B255}"/>
                </a:ext>
              </a:extLst>
            </p:cNvPr>
            <p:cNvSpPr txBox="1"/>
            <p:nvPr/>
          </p:nvSpPr>
          <p:spPr>
            <a:xfrm>
              <a:off x="1670439" y="4125738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79FC45D-3AFD-4FF1-A215-E372618DF7BA}"/>
                </a:ext>
              </a:extLst>
            </p:cNvPr>
            <p:cNvSpPr txBox="1"/>
            <p:nvPr/>
          </p:nvSpPr>
          <p:spPr>
            <a:xfrm rot="16200000">
              <a:off x="-541591" y="2249821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DFB13D4-0FBD-4990-86C3-1B70B1687239}"/>
                </a:ext>
              </a:extLst>
            </p:cNvPr>
            <p:cNvSpPr txBox="1"/>
            <p:nvPr/>
          </p:nvSpPr>
          <p:spPr>
            <a:xfrm>
              <a:off x="3578110" y="4309290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235BE32-1DF7-4F08-8EF5-DFB00406B590}"/>
                </a:ext>
              </a:extLst>
            </p:cNvPr>
            <p:cNvSpPr txBox="1"/>
            <p:nvPr/>
          </p:nvSpPr>
          <p:spPr>
            <a:xfrm>
              <a:off x="286607" y="516362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8E65696-EB1B-4772-93B1-4A58DC370CA8}"/>
                </a:ext>
              </a:extLst>
            </p:cNvPr>
            <p:cNvSpPr txBox="1"/>
            <p:nvPr/>
          </p:nvSpPr>
          <p:spPr>
            <a:xfrm>
              <a:off x="316046" y="5415626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65AD673F-0851-4BFC-B8E4-5B02881DA4EC}"/>
                </a:ext>
              </a:extLst>
            </p:cNvPr>
            <p:cNvSpPr txBox="1"/>
            <p:nvPr/>
          </p:nvSpPr>
          <p:spPr>
            <a:xfrm>
              <a:off x="284820" y="572289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21998AC-A70A-4165-989A-2F743396FEE7}"/>
                </a:ext>
              </a:extLst>
            </p:cNvPr>
            <p:cNvSpPr txBox="1"/>
            <p:nvPr/>
          </p:nvSpPr>
          <p:spPr>
            <a:xfrm>
              <a:off x="682629" y="4960138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6B7243B-8C9F-4E3A-B062-6C96A53E5D35}"/>
                </a:ext>
              </a:extLst>
            </p:cNvPr>
            <p:cNvSpPr txBox="1"/>
            <p:nvPr/>
          </p:nvSpPr>
          <p:spPr>
            <a:xfrm>
              <a:off x="682884" y="4609667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62438EA-38B8-4E26-BF3A-C679EF9B2FB3}"/>
                </a:ext>
              </a:extLst>
            </p:cNvPr>
            <p:cNvSpPr txBox="1"/>
            <p:nvPr/>
          </p:nvSpPr>
          <p:spPr>
            <a:xfrm>
              <a:off x="285883" y="479213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35B9196-ED80-405F-8AFC-0A2641EF685B}"/>
                </a:ext>
              </a:extLst>
            </p:cNvPr>
            <p:cNvSpPr txBox="1"/>
            <p:nvPr/>
          </p:nvSpPr>
          <p:spPr>
            <a:xfrm>
              <a:off x="380301" y="3981069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CBBEA1A-4278-46DA-BCA2-87E11833CE65}"/>
                </a:ext>
              </a:extLst>
            </p:cNvPr>
            <p:cNvSpPr txBox="1"/>
            <p:nvPr/>
          </p:nvSpPr>
          <p:spPr>
            <a:xfrm>
              <a:off x="2790809" y="412391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BA5E35F-268A-46F7-B927-92560C7F8926}"/>
                </a:ext>
              </a:extLst>
            </p:cNvPr>
            <p:cNvSpPr txBox="1"/>
            <p:nvPr/>
          </p:nvSpPr>
          <p:spPr>
            <a:xfrm>
              <a:off x="7252303" y="412390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312B0CB-AA8F-4FA6-B1D6-96C735F645E8}"/>
                </a:ext>
              </a:extLst>
            </p:cNvPr>
            <p:cNvSpPr txBox="1"/>
            <p:nvPr/>
          </p:nvSpPr>
          <p:spPr>
            <a:xfrm>
              <a:off x="3912162" y="412573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5B0B9F91-5260-4ADC-AEC4-881F48CCDA84}"/>
                </a:ext>
              </a:extLst>
            </p:cNvPr>
            <p:cNvSpPr txBox="1"/>
            <p:nvPr/>
          </p:nvSpPr>
          <p:spPr>
            <a:xfrm>
              <a:off x="6131417" y="413175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7FE7931-63A2-4EA6-B0FC-51F0D6FFCCC3}"/>
                </a:ext>
              </a:extLst>
            </p:cNvPr>
            <p:cNvSpPr txBox="1"/>
            <p:nvPr/>
          </p:nvSpPr>
          <p:spPr>
            <a:xfrm>
              <a:off x="5010075" y="412571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5EF1A11-4151-45D4-8AF8-6AE18810D7C4}"/>
                </a:ext>
              </a:extLst>
            </p:cNvPr>
            <p:cNvSpPr txBox="1"/>
            <p:nvPr/>
          </p:nvSpPr>
          <p:spPr>
            <a:xfrm>
              <a:off x="8341281" y="4125409"/>
              <a:ext cx="516960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25B70B8-52EB-42E8-80FA-7B1EB33EF0B0}"/>
                </a:ext>
              </a:extLst>
            </p:cNvPr>
            <p:cNvSpPr txBox="1"/>
            <p:nvPr/>
          </p:nvSpPr>
          <p:spPr>
            <a:xfrm>
              <a:off x="533936" y="52022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C25D5EA-6516-4473-BB2C-B9CA789A4FDD}"/>
                </a:ext>
              </a:extLst>
            </p:cNvPr>
            <p:cNvSpPr/>
            <p:nvPr/>
          </p:nvSpPr>
          <p:spPr>
            <a:xfrm>
              <a:off x="6264907" y="5307089"/>
              <a:ext cx="2179005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729D27E7-E4B0-4F30-9191-A1A9A01A5E19}"/>
                </a:ext>
              </a:extLst>
            </p:cNvPr>
            <p:cNvSpPr/>
            <p:nvPr/>
          </p:nvSpPr>
          <p:spPr>
            <a:xfrm>
              <a:off x="5966707" y="5894904"/>
              <a:ext cx="149047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132BCF85-9776-4CEA-811E-C7592514E236}"/>
                </a:ext>
              </a:extLst>
            </p:cNvPr>
            <p:cNvSpPr/>
            <p:nvPr/>
          </p:nvSpPr>
          <p:spPr>
            <a:xfrm>
              <a:off x="6270893" y="5491932"/>
              <a:ext cx="217627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E7A14B7-218D-4661-8013-8BA90640F62B}"/>
                </a:ext>
              </a:extLst>
            </p:cNvPr>
            <p:cNvSpPr txBox="1"/>
            <p:nvPr/>
          </p:nvSpPr>
          <p:spPr>
            <a:xfrm>
              <a:off x="8364626" y="539235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3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CD0E8636-815D-45BF-B840-BE02529E5FBC}"/>
                </a:ext>
              </a:extLst>
            </p:cNvPr>
            <p:cNvSpPr/>
            <p:nvPr/>
          </p:nvSpPr>
          <p:spPr>
            <a:xfrm>
              <a:off x="6266537" y="4902547"/>
              <a:ext cx="217737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6208795-8C08-40E1-B83A-505D53C9707D}"/>
                </a:ext>
              </a:extLst>
            </p:cNvPr>
            <p:cNvSpPr txBox="1"/>
            <p:nvPr/>
          </p:nvSpPr>
          <p:spPr>
            <a:xfrm>
              <a:off x="8356648" y="5220245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8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0840386-9239-4CEE-B928-699AEC87C2BE}"/>
                </a:ext>
              </a:extLst>
            </p:cNvPr>
            <p:cNvSpPr txBox="1"/>
            <p:nvPr/>
          </p:nvSpPr>
          <p:spPr>
            <a:xfrm>
              <a:off x="8373987" y="4796689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3B278A0-EA0C-4139-A32E-EC3871A9D163}"/>
                </a:ext>
              </a:extLst>
            </p:cNvPr>
            <p:cNvSpPr txBox="1"/>
            <p:nvPr/>
          </p:nvSpPr>
          <p:spPr>
            <a:xfrm>
              <a:off x="7373189" y="561840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3320A5B8-C119-4B61-B7B8-6AEC537992C5}"/>
                </a:ext>
              </a:extLst>
            </p:cNvPr>
            <p:cNvSpPr/>
            <p:nvPr/>
          </p:nvSpPr>
          <p:spPr>
            <a:xfrm>
              <a:off x="6746925" y="5704585"/>
              <a:ext cx="70408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2EC613F7-4DA6-4157-8351-4399EA14A4D4}"/>
                </a:ext>
              </a:extLst>
            </p:cNvPr>
            <p:cNvSpPr/>
            <p:nvPr/>
          </p:nvSpPr>
          <p:spPr>
            <a:xfrm>
              <a:off x="7155657" y="2614354"/>
              <a:ext cx="1069182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F3D2FEA3-5DC9-46A7-93A2-6E4AF6E3BE0E}"/>
                </a:ext>
              </a:extLst>
            </p:cNvPr>
            <p:cNvSpPr/>
            <p:nvPr/>
          </p:nvSpPr>
          <p:spPr>
            <a:xfrm>
              <a:off x="787268" y="2614742"/>
              <a:ext cx="8023314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F83360E-46B8-43E8-B344-7E52B09E24DC}"/>
                </a:ext>
              </a:extLst>
            </p:cNvPr>
            <p:cNvSpPr txBox="1"/>
            <p:nvPr/>
          </p:nvSpPr>
          <p:spPr>
            <a:xfrm>
              <a:off x="6670534" y="3655400"/>
              <a:ext cx="2191828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B3 DNA binding domain </a:t>
              </a:r>
              <a:r>
                <a:rPr lang="en-US" sz="1800" dirty="0"/>
                <a:t>family</a:t>
              </a:r>
              <a:endParaRPr lang="en-US" dirty="0"/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id="{10DE5545-697F-4BC4-B069-2D713A390EBA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4</a:t>
            </a:r>
          </a:p>
        </p:txBody>
      </p:sp>
    </p:spTree>
    <p:extLst>
      <p:ext uri="{BB962C8B-B14F-4D97-AF65-F5344CB8AC3E}">
        <p14:creationId xmlns:p14="http://schemas.microsoft.com/office/powerpoint/2010/main" val="57916980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0E93FFD-0519-4BF2-8F93-7476EB284DC7}"/>
              </a:ext>
            </a:extLst>
          </p:cNvPr>
          <p:cNvGrpSpPr/>
          <p:nvPr/>
        </p:nvGrpSpPr>
        <p:grpSpPr>
          <a:xfrm>
            <a:off x="-75077" y="232727"/>
            <a:ext cx="10735042" cy="5775028"/>
            <a:chOff x="-75077" y="232727"/>
            <a:chExt cx="10735042" cy="5775028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6CDB93E-B23F-48CA-81CE-8B2CF0B272A3}"/>
                </a:ext>
              </a:extLst>
            </p:cNvPr>
            <p:cNvSpPr txBox="1"/>
            <p:nvPr/>
          </p:nvSpPr>
          <p:spPr>
            <a:xfrm>
              <a:off x="663119" y="2288128"/>
              <a:ext cx="9996846" cy="1277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ATRLLRTNFIRRSYRLPAFSPVGPPTVTASTAVVPEILSFGQQAPEPPLHHPKPTEQSHDGLDLSDQARLFSSIPTSDLLRSTAVLHAAAIGPMVDLGTWVMSSKLMDASVTRGMVLGLVKSTFYDHFCAGEDADAAAERVRSVYEATGLKGMLVYGVEHADDAVSCDDNMQQFIRTIEAAKSLPTSHFSSVVVKITAICPISLLKRVSDLLRWEYKSPNFKLSWKLKSFPVFSESSPLYHTNSEPEPLTAEEERELEAAHGRIQEICRKCQESNVPLLIDAEDTILQPAIDYMAYSSAIMFNADKDRPIVYNTIQAYLRDAGERLHLAVQNAEKENVPMGFKLVRGAYMSSEASLADSLGCKSPVHDTIQDTHSCYNDCMTFLMEKASNGSGFGVVLATHNADSGRLASRKASDLGIDKQNGKIEFAQ</a:t>
              </a:r>
              <a:r>
                <a:rPr lang="en-US" sz="2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LYGMSDALSFGL</a:t>
              </a:r>
              <a:r>
                <a:rPr lang="en-US" sz="210" dirty="0">
                  <a:effectLst/>
                  <a:highlight>
                    <a:srgbClr val="D3D3D3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KRAGFNV</a:t>
              </a:r>
              <a:r>
                <a:rPr lang="en-US" sz="2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SKYMPFGPVATAIPYLLRRAYENRGMMATGAHDRQLMR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ELKRRLIAGIA</a:t>
              </a:r>
              <a:endParaRPr lang="en-US" sz="21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99A5C3C-684C-4595-B501-8A1CC7A812C5}"/>
                </a:ext>
              </a:extLst>
            </p:cNvPr>
            <p:cNvSpPr txBox="1"/>
            <p:nvPr/>
          </p:nvSpPr>
          <p:spPr>
            <a:xfrm>
              <a:off x="663099" y="2411813"/>
              <a:ext cx="9230992" cy="1263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TRLLRTNFIRRSYRLPAFSPVGPPTVTASTAVVPEILSFGQQAPEPPLHHPKPTEQSHDGLDLSDQARLFSSIPTSDLLRSTAVLHAAAIGPMVDLGTWVMSSKLMDASVTRGMVLGLVKSTFYDHFCAGEDADAAAERVRSVYEAT</a:t>
              </a:r>
              <a:r>
                <a:rPr lang="en-US" sz="2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LKGMLVYGVEHADDAVSCDDNMQQFIRTIEAAKSLPTSHFSSVVVKITAICPISLLKRVSDLLRWEYKSPNFKLSWKLKSFPVFSESSPLYHTNSEPEPLTAEEERELEAAHGRIQEICRKCQESNVPLLIDAEDTILQPAIDYMAYSSAIMFNADKDRPIVYNTIQAYLRDAGERLHLAVQNAEKENVPMGFKLVRGAYMSSEASLADSLGCKSPVHDTIQDTHSCYNDCMTFLMEKASNGSGFGVVLATHNADSGRLASRKASDLGIDKQNGKIEFAQLYGMSDALSFGLKRAGFNVSKYMPFGPVATAIPYLLRRAYENRGM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TGAHDRQLMRMELKRRLIAGIA</a:t>
              </a:r>
              <a:endParaRPr lang="en-US" sz="2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 descr="Chart&#10;&#10;Description automatically generated">
              <a:extLst>
                <a:ext uri="{FF2B5EF4-FFF2-40B4-BE49-F238E27FC236}">
                  <a16:creationId xmlns:a16="http://schemas.microsoft.com/office/drawing/2014/main" id="{973EF597-8DFC-4635-88F1-0200EACBD178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97" t="9757" r="4302" b="10898"/>
            <a:stretch/>
          </p:blipFill>
          <p:spPr>
            <a:xfrm>
              <a:off x="650727" y="551479"/>
              <a:ext cx="8126561" cy="3627637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75077" y="232727"/>
              <a:ext cx="7956024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30775.1 or .2: ARABIDOPSIS THALIANA PROLINE OXIDASE; 499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13137" y="496304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47948" y="95658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12817" y="144698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47948" y="194727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22912" y="246252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19276" y="2927796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71616" y="3424957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07454" y="4054617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106366" y="4038855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55891" y="2249821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69445" y="4240660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166433" y="5247842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193236" y="5514927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162458" y="570596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7771490" y="5414671"/>
              <a:ext cx="71323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7582352" y="5803610"/>
              <a:ext cx="90525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39367" y="5069988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7583295" y="5596736"/>
              <a:ext cx="89611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8418793" y="5515165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8414631" y="5710301"/>
              <a:ext cx="617477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00+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39367" y="4472153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165709" y="4637066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167538" y="486308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7582352" y="4791010"/>
              <a:ext cx="90525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398157" y="4691662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7582352" y="4950460"/>
              <a:ext cx="90525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8415568" y="485011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04101" y="3904869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700732" y="404187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500728" y="40501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301231" y="40501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6098693" y="404968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6886630" y="406001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7684575" y="404866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00477" y="612261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995695" y="781538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B01E1D5-6E26-4B11-8343-AC2C2ED3245F}"/>
                </a:ext>
              </a:extLst>
            </p:cNvPr>
            <p:cNvSpPr txBox="1"/>
            <p:nvPr/>
          </p:nvSpPr>
          <p:spPr>
            <a:xfrm>
              <a:off x="2897621" y="404492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B957FB5-596D-494F-AA72-68FA9FD447CC}"/>
                </a:ext>
              </a:extLst>
            </p:cNvPr>
            <p:cNvSpPr txBox="1"/>
            <p:nvPr/>
          </p:nvSpPr>
          <p:spPr>
            <a:xfrm>
              <a:off x="1353024" y="403646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73B82F22-0DD6-44F8-829E-5A1FA6AAEEF5}"/>
                </a:ext>
              </a:extLst>
            </p:cNvPr>
            <p:cNvSpPr/>
            <p:nvPr/>
          </p:nvSpPr>
          <p:spPr>
            <a:xfrm>
              <a:off x="3119437" y="2570536"/>
              <a:ext cx="5176838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89F14F19-9C06-4A1E-B028-083EA49B7283}"/>
                </a:ext>
              </a:extLst>
            </p:cNvPr>
            <p:cNvSpPr/>
            <p:nvPr/>
          </p:nvSpPr>
          <p:spPr>
            <a:xfrm>
              <a:off x="744406" y="2571878"/>
              <a:ext cx="7940014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0207B70-9E88-48F3-9170-96B6C3720E54}"/>
                </a:ext>
              </a:extLst>
            </p:cNvPr>
            <p:cNvSpPr txBox="1"/>
            <p:nvPr/>
          </p:nvSpPr>
          <p:spPr>
            <a:xfrm>
              <a:off x="4067703" y="3774800"/>
              <a:ext cx="329975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Proline dehydrogenase </a:t>
              </a:r>
              <a:r>
                <a:rPr lang="en-US" sz="1800" dirty="0"/>
                <a:t>family</a:t>
              </a:r>
              <a:endParaRPr lang="en-US" dirty="0"/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09E0C90E-3B8A-413D-9CB3-7B1D8FCC23B4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5</a:t>
            </a:r>
          </a:p>
        </p:txBody>
      </p:sp>
    </p:spTree>
    <p:extLst>
      <p:ext uri="{BB962C8B-B14F-4D97-AF65-F5344CB8AC3E}">
        <p14:creationId xmlns:p14="http://schemas.microsoft.com/office/powerpoint/2010/main" val="241057976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>
            <a:extLst>
              <a:ext uri="{FF2B5EF4-FFF2-40B4-BE49-F238E27FC236}">
                <a16:creationId xmlns:a16="http://schemas.microsoft.com/office/drawing/2014/main" id="{21087AB5-B702-4F5E-9A14-5EB8653D4FF1}"/>
              </a:ext>
            </a:extLst>
          </p:cNvPr>
          <p:cNvSpPr txBox="1"/>
          <p:nvPr/>
        </p:nvSpPr>
        <p:spPr>
          <a:xfrm>
            <a:off x="1547537" y="3503721"/>
            <a:ext cx="7498557" cy="123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MAVSEQSQDVFPWLKSLPVAPEFRPTLAEFQDPIAYILKIEEEASRYGICKILPPLPPPSKKTSISNLNRSLAARAAARVRDGGFGACDYDGGPTFATRQQQIGFCPRKQRPVQRPVWQSGEEYSFGEFEFKAKNFEKNYLKKCGKKSQLSALEIETLYWRATVDKPFSVEYANDMPGSAFIPLSLAAARRRESGGEGGTVGETAWNMRAMSRAEGSLLKFMKEEIPGVTSPMVYVAMMFSWFAWHVEDHDLHSLNYLHMGAGKTWYGVPKDAALAFEEVVRVHGYGEELNPLVTFSTLGEKTTVMSPEVFVKAGIPCCRLVQNPGEFVVTFPGAYHSGFSHGFNFGEASNIATPEWLRMAKDAAIRRAAINYPPMVSHLQLLYDFVLALGSRVPTSINPKPRSSRLKDKARSEGERLTKKLFVQNIIHNNELLSSLGKGSPVALLPQSSSDISVCSDLRIGSHLITNQENPIQLKCEDLSSDSVVVDLSNGLKDTVSVKEKFTSLCERSRNHLASTEKDTQETLSDAERRKNDAAVALSDQRLFSCVTCGVLSFDCVAIVQPKEAAARYLMSADCSFFNDWTAASGSANLGQAARSLHPQSKEKHDVNYFYNVPVQTMDHSVKTGDQKTSTTSPTIAHKDNDVLGMLASAYGDSSDSEEEDQKGLVTPSSKGETKTYDQEGSDGHEEARDGRTSDFNCQRLTSEQNGLSKGGKSSLLEIALPFIPRSDDDSCRLHVFCLEHAAEVEQQLRPFGGINLMLLCHPEYPRIEAEAKIVAEELVINHEWNDTEFRNVTREDEETIQAALDNVEAKGGNSDWTVKLGVNLSYSAILSRSPLYSKQMPYNSIIYKAFGRSSPVASSPSKPKVSGKRSSRQRKYVVGKWCGKVWMSHQVHPFLLEQDLEGEESERSCHLRVAMDEDATGKRSFPNNVSRDSTTMFGRKYCRKRKIRAKAVPRKKLTSFKREDGVSDDTSEDHSYKQQWRASGNEEESYFETGNTASGDSSNQMSDPHKGIIRHKGYKEFESDDEVSDRSLGEEYTVRACAASESSMENGSQHSMYDHDDDDDDIDRQPRGIPRSQQTRVFRNPVSYESEDNGVYQQSGRISISNRQANRMVGEYDSAE</a:t>
            </a:r>
            <a:r>
              <a:rPr lang="en-US" sz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SLEERGFCSTGKRQTRSTAKRIAKTKTVQSSRDTKGRFLQEFASGKKNEELDSYMEGPSTRLR</a:t>
            </a:r>
            <a:r>
              <a:rPr lang="en-US" sz="100" dirty="0"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RHQ</a:t>
            </a:r>
            <a:r>
              <a:rPr lang="en-US" sz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PSRGSLETKPKKIGKKRSGNASFSRVATEKDVEE</a:t>
            </a:r>
            <a:r>
              <a:rPr lang="en-US" sz="1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KEEEEEEEENEEEECAAYQCNMEGCTMSFSSEKQLMLHKRNICPIKGCGKNFFSHKYLVQHQR</a:t>
            </a:r>
            <a:r>
              <a:rPr lang="en-US" sz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HSDDRPLKCPWKGCKMTFKWAWSRTEHIRVHTGARPYVCAEPDCGQTFRFVSDFSRHKRK</a:t>
            </a:r>
            <a:r>
              <a:rPr lang="en-US" sz="100" dirty="0">
                <a:effectLst/>
                <a:latin typeface="Courier New" panose="02070309020205020404" pitchFamily="49" charset="0"/>
                <a:ea typeface="Calibri" panose="020F0502020204030204" pitchFamily="34" charset="0"/>
              </a:rPr>
              <a:t>TGHSVKKTNKR</a:t>
            </a:r>
            <a:endParaRPr lang="en-US" sz="100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959B7FC-DBA8-4792-9E3A-41C7EEED822A}"/>
              </a:ext>
            </a:extLst>
          </p:cNvPr>
          <p:cNvGrpSpPr/>
          <p:nvPr/>
        </p:nvGrpSpPr>
        <p:grpSpPr>
          <a:xfrm>
            <a:off x="-35101" y="246526"/>
            <a:ext cx="9275084" cy="6250865"/>
            <a:chOff x="-35101" y="246526"/>
            <a:chExt cx="9275084" cy="625086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B0BB80A-3501-4C46-8904-C4D36B66FEA6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6" t="19166" b="-1"/>
            <a:stretch/>
          </p:blipFill>
          <p:spPr>
            <a:xfrm>
              <a:off x="531019" y="3378964"/>
              <a:ext cx="8451056" cy="5956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BBDC128-F15C-49AB-AE15-B5210CE56B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3" t="-6181"/>
            <a:stretch/>
          </p:blipFill>
          <p:spPr>
            <a:xfrm>
              <a:off x="519114" y="3310149"/>
              <a:ext cx="8460244" cy="92132"/>
            </a:xfrm>
            <a:prstGeom prst="rect">
              <a:avLst/>
            </a:prstGeom>
          </p:spPr>
        </p:pic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CA5E8BA5-7A8D-4EFB-9905-CC41F2B39C96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74" t="10885" r="5002" b="11740"/>
            <a:stretch/>
          </p:blipFill>
          <p:spPr>
            <a:xfrm>
              <a:off x="419027" y="993374"/>
              <a:ext cx="8572501" cy="3537578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35101" y="246526"/>
              <a:ext cx="9144000" cy="6669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3G48430.1: EIN6, ETHYLENE INSENSITIVE 6, JMJ12, JUMONJI DOMAIN-CONTAINING PROTEIN 12, REF6, RELATIVE OF EARLY FLOWERING 6; 1360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30652" y="158360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170616" y="192951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20854" y="225310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170347" y="261036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18594" y="298360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128104" y="3295720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179400" y="3670442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179849" y="1237467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393965" y="442615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6472599" y="4428620"/>
              <a:ext cx="530915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68753" y="262150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72097" y="4593312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-5818" y="581576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-5924" y="597340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11625" y="5614616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8A0873A-F8FD-4145-9021-3ACE4A37BAE7}"/>
                </a:ext>
              </a:extLst>
            </p:cNvPr>
            <p:cNvSpPr txBox="1"/>
            <p:nvPr/>
          </p:nvSpPr>
          <p:spPr>
            <a:xfrm>
              <a:off x="7821995" y="6199936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8039363" y="6013008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B6C7952F-CBF3-43EE-87BC-2A1429C154B5}"/>
                </a:ext>
              </a:extLst>
            </p:cNvPr>
            <p:cNvSpPr/>
            <p:nvPr/>
          </p:nvSpPr>
          <p:spPr>
            <a:xfrm>
              <a:off x="7477565" y="6289420"/>
              <a:ext cx="420624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14063" y="4780014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-6884" y="4964390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4785" y="526454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-9939" y="547587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7E2E0FAE-55D3-4451-9C5A-052C4A520375}"/>
                </a:ext>
              </a:extLst>
            </p:cNvPr>
            <p:cNvSpPr txBox="1"/>
            <p:nvPr/>
          </p:nvSpPr>
          <p:spPr>
            <a:xfrm>
              <a:off x="8794027" y="5078678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67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7477565" y="5021497"/>
              <a:ext cx="64008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031435" y="4927258"/>
              <a:ext cx="617477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00+</a:t>
              </a:r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2B1323B2-DB74-44CC-9874-F13EBB63A30E}"/>
                </a:ext>
              </a:extLst>
            </p:cNvPr>
            <p:cNvSpPr/>
            <p:nvPr/>
          </p:nvSpPr>
          <p:spPr>
            <a:xfrm>
              <a:off x="8507198" y="5168506"/>
              <a:ext cx="37490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C6A08A1-E439-4B38-BC6D-EDDAA2F95175}"/>
                </a:ext>
              </a:extLst>
            </p:cNvPr>
            <p:cNvSpPr txBox="1"/>
            <p:nvPr/>
          </p:nvSpPr>
          <p:spPr>
            <a:xfrm>
              <a:off x="8808295" y="534483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1DFE38B-62B4-4C18-A728-F8B9C09E5EFD}"/>
                </a:ext>
              </a:extLst>
            </p:cNvPr>
            <p:cNvSpPr txBox="1"/>
            <p:nvPr/>
          </p:nvSpPr>
          <p:spPr>
            <a:xfrm>
              <a:off x="8053176" y="5188643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235973" y="904568"/>
              <a:ext cx="30478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135474" y="3990196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1547537" y="442349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5273200" y="443039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2771029" y="442319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711897" y="4425639"/>
              <a:ext cx="530915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2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4020840" y="443085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6732530" y="987850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427748" y="1157127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0B63047-8CAA-4BF4-8BEF-7D8B27151B1F}"/>
                </a:ext>
              </a:extLst>
            </p:cNvPr>
            <p:cNvSpPr txBox="1"/>
            <p:nvPr/>
          </p:nvSpPr>
          <p:spPr>
            <a:xfrm>
              <a:off x="206616" y="4340709"/>
              <a:ext cx="362258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2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75C733A-3DC6-4C9B-BEBC-F02A0B440D19}"/>
                </a:ext>
              </a:extLst>
            </p:cNvPr>
            <p:cNvSpPr txBox="1"/>
            <p:nvPr/>
          </p:nvSpPr>
          <p:spPr>
            <a:xfrm>
              <a:off x="8031435" y="5837221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4B889C59-D57C-4A91-91CA-E6E9FF9D9CEF}"/>
                </a:ext>
              </a:extLst>
            </p:cNvPr>
            <p:cNvSpPr/>
            <p:nvPr/>
          </p:nvSpPr>
          <p:spPr>
            <a:xfrm>
              <a:off x="7480880" y="5283227"/>
              <a:ext cx="64008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E9314823-5F2F-4FC9-B560-E3FA26B4E929}"/>
                </a:ext>
              </a:extLst>
            </p:cNvPr>
            <p:cNvSpPr/>
            <p:nvPr/>
          </p:nvSpPr>
          <p:spPr>
            <a:xfrm>
              <a:off x="8510513" y="5430236"/>
              <a:ext cx="37490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B3575AAA-6C86-4EFE-BB06-150CFC0E6225}"/>
                </a:ext>
              </a:extLst>
            </p:cNvPr>
            <p:cNvSpPr/>
            <p:nvPr/>
          </p:nvSpPr>
          <p:spPr>
            <a:xfrm>
              <a:off x="7470941" y="5581400"/>
              <a:ext cx="640080" cy="106672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8DA358E7-2E6D-41FE-B7D9-6435AFF9413B}"/>
                </a:ext>
              </a:extLst>
            </p:cNvPr>
            <p:cNvSpPr/>
            <p:nvPr/>
          </p:nvSpPr>
          <p:spPr>
            <a:xfrm>
              <a:off x="7475965" y="5938661"/>
              <a:ext cx="64008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8CE700C1-849D-40B7-B70C-4E8B3FDB00EA}"/>
                </a:ext>
              </a:extLst>
            </p:cNvPr>
            <p:cNvSpPr/>
            <p:nvPr/>
          </p:nvSpPr>
          <p:spPr>
            <a:xfrm>
              <a:off x="7474216" y="6108394"/>
              <a:ext cx="640080" cy="106672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02311084-A06A-4AD2-854B-A4860E532B46}"/>
                </a:ext>
              </a:extLst>
            </p:cNvPr>
            <p:cNvSpPr/>
            <p:nvPr/>
          </p:nvSpPr>
          <p:spPr>
            <a:xfrm>
              <a:off x="1974055" y="3056128"/>
              <a:ext cx="738189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2F7538E-918B-4F79-A83D-F67DB29175A4}"/>
                </a:ext>
              </a:extLst>
            </p:cNvPr>
            <p:cNvSpPr txBox="1"/>
            <p:nvPr/>
          </p:nvSpPr>
          <p:spPr>
            <a:xfrm>
              <a:off x="1348766" y="3927549"/>
              <a:ext cx="2114390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 err="1"/>
                <a:t>JmjC</a:t>
              </a:r>
              <a:r>
                <a:rPr lang="en-US" dirty="0"/>
                <a:t> domain, hydroxylase domain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114A341A-B7BE-41E7-8B66-7EBED2AD7D81}"/>
                </a:ext>
              </a:extLst>
            </p:cNvPr>
            <p:cNvSpPr/>
            <p:nvPr/>
          </p:nvSpPr>
          <p:spPr>
            <a:xfrm>
              <a:off x="664437" y="3058278"/>
              <a:ext cx="209481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F1F6FD7-063B-499E-A6B1-747869DBBE06}"/>
                </a:ext>
              </a:extLst>
            </p:cNvPr>
            <p:cNvSpPr txBox="1"/>
            <p:nvPr/>
          </p:nvSpPr>
          <p:spPr>
            <a:xfrm>
              <a:off x="439130" y="3752711"/>
              <a:ext cx="937797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 err="1"/>
                <a:t>JmjN</a:t>
              </a:r>
              <a:r>
                <a:rPr lang="en-US" dirty="0"/>
                <a:t> domain family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375E8542-78A9-4EC4-9AE8-2B59F3E217CB}"/>
                </a:ext>
              </a:extLst>
            </p:cNvPr>
            <p:cNvSpPr/>
            <p:nvPr/>
          </p:nvSpPr>
          <p:spPr>
            <a:xfrm>
              <a:off x="520566" y="3057654"/>
              <a:ext cx="8447222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01B867CD-DFC1-4BC1-B038-7AF962F66D8F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2783CC-7F8E-0D78-8BA2-10E040ED2CC7}"/>
              </a:ext>
            </a:extLst>
          </p:cNvPr>
          <p:cNvSpPr txBox="1"/>
          <p:nvPr/>
        </p:nvSpPr>
        <p:spPr>
          <a:xfrm>
            <a:off x="697662" y="6571038"/>
            <a:ext cx="49232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3G48430.2 (1001 aa)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172FFB3-965C-E7AD-F896-D27F275355A0}"/>
              </a:ext>
            </a:extLst>
          </p:cNvPr>
          <p:cNvSpPr/>
          <p:nvPr/>
        </p:nvSpPr>
        <p:spPr>
          <a:xfrm>
            <a:off x="533125" y="6499437"/>
            <a:ext cx="2203704" cy="10667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8C6CAD-EBD1-1AC7-28F7-4F9D12BC558E}"/>
              </a:ext>
            </a:extLst>
          </p:cNvPr>
          <p:cNvSpPr txBox="1"/>
          <p:nvPr/>
        </p:nvSpPr>
        <p:spPr>
          <a:xfrm>
            <a:off x="744392" y="6242007"/>
            <a:ext cx="308321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359 aa deletion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156670543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DFC7D17-2BDD-4618-9CEC-84D9443DC3A8}"/>
              </a:ext>
            </a:extLst>
          </p:cNvPr>
          <p:cNvGrpSpPr/>
          <p:nvPr/>
        </p:nvGrpSpPr>
        <p:grpSpPr>
          <a:xfrm>
            <a:off x="-64642" y="217924"/>
            <a:ext cx="9827566" cy="5462787"/>
            <a:chOff x="-64642" y="217924"/>
            <a:chExt cx="9827566" cy="5462787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8731484-2A65-4530-B41F-A5379E25613B}"/>
                </a:ext>
              </a:extLst>
            </p:cNvPr>
            <p:cNvSpPr txBox="1"/>
            <p:nvPr/>
          </p:nvSpPr>
          <p:spPr>
            <a:xfrm>
              <a:off x="528230" y="2964770"/>
              <a:ext cx="8859101" cy="10855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HSSLSSSSSSSPPSSLSSESCCVKVAVNVRPLIGDEVTQGCRECVSVSPVTPQVQMGTHPFTFDHVYGSNGSPSSLMFEECVAPLVDGLFHGYNATVLAYGQTGSGKTYTMGTGIKDGTKNGLIPQVMSALFNKIDSVKHQMGFQLHVSFIEILKEEVLDLLDSSVPFNRLANGTPGKVVLSKSPVQIRESPNGVITLSGATEVPIATKEEMASCLEQGSLTRATGSTNMNNESSRSHAIFTITLEQMRKISSISVVKDTVDEDMGEEYCCAKLHLVDLAGSERAKRTGSGGVRLKEGIHINRGLLALGNVISALGDEKRRKEGAHVPYRDSKLTRLLQDSLGGNSKTVMIACISPADINAEETLNTLKYANRARNIQNKPVANKDLICSEMQKMRQELQYLQATLCARGATSSEEVQVMREKIMKLESANEELSRELHIYRSKRVTLDYCNIDAQEDGVIFSKDDGLKRGFESMDSDYEMSEATSGGISEDIGAAEEWEHALRQNSMGKELNELSKRLEEKESEMRVCGIGTETIRQHFEKKMMELEKEKRTVQDERDMLLAEVEELAASSDRQAQVARDNHAHKLKALETQILNLKKKQENQVEVLKQKQKSEDAAKRLKTEIQCIKAQKVQLQQKMKQEAEQFRQWKASQEKELLQLKKEGRKTEHERLKLEALNRRQKMVLQRKTEEAAMATKRLKELLEARKSSPHDISVIANGQPPSRQTNEKSLRKWLDNELEVMAKVHQVRFQYEKQIQVRAALAVELTSLRQEMEFPSNSHQEKNGQFRFLSPNTRLERIASLESMLD</a:t>
              </a:r>
              <a:r>
                <a:rPr lang="en-US" sz="10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</a:t>
              </a:r>
              <a:r>
                <a:rPr lang="en-US" sz="1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NALTAMGSQLSEAEEREHSLHAKPRWNHIQSMTDAKYLLQYVFDSTAEARSKIWEKDRDIKEKKEQ</a:t>
              </a:r>
              <a:r>
                <a:rPr lang="en-US" sz="1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DLLCLLQLTEVQNREILKEKKTREQTVSIALASTSSSYSGSSRSSSKHYGDNNASDDPSSPSSTYHRATKHLKYTGPGIVNISVRESEALLEETRKMKAMKKMGQSGKLWKWKRSHHQWLLQFKWKWQKPWKLSEWIKQNDETTMHVMSKSHHDDEDDHSWNRHSMFQGA</a:t>
              </a:r>
              <a:endParaRPr lang="en-US" sz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D3CA950-A225-40FD-923F-0DF76C656507}"/>
                </a:ext>
              </a:extLst>
            </p:cNvPr>
            <p:cNvSpPr txBox="1"/>
            <p:nvPr/>
          </p:nvSpPr>
          <p:spPr>
            <a:xfrm>
              <a:off x="527484" y="3250492"/>
              <a:ext cx="9235440" cy="12503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HSSLSSSSSSSPPSSLSSESCCVKVAVNVRPLIGDEVTQGCRECVSVSP</a:t>
              </a:r>
              <a:r>
                <a:rPr lang="en-US" sz="10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TPQVQMGTHPFTFDHVYGSNGSPSSLMFEECVAPLVDGLFHGYNATVLAYGQTGSGKTYTMGTGIKDGTKNGLIPQVMSALFNKIDSVKHQMGFQLHVSFIEILKEEVLDLLDSSVPFNRLANGTPGKVVLSKSPVQIRESPNGVITLSGATEVPIATKEEMASCLEQGSLTRATGSTNMNNESSRSHAIFTITLEQMRKISSISVVKDTVDEDMGEEYCCAKLHLVDLAGSERAKRTGSGGVRLKEGIHINRGLLALGNVISALGDEKRRKEGAHVPYRDSKLTRLLQDSLGGNSKTVMIACISPADINAEETLNTLKYANRARNI</a:t>
              </a:r>
              <a:r>
                <a:rPr lang="en-US" sz="1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NKPVANKDLICSEMQKMRQELQYLQATLCARGATSSEEVQVMREKIMKLESANEELSRELHIYRSKRVTLDYCNIDAQEDGVIFSKDDGLKRGFESMDSDYEMSEATSGGISEDIGAAEEWEHALRQNSMGKELNELSKRLEEKESEMRVCGIGTETIRQHFEKKMMELEKEKRTVQDERDMLLAEVEELAASSDRQAQVARDNHAHKLKALETQILNLKKKQENQVEVLKQKQKSEDAAKRLKTEIQCIKAQKVQLQQKMKQEAEQFRQWKASQEKELLQLKKEGRKTEHERLKLEALNRRQKMVLQRKTEEAAMATKRLKELLEARKSSPHDISVIANGQPPSRQTNEKSLRKWLDNELEVMAKVHQVRFQYEKQIQVRAALAVELTSLRQEMEFPSNSHQEKNGQFRFLSPNTRLERIASLESMLDVSSNALTAMGSQLSEAEEREHSLHAKPRWNHIQSMTDAKYLLQYVFDSTAEARSKIWEKDRDIKEKKEQLNDLLCLLQLTEVQNREILKEKKTREQTVSIALASTSSSYSGSSRSSSKHYGDNNASDDPSSPSSTYHRATKHLKYTGPGIVNISVRESEALLEETRKMKAMKKMGQSGKLWKWKRSHHQWLLQFKWKWQKPWKLSEWIKQNDETTMHVMSKSHHDDEDDHSWNRHSMFQGA</a:t>
              </a:r>
              <a:endParaRPr lang="en-US" sz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6226DDC5-C6A6-4629-963C-9BB64942E877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02" t="10725" r="4365" b="11359"/>
            <a:stretch/>
          </p:blipFill>
          <p:spPr>
            <a:xfrm>
              <a:off x="549321" y="684944"/>
              <a:ext cx="8513717" cy="3562350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4642" y="217924"/>
              <a:ext cx="698261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3G50240.1: KICP-02 (KINESIN-RELATED PROTEIN); 1051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71669" y="101248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211813" y="145135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90298" y="188523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30018" y="230250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84050" y="271098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159858" y="3157314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218612" y="3597956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211813" y="601083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484023" y="4132674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15851" y="2304635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660138" y="4263674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116348" y="538530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503672" y="5084009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7054435" y="5471984"/>
              <a:ext cx="53949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7532517" y="5383256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503672" y="4435624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85406" y="465390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16161" y="496042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7058836" y="4772191"/>
              <a:ext cx="53949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7505106" y="4679001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7062809" y="4954993"/>
              <a:ext cx="53035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968C584B-562E-43FF-B33B-E3B34B614107}"/>
                </a:ext>
              </a:extLst>
            </p:cNvPr>
            <p:cNvSpPr txBox="1"/>
            <p:nvPr/>
          </p:nvSpPr>
          <p:spPr>
            <a:xfrm>
              <a:off x="7532517" y="4872245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7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175449" y="4038601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6136685" y="682088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5831903" y="851365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949FDF2-6ABB-485E-8154-E6CBF3CA743E}"/>
                </a:ext>
              </a:extLst>
            </p:cNvPr>
            <p:cNvSpPr txBox="1"/>
            <p:nvPr/>
          </p:nvSpPr>
          <p:spPr>
            <a:xfrm>
              <a:off x="8306558" y="4127499"/>
              <a:ext cx="530915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8C7B45B-ADED-437D-820A-FEF917A62DFA}"/>
                </a:ext>
              </a:extLst>
            </p:cNvPr>
            <p:cNvSpPr txBox="1"/>
            <p:nvPr/>
          </p:nvSpPr>
          <p:spPr>
            <a:xfrm>
              <a:off x="1972703" y="413859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333B9E8-85C5-4118-BBB2-6454772906B3}"/>
                </a:ext>
              </a:extLst>
            </p:cNvPr>
            <p:cNvSpPr txBox="1"/>
            <p:nvPr/>
          </p:nvSpPr>
          <p:spPr>
            <a:xfrm>
              <a:off x="6762489" y="412644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2DD5818-8FAF-4632-9DD3-9A320AEBBE85}"/>
                </a:ext>
              </a:extLst>
            </p:cNvPr>
            <p:cNvSpPr txBox="1"/>
            <p:nvPr/>
          </p:nvSpPr>
          <p:spPr>
            <a:xfrm>
              <a:off x="3567554" y="413735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D3D8EFAE-DD99-47FE-975D-296DDC0D2AEE}"/>
                </a:ext>
              </a:extLst>
            </p:cNvPr>
            <p:cNvSpPr txBox="1"/>
            <p:nvPr/>
          </p:nvSpPr>
          <p:spPr>
            <a:xfrm>
              <a:off x="5162383" y="413453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9A17DDB-17C6-4AEC-91FD-28D2523ED2F4}"/>
                </a:ext>
              </a:extLst>
            </p:cNvPr>
            <p:cNvSpPr txBox="1"/>
            <p:nvPr/>
          </p:nvSpPr>
          <p:spPr>
            <a:xfrm>
              <a:off x="1070101" y="3881837"/>
              <a:ext cx="248336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Kinesin motor domain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7D9C68C-E554-445D-B0D5-C0CD32926562}"/>
                </a:ext>
              </a:extLst>
            </p:cNvPr>
            <p:cNvSpPr/>
            <p:nvPr/>
          </p:nvSpPr>
          <p:spPr>
            <a:xfrm>
              <a:off x="1034065" y="2839548"/>
              <a:ext cx="2602104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1A7E0A4F-0A40-4DCC-83A8-C670DA9C7A1B}"/>
                </a:ext>
              </a:extLst>
            </p:cNvPr>
            <p:cNvSpPr/>
            <p:nvPr/>
          </p:nvSpPr>
          <p:spPr>
            <a:xfrm>
              <a:off x="606292" y="2840957"/>
              <a:ext cx="836387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A203130C-4D1B-40DE-A9D1-42A82C903205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7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D35F8A2-DD3D-F770-BA6A-A96399E0327B}"/>
              </a:ext>
            </a:extLst>
          </p:cNvPr>
          <p:cNvSpPr/>
          <p:nvPr/>
        </p:nvSpPr>
        <p:spPr>
          <a:xfrm>
            <a:off x="621008" y="6468258"/>
            <a:ext cx="804672" cy="10667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43F9C4-E94D-4EEC-E999-0ACBA1B8CE67}"/>
              </a:ext>
            </a:extLst>
          </p:cNvPr>
          <p:cNvSpPr txBox="1"/>
          <p:nvPr/>
        </p:nvSpPr>
        <p:spPr>
          <a:xfrm>
            <a:off x="42795" y="6200608"/>
            <a:ext cx="3558603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For .3, 102 aa deletion due to alternative splicing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9B1B815-E51F-EBA3-9FF0-4EC36568C77B}"/>
              </a:ext>
            </a:extLst>
          </p:cNvPr>
          <p:cNvSpPr/>
          <p:nvPr/>
        </p:nvSpPr>
        <p:spPr>
          <a:xfrm>
            <a:off x="4498509" y="6494454"/>
            <a:ext cx="18288" cy="10667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6344DD-461C-F7BC-8014-92DAF243C257}"/>
              </a:ext>
            </a:extLst>
          </p:cNvPr>
          <p:cNvSpPr txBox="1"/>
          <p:nvPr/>
        </p:nvSpPr>
        <p:spPr>
          <a:xfrm>
            <a:off x="2999942" y="6575076"/>
            <a:ext cx="3385479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For .4, 4 aa deletion due to alternative splici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B77D38-386F-F263-9DDB-1B009CEF48D3}"/>
              </a:ext>
            </a:extLst>
          </p:cNvPr>
          <p:cNvSpPr txBox="1"/>
          <p:nvPr/>
        </p:nvSpPr>
        <p:spPr>
          <a:xfrm>
            <a:off x="5851710" y="6174667"/>
            <a:ext cx="3211328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For .2,  110 aa deletion and  ~21 aa change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C345B04-12A1-5488-4B1B-88B5E30D37E9}"/>
              </a:ext>
            </a:extLst>
          </p:cNvPr>
          <p:cNvSpPr/>
          <p:nvPr/>
        </p:nvSpPr>
        <p:spPr>
          <a:xfrm>
            <a:off x="7918311" y="6433923"/>
            <a:ext cx="1042416" cy="10667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5898521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9428238-B349-4EF1-94FA-D8568F893DED}"/>
              </a:ext>
            </a:extLst>
          </p:cNvPr>
          <p:cNvGrpSpPr/>
          <p:nvPr/>
        </p:nvGrpSpPr>
        <p:grpSpPr>
          <a:xfrm>
            <a:off x="-72122" y="234695"/>
            <a:ext cx="10176373" cy="5419965"/>
            <a:chOff x="-72122" y="234695"/>
            <a:chExt cx="10176373" cy="5419965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B11447A-E3A8-489A-A52D-C45EE8DB404C}"/>
                </a:ext>
              </a:extLst>
            </p:cNvPr>
            <p:cNvSpPr txBox="1"/>
            <p:nvPr/>
          </p:nvSpPr>
          <p:spPr>
            <a:xfrm>
              <a:off x="398907" y="2260738"/>
              <a:ext cx="9186880" cy="1604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DQTVSENLIQVKKESGGIAVITINRPKSLNSLTRAMMVDLAKAFKDMDSDESVQVVIFTGSGRSFCSGVDLTAAESVFKGDVKDPETDPVVQMERLRKPIIGAINGFAITAGFELALACDILVASRGAKFMDTHARFGIF</a:t>
              </a:r>
              <a:r>
                <a:rPr lang="en-US" sz="42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42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WGLSQKLSRIIGANKAREVSLTSMPLTADVAGKLGFVNHVVEEG</a:t>
              </a:r>
              <a:r>
                <a:rPr lang="en-US" sz="42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LKK</a:t>
              </a:r>
              <a:r>
                <a:rPr lang="en-US" sz="42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REIAEAIIKNEQGMVL</a:t>
              </a:r>
              <a:r>
                <a:rPr lang="en-US" sz="42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IKSVINDGLKLDLGHALTLEKERAHAYYSGMTKEQFRKMQEF</a:t>
              </a:r>
              <a:r>
                <a:rPr lang="en-US" sz="42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AG</a:t>
              </a:r>
              <a:r>
                <a:rPr lang="en-US" sz="4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GSKKPSSKL</a:t>
              </a:r>
              <a:endParaRPr lang="en-US" sz="42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237A935-530A-41A2-9E9B-B87C3AA6CE01}"/>
                </a:ext>
              </a:extLst>
            </p:cNvPr>
            <p:cNvSpPr txBox="1"/>
            <p:nvPr/>
          </p:nvSpPr>
          <p:spPr>
            <a:xfrm>
              <a:off x="397726" y="2516993"/>
              <a:ext cx="9706525" cy="1604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DQTVSENLIQVKKE</a:t>
              </a:r>
              <a:r>
                <a:rPr lang="en-US" sz="42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GGIAVITINRPKSLNSLTRAMMVDLAKAFKDMDSDESVQVVIFTGSGRSFCSGVDLTAAESVFKGDVKDPETDPVVQMERLRKPIIGAINGFAITAGFELALACDILVASRGAKFMDTHARFGIFPSWGLSQKLSRIIGANKAREVSLTSMPLTADVAGKLGFVNHVVEEGEALKKAREIAEAIIKNEQGMVLRIKSVINDGLKLDLGHALTLEKERAHAYYS</a:t>
              </a:r>
              <a:r>
                <a:rPr lang="en-US" sz="42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MTKEQFRKMQEFIAGRGSKKPSSKL</a:t>
              </a:r>
              <a:endParaRPr lang="en-US" sz="42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72EE800D-8056-46A3-87BA-2E76F7D45A3D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00" t="10508" r="4814" b="11583"/>
            <a:stretch/>
          </p:blipFill>
          <p:spPr>
            <a:xfrm>
              <a:off x="447064" y="704643"/>
              <a:ext cx="8510431" cy="3562026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72122" y="234695"/>
              <a:ext cx="9407512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50" dirty="0"/>
                <a:t>AT4G16210: ENOYL-COA HYDRATASE 2, ENOYL-COA HYDRATASE/ISOMERASE A; 265 amino acids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107236" y="63293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186505" y="115501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125630" y="176920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02739" y="233250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91272" y="2908971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139414" y="3500562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357744" y="4179745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3484676" y="4183424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87286" y="2184116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296391" y="4314827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3834" y="533891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389382" y="5129880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8496585" y="5357206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386683" y="4523349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3834" y="473171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4898" y="494007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7045401" y="4759820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6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8424322" y="4937596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89158" y="4047572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6713794" y="417973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1896456" y="4177168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073087" y="417068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8319919" y="417973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34858" y="723885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030076" y="893162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4996330" y="4854015"/>
              <a:ext cx="213055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6430041" y="5030568"/>
              <a:ext cx="2066544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4969782" y="5452508"/>
              <a:ext cx="361188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7313E71-8B29-4E44-9C7E-CF726BFF0A87}"/>
                </a:ext>
              </a:extLst>
            </p:cNvPr>
            <p:cNvSpPr txBox="1"/>
            <p:nvPr/>
          </p:nvSpPr>
          <p:spPr>
            <a:xfrm>
              <a:off x="2430207" y="3884251"/>
              <a:ext cx="4027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Enoyl-CoA hydratase/isomerase domain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1F531B7F-BAA9-486F-A793-17449401D22E}"/>
                </a:ext>
              </a:extLst>
            </p:cNvPr>
            <p:cNvSpPr/>
            <p:nvPr/>
          </p:nvSpPr>
          <p:spPr>
            <a:xfrm>
              <a:off x="964406" y="2436760"/>
              <a:ext cx="7112794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489E20F-BC20-4422-B45E-1C4F3F788794}"/>
                </a:ext>
              </a:extLst>
            </p:cNvPr>
            <p:cNvSpPr/>
            <p:nvPr/>
          </p:nvSpPr>
          <p:spPr>
            <a:xfrm>
              <a:off x="482462" y="2438520"/>
              <a:ext cx="8432938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4619F9B7-4072-4B70-AA4B-51B594D161B3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8</a:t>
            </a:r>
          </a:p>
        </p:txBody>
      </p:sp>
    </p:spTree>
    <p:extLst>
      <p:ext uri="{BB962C8B-B14F-4D97-AF65-F5344CB8AC3E}">
        <p14:creationId xmlns:p14="http://schemas.microsoft.com/office/powerpoint/2010/main" val="129525001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4229C19-CA55-431D-B791-DAE19F934F27}"/>
              </a:ext>
            </a:extLst>
          </p:cNvPr>
          <p:cNvGrpSpPr/>
          <p:nvPr/>
        </p:nvGrpSpPr>
        <p:grpSpPr>
          <a:xfrm>
            <a:off x="-35975" y="294800"/>
            <a:ext cx="9596301" cy="5954522"/>
            <a:chOff x="-35975" y="186512"/>
            <a:chExt cx="9596301" cy="5954522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F5F77EE-B7F7-44C8-87C3-8CAB518E6BDA}"/>
                </a:ext>
              </a:extLst>
            </p:cNvPr>
            <p:cNvSpPr txBox="1"/>
            <p:nvPr/>
          </p:nvSpPr>
          <p:spPr>
            <a:xfrm>
              <a:off x="930635" y="3488497"/>
              <a:ext cx="8298658" cy="11015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TLKPSFTVSPPNSNPIRFGSFPPQCFLRVPKPRRLILPRFRKTTGGGGGLIRCELPDFHLSATATTVSGVSTVNLVDQVQIPKGEMWSVHKFGGTCVGNSQRIRNVAEVIINDNSERKLVVVSAMSKVTDMMYDLIRKAQSRDDSYLSALEAVLEKHRLTARDLLDGDDLASFLSHLHNDISNLKAMLRAIYIAGHASESFSDFVAGHGELWSAQMLSYVVRKTGLECKWMDTRDVLIVNPTSSNQVDPDFGESEKRLDKWFSLNPSKIIIATGFIASTPQNIPTTLKRDGSDFSAAIMGALLRARQVTIWTDVDGVYSADPRKVNEAVILQTLSYQEAWEMSYFGANVLHPRTIIPVMRYNIPIVIRNIFNLSAPGTIICQPPEDDYDLKLTTPVKGFATIDNLALINVEGTGMAGVPGTASDIFGCVKDVGANVIMISQASSEHSVCFAVPEKEVNAVSEALRSRFSEALQAGRLSQIEVIPNCSILAAVGQKMASTPGVSCTLFSALAKANINVRAISQGCSEYNVTVVIKREDSVKALRAVHSRFFLSRTTLAMGIVGPGLIGATLLDQLRDQAAVLKQEFNIDLRVLGITGSKKMLLSDIGIDLSRWRELLNEKGTE</a:t>
              </a:r>
              <a:r>
                <a:rPr lang="en-US" sz="11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DLDKFTQQVHGNHFIPNSVVVDCTADSAIASRYYDWLRKGIHVITPNKKANSGPLDQYLK</a:t>
              </a:r>
              <a:r>
                <a:rPr lang="en-US" sz="110" dirty="0">
                  <a:effectLst/>
                  <a:highlight>
                    <a:srgbClr val="D3D3D3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RD</a:t>
              </a:r>
              <a:r>
                <a:rPr lang="en-US" sz="11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QRKSYTHYFYEATVGAGLPIISTLRGLLETGDKIL</a:t>
              </a:r>
              <a:r>
                <a:rPr lang="en-US" sz="11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</a:t>
              </a:r>
              <a:r>
                <a:rPr lang="en-US" sz="11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GICSGTLSYLFNNFVGDRSFSEVVTEAKNAGFTEPDPRDDLSGTDVARKVIILARESGLKLDLADLPIRSLVP</a:t>
              </a:r>
              <a:r>
                <a:rPr lang="en-US" sz="1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PLKGCTSVEEFMEKLPQYDGDLAKERLDAENSGEVLRYVGVVDAVNQKGTVELRRYKKEHPFAQLAGSDNIIAFTTTRYKDHPLIVRGPGAGAQVTAGGIFSD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LRLASYLGAPS</a:t>
              </a:r>
              <a:endParaRPr lang="en-US" sz="1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1C0EB25-26FA-4EFD-9823-483C5F6DE3B9}"/>
                </a:ext>
              </a:extLst>
            </p:cNvPr>
            <p:cNvSpPr txBox="1"/>
            <p:nvPr/>
          </p:nvSpPr>
          <p:spPr>
            <a:xfrm>
              <a:off x="931067" y="3072735"/>
              <a:ext cx="8298658" cy="1092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ATLKPSFTVSPPNSNPIRFGSFPPQCFLRVPKPRRLILPRFRKTTGGGGGLIRCELPDFHLSATATTVSGVSTVNLVDQVQIPKGE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MWSVHKFGGTCVGNSQRIRNVAEVIINDNSERKLVVVSAMSKVTDMMYDLIRKAQSRDDSYLSALEAVLEKHRLTARDLLDGDDLASFLSHLHNDISNLKAMLRAIYIAGHASESFSDFVAGHGELWSAQMLSYVVRKTGLECKWMDTRDVLIVNPTSSNQVDPDFGESEKRLDKWFSLNPSKIIIATGFIASTPQNIPTTLKRDGSDFSAAIMGALLRARQVTIWTDVDGVYSADPRKVNEAVILQTLSYQEAWEMSYFGANVLHPRTIIPVMRYNIPIVIRN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IFNLSAPGTIICQPPEDDYDLKLTTPVKGFATIDNLALINVEGT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GMAGVPGTASDIFGCVKDVGANVIMISQASSEHSVCFAVPEKEVNAVSEALRSR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FSEALQAGRLSQIEV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IPNCSILAAVGQKMASTPGVSCTLFSALAKANINVRAISQGCSEYNVTVVIKREDSVKALRAVHS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RFFLSRTTLAMGIV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GPGLIGATLLDQLRDQAAVLKQEFNIDLRVLGITGSKKMLLSDIGIDLSRWRELLNEKGTEADLDKFTQQVHGNHFIPNSVVVDCTADSAIASRYYDWLRKGIHVITPNKKANSGPLDQYLKLRDLQRKSYTHYFYE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ATVGAGL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PIISTLRGLLETGDKILRIEGICSGTLSYLFNNFVGDRSFSEVVTEAKNAGFTEPDPRDDLSGTDVARKVIILARESGLKLDLADLPIRSLVPEPLKGCTSVEEFMEKLPQYDGDLAKERLDAENSGEVLRYVGVVDAVNQKGTVELRRYKKEHPFAQLAGSDNIIAFTTTRYKDHPLIVRGPGAGAQVTAGGIFSDIL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RLASYLGAPS</a:t>
              </a:r>
              <a:endParaRPr lang="en-US" sz="110" dirty="0"/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83A353B6-4F3C-4CA2-A31D-49018744B07D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41" t="10837" r="4657" b="11929"/>
            <a:stretch/>
          </p:blipFill>
          <p:spPr>
            <a:xfrm>
              <a:off x="966497" y="847511"/>
              <a:ext cx="7385775" cy="3531141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35975" y="186512"/>
              <a:ext cx="9596301" cy="6669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4G19710.2: ASPARTATE KINASE-HOMOSERINE DEHYDROGENASE, ASPARTATE KINASE-HOMOSERINE DEHYDROGENASE II; 916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691013" y="78492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639717" y="1227533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707716" y="173891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620747" y="2271598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701264" y="271943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589658" y="3207147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639717" y="3698174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893264" y="4292315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582755" y="4284725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327674" y="2240723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237467" y="4425182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507302" y="5477899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475342" y="584357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914834" y="5177322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6703837" y="5501374"/>
              <a:ext cx="512832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23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6714223" y="582982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7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915422" y="4697721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503210" y="5002763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584932" y="4169058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381760" y="42876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188745" y="428476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3975227" y="42876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4771435" y="428425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5576139" y="42876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6368935" y="428326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5975F69-7333-4101-8736-185613BB6786}"/>
                </a:ext>
              </a:extLst>
            </p:cNvPr>
            <p:cNvSpPr txBox="1"/>
            <p:nvPr/>
          </p:nvSpPr>
          <p:spPr>
            <a:xfrm>
              <a:off x="7176687" y="428286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62D7C37-0895-41E3-91E8-78D3B6D2592A}"/>
                </a:ext>
              </a:extLst>
            </p:cNvPr>
            <p:cNvSpPr txBox="1"/>
            <p:nvPr/>
          </p:nvSpPr>
          <p:spPr>
            <a:xfrm>
              <a:off x="7965654" y="428286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900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598632" y="1040511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Rectangle 278">
              <a:extLst>
                <a:ext uri="{FF2B5EF4-FFF2-40B4-BE49-F238E27FC236}">
                  <a16:creationId xmlns:a16="http://schemas.microsoft.com/office/drawing/2014/main" id="{F274DA5E-3DD4-46C9-AAAC-5399892470E0}"/>
                </a:ext>
              </a:extLst>
            </p:cNvPr>
            <p:cNvSpPr/>
            <p:nvPr/>
          </p:nvSpPr>
          <p:spPr>
            <a:xfrm>
              <a:off x="7372670" y="4991463"/>
              <a:ext cx="82296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6903414" y="871234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5981461" y="5593209"/>
              <a:ext cx="79552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505D75FF-2114-4A6A-BDD3-8A9BAD955226}"/>
                </a:ext>
              </a:extLst>
            </p:cNvPr>
            <p:cNvSpPr/>
            <p:nvPr/>
          </p:nvSpPr>
          <p:spPr>
            <a:xfrm>
              <a:off x="5981461" y="5759375"/>
              <a:ext cx="49377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1E2ABE54-58ED-4271-8F76-43AA3F9F1919}"/>
                </a:ext>
              </a:extLst>
            </p:cNvPr>
            <p:cNvSpPr/>
            <p:nvPr/>
          </p:nvSpPr>
          <p:spPr>
            <a:xfrm>
              <a:off x="5976699" y="5931374"/>
              <a:ext cx="80467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A0475E4-2F19-4B83-A961-7AA1FCD313CF}"/>
                </a:ext>
              </a:extLst>
            </p:cNvPr>
            <p:cNvSpPr/>
            <p:nvPr/>
          </p:nvSpPr>
          <p:spPr>
            <a:xfrm>
              <a:off x="1709738" y="2816106"/>
              <a:ext cx="2257425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6556BB6-6339-4E90-89DB-DC0951508155}"/>
                </a:ext>
              </a:extLst>
            </p:cNvPr>
            <p:cNvSpPr txBox="1"/>
            <p:nvPr/>
          </p:nvSpPr>
          <p:spPr>
            <a:xfrm>
              <a:off x="6313867" y="3640148"/>
              <a:ext cx="2185255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Homoserine dehydrogenase domain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395ADF5-CA3D-49B6-BDFC-8C8084EC2F37}"/>
                </a:ext>
              </a:extLst>
            </p:cNvPr>
            <p:cNvSpPr txBox="1"/>
            <p:nvPr/>
          </p:nvSpPr>
          <p:spPr>
            <a:xfrm>
              <a:off x="1804931" y="3844426"/>
              <a:ext cx="1669203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Amino acid kinase family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16C7ABF-C47E-45C8-A5FA-A9970B316122}"/>
                </a:ext>
              </a:extLst>
            </p:cNvPr>
            <p:cNvSpPr txBox="1"/>
            <p:nvPr/>
          </p:nvSpPr>
          <p:spPr>
            <a:xfrm>
              <a:off x="4430035" y="4079686"/>
              <a:ext cx="1416391" cy="32637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ACT domain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0E4AB30-33A9-4255-92F9-E4EAD1CC14C0}"/>
                </a:ext>
              </a:extLst>
            </p:cNvPr>
            <p:cNvSpPr txBox="1"/>
            <p:nvPr/>
          </p:nvSpPr>
          <p:spPr>
            <a:xfrm>
              <a:off x="3907507" y="3882690"/>
              <a:ext cx="1416391" cy="32637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ACT domai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91FF0BD-D7F9-4777-AF81-C0B0F839190F}"/>
                </a:ext>
              </a:extLst>
            </p:cNvPr>
            <p:cNvSpPr txBox="1"/>
            <p:nvPr/>
          </p:nvSpPr>
          <p:spPr>
            <a:xfrm>
              <a:off x="4657264" y="1124817"/>
              <a:ext cx="2920461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Homoserine dehydrogenase, NAD binding domain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F4807DF6-B2D7-467A-A513-1B7996E4D2FE}"/>
                </a:ext>
              </a:extLst>
            </p:cNvPr>
            <p:cNvSpPr/>
            <p:nvPr/>
          </p:nvSpPr>
          <p:spPr>
            <a:xfrm>
              <a:off x="4317205" y="2820586"/>
              <a:ext cx="428625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2DC42607-B8D7-44E5-935C-31AF8A65936F}"/>
                </a:ext>
              </a:extLst>
            </p:cNvPr>
            <p:cNvSpPr/>
            <p:nvPr/>
          </p:nvSpPr>
          <p:spPr>
            <a:xfrm>
              <a:off x="4864895" y="2815824"/>
              <a:ext cx="514350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15A754E7-C1FB-49C7-A20B-61259D23E107}"/>
                </a:ext>
              </a:extLst>
            </p:cNvPr>
            <p:cNvSpPr/>
            <p:nvPr/>
          </p:nvSpPr>
          <p:spPr>
            <a:xfrm>
              <a:off x="5491162" y="2817960"/>
              <a:ext cx="1088232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5E569257-2540-4AFE-B611-5765B9724F84}"/>
                </a:ext>
              </a:extLst>
            </p:cNvPr>
            <p:cNvSpPr/>
            <p:nvPr/>
          </p:nvSpPr>
          <p:spPr>
            <a:xfrm>
              <a:off x="6634163" y="2817960"/>
              <a:ext cx="1578768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DDD758D-FD8A-479F-93DD-D1439D492611}"/>
                </a:ext>
              </a:extLst>
            </p:cNvPr>
            <p:cNvSpPr/>
            <p:nvPr/>
          </p:nvSpPr>
          <p:spPr>
            <a:xfrm>
              <a:off x="1013490" y="2817144"/>
              <a:ext cx="7287548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B51E9ABC-D8C8-43A7-9750-187C262309CC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9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37520D3-5ED9-4CF1-84FA-3EB21AB08EE4}"/>
              </a:ext>
            </a:extLst>
          </p:cNvPr>
          <p:cNvSpPr/>
          <p:nvPr/>
        </p:nvSpPr>
        <p:spPr>
          <a:xfrm>
            <a:off x="7665831" y="6445731"/>
            <a:ext cx="621792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DD2A29-238D-1E1F-23EE-EF2F91865FCD}"/>
              </a:ext>
            </a:extLst>
          </p:cNvPr>
          <p:cNvSpPr txBox="1"/>
          <p:nvPr/>
        </p:nvSpPr>
        <p:spPr>
          <a:xfrm>
            <a:off x="21908" y="6528638"/>
            <a:ext cx="968597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All of the GmPM12 tags are valid for AT4G19710.1 (859 aa) but only a portion of LEA14 tag is valid for the shorter isoform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DBC10D6-04B4-BA48-080D-1A28A21FB66B}"/>
              </a:ext>
            </a:extLst>
          </p:cNvPr>
          <p:cNvSpPr txBox="1"/>
          <p:nvPr/>
        </p:nvSpPr>
        <p:spPr>
          <a:xfrm>
            <a:off x="5817883" y="6198511"/>
            <a:ext cx="3211328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For .1,  57 aa deletion and  ~22 aa changes</a:t>
            </a:r>
          </a:p>
        </p:txBody>
      </p:sp>
    </p:spTree>
    <p:extLst>
      <p:ext uri="{BB962C8B-B14F-4D97-AF65-F5344CB8AC3E}">
        <p14:creationId xmlns:p14="http://schemas.microsoft.com/office/powerpoint/2010/main" val="3860978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EBEC98E0-C1CA-45BD-B63E-01400AF75CFF}"/>
              </a:ext>
            </a:extLst>
          </p:cNvPr>
          <p:cNvGrpSpPr/>
          <p:nvPr/>
        </p:nvGrpSpPr>
        <p:grpSpPr>
          <a:xfrm>
            <a:off x="-547185" y="-34447"/>
            <a:ext cx="9601099" cy="6707865"/>
            <a:chOff x="-594810" y="-34447"/>
            <a:chExt cx="9601099" cy="6707865"/>
          </a:xfrm>
        </p:grpSpPr>
        <p:pic>
          <p:nvPicPr>
            <p:cNvPr id="35" name="Picture 34" descr="Table&#10;&#10;Description automatically generated">
              <a:extLst>
                <a:ext uri="{FF2B5EF4-FFF2-40B4-BE49-F238E27FC236}">
                  <a16:creationId xmlns:a16="http://schemas.microsoft.com/office/drawing/2014/main" id="{EDB11A31-8E2F-4A65-A2E2-F163F56E64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861" b="41702"/>
            <a:stretch/>
          </p:blipFill>
          <p:spPr>
            <a:xfrm>
              <a:off x="2148289" y="2305132"/>
              <a:ext cx="6858000" cy="2001795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F866F6A-1662-43D5-90B0-16F745823DD6}"/>
                </a:ext>
              </a:extLst>
            </p:cNvPr>
            <p:cNvGrpSpPr/>
            <p:nvPr/>
          </p:nvGrpSpPr>
          <p:grpSpPr>
            <a:xfrm>
              <a:off x="2135932" y="100557"/>
              <a:ext cx="6858000" cy="2357943"/>
              <a:chOff x="8427" y="457197"/>
              <a:chExt cx="6858000" cy="2357943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B0958766-E0F9-40E1-8AF8-BB7B862F67EC}"/>
                  </a:ext>
                </a:extLst>
              </p:cNvPr>
              <p:cNvGrpSpPr/>
              <p:nvPr/>
            </p:nvGrpSpPr>
            <p:grpSpPr>
              <a:xfrm>
                <a:off x="8427" y="457197"/>
                <a:ext cx="6858000" cy="2016472"/>
                <a:chOff x="8427" y="457197"/>
                <a:chExt cx="6858000" cy="2016472"/>
              </a:xfrm>
            </p:grpSpPr>
            <p:pic>
              <p:nvPicPr>
                <p:cNvPr id="18" name="Picture 17" descr="Graphical user interface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BED8CE90-9D5E-4F25-9D6C-C7F7AAECA4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8859" b="41707"/>
                <a:stretch/>
              </p:blipFill>
              <p:spPr>
                <a:xfrm>
                  <a:off x="8427" y="457197"/>
                  <a:ext cx="6858000" cy="2001795"/>
                </a:xfrm>
                <a:prstGeom prst="rect">
                  <a:avLst/>
                </a:prstGeom>
              </p:spPr>
            </p:pic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F8D8E49D-91B9-4B14-A2E1-293C41F1D1AD}"/>
                    </a:ext>
                  </a:extLst>
                </p:cNvPr>
                <p:cNvSpPr/>
                <p:nvPr/>
              </p:nvSpPr>
              <p:spPr>
                <a:xfrm>
                  <a:off x="3528839" y="1423075"/>
                  <a:ext cx="163984" cy="1047515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A0ED3194-867E-423B-822E-CC98AA83FE19}"/>
                    </a:ext>
                  </a:extLst>
                </p:cNvPr>
                <p:cNvSpPr/>
                <p:nvPr/>
              </p:nvSpPr>
              <p:spPr>
                <a:xfrm>
                  <a:off x="3694501" y="1374703"/>
                  <a:ext cx="174233" cy="1098966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32F16CF7-5510-4189-A59A-6FD20C227F1A}"/>
                    </a:ext>
                  </a:extLst>
                </p:cNvPr>
                <p:cNvSpPr/>
                <p:nvPr/>
              </p:nvSpPr>
              <p:spPr>
                <a:xfrm>
                  <a:off x="3367116" y="1372018"/>
                  <a:ext cx="163984" cy="1098966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72C3AF82-E72F-42C8-8A65-EA71ACFB2EDF}"/>
                    </a:ext>
                  </a:extLst>
                </p:cNvPr>
                <p:cNvSpPr/>
                <p:nvPr/>
              </p:nvSpPr>
              <p:spPr>
                <a:xfrm>
                  <a:off x="3203615" y="1423658"/>
                  <a:ext cx="163984" cy="1047515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96FD2ECC-78B5-4183-9689-1F5C7BB91527}"/>
                    </a:ext>
                  </a:extLst>
                </p:cNvPr>
                <p:cNvSpPr/>
                <p:nvPr/>
              </p:nvSpPr>
              <p:spPr>
                <a:xfrm>
                  <a:off x="2873354" y="1425721"/>
                  <a:ext cx="163984" cy="1047515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EBC423E6-105D-4E87-BB20-4DB39D48CB56}"/>
                    </a:ext>
                  </a:extLst>
                </p:cNvPr>
                <p:cNvSpPr/>
                <p:nvPr/>
              </p:nvSpPr>
              <p:spPr>
                <a:xfrm>
                  <a:off x="3038609" y="1372599"/>
                  <a:ext cx="163984" cy="1098966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B068443A-0A04-42AA-9427-0B186BD367B7}"/>
                    </a:ext>
                  </a:extLst>
                </p:cNvPr>
                <p:cNvSpPr/>
                <p:nvPr/>
              </p:nvSpPr>
              <p:spPr>
                <a:xfrm>
                  <a:off x="2707274" y="1373179"/>
                  <a:ext cx="166555" cy="1098966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9900CC"/>
                    </a:solidFill>
                  </a:endParaRP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5A6658D-9ADD-4E77-808C-38D9C3179251}"/>
                    </a:ext>
                  </a:extLst>
                </p:cNvPr>
                <p:cNvSpPr txBox="1"/>
                <p:nvPr/>
              </p:nvSpPr>
              <p:spPr>
                <a:xfrm>
                  <a:off x="2597576" y="1085286"/>
                  <a:ext cx="40821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M</a:t>
                  </a:r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DD72F803-2615-4CD1-9FC1-6EBA322AB173}"/>
                    </a:ext>
                  </a:extLst>
                </p:cNvPr>
                <p:cNvSpPr/>
                <p:nvPr/>
              </p:nvSpPr>
              <p:spPr>
                <a:xfrm>
                  <a:off x="2810796" y="1085432"/>
                  <a:ext cx="316582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L</a:t>
                  </a:r>
                  <a:endParaRPr lang="en-US" b="1" dirty="0"/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5522E2D5-4332-44F8-AD28-71840A0D7553}"/>
                    </a:ext>
                  </a:extLst>
                </p:cNvPr>
                <p:cNvSpPr/>
                <p:nvPr/>
              </p:nvSpPr>
              <p:spPr>
                <a:xfrm>
                  <a:off x="2941924" y="1087675"/>
                  <a:ext cx="370483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G</a:t>
                  </a:r>
                  <a:endParaRPr lang="en-US" b="1" dirty="0"/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99062429-E213-4703-9971-21E19445A317}"/>
                    </a:ext>
                  </a:extLst>
                </p:cNvPr>
                <p:cNvSpPr/>
                <p:nvPr/>
              </p:nvSpPr>
              <p:spPr>
                <a:xfrm>
                  <a:off x="3116376" y="1091890"/>
                  <a:ext cx="370483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D</a:t>
                  </a:r>
                  <a:endParaRPr lang="en-US" b="1" dirty="0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F6426A4D-3444-4C45-8857-62429210C0C2}"/>
                    </a:ext>
                  </a:extLst>
                </p:cNvPr>
                <p:cNvSpPr/>
                <p:nvPr/>
              </p:nvSpPr>
              <p:spPr>
                <a:xfrm>
                  <a:off x="3297105" y="1091890"/>
                  <a:ext cx="345329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P</a:t>
                  </a:r>
                  <a:endParaRPr lang="en-US" b="1" dirty="0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72C5A641-8AB4-4F5E-ADAB-F64D9D374716}"/>
                    </a:ext>
                  </a:extLst>
                </p:cNvPr>
                <p:cNvSpPr/>
                <p:nvPr/>
              </p:nvSpPr>
              <p:spPr>
                <a:xfrm>
                  <a:off x="3454026" y="1091315"/>
                  <a:ext cx="374077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N</a:t>
                  </a:r>
                  <a:endParaRPr lang="en-US" b="1" dirty="0"/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0340F4C5-F3C6-4D26-BF86-79547793E067}"/>
                    </a:ext>
                  </a:extLst>
                </p:cNvPr>
                <p:cNvSpPr/>
                <p:nvPr/>
              </p:nvSpPr>
              <p:spPr>
                <a:xfrm>
                  <a:off x="3635879" y="1096960"/>
                  <a:ext cx="329158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S</a:t>
                  </a:r>
                  <a:endParaRPr lang="en-US" b="1" dirty="0"/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4E16EB8C-6EF9-43DC-BBD0-C6B286596636}"/>
                    </a:ext>
                  </a:extLst>
                </p:cNvPr>
                <p:cNvSpPr/>
                <p:nvPr/>
              </p:nvSpPr>
              <p:spPr>
                <a:xfrm>
                  <a:off x="3870290" y="1425249"/>
                  <a:ext cx="173390" cy="1047515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58716181-0B26-48E1-AB8B-050A973B8FBB}"/>
                    </a:ext>
                  </a:extLst>
                </p:cNvPr>
                <p:cNvSpPr/>
                <p:nvPr/>
              </p:nvSpPr>
              <p:spPr>
                <a:xfrm>
                  <a:off x="3797525" y="1096385"/>
                  <a:ext cx="329158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S</a:t>
                  </a:r>
                  <a:endParaRPr lang="en-US" b="1" dirty="0"/>
                </a:p>
              </p:txBody>
            </p:sp>
          </p:grp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D6B951A4-5AC5-48EB-B0BD-E7F8D0E4D06D}"/>
                  </a:ext>
                </a:extLst>
              </p:cNvPr>
              <p:cNvSpPr/>
              <p:nvPr/>
            </p:nvSpPr>
            <p:spPr>
              <a:xfrm>
                <a:off x="3476428" y="1423074"/>
                <a:ext cx="341244" cy="115671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25AC008-3303-4C41-9747-5845D78BB35A}"/>
                  </a:ext>
                </a:extLst>
              </p:cNvPr>
              <p:cNvSpPr txBox="1"/>
              <p:nvPr/>
            </p:nvSpPr>
            <p:spPr>
              <a:xfrm>
                <a:off x="3367116" y="2507363"/>
                <a:ext cx="58150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EcoRI</a:t>
                </a:r>
                <a:endParaRPr lang="en-US" sz="1400" dirty="0"/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F597419B-151A-4145-A878-62B8B01C4870}"/>
                </a:ext>
              </a:extLst>
            </p:cNvPr>
            <p:cNvGrpSpPr/>
            <p:nvPr/>
          </p:nvGrpSpPr>
          <p:grpSpPr>
            <a:xfrm>
              <a:off x="2148289" y="4328277"/>
              <a:ext cx="6858000" cy="2345141"/>
              <a:chOff x="0" y="5645591"/>
              <a:chExt cx="6858000" cy="2345141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0FCF0191-F6D3-4A5C-A5DF-999BF0376E40}"/>
                  </a:ext>
                </a:extLst>
              </p:cNvPr>
              <p:cNvGrpSpPr/>
              <p:nvPr/>
            </p:nvGrpSpPr>
            <p:grpSpPr>
              <a:xfrm>
                <a:off x="0" y="5645591"/>
                <a:ext cx="6858000" cy="2345141"/>
                <a:chOff x="0" y="4870087"/>
                <a:chExt cx="6858000" cy="2345141"/>
              </a:xfrm>
            </p:grpSpPr>
            <p:pic>
              <p:nvPicPr>
                <p:cNvPr id="10" name="Picture 9" descr="Graphical user interface, application, table&#10;&#10;Description automatically generated">
                  <a:extLst>
                    <a:ext uri="{FF2B5EF4-FFF2-40B4-BE49-F238E27FC236}">
                      <a16:creationId xmlns:a16="http://schemas.microsoft.com/office/drawing/2014/main" id="{81CD1B4B-7FBE-4302-B985-BB16B8CF20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9200" b="42007"/>
                <a:stretch/>
              </p:blipFill>
              <p:spPr>
                <a:xfrm>
                  <a:off x="0" y="4870087"/>
                  <a:ext cx="6858000" cy="1969645"/>
                </a:xfrm>
                <a:prstGeom prst="rect">
                  <a:avLst/>
                </a:prstGeom>
              </p:spPr>
            </p:pic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id="{A20F8A83-4582-4FAD-9FE9-79FE803294EE}"/>
                    </a:ext>
                  </a:extLst>
                </p:cNvPr>
                <p:cNvSpPr/>
                <p:nvPr/>
              </p:nvSpPr>
              <p:spPr>
                <a:xfrm>
                  <a:off x="3044215" y="5903627"/>
                  <a:ext cx="341244" cy="100382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B6A2963A-CD87-49A7-AF1C-E5E2C7FF8974}"/>
                    </a:ext>
                  </a:extLst>
                </p:cNvPr>
                <p:cNvSpPr txBox="1"/>
                <p:nvPr/>
              </p:nvSpPr>
              <p:spPr>
                <a:xfrm>
                  <a:off x="2883656" y="6907451"/>
                  <a:ext cx="6623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err="1"/>
                    <a:t>HindIII</a:t>
                  </a:r>
                  <a:endParaRPr lang="en-US" sz="1400" dirty="0"/>
                </a:p>
              </p:txBody>
            </p:sp>
          </p:grp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B689311-53A4-439A-B086-436A89489B3A}"/>
                  </a:ext>
                </a:extLst>
              </p:cNvPr>
              <p:cNvSpPr/>
              <p:nvPr/>
            </p:nvSpPr>
            <p:spPr>
              <a:xfrm>
                <a:off x="2986340" y="6894832"/>
                <a:ext cx="347472" cy="833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379E28D4-65DB-49DF-A6CA-C8AEC77742A9}"/>
                  </a:ext>
                </a:extLst>
              </p:cNvPr>
              <p:cNvSpPr/>
              <p:nvPr/>
            </p:nvSpPr>
            <p:spPr>
              <a:xfrm>
                <a:off x="2986826" y="7467219"/>
                <a:ext cx="347472" cy="833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6E6B558-5D55-4C2F-9C23-B329BF1A61A0}"/>
                </a:ext>
              </a:extLst>
            </p:cNvPr>
            <p:cNvSpPr txBox="1"/>
            <p:nvPr/>
          </p:nvSpPr>
          <p:spPr>
            <a:xfrm>
              <a:off x="-49622" y="-34447"/>
              <a:ext cx="24039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upplemental Figure 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7C72DCC-2CF0-4F50-B254-CECF155132BF}"/>
                </a:ext>
              </a:extLst>
            </p:cNvPr>
            <p:cNvSpPr txBox="1"/>
            <p:nvPr/>
          </p:nvSpPr>
          <p:spPr>
            <a:xfrm>
              <a:off x="-594810" y="352207"/>
              <a:ext cx="294417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/>
                <a:t>Mapping the paired end reads with overlap.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5E902EC-E0BD-4FEA-8862-EA004165EDA7}"/>
                </a:ext>
              </a:extLst>
            </p:cNvPr>
            <p:cNvSpPr txBox="1"/>
            <p:nvPr/>
          </p:nvSpPr>
          <p:spPr>
            <a:xfrm>
              <a:off x="146647" y="5362285"/>
              <a:ext cx="247431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/>
                <a:t>Reverse read (read 2 of the paired end reads).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EFA424A-775E-41C4-9A96-17A0A2440F6E}"/>
                </a:ext>
              </a:extLst>
            </p:cNvPr>
            <p:cNvSpPr txBox="1"/>
            <p:nvPr/>
          </p:nvSpPr>
          <p:spPr>
            <a:xfrm>
              <a:off x="-30572" y="3533727"/>
              <a:ext cx="28436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Overlapping reads section.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BE9E615-93DF-4FB0-BDFD-140B2A290B21}"/>
                </a:ext>
              </a:extLst>
            </p:cNvPr>
            <p:cNvSpPr txBox="1"/>
            <p:nvPr/>
          </p:nvSpPr>
          <p:spPr>
            <a:xfrm>
              <a:off x="-11043" y="1329065"/>
              <a:ext cx="26305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/>
                <a:t>Forward read (read 1 of the paired end reads)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1812195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id="{CA7A8863-FBEF-4448-A3F5-40813062743D}"/>
              </a:ext>
            </a:extLst>
          </p:cNvPr>
          <p:cNvSpPr txBox="1"/>
          <p:nvPr/>
        </p:nvSpPr>
        <p:spPr>
          <a:xfrm>
            <a:off x="431613" y="3069273"/>
            <a:ext cx="8546134" cy="1250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DLSLQLQIHGALINKGPSCTSYWASSSSLSLPRDFISSSTFLLHRRLRRRSCSRSRGIRLRRSGFSAMPCSSSDTLTASRVGCGGGGGGGAVGGGAENASVANFKLNESTFIASLMPKKEIRADCFIEAHPEYDGRGVVIAIFDSGFDPSAAGLHVTSDGKPKVLDVIDCTGSGDIDTSTVVKANEDGHIRGASGATLVVNSSWKNPTGEWRVGSKLVYQLFTDDLTSRVKKERRKSWDEKNQEEIAKAVNNLYDFDQKHSKVEDAKLKKTREDLQSKVDFLKKQADKYEDKGPVIDAVVWHDGEVWRVALDTQSLEEDPDSGKLADFSPLTNYRIERKYGVFSRLDACSFVANVYDEGKVLSIVTDSSPHGTHVAGIATAHHPEEHLLNGVAPGAQIISCKIGDSRLGSMETGTGLTRALIAALEHNCDLVNMSYGEPALLPDYGRFVDLVTEAVNKRRLIFVSSAGNSGPALTTVGAPGGTTSSIIGVGAYVSPAMAAGAHSVVEPPSEGLEYTWSSRGPTSDGDLGVCISAPGGAVAPVPTWTLQRRMLMNGTSMASPSACGAIALLLSAMKAEGIPVSPYSVRRALENTSTPVGDLPEDKLTTGQGLMQVDKAYEYLKQFQDYPCVFYQIKVNLSGKTIPTSRGIYLREGTACRQSTEWTIQVDPKFHEGASNLKELVPFEECLELHSTDEGVVRVPDYLLLTNNGRGFNVVVDPTNLGDGVHYFEVYGIDCKAPERGPLFRIPVTIIIPKTVANQPPVISFQQMSFISGHIERRYIEVPHGATWAEATMRTSGFDTTRRFYIDTLQVCPLRRPIKWESAPTFASPSAKSFVFPVVSGQTMELAIAQFWSSGLGSREPTIVDFEIEFHGVGVDKEELLLDGSEAPIKVEAEALLASEKLVPIAVLNKIRVPYQPIDAQLKTLSTGRDRLLSGKQILALTLTYKFKLEDSAEVKPYIPLLNNRIYDTKFESQFFMISDTNKRVYAMGDVYPESSKLPKGEYKLQLYLRHENVELLEKLKQLTVFIERNMGEIRLNLHSEPDGPFTGNGAFKSSVLMPGVKEAFYLGPPTKDKLPKNTPQGSMLVGEISYGKLSFDEKEGKNPKDNPVSYPISYVVPPNKPEEDKKAASAPTCSKSVSERLEQEVRDTKIKFLGNLKQETEEERSEWRKLCTCLKSEYPDYTPLLAKILEGLLSRSDAGDKISHHEEIIEAANEVVRSVDVDELARFLLDKTEPEDDEAEKLKKKMEVTRDQL</a:t>
            </a:r>
            <a:r>
              <a:rPr lang="en-US" sz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DALYQKGLAMARIENLK</a:t>
            </a:r>
            <a:r>
              <a:rPr lang="en-US" sz="100" dirty="0">
                <a:effectLst/>
                <a:highlight>
                  <a:srgbClr val="D3D3D3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EKEGEGEEESS</a:t>
            </a:r>
            <a:r>
              <a:rPr lang="en-US" sz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QKDKFEENFKELTKWVD</a:t>
            </a:r>
            <a:r>
              <a:rPr lang="en-US" sz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VKSSKYGTLTVLREKRLS</a:t>
            </a:r>
            <a:r>
              <a:rPr lang="en-US" sz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RLGTALKVLDDLIQNENETANKKLYELK</a:t>
            </a:r>
            <a:r>
              <a:rPr lang="en-US" sz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LDLLEEIGWSHLVTYEKQWMQVRFPKSLPLF</a:t>
            </a:r>
            <a:endParaRPr lang="en-US" sz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68698889-D2C5-4ADB-A8BC-34D556B8C496}"/>
              </a:ext>
            </a:extLst>
          </p:cNvPr>
          <p:cNvSpPr txBox="1"/>
          <p:nvPr/>
        </p:nvSpPr>
        <p:spPr>
          <a:xfrm>
            <a:off x="79042" y="3137692"/>
            <a:ext cx="515525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0.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CB8F220-D0D7-476D-B8C4-7DFF1524370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392" y="3072735"/>
            <a:ext cx="8595360" cy="6542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55B3E10-6750-4380-A144-1FD57C14D79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392" y="3138365"/>
            <a:ext cx="8595360" cy="69599"/>
          </a:xfrm>
          <a:prstGeom prst="rect">
            <a:avLst/>
          </a:prstGeom>
        </p:spPr>
      </p:pic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72BF945E-BC28-47EE-8F0D-ED04B199C994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75" t="11045" r="4336" b="11795"/>
          <a:stretch/>
        </p:blipFill>
        <p:spPr>
          <a:xfrm>
            <a:off x="431612" y="675031"/>
            <a:ext cx="8712387" cy="3527726"/>
          </a:xfrm>
          <a:prstGeom prst="rect">
            <a:avLst/>
          </a:prstGeom>
        </p:spPr>
      </p:pic>
      <p:sp>
        <p:nvSpPr>
          <p:cNvPr id="231" name="TextBox 230">
            <a:extLst>
              <a:ext uri="{FF2B5EF4-FFF2-40B4-BE49-F238E27FC236}">
                <a16:creationId xmlns:a16="http://schemas.microsoft.com/office/drawing/2014/main" id="{260D0E5C-706F-4FF0-8746-20D3F475925B}"/>
              </a:ext>
            </a:extLst>
          </p:cNvPr>
          <p:cNvSpPr txBox="1"/>
          <p:nvPr/>
        </p:nvSpPr>
        <p:spPr>
          <a:xfrm>
            <a:off x="-63822" y="283960"/>
            <a:ext cx="5727850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AT4G20850: TRIPEPTIDYL PEPTIDASE II; 1380 amino acids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27375DE-0BE7-4A29-95B2-4C4D7BB29E39}"/>
              </a:ext>
            </a:extLst>
          </p:cNvPr>
          <p:cNvSpPr txBox="1"/>
          <p:nvPr/>
        </p:nvSpPr>
        <p:spPr>
          <a:xfrm>
            <a:off x="188056" y="1007332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2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317B04D6-7657-4F34-A595-3B510AB1F16E}"/>
              </a:ext>
            </a:extLst>
          </p:cNvPr>
          <p:cNvSpPr txBox="1"/>
          <p:nvPr/>
        </p:nvSpPr>
        <p:spPr>
          <a:xfrm>
            <a:off x="130338" y="1407709"/>
            <a:ext cx="464229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1.5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7B31341E-CBBB-447D-9D2C-7CA4E3703C10}"/>
              </a:ext>
            </a:extLst>
          </p:cNvPr>
          <p:cNvSpPr txBox="1"/>
          <p:nvPr/>
        </p:nvSpPr>
        <p:spPr>
          <a:xfrm>
            <a:off x="205971" y="1852410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1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6CC67E57-6938-4197-BB82-D9A3C121FD62}"/>
              </a:ext>
            </a:extLst>
          </p:cNvPr>
          <p:cNvSpPr txBox="1"/>
          <p:nvPr/>
        </p:nvSpPr>
        <p:spPr>
          <a:xfrm>
            <a:off x="140181" y="2268437"/>
            <a:ext cx="464229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0.5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B40C9032-1B63-49DC-9778-7A48C6A8F367}"/>
              </a:ext>
            </a:extLst>
          </p:cNvPr>
          <p:cNvSpPr txBox="1"/>
          <p:nvPr/>
        </p:nvSpPr>
        <p:spPr>
          <a:xfrm>
            <a:off x="162407" y="3539724"/>
            <a:ext cx="385149" cy="297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1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D85A3D30-7297-4021-BD7F-87209A81379C}"/>
              </a:ext>
            </a:extLst>
          </p:cNvPr>
          <p:cNvSpPr txBox="1"/>
          <p:nvPr/>
        </p:nvSpPr>
        <p:spPr>
          <a:xfrm>
            <a:off x="109001" y="603715"/>
            <a:ext cx="515525" cy="297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2.5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13536D16-058C-4DC2-A0CC-E831C536FE61}"/>
              </a:ext>
            </a:extLst>
          </p:cNvPr>
          <p:cNvSpPr txBox="1"/>
          <p:nvPr/>
        </p:nvSpPr>
        <p:spPr>
          <a:xfrm>
            <a:off x="333182" y="4114038"/>
            <a:ext cx="27122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0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8C282AB0-EDE9-4B3F-9317-1F532881BC30}"/>
              </a:ext>
            </a:extLst>
          </p:cNvPr>
          <p:cNvSpPr txBox="1"/>
          <p:nvPr/>
        </p:nvSpPr>
        <p:spPr>
          <a:xfrm>
            <a:off x="6414952" y="4118505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1000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AC9CD7D3-0E94-4D74-83EF-2F5827E3B4C4}"/>
              </a:ext>
            </a:extLst>
          </p:cNvPr>
          <p:cNvSpPr txBox="1"/>
          <p:nvPr/>
        </p:nvSpPr>
        <p:spPr>
          <a:xfrm rot="16200000">
            <a:off x="-799347" y="2024271"/>
            <a:ext cx="1833323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33"/>
              </a:lnSpc>
            </a:pPr>
            <a:r>
              <a:rPr lang="en-US" sz="1600" dirty="0"/>
              <a:t>Hydrophilicity index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531F24F5-A0B8-4CB4-88B6-92334840F476}"/>
              </a:ext>
            </a:extLst>
          </p:cNvPr>
          <p:cNvSpPr txBox="1"/>
          <p:nvPr/>
        </p:nvSpPr>
        <p:spPr>
          <a:xfrm>
            <a:off x="3505774" y="4266131"/>
            <a:ext cx="2524474" cy="338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rotein length (amino acids)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AB9FBE55-EBF6-4176-AC07-3C19B00016DD}"/>
              </a:ext>
            </a:extLst>
          </p:cNvPr>
          <p:cNvSpPr txBox="1"/>
          <p:nvPr/>
        </p:nvSpPr>
        <p:spPr>
          <a:xfrm>
            <a:off x="31454" y="5309957"/>
            <a:ext cx="512833" cy="205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60960" tIns="0" rIns="60960" bIns="0" rtlCol="0">
            <a:spAutoFit/>
          </a:bodyPr>
          <a:lstStyle/>
          <a:p>
            <a:r>
              <a:rPr lang="en-US" sz="1333" dirty="0">
                <a:solidFill>
                  <a:schemeClr val="accent6">
                    <a:lumMod val="75000"/>
                  </a:schemeClr>
                </a:solidFill>
              </a:rPr>
              <a:t>Rep 2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93FB5C87-2E0F-407F-A1E0-B5FFFA709DCF}"/>
              </a:ext>
            </a:extLst>
          </p:cNvPr>
          <p:cNvSpPr txBox="1"/>
          <p:nvPr/>
        </p:nvSpPr>
        <p:spPr>
          <a:xfrm>
            <a:off x="2147" y="5665105"/>
            <a:ext cx="57438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accent4">
                    <a:lumMod val="50000"/>
                  </a:schemeClr>
                </a:solidFill>
              </a:rPr>
              <a:t>Rep 3</a:t>
            </a:r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76960ACD-A54D-4697-BC7F-7550072E877B}"/>
              </a:ext>
            </a:extLst>
          </p:cNvPr>
          <p:cNvSpPr/>
          <p:nvPr/>
        </p:nvSpPr>
        <p:spPr>
          <a:xfrm>
            <a:off x="8269542" y="5717048"/>
            <a:ext cx="585216" cy="109728"/>
          </a:xfrm>
          <a:prstGeom prst="rect">
            <a:avLst/>
          </a:prstGeom>
          <a:solidFill>
            <a:schemeClr val="accent4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6FD794FB-0584-42B1-A29E-0FCC91E3401E}"/>
              </a:ext>
            </a:extLst>
          </p:cNvPr>
          <p:cNvSpPr txBox="1"/>
          <p:nvPr/>
        </p:nvSpPr>
        <p:spPr>
          <a:xfrm>
            <a:off x="374484" y="4991025"/>
            <a:ext cx="4858126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Binding region from Glyma04g009900 replicates</a:t>
            </a:r>
          </a:p>
        </p:txBody>
      </p:sp>
      <p:sp>
        <p:nvSpPr>
          <p:cNvPr id="253" name="Rectangle 252">
            <a:extLst>
              <a:ext uri="{FF2B5EF4-FFF2-40B4-BE49-F238E27FC236}">
                <a16:creationId xmlns:a16="http://schemas.microsoft.com/office/drawing/2014/main" id="{2451F93B-2472-4E30-B102-3B07D2746539}"/>
              </a:ext>
            </a:extLst>
          </p:cNvPr>
          <p:cNvSpPr/>
          <p:nvPr/>
        </p:nvSpPr>
        <p:spPr>
          <a:xfrm>
            <a:off x="8274304" y="5355561"/>
            <a:ext cx="576072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509CC5A8-CC0A-4C6F-A04A-94C489C61234}"/>
              </a:ext>
            </a:extLst>
          </p:cNvPr>
          <p:cNvSpPr txBox="1"/>
          <p:nvPr/>
        </p:nvSpPr>
        <p:spPr>
          <a:xfrm>
            <a:off x="8781425" y="5617759"/>
            <a:ext cx="35939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2</a:t>
            </a:r>
          </a:p>
        </p:txBody>
      </p:sp>
      <p:sp>
        <p:nvSpPr>
          <p:cNvPr id="255" name="Rectangle 254">
            <a:extLst>
              <a:ext uri="{FF2B5EF4-FFF2-40B4-BE49-F238E27FC236}">
                <a16:creationId xmlns:a16="http://schemas.microsoft.com/office/drawing/2014/main" id="{505D75FF-2114-4A6A-BDD3-8A9BAD955226}"/>
              </a:ext>
            </a:extLst>
          </p:cNvPr>
          <p:cNvSpPr/>
          <p:nvPr/>
        </p:nvSpPr>
        <p:spPr>
          <a:xfrm>
            <a:off x="8387618" y="5535697"/>
            <a:ext cx="283464" cy="10667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DBD43DA8-6A76-46D9-996E-B00464B16920}"/>
              </a:ext>
            </a:extLst>
          </p:cNvPr>
          <p:cNvSpPr txBox="1"/>
          <p:nvPr/>
        </p:nvSpPr>
        <p:spPr>
          <a:xfrm>
            <a:off x="372295" y="4473328"/>
            <a:ext cx="4268733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/>
              <a:t>Binding region from AT2G21490 replicates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2D46BD0B-32BA-4DF6-B920-F1A2E7EB1032}"/>
              </a:ext>
            </a:extLst>
          </p:cNvPr>
          <p:cNvSpPr txBox="1"/>
          <p:nvPr/>
        </p:nvSpPr>
        <p:spPr>
          <a:xfrm>
            <a:off x="1129" y="4693743"/>
            <a:ext cx="574388" cy="297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accent1">
                    <a:lumMod val="50000"/>
                  </a:schemeClr>
                </a:solidFill>
              </a:rPr>
              <a:t>Rep 1</a:t>
            </a:r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4EEEFEFA-B45E-4EE1-8D74-3DC29B4E7AC2}"/>
              </a:ext>
            </a:extLst>
          </p:cNvPr>
          <p:cNvSpPr/>
          <p:nvPr/>
        </p:nvSpPr>
        <p:spPr>
          <a:xfrm>
            <a:off x="8269542" y="4932721"/>
            <a:ext cx="402336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7C8BFC50-B2EE-4C6D-A67D-D1555144E235}"/>
              </a:ext>
            </a:extLst>
          </p:cNvPr>
          <p:cNvSpPr txBox="1"/>
          <p:nvPr/>
        </p:nvSpPr>
        <p:spPr>
          <a:xfrm>
            <a:off x="8781425" y="4677000"/>
            <a:ext cx="44595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16</a:t>
            </a:r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47FB02D5-95D1-45F6-8248-5A6FB1433ADF}"/>
              </a:ext>
            </a:extLst>
          </p:cNvPr>
          <p:cNvSpPr/>
          <p:nvPr/>
        </p:nvSpPr>
        <p:spPr>
          <a:xfrm>
            <a:off x="8269542" y="4770395"/>
            <a:ext cx="585216" cy="10667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5EBB84A2-740A-47E0-B872-324A2C5654E5}"/>
              </a:ext>
            </a:extLst>
          </p:cNvPr>
          <p:cNvSpPr txBox="1"/>
          <p:nvPr/>
        </p:nvSpPr>
        <p:spPr>
          <a:xfrm>
            <a:off x="82086" y="4000915"/>
            <a:ext cx="484345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-1.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C1808B4-924E-4D85-81EC-78FAE7881B9E}"/>
              </a:ext>
            </a:extLst>
          </p:cNvPr>
          <p:cNvSpPr txBox="1"/>
          <p:nvPr/>
        </p:nvSpPr>
        <p:spPr>
          <a:xfrm>
            <a:off x="1469197" y="4119551"/>
            <a:ext cx="44435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20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2CBE4AA6-7300-490B-947F-4CDE80528FF0}"/>
              </a:ext>
            </a:extLst>
          </p:cNvPr>
          <p:cNvSpPr txBox="1"/>
          <p:nvPr/>
        </p:nvSpPr>
        <p:spPr>
          <a:xfrm>
            <a:off x="5207593" y="4112444"/>
            <a:ext cx="44435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800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ABEB38F1-E0F4-48AD-BD72-D0E2214FA77B}"/>
              </a:ext>
            </a:extLst>
          </p:cNvPr>
          <p:cNvSpPr txBox="1"/>
          <p:nvPr/>
        </p:nvSpPr>
        <p:spPr>
          <a:xfrm>
            <a:off x="2712101" y="4119551"/>
            <a:ext cx="44435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400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F032DC2D-38D7-4DDF-A001-A30FCE5D25CC}"/>
              </a:ext>
            </a:extLst>
          </p:cNvPr>
          <p:cNvSpPr txBox="1"/>
          <p:nvPr/>
        </p:nvSpPr>
        <p:spPr>
          <a:xfrm>
            <a:off x="7673375" y="4136767"/>
            <a:ext cx="530915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120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035FE6C2-83A5-4473-BE07-F983B2AF5C94}"/>
              </a:ext>
            </a:extLst>
          </p:cNvPr>
          <p:cNvSpPr txBox="1"/>
          <p:nvPr/>
        </p:nvSpPr>
        <p:spPr>
          <a:xfrm>
            <a:off x="3968305" y="4122453"/>
            <a:ext cx="44435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600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C82ADEA3-5051-4EDF-A2CF-15D20CE77B8E}"/>
              </a:ext>
            </a:extLst>
          </p:cNvPr>
          <p:cNvSpPr txBox="1"/>
          <p:nvPr/>
        </p:nvSpPr>
        <p:spPr>
          <a:xfrm>
            <a:off x="7648366" y="643612"/>
            <a:ext cx="14488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Hopp</a:t>
            </a:r>
            <a:r>
              <a:rPr lang="en-US" sz="1600" dirty="0"/>
              <a:t> &amp; Woods</a:t>
            </a:r>
          </a:p>
        </p:txBody>
      </p: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3D165928-33DE-4171-994A-A042D0D8B678}"/>
              </a:ext>
            </a:extLst>
          </p:cNvPr>
          <p:cNvCxnSpPr>
            <a:cxnSpLocks/>
            <a:endCxn id="288" idx="1"/>
          </p:cNvCxnSpPr>
          <p:nvPr/>
        </p:nvCxnSpPr>
        <p:spPr>
          <a:xfrm>
            <a:off x="7343584" y="812889"/>
            <a:ext cx="304782" cy="0"/>
          </a:xfrm>
          <a:prstGeom prst="line">
            <a:avLst/>
          </a:prstGeom>
          <a:ln w="19050">
            <a:solidFill>
              <a:srgbClr val="D45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7DCB72E6-9598-462F-A201-E8011C3583D0}"/>
              </a:ext>
            </a:extLst>
          </p:cNvPr>
          <p:cNvSpPr txBox="1"/>
          <p:nvPr/>
        </p:nvSpPr>
        <p:spPr>
          <a:xfrm>
            <a:off x="8618352" y="4832217"/>
            <a:ext cx="359394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/>
              <a:t>X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87E6578-291C-4789-B841-D09B9E8677D8}"/>
              </a:ext>
            </a:extLst>
          </p:cNvPr>
          <p:cNvSpPr txBox="1"/>
          <p:nvPr/>
        </p:nvSpPr>
        <p:spPr>
          <a:xfrm>
            <a:off x="5207593" y="3800371"/>
            <a:ext cx="3214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Tripeptidyl peptidase II family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E8DA1A3-331E-4653-854B-5215AFCEC3C8}"/>
              </a:ext>
            </a:extLst>
          </p:cNvPr>
          <p:cNvSpPr txBox="1"/>
          <p:nvPr/>
        </p:nvSpPr>
        <p:spPr>
          <a:xfrm>
            <a:off x="1203864" y="3805980"/>
            <a:ext cx="30164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 err="1"/>
              <a:t>Subtilase</a:t>
            </a:r>
            <a:r>
              <a:rPr lang="en-US" dirty="0"/>
              <a:t> family domain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FF7D61E6-87CC-40F2-AF3D-4E5BB6EAE4FA}"/>
              </a:ext>
            </a:extLst>
          </p:cNvPr>
          <p:cNvSpPr txBox="1"/>
          <p:nvPr/>
        </p:nvSpPr>
        <p:spPr>
          <a:xfrm>
            <a:off x="232578" y="2705814"/>
            <a:ext cx="333853" cy="297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0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0BF58435-675B-486C-B2CC-0B2D699583C7}"/>
              </a:ext>
            </a:extLst>
          </p:cNvPr>
          <p:cNvSpPr/>
          <p:nvPr/>
        </p:nvSpPr>
        <p:spPr>
          <a:xfrm>
            <a:off x="6050756" y="2813286"/>
            <a:ext cx="1131094" cy="10972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7FB1601-1202-46B1-8881-44F6C26E37BD}"/>
              </a:ext>
            </a:extLst>
          </p:cNvPr>
          <p:cNvSpPr/>
          <p:nvPr/>
        </p:nvSpPr>
        <p:spPr>
          <a:xfrm>
            <a:off x="1321593" y="2816861"/>
            <a:ext cx="2883695" cy="10972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CE9BD368-ACE5-4711-A9CD-2B5F12BDAFAA}"/>
              </a:ext>
            </a:extLst>
          </p:cNvPr>
          <p:cNvSpPr/>
          <p:nvPr/>
        </p:nvSpPr>
        <p:spPr>
          <a:xfrm>
            <a:off x="470713" y="2817144"/>
            <a:ext cx="8575656" cy="1066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C562950-E67C-4739-9F95-99EE7BCF2E9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0</a:t>
            </a:r>
          </a:p>
        </p:txBody>
      </p:sp>
    </p:spTree>
    <p:extLst>
      <p:ext uri="{BB962C8B-B14F-4D97-AF65-F5344CB8AC3E}">
        <p14:creationId xmlns:p14="http://schemas.microsoft.com/office/powerpoint/2010/main" val="394153751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717A15CC-7D31-4C9B-ABE6-B5D5C83E7BC8}"/>
              </a:ext>
            </a:extLst>
          </p:cNvPr>
          <p:cNvGrpSpPr/>
          <p:nvPr/>
        </p:nvGrpSpPr>
        <p:grpSpPr>
          <a:xfrm>
            <a:off x="-53465" y="224999"/>
            <a:ext cx="10194271" cy="5897966"/>
            <a:chOff x="-53465" y="224999"/>
            <a:chExt cx="10194271" cy="5897966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D1299A2-5271-428D-96BA-9A55288327F9}"/>
                </a:ext>
              </a:extLst>
            </p:cNvPr>
            <p:cNvSpPr txBox="1"/>
            <p:nvPr/>
          </p:nvSpPr>
          <p:spPr>
            <a:xfrm>
              <a:off x="706396" y="3088308"/>
              <a:ext cx="9434410" cy="14908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PPLTGSGGGFSGGRGR</a:t>
              </a:r>
              <a:r>
                <a:rPr lang="en-US" sz="340" dirty="0">
                  <a:effectLst/>
                  <a:highlight>
                    <a:srgbClr val="D3D3D3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GYSGGRGDGGFSGGRGGGGRGGGRGFSDRGGRGRGRGPPRGGARGGRGPAGRGGMKGGSKVIVEPHRH</a:t>
              </a: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GVFIAKG</a:t>
              </a:r>
              <a:r>
                <a:rPr lang="en-US" sz="34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EDALVTKNLVPGEAVYNEKRISVQNEDGTKTEYRVWNPFRSKLAAAILGGVDNIWIKP</a:t>
              </a:r>
              <a:r>
                <a:rPr lang="en-US" sz="34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KVLY</a:t>
              </a:r>
              <a:r>
                <a:rPr lang="en-US" sz="34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GAASGTTVSHVSDLVGPEGC</a:t>
              </a:r>
              <a:r>
                <a:rPr lang="en-US" sz="34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YA</a:t>
              </a:r>
              <a:r>
                <a:rPr lang="en-US" sz="34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</a:t>
              </a: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FSHRSGRDLVNMAKKRTNVIPIIEDARHPAKYRMLVGMVDVIFSDVAQPDQARILAL</a:t>
              </a:r>
              <a:r>
                <a:rPr lang="en-US" sz="34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ASYFLKSGGHFVISIKANCIDSTVPAEAVFQTEVKKLQQEQFKPAEQVTLEPFERDHACVVGGY</a:t>
              </a: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MPKKPKAATAA</a:t>
              </a:r>
              <a:endParaRPr lang="en-US" sz="3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41BB2B3-D4BD-4886-AE0C-E544807D15FC}"/>
                </a:ext>
              </a:extLst>
            </p:cNvPr>
            <p:cNvSpPr txBox="1"/>
            <p:nvPr/>
          </p:nvSpPr>
          <p:spPr>
            <a:xfrm>
              <a:off x="705701" y="3197695"/>
              <a:ext cx="8686800" cy="20338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PPLTGSGGGFSGGRGRGGYSGGRGDGGFSGGRGGGGRGGGRGFSDRGGRGRGRGPPRGGARGGRGPAGRGGMKGGSKVI</a:t>
              </a:r>
              <a:r>
                <a:rPr lang="en-US" sz="34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EPHRHAGVFIAKGKEDALVTKNLVPGEAVYNEKRISVQNEDGTKTEYRVWNPFRSKLAAAILGGVDNIWIKPGAKVLYLGAASGTTVSHVSDLVGPEGCVYAVEFSHRSGRDLVNMAKKRTNVIPIIEDARHPAKYRMLVGMVDVIFSDVAQPDQARILALNASYFLKSGGHFVISIKANCIDSTVPAEAVFQTEVKKLQQEQFKPAEQVTLEPFERDHACVVGGYR</a:t>
              </a:r>
              <a:r>
                <a:rPr lang="en-US" sz="34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PKKPKAATAA</a:t>
              </a:r>
              <a:endParaRPr lang="en-US" sz="3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B012E7B3-25F4-44F7-93F9-BBBBB0E44AC6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56" t="11115" r="4641" b="11703"/>
            <a:stretch/>
          </p:blipFill>
          <p:spPr>
            <a:xfrm>
              <a:off x="737121" y="563335"/>
              <a:ext cx="8261624" cy="3528780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3465" y="224999"/>
              <a:ext cx="446840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4G25630: FIBRILLARIN 2; 320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19006" y="47779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58414" y="89763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36784" y="141655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77691" y="190213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28530" y="244286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25973" y="2905914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80401" y="3385213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37367" y="3997823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3093447" y="3990897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17769" y="219449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41731" y="4163162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191003" y="557006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192318" y="581447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74312" y="5396925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2905386" y="5825510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77821" y="4397721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196249" y="459345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27708" y="5044103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190381" y="521501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4761026" y="4669285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0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5392607" y="520693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02106" y="3922800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5656446" y="399263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8217934" y="399311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6939758" y="399818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1855629" y="3989706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2E23C55-961A-4289-86B1-0C3083882F80}"/>
                </a:ext>
              </a:extLst>
            </p:cNvPr>
            <p:cNvSpPr txBox="1"/>
            <p:nvPr/>
          </p:nvSpPr>
          <p:spPr>
            <a:xfrm>
              <a:off x="4380389" y="399274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548921" y="549849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244139" y="719126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3183762" y="4772442"/>
              <a:ext cx="165506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3183762" y="4936375"/>
              <a:ext cx="228600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3186143" y="5109483"/>
              <a:ext cx="224942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3182707" y="5303173"/>
              <a:ext cx="22860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6944765" y="5631421"/>
              <a:ext cx="164592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B6C7952F-CBF3-43EE-87BC-2A1429C154B5}"/>
                </a:ext>
              </a:extLst>
            </p:cNvPr>
            <p:cNvSpPr/>
            <p:nvPr/>
          </p:nvSpPr>
          <p:spPr>
            <a:xfrm>
              <a:off x="1226950" y="5919374"/>
              <a:ext cx="175564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15B86D4-CDC5-4711-901D-1925404A2BAD}"/>
                </a:ext>
              </a:extLst>
            </p:cNvPr>
            <p:cNvSpPr txBox="1"/>
            <p:nvPr/>
          </p:nvSpPr>
          <p:spPr>
            <a:xfrm>
              <a:off x="4747193" y="3705875"/>
              <a:ext cx="1865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Fibrillarin domain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7F047185-F1E5-4145-886E-9626EB73C548}"/>
                </a:ext>
              </a:extLst>
            </p:cNvPr>
            <p:cNvSpPr/>
            <p:nvPr/>
          </p:nvSpPr>
          <p:spPr>
            <a:xfrm>
              <a:off x="2852738" y="2519870"/>
              <a:ext cx="5793582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9B4F2FB2-6EF5-44EB-89A8-02D6BA70A461}"/>
                </a:ext>
              </a:extLst>
            </p:cNvPr>
            <p:cNvSpPr/>
            <p:nvPr/>
          </p:nvSpPr>
          <p:spPr>
            <a:xfrm>
              <a:off x="789345" y="2519588"/>
              <a:ext cx="8147486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06D7D0BF-23A2-4B73-8448-60A95FB725F5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1</a:t>
            </a:r>
          </a:p>
        </p:txBody>
      </p:sp>
    </p:spTree>
    <p:extLst>
      <p:ext uri="{BB962C8B-B14F-4D97-AF65-F5344CB8AC3E}">
        <p14:creationId xmlns:p14="http://schemas.microsoft.com/office/powerpoint/2010/main" val="390413616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B49DFD5B-BDCD-4537-8E8A-7499E3A5B2DF}"/>
              </a:ext>
            </a:extLst>
          </p:cNvPr>
          <p:cNvGrpSpPr/>
          <p:nvPr/>
        </p:nvGrpSpPr>
        <p:grpSpPr>
          <a:xfrm>
            <a:off x="-63822" y="283960"/>
            <a:ext cx="9907212" cy="5536045"/>
            <a:chOff x="-63822" y="283960"/>
            <a:chExt cx="9907212" cy="5536045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B6EB92C-D5D6-4571-A259-0529871981F2}"/>
                </a:ext>
              </a:extLst>
            </p:cNvPr>
            <p:cNvSpPr txBox="1"/>
            <p:nvPr/>
          </p:nvSpPr>
          <p:spPr>
            <a:xfrm>
              <a:off x="646165" y="3125198"/>
              <a:ext cx="9197225" cy="1976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6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NKLFLVCAALALCFILTNASVYRTVVEFDEDDASNPIGPIQKCQ</a:t>
              </a:r>
              <a:r>
                <a:rPr lang="en-US" sz="6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E</a:t>
              </a:r>
              <a:r>
                <a:rPr lang="en-US" sz="6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QQDQHLRACQRWMRKQMWQGRGGG</a:t>
              </a:r>
              <a:r>
                <a:rPr lang="en-US" sz="6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SLDDEFDMEDDIENPQRRQLLQKCCSELRQEEPVC</a:t>
              </a:r>
              <a:r>
                <a:rPr lang="en-US" sz="6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CPT</a:t>
              </a:r>
              <a:r>
                <a:rPr lang="en-US" sz="6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RQAAKAVRFQGQQHQPEQVRKIYQ</a:t>
              </a:r>
              <a:r>
                <a:rPr lang="en-US" sz="6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AKYLPNICKIQQVGVCPFQIPSIPSYY</a:t>
              </a:r>
              <a:endParaRPr lang="en-US" sz="6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277D7B4-AE67-4B7D-9900-5D2608AF6750}"/>
                </a:ext>
              </a:extLst>
            </p:cNvPr>
            <p:cNvSpPr txBox="1"/>
            <p:nvPr/>
          </p:nvSpPr>
          <p:spPr>
            <a:xfrm>
              <a:off x="647189" y="2778394"/>
              <a:ext cx="8778240" cy="3046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6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NKLFLVCAALALCFILTNASVYRTVVEFDEDDASNPIGPIQKCQKEFQQDQHLRA</a:t>
              </a:r>
              <a:r>
                <a:rPr lang="en-US" sz="6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CQRWMRKQMWQGRGGGPSLDDEFDMEDDIENPQRRQLLQKCCSELRQEEPVCVCPTLRQAAKAVRFQGQQHQPEQVRKIYQAAKYLPNICKIQQVGVC</a:t>
              </a:r>
              <a:r>
                <a:rPr lang="en-US" sz="6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FQIPSIPSYY</a:t>
              </a:r>
              <a:endParaRPr lang="en-US" sz="6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EBE54FD9-07D7-4D8C-8364-303869774710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14" t="10654" r="4118" b="11226"/>
            <a:stretch/>
          </p:blipFill>
          <p:spPr>
            <a:xfrm>
              <a:off x="661149" y="686279"/>
              <a:ext cx="8359026" cy="3571651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83960"/>
              <a:ext cx="640502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4G27170: SEED STORAGE ALBUMIN 4; SESA4; 166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36137" y="60114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48102" y="108788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26612" y="155278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48102" y="2052928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26399" y="253898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98225" y="3040373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61092" y="3539528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589742" y="415974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477716" y="414363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16267" y="2138330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85270" y="4323893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96286" y="528972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97208" y="548255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25618" y="5102843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7444731" y="5522551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6021404" y="497829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21900" y="4559224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23807" y="4781847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96286" y="4941090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1DFE38B-62B4-4C18-A728-F8B9C09E5EFD}"/>
                </a:ext>
              </a:extLst>
            </p:cNvPr>
            <p:cNvSpPr txBox="1"/>
            <p:nvPr/>
          </p:nvSpPr>
          <p:spPr>
            <a:xfrm>
              <a:off x="6036893" y="4774232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02469" y="3986912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483435" y="414659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484550" y="4145289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4463663" y="414659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421549" y="414329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6398162" y="414528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2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7402133" y="415022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4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9A1585C-9154-479D-B97E-3A52627C89DA}"/>
                </a:ext>
              </a:extLst>
            </p:cNvPr>
            <p:cNvSpPr txBox="1"/>
            <p:nvPr/>
          </p:nvSpPr>
          <p:spPr>
            <a:xfrm>
              <a:off x="8378949" y="413842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6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536124" y="678315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231342" y="847592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4323597" y="4874087"/>
              <a:ext cx="176479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4323597" y="5066173"/>
              <a:ext cx="176479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3088046" y="5442849"/>
              <a:ext cx="320040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2991372" y="5624960"/>
              <a:ext cx="452628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1A2D5E6-D71E-4947-83E7-1569A7A9D75B}"/>
                </a:ext>
              </a:extLst>
            </p:cNvPr>
            <p:cNvSpPr txBox="1"/>
            <p:nvPr/>
          </p:nvSpPr>
          <p:spPr>
            <a:xfrm>
              <a:off x="3516095" y="3857794"/>
              <a:ext cx="491141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Protease inhibitor/seed storage protein/LTP family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07AA1C2-3366-46CD-9F62-4F9EAF6B2186}"/>
                </a:ext>
              </a:extLst>
            </p:cNvPr>
            <p:cNvSpPr/>
            <p:nvPr/>
          </p:nvSpPr>
          <p:spPr>
            <a:xfrm>
              <a:off x="3543299" y="2662460"/>
              <a:ext cx="4824413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71FEFCBD-47E8-4424-BA0D-BF24E1184323}"/>
                </a:ext>
              </a:extLst>
            </p:cNvPr>
            <p:cNvSpPr/>
            <p:nvPr/>
          </p:nvSpPr>
          <p:spPr>
            <a:xfrm>
              <a:off x="727432" y="2662460"/>
              <a:ext cx="8176062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5594F271-07D3-4600-A298-BAA4A314CF70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2</a:t>
            </a:r>
          </a:p>
        </p:txBody>
      </p:sp>
    </p:spTree>
    <p:extLst>
      <p:ext uri="{BB962C8B-B14F-4D97-AF65-F5344CB8AC3E}">
        <p14:creationId xmlns:p14="http://schemas.microsoft.com/office/powerpoint/2010/main" val="342902212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F5C5D4E-86DA-4640-943F-C636058135BD}"/>
              </a:ext>
            </a:extLst>
          </p:cNvPr>
          <p:cNvGrpSpPr/>
          <p:nvPr/>
        </p:nvGrpSpPr>
        <p:grpSpPr>
          <a:xfrm>
            <a:off x="-46737" y="266020"/>
            <a:ext cx="9988354" cy="5531526"/>
            <a:chOff x="-46737" y="266020"/>
            <a:chExt cx="9988354" cy="5531526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9A831C0-8EC4-4B47-805C-2929AA119C1E}"/>
                </a:ext>
              </a:extLst>
            </p:cNvPr>
            <p:cNvSpPr txBox="1"/>
            <p:nvPr/>
          </p:nvSpPr>
          <p:spPr>
            <a:xfrm>
              <a:off x="899765" y="2921847"/>
              <a:ext cx="8503920" cy="13484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IKVCMNALCGAASTSGEWKKGWPMRSGDLASLCDKCGCAYEQSIFCEVFHAKESGWRECNSCDKRLHCGCIASRFMMELLENGGVTCISCAKKSGLISMNVSHESNGKDFPSFASAEHVGSVLERTNLKHLLHFQRIDPTHSSLQMKQEESLLPSSLDALRHKTERKELSAQPNLSISLGPTLMTSPFHDAAVDDRSKTNSIFQLAPRSRQLLPKPANSAPIAAGMEPSGSLVSQIHVARPPPEGRGKTQLLPRYWPRITDQELLQLSGQYPHLSNSKIIPL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EKVLSASDAGRIGRLVLPKACAEAYFPPISLPEGLPLKIQDIKGKEWVFQFRFWPNNNSRMYVLEGVTPCIQSMQLQAGDTVTFSRTEPEGKLVMGYRK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NSTATQMFKGSSEPNLNMFSNSLNPGCGDINWSKLEKSEDMAKDNLFLQSSLTSARKRVRNIGTKSKRLLIDSVDVLELKITWEEAQELLRPPQSTKPSIFTLENQDFEEYDEPPVFGKRTLFVSRQTGEQE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WVQCDACGKWRQLPVDILLPPKWSCSDNLLDPGRSSCSAPDE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SPREQDTLVRQSKEFKRRRLASSNEKLNQSQDASALNSLGNAGITTTGEQGEITVAATTKHPRHRAGCSCIVCSQPPSGKGKHKPSCTCTVCEAVKRRFRTLMLRKRNKGEAGQASQQAQSQSECRDETEVESIPAVELAAGENIDLNSDPGASRVSMMRLLQAAAFPLEAYLKQKAISNTAGEQQSSDMVSTEHGSSSAAQETEKDTTNGAHDPVN</a:t>
              </a:r>
              <a:endParaRPr lang="en-US" sz="1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6BEC427-BA01-42F6-BCB8-35AB70711C29}"/>
                </a:ext>
              </a:extLst>
            </p:cNvPr>
            <p:cNvSpPr txBox="1"/>
            <p:nvPr/>
          </p:nvSpPr>
          <p:spPr>
            <a:xfrm>
              <a:off x="899723" y="2861759"/>
              <a:ext cx="9041852" cy="1166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MESIKVCMNALCGAASTSGEWKKGWPMRSGDLASLCDKCGCAYEQSIFCEVFHAKESGWRECNSCDKRLHCGCIASRFMMELLENGGVTCISCAKKSGLISMNVSHESNGKDFPSFASAEHVGSVLERTNLKHLLHFQRIDPTHSSLQMKQEESLLPSSLDALRHKTERKELSAQPNLSISLGPTLMTSPFHDAAVDDRSKTNSIFQLAPRSRQLLPKPANSAPIAAGMEPSGSLVSQIHVARPPPEGRGKTQLLPRYWPRITDQELLQLSGQYPHLSNSKII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PLFEKVLSASDAGRIGRLVLPKACAEAYFPPISLPEGLPLKIQDIKGKEWVFQFRFWPNNNSRMYVLEGVTPCIQSMQLQAGDTVTFSRTEPEGKLVMGYRK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ATNSTATQMFKGSSEPNLNMFSNSLNPGCGDINWSKLEKSEDMAKDNLFLQSSLTSARKRVRNIGTKSKRLLIDSVDVLELKITWEEAQELLRPPQSTKPSIFTLENQDFEEYDEPPVFGKRTLFVS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RQTGEQEQWVQCDACGKW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00008B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RQLPVDILLPPKWSCSDNLLDPGRSSCSAPDEL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SPREQDTLVRQSK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EFKRRRLASSNEKLNQSQDASALNSLGNAGIT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TTGEQGEITVAATTKHPRHRAGCSCIVCSQPPSGKGKHKPSCTCTVCEAVKRRFRTLMLR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KRNKGEAGQASQQAQSQSECRDETEVE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SIPAVELAAGENIDLNSDPGASRVSMMRLLQAAAFPLEAYLKQKAIS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NTAGEQQSSDMVSTEHGSSSAAQETEKDTTNGAHDPVN</a:t>
              </a:r>
              <a:endParaRPr lang="en-US" sz="13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DD98D36-ABA9-416B-B926-C95C57BE1CEB}"/>
                </a:ext>
              </a:extLst>
            </p:cNvPr>
            <p:cNvSpPr txBox="1"/>
            <p:nvPr/>
          </p:nvSpPr>
          <p:spPr>
            <a:xfrm>
              <a:off x="899979" y="3008579"/>
              <a:ext cx="8618080" cy="1134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IKVCMNALCGAASTSGEWKKGWPMRSGDLASLCDKCGCAYEQSIFCEVFHAKESGWRECNSCDKRLHCGCIASRFMMELLENGGVTCISCAKKSGLISMNVSHESNGKDFPSFASAEHVGSVLERTNLKHLLHFQRIDPTHSSLQMKQEESLLPSSLDALRHKTERKELSAQPNLSISLGPTLMTSPFHDAAVDDRSKTNSIFQLAPRSRQLLPKPANSAPIAAGMEPSGSLVSQIHVARPPPEGRGKTQLLPRYWPRITDQELLQLSGQYPHLSNSKIIPLFEKVLSASDAGRIGRLVLPKACAEAYFPPISLPEGLPLKIQDIKGKEWVFQFRFWPNNNSRMYVLEGVTPCIQSMQLQAGDTVTFSRTEPEGKLVMGYRKATNSTATQMFKGSSEPNLNMFSNSLNPGCGDINWSKLEKSEDMAKDNLFLQSSLTSARKRVRNIGTKSKRLLIDSVDVLELKITWEEAQELLRPPQSTKPSIFTLENQDFEEYDEPPVFGKRTLFVSRQTGEQEQWVQCDACGKWRQLPVDILLPPKWSCSDNLLDPGRSSCSAPDELSPREQDTLVRQSKEFKRRRLASSNEKLNQSQDASALNSL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NAGITTTGEQGEITVAATTKHPRHRAGCSCIVCSQPPSGKGKHKPSCTCTVCEAVKRRFRTLML</a:t>
              </a:r>
              <a:r>
                <a:rPr lang="en-US" sz="1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KRNKGEAGQASQQAQSQSECRDETEVESIPAVELAAGENIDLNSDPGASRVSMMRLLQAAAFPLEAYLKQKAISNTAGEQ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SSDMVSTEHGSSSAAQETEKDTTNGAHDPVN</a:t>
              </a:r>
              <a:endParaRPr lang="en-US" sz="1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3E6FEA2-5908-A3F2-6056-561473496A68}"/>
                </a:ext>
              </a:extLst>
            </p:cNvPr>
            <p:cNvSpPr txBox="1"/>
            <p:nvPr/>
          </p:nvSpPr>
          <p:spPr>
            <a:xfrm>
              <a:off x="899765" y="2877841"/>
              <a:ext cx="9041852" cy="1166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MESIKVCMNALCGAASTSGEWKKGWPMRSGDLASLCDKCGCAYEQSIFCEVFHAKESGWRECNSCDKRLHCGCIASRFMMELLENGGVTCISCAKKSGLISMNVSHESNGKDFPSFASAEHVGSVLERTNLKHLLHFQRIDPTHSSLQMKQEESLLPSSLDALRHKTERKELSAQPNLSISLGPTLMTSPFHDAAVDDRSKTNSIFQLAPRSRQLLPKPANSAPIAAGMEPSGSLVSQIHVARPPPEGRGKTQLLPRYWPRITDQELLQLSGQYPHLSNSKII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PLFEKVLSASDAGRIGRLVLPKACAEAYFPPISLPEGLPLKIQDIKGKEWVFQFRFWPNNNSRMYVLEGVTPCIQSMQLQAGDTVTFSRTEPEGKLVMGYRK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ATNSTATQMFKGSSEPNLNMFSNSLNPGCGDINWSKLEKSEDMAKDNLFLQSSLTSARKRVRNIGTKSKRLLIDSVDVLELKITWEEAQELLRPPQSTKPSIFTLENQDFEEYDEPPVFGKRTLFVS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RQTGEQEQWVQCDACGKW</a:t>
              </a:r>
              <a:r>
                <a:rPr lang="en-US" sz="130" dirty="0">
                  <a:solidFill>
                    <a:srgbClr val="FFFFFF"/>
                  </a:solidFill>
                  <a:effectLst/>
                  <a:highlight>
                    <a:srgbClr val="00008B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RQLPVDILLPPKWSCSDNLLDPGRSSCSAPDEL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SPREQDTLVRQSK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EFKRRRLASSNEKLNQSQDASALNSLGNAGIT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TTGEQGEITVAATTKHPRHRAGCSCIVCSQPPSGKGKHKPSCTCTVCEAVKRRFRTLMLR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KRNKGEAGQASQQAQSQSECRDETEVE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SIPAVELAAGENIDLNSDPGASRVSMMRLLQAAAFPLEAYLKQKAIS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NTAGEQQSSDMVSTEHGSSSAAQETEKDTTNGAHDPVN</a:t>
              </a:r>
              <a:endParaRPr lang="en-US" sz="13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788BC5E-461C-18FC-8149-AAB793441AA4}"/>
                </a:ext>
              </a:extLst>
            </p:cNvPr>
            <p:cNvSpPr txBox="1"/>
            <p:nvPr/>
          </p:nvSpPr>
          <p:spPr>
            <a:xfrm>
              <a:off x="900021" y="3024661"/>
              <a:ext cx="8618080" cy="1134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IKVCMNALCGAASTSGEWKKGWPMRSGDLASLCDKCGCAYEQSIFCEVFHAKESGWRECNSCDKRLHCGCIASRFMMELLENGGVTCISCAKKSGLISMNVSHESNGKDFPSFASAEHVGSVLERTNLKHLLHFQRIDPTHSSLQMKQEESLLPSSLDALRHKTERKELSAQPNLSISLGPTLMTSPFHDAAVDDRSKTNSIFQLAPRSRQLLPKPANSAPIAAGMEPSGSLVSQIHVARPPPEGRGKTQLLPRYWPRITDQELLQLSGQYPHLSNSKIIPLFEKVLSASDAGRIGRLVLPKACAEAYFPPISLPEGLPLKIQDIKGKEWVFQFRFWPNNNSRMYVLEGVTPCIQSMQLQAGDTVTFSRTEPEGKLVMGYRKATNSTATQMFKGSSEPNLNMFSNSLNPGCGDINWSKLEKSEDMAKDNLFLQSSLTSARKRVRNIGTKSKRLLIDSVDVLELKITWEEAQELLRPPQSTKPSIFTLENQDFEEYDEPPVFGKRTLFVSRQTGEQEQWVQCDACGKWRQLPVDILLPPKWSCSDNLLDPGRSSCSAPDELSPREQDTLVRQSKEFKRRRLASSNEKLNQSQDASALNSL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NAGITTTGEQGEITVAATTKHPRHRAGCSCIVCSQPPSGKGKHKPSCTCTVCEAVKRRFRTLML</a:t>
              </a:r>
              <a:r>
                <a:rPr lang="en-US" sz="1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KRNKGEAGQASQQAQSQSECRDETEVESIPAVELAAGENIDLNSDPGASRVSMMRLLQAAAFPLEAYLKQKAISNTAGEQ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SSDMVSTEHGSSSAAQETEKDTTNGAHDPVN</a:t>
              </a:r>
              <a:endParaRPr lang="en-US" sz="1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27" name="Picture 26" descr="Chart&#10;&#10;Description automatically generated">
              <a:extLst>
                <a:ext uri="{FF2B5EF4-FFF2-40B4-BE49-F238E27FC236}">
                  <a16:creationId xmlns:a16="http://schemas.microsoft.com/office/drawing/2014/main" id="{49362C5F-B08A-4559-9860-85AE306D251E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38" t="11055" r="4575" b="11746"/>
            <a:stretch/>
          </p:blipFill>
          <p:spPr>
            <a:xfrm>
              <a:off x="919027" y="732551"/>
              <a:ext cx="7568990" cy="3557016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472798E-F132-4462-B288-348C9DB4ECD2}"/>
                </a:ext>
              </a:extLst>
            </p:cNvPr>
            <p:cNvSpPr txBox="1"/>
            <p:nvPr/>
          </p:nvSpPr>
          <p:spPr>
            <a:xfrm>
              <a:off x="-46737" y="266020"/>
              <a:ext cx="619483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4G32010.1: </a:t>
              </a:r>
              <a:r>
                <a:rPr lang="en-US" dirty="0"/>
                <a:t>VIVIPAROUS1/ABI3-LIKE2; </a:t>
              </a:r>
              <a:r>
                <a:rPr lang="en-US" sz="1867" dirty="0"/>
                <a:t>VAL2; 780 amino acid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C8C0B78-3A41-44C6-AE35-2E653549F0C5}"/>
                </a:ext>
              </a:extLst>
            </p:cNvPr>
            <p:cNvSpPr txBox="1"/>
            <p:nvPr/>
          </p:nvSpPr>
          <p:spPr>
            <a:xfrm>
              <a:off x="8035523" y="4789128"/>
              <a:ext cx="359394" cy="297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0" dirty="0"/>
                <a:t>X9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C43C16D-92D9-4FFF-A6D2-F21525D0D123}"/>
                </a:ext>
              </a:extLst>
            </p:cNvPr>
            <p:cNvSpPr txBox="1"/>
            <p:nvPr/>
          </p:nvSpPr>
          <p:spPr>
            <a:xfrm>
              <a:off x="8033894" y="5500542"/>
              <a:ext cx="46406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0" dirty="0"/>
                <a:t>X6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B094B5D-7A91-48D2-8BBE-F5E071B619A0}"/>
                </a:ext>
              </a:extLst>
            </p:cNvPr>
            <p:cNvSpPr txBox="1"/>
            <p:nvPr/>
          </p:nvSpPr>
          <p:spPr>
            <a:xfrm>
              <a:off x="7258505" y="4957120"/>
              <a:ext cx="359394" cy="297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0" dirty="0"/>
                <a:t>X3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69E6DD9-D435-4451-969F-480BC3ECF97D}"/>
                </a:ext>
              </a:extLst>
            </p:cNvPr>
            <p:cNvSpPr txBox="1"/>
            <p:nvPr/>
          </p:nvSpPr>
          <p:spPr>
            <a:xfrm>
              <a:off x="693593" y="62604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D5C1622-233F-4674-B662-3296C98DA163}"/>
                </a:ext>
              </a:extLst>
            </p:cNvPr>
            <p:cNvSpPr txBox="1"/>
            <p:nvPr/>
          </p:nvSpPr>
          <p:spPr>
            <a:xfrm>
              <a:off x="624016" y="1109172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4B95469-8C85-4BBF-B5EC-3FD1A06F1264}"/>
                </a:ext>
              </a:extLst>
            </p:cNvPr>
            <p:cNvSpPr txBox="1"/>
            <p:nvPr/>
          </p:nvSpPr>
          <p:spPr>
            <a:xfrm>
              <a:off x="698782" y="159017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A26A063-DF45-44F7-B522-DD683CC171F7}"/>
                </a:ext>
              </a:extLst>
            </p:cNvPr>
            <p:cNvSpPr txBox="1"/>
            <p:nvPr/>
          </p:nvSpPr>
          <p:spPr>
            <a:xfrm>
              <a:off x="633883" y="210696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CE4B1D1-E188-4F39-BCAF-C14B39868D40}"/>
                </a:ext>
              </a:extLst>
            </p:cNvPr>
            <p:cNvSpPr txBox="1"/>
            <p:nvPr/>
          </p:nvSpPr>
          <p:spPr>
            <a:xfrm>
              <a:off x="696563" y="2613174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8C68103-DE9E-4BB3-B647-085EB2FB62DE}"/>
                </a:ext>
              </a:extLst>
            </p:cNvPr>
            <p:cNvSpPr txBox="1"/>
            <p:nvPr/>
          </p:nvSpPr>
          <p:spPr>
            <a:xfrm>
              <a:off x="569698" y="3111172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00D04E2-C32A-467E-B46D-81B4C4A24885}"/>
                </a:ext>
              </a:extLst>
            </p:cNvPr>
            <p:cNvSpPr txBox="1"/>
            <p:nvPr/>
          </p:nvSpPr>
          <p:spPr>
            <a:xfrm>
              <a:off x="646454" y="3574390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DDB9619-BCA1-4CF6-85BC-03980A80C1B9}"/>
                </a:ext>
              </a:extLst>
            </p:cNvPr>
            <p:cNvSpPr txBox="1"/>
            <p:nvPr/>
          </p:nvSpPr>
          <p:spPr>
            <a:xfrm>
              <a:off x="852671" y="4199289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D2F0666-ADDB-48D7-92D7-6AE201CF5396}"/>
                </a:ext>
              </a:extLst>
            </p:cNvPr>
            <p:cNvSpPr txBox="1"/>
            <p:nvPr/>
          </p:nvSpPr>
          <p:spPr>
            <a:xfrm rot="16200000">
              <a:off x="-365501" y="2405916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7BEDABD-6EF4-4B27-B489-2A88C878BF2B}"/>
                </a:ext>
              </a:extLst>
            </p:cNvPr>
            <p:cNvSpPr txBox="1"/>
            <p:nvPr/>
          </p:nvSpPr>
          <p:spPr>
            <a:xfrm>
              <a:off x="569698" y="4082940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62FA76F-E2D2-4758-A1D0-DCC98B4639EB}"/>
                </a:ext>
              </a:extLst>
            </p:cNvPr>
            <p:cNvSpPr txBox="1"/>
            <p:nvPr/>
          </p:nvSpPr>
          <p:spPr>
            <a:xfrm>
              <a:off x="1716548" y="4212690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C565C78-939D-44BB-ADF4-5FAF460DBAB0}"/>
                </a:ext>
              </a:extLst>
            </p:cNvPr>
            <p:cNvSpPr txBox="1"/>
            <p:nvPr/>
          </p:nvSpPr>
          <p:spPr>
            <a:xfrm>
              <a:off x="3525167" y="4344094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69D8DFE-B5E7-4533-B4E3-DB2324292CB9}"/>
                </a:ext>
              </a:extLst>
            </p:cNvPr>
            <p:cNvSpPr txBox="1"/>
            <p:nvPr/>
          </p:nvSpPr>
          <p:spPr>
            <a:xfrm>
              <a:off x="2669460" y="420659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7B9C87B-30BF-4A01-9020-72F504125560}"/>
                </a:ext>
              </a:extLst>
            </p:cNvPr>
            <p:cNvSpPr txBox="1"/>
            <p:nvPr/>
          </p:nvSpPr>
          <p:spPr>
            <a:xfrm>
              <a:off x="3621296" y="420368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7D0A324-6930-420E-B019-7036C0FCCB91}"/>
                </a:ext>
              </a:extLst>
            </p:cNvPr>
            <p:cNvSpPr txBox="1"/>
            <p:nvPr/>
          </p:nvSpPr>
          <p:spPr>
            <a:xfrm>
              <a:off x="4570738" y="420659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5CA077B-0E33-4EE0-B84D-897EF731EB03}"/>
                </a:ext>
              </a:extLst>
            </p:cNvPr>
            <p:cNvSpPr txBox="1"/>
            <p:nvPr/>
          </p:nvSpPr>
          <p:spPr>
            <a:xfrm>
              <a:off x="5538963" y="420316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C38EAA3-F3A8-4700-ADE4-CB7FACF71BEC}"/>
                </a:ext>
              </a:extLst>
            </p:cNvPr>
            <p:cNvSpPr txBox="1"/>
            <p:nvPr/>
          </p:nvSpPr>
          <p:spPr>
            <a:xfrm>
              <a:off x="6488521" y="420659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D7DD7E5-29AD-45C8-AAB1-2F10406D3F55}"/>
                </a:ext>
              </a:extLst>
            </p:cNvPr>
            <p:cNvSpPr txBox="1"/>
            <p:nvPr/>
          </p:nvSpPr>
          <p:spPr>
            <a:xfrm>
              <a:off x="7444275" y="420217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9E80B35-86D6-4BB1-BFA4-ECA28FB91D9A}"/>
                </a:ext>
              </a:extLst>
            </p:cNvPr>
            <p:cNvSpPr txBox="1"/>
            <p:nvPr/>
          </p:nvSpPr>
          <p:spPr>
            <a:xfrm>
              <a:off x="7047820" y="713474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0E05F2C6-0AD9-4AC6-8046-4E609E90FB6B}"/>
                </a:ext>
              </a:extLst>
            </p:cNvPr>
            <p:cNvCxnSpPr>
              <a:cxnSpLocks/>
              <a:endCxn id="67" idx="1"/>
            </p:cNvCxnSpPr>
            <p:nvPr/>
          </p:nvCxnSpPr>
          <p:spPr>
            <a:xfrm>
              <a:off x="6743038" y="882751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9E8528D-65FD-407C-951A-83E6E56CC571}"/>
                </a:ext>
              </a:extLst>
            </p:cNvPr>
            <p:cNvSpPr txBox="1"/>
            <p:nvPr/>
          </p:nvSpPr>
          <p:spPr>
            <a:xfrm>
              <a:off x="423274" y="531335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A65DC64-9CA8-4F1A-B368-4D0205D0238F}"/>
                </a:ext>
              </a:extLst>
            </p:cNvPr>
            <p:cNvSpPr txBox="1"/>
            <p:nvPr/>
          </p:nvSpPr>
          <p:spPr>
            <a:xfrm>
              <a:off x="452863" y="4865355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C960F92-B86F-426F-94BE-B177BF776DC5}"/>
                </a:ext>
              </a:extLst>
            </p:cNvPr>
            <p:cNvSpPr txBox="1"/>
            <p:nvPr/>
          </p:nvSpPr>
          <p:spPr>
            <a:xfrm>
              <a:off x="452938" y="5564380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1B6E5730-0654-4989-8FDB-2775D6855BA9}"/>
                </a:ext>
              </a:extLst>
            </p:cNvPr>
            <p:cNvSpPr/>
            <p:nvPr/>
          </p:nvSpPr>
          <p:spPr>
            <a:xfrm>
              <a:off x="6730112" y="5600159"/>
              <a:ext cx="137967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5DFFADB1-FF4D-4AA3-9C15-89BFF8A0A216}"/>
                </a:ext>
              </a:extLst>
            </p:cNvPr>
            <p:cNvSpPr/>
            <p:nvPr/>
          </p:nvSpPr>
          <p:spPr>
            <a:xfrm>
              <a:off x="6731423" y="5050366"/>
              <a:ext cx="60350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E8DD3ACC-8236-4E2C-BC94-1E82137AE4F6}"/>
                </a:ext>
              </a:extLst>
            </p:cNvPr>
            <p:cNvSpPr/>
            <p:nvPr/>
          </p:nvSpPr>
          <p:spPr>
            <a:xfrm>
              <a:off x="6729042" y="4881820"/>
              <a:ext cx="1380744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5D5C7FF0-F5DF-40B8-AAFF-3723EE6D90EA}"/>
                </a:ext>
              </a:extLst>
            </p:cNvPr>
            <p:cNvSpPr/>
            <p:nvPr/>
          </p:nvSpPr>
          <p:spPr>
            <a:xfrm>
              <a:off x="6729270" y="5431212"/>
              <a:ext cx="612648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56F57A1-35C0-47B3-9373-01436B3FC2A0}"/>
                </a:ext>
              </a:extLst>
            </p:cNvPr>
            <p:cNvSpPr txBox="1"/>
            <p:nvPr/>
          </p:nvSpPr>
          <p:spPr>
            <a:xfrm>
              <a:off x="888593" y="5139264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FCFA228-3417-44E4-A041-E561F8B05B43}"/>
                </a:ext>
              </a:extLst>
            </p:cNvPr>
            <p:cNvSpPr txBox="1"/>
            <p:nvPr/>
          </p:nvSpPr>
          <p:spPr>
            <a:xfrm>
              <a:off x="888593" y="4606056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82199D0-16B4-4DB0-9452-68174A1543A7}"/>
                </a:ext>
              </a:extLst>
            </p:cNvPr>
            <p:cNvSpPr txBox="1"/>
            <p:nvPr/>
          </p:nvSpPr>
          <p:spPr>
            <a:xfrm>
              <a:off x="3361072" y="3729075"/>
              <a:ext cx="1564546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B3 DNA binding family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CD4394A-DC92-4A33-9BB7-DA284DE3FD4A}"/>
                </a:ext>
              </a:extLst>
            </p:cNvPr>
            <p:cNvSpPr txBox="1"/>
            <p:nvPr/>
          </p:nvSpPr>
          <p:spPr>
            <a:xfrm>
              <a:off x="5331935" y="3703222"/>
              <a:ext cx="1682077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CW-type Zinc Finger domain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A78F63F9-67A2-439C-A7FB-B2FFD25450E7}"/>
                </a:ext>
              </a:extLst>
            </p:cNvPr>
            <p:cNvSpPr/>
            <p:nvPr/>
          </p:nvSpPr>
          <p:spPr>
            <a:xfrm>
              <a:off x="3705224" y="2708436"/>
              <a:ext cx="952501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55E8B740-920D-4819-A05E-FB9BA7901D1F}"/>
                </a:ext>
              </a:extLst>
            </p:cNvPr>
            <p:cNvSpPr/>
            <p:nvPr/>
          </p:nvSpPr>
          <p:spPr>
            <a:xfrm>
              <a:off x="5934075" y="2707175"/>
              <a:ext cx="409575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F95219D-0D40-4C32-99DC-4CAB290F6C8B}"/>
                </a:ext>
              </a:extLst>
            </p:cNvPr>
            <p:cNvSpPr/>
            <p:nvPr/>
          </p:nvSpPr>
          <p:spPr>
            <a:xfrm>
              <a:off x="986992" y="2707704"/>
              <a:ext cx="7440252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5B06A5C3-2279-471F-BF0F-FA2A420310B8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30D734-EE51-220D-6AE7-D9052790665E}"/>
              </a:ext>
            </a:extLst>
          </p:cNvPr>
          <p:cNvSpPr txBox="1"/>
          <p:nvPr/>
        </p:nvSpPr>
        <p:spPr>
          <a:xfrm>
            <a:off x="997662" y="6407314"/>
            <a:ext cx="62094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chemeClr val="bg1">
                    <a:lumMod val="50000"/>
                  </a:schemeClr>
                </a:solidFill>
              </a:rPr>
              <a:t>Binding regions are also valid for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T4G32010.2 (776aa).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CAEEFA1-202B-AC64-79FE-C96D8D728BC9}"/>
              </a:ext>
            </a:extLst>
          </p:cNvPr>
          <p:cNvSpPr/>
          <p:nvPr/>
        </p:nvSpPr>
        <p:spPr>
          <a:xfrm>
            <a:off x="3590573" y="6278185"/>
            <a:ext cx="36576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5A2A0F-4422-B787-25CA-82D5EBCCD478}"/>
              </a:ext>
            </a:extLst>
          </p:cNvPr>
          <p:cNvSpPr txBox="1"/>
          <p:nvPr/>
        </p:nvSpPr>
        <p:spPr>
          <a:xfrm>
            <a:off x="3414837" y="6021044"/>
            <a:ext cx="407246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4 aa deletion  and 1 aa change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202753977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D0649C4B-72CE-42F2-9E8F-6278F505D3D1}"/>
              </a:ext>
            </a:extLst>
          </p:cNvPr>
          <p:cNvGrpSpPr/>
          <p:nvPr/>
        </p:nvGrpSpPr>
        <p:grpSpPr>
          <a:xfrm>
            <a:off x="-40688" y="360247"/>
            <a:ext cx="9721271" cy="5537854"/>
            <a:chOff x="-40688" y="215866"/>
            <a:chExt cx="9721271" cy="5537854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974E141-EA04-4395-B4A8-F8A2401E654E}"/>
                </a:ext>
              </a:extLst>
            </p:cNvPr>
            <p:cNvSpPr txBox="1"/>
            <p:nvPr/>
          </p:nvSpPr>
          <p:spPr>
            <a:xfrm>
              <a:off x="417170" y="2554550"/>
              <a:ext cx="9263413" cy="1522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RLSSTLCLTFLILATVAFGVPPKKSINVPFGRNYFPTWAFDHIKYLNGGSEVHLVLDKYTGTGFQSKGSYLFGHFSMHIKMVA</a:t>
              </a:r>
              <a:r>
                <a:rPr lang="en-US" sz="37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DSAGTVTAFYLSSQNSEHDEIDFEFLGNRTGQPYILQTNVFTGGAGNREQ</a:t>
              </a:r>
              <a:r>
                <a:rPr lang="en-US" sz="3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INLWFDPSKDYHSYSVLWNMYQIVFFVDDVPIRVFKNSKDVGVKFPFNQPMKIYSSLWNADDWATRGGLEKTNWEKAPFVASYRGFHVDGCEASVNAKFCETQGKRWWDQKEFQDLDANQYKRLKWVRKRYTIYNYCTDRVRFPVPPPECRRDRDI</a:t>
              </a:r>
              <a:endParaRPr lang="en-US" sz="3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E9E0CF4-A7EA-40CD-B7A6-494B1784E788}"/>
                </a:ext>
              </a:extLst>
            </p:cNvPr>
            <p:cNvSpPr txBox="1"/>
            <p:nvPr/>
          </p:nvSpPr>
          <p:spPr>
            <a:xfrm>
              <a:off x="432709" y="2908640"/>
              <a:ext cx="9144000" cy="21320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RLSSTLCLTFLILATVAFGVPPKKSINVPF</a:t>
              </a:r>
              <a:r>
                <a:rPr lang="en-US" sz="37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RNYFPTWAFDHIKYLNGGSEVHLVLDKYTGTGFQSKGSYLFGHFSMHIKMVAGDSAGTVTAFYLSSQNSEHDEIDFEFLGNRTGQPYILQTNVFTGGAGNREQRINLWFDPSKDYHSYSVLWNMYQIVFFVDDVPIRVFKNSKDVGVKFPFNQPMKIYSSLWNADDWATRGGLEKTNWE</a:t>
              </a:r>
              <a:r>
                <a:rPr lang="en-US" sz="3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APFVASYRGFHVDGCEASVNAKFCET</a:t>
              </a:r>
              <a:r>
                <a:rPr lang="en-US" sz="37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GKRWWDQKEFQDLDANQYKRLKWVRKRYTIYNYCTDRVRFPVPPPEC</a:t>
              </a:r>
              <a:r>
                <a:rPr lang="en-US" sz="37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RDRDI</a:t>
              </a:r>
              <a:endParaRPr lang="en-US" sz="37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2DDAE9A9-F870-47D2-9383-15DEA38E3E58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04" t="11242" r="4309" b="11415"/>
            <a:stretch/>
          </p:blipFill>
          <p:spPr>
            <a:xfrm>
              <a:off x="439214" y="796268"/>
              <a:ext cx="8547433" cy="3536108"/>
            </a:xfrm>
            <a:prstGeom prst="rect">
              <a:avLst/>
            </a:prstGeom>
          </p:spPr>
        </p:pic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31872" y="71658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153242" y="110012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37060" y="153585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145001" y="195305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31872" y="240549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92166" y="2820812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157353" y="3268619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381342" y="4259052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736594" y="4235863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800554" y="2465457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630795" y="4385363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23541" y="5548599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08117" y="5246545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08681" y="4578228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2755" y="487607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-5753" y="504137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4339392" y="5052391"/>
              <a:ext cx="532518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51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91319" y="3682373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120906" y="424154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570482" y="423895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6014809" y="424107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447146" y="423547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67118A68-476E-4FF1-8B3A-5F331B2456C8}"/>
                </a:ext>
              </a:extLst>
            </p:cNvPr>
            <p:cNvSpPr txBox="1"/>
            <p:nvPr/>
          </p:nvSpPr>
          <p:spPr>
            <a:xfrm>
              <a:off x="170895" y="4147547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2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40688" y="215866"/>
              <a:ext cx="9721271" cy="6669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5G13870.1, .2 or .3: ENDOXYLOGLUCAN TRANSFERASE A4, XYLOGLUCAN ENDOTRANSGLUCOSYLASE /HYDROLASE 5; 293 amino acids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48288" y="786136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043506" y="955413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2943280" y="4963889"/>
              <a:ext cx="144475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2943280" y="5140687"/>
              <a:ext cx="146304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2943280" y="5623051"/>
              <a:ext cx="144475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6A121BF-B6B1-4427-928D-7708A8783AFD}"/>
                </a:ext>
              </a:extLst>
            </p:cNvPr>
            <p:cNvSpPr txBox="1"/>
            <p:nvPr/>
          </p:nvSpPr>
          <p:spPr>
            <a:xfrm>
              <a:off x="2278653" y="3941879"/>
              <a:ext cx="382320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Glycosyl hydrolase family 16 domain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73201D66-A2BF-4517-9E5A-1D47312A8C33}"/>
                </a:ext>
              </a:extLst>
            </p:cNvPr>
            <p:cNvSpPr/>
            <p:nvPr/>
          </p:nvSpPr>
          <p:spPr>
            <a:xfrm>
              <a:off x="7353922" y="2496571"/>
              <a:ext cx="1370109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D8F3E5A-3606-47B1-AD4E-1DFFABEEAAB8}"/>
                </a:ext>
              </a:extLst>
            </p:cNvPr>
            <p:cNvSpPr txBox="1"/>
            <p:nvPr/>
          </p:nvSpPr>
          <p:spPr>
            <a:xfrm>
              <a:off x="6614901" y="3539393"/>
              <a:ext cx="2452548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Xyloglucan endo-</a:t>
              </a:r>
              <a:r>
                <a:rPr lang="en-US" dirty="0" err="1"/>
                <a:t>transglycosylase</a:t>
              </a:r>
              <a:r>
                <a:rPr lang="en-US" dirty="0"/>
                <a:t> (XET) C-terminus family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7B0C118F-B2A5-462B-B03E-17AFE5C0A4F6}"/>
                </a:ext>
              </a:extLst>
            </p:cNvPr>
            <p:cNvSpPr/>
            <p:nvPr/>
          </p:nvSpPr>
          <p:spPr>
            <a:xfrm>
              <a:off x="1438615" y="2497691"/>
              <a:ext cx="5143873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7453539D-C5D5-4403-A202-49F4332FE867}"/>
                </a:ext>
              </a:extLst>
            </p:cNvPr>
            <p:cNvSpPr/>
            <p:nvPr/>
          </p:nvSpPr>
          <p:spPr>
            <a:xfrm>
              <a:off x="505970" y="2498152"/>
              <a:ext cx="8383236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D0494B8D-2A21-4AED-BB35-CC4420EB3569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4</a:t>
            </a:r>
          </a:p>
        </p:txBody>
      </p:sp>
    </p:spTree>
    <p:extLst>
      <p:ext uri="{BB962C8B-B14F-4D97-AF65-F5344CB8AC3E}">
        <p14:creationId xmlns:p14="http://schemas.microsoft.com/office/powerpoint/2010/main" val="173365819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15A7CBE7-FB13-43E7-A81D-7B73BECF012C}"/>
              </a:ext>
            </a:extLst>
          </p:cNvPr>
          <p:cNvGrpSpPr/>
          <p:nvPr/>
        </p:nvGrpSpPr>
        <p:grpSpPr>
          <a:xfrm>
            <a:off x="-7772" y="299509"/>
            <a:ext cx="9816158" cy="5567114"/>
            <a:chOff x="-7772" y="34333"/>
            <a:chExt cx="9816158" cy="5567114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063FA81-8FBD-4FE0-AD82-137633D20632}"/>
                </a:ext>
              </a:extLst>
            </p:cNvPr>
            <p:cNvSpPr txBox="1"/>
            <p:nvPr/>
          </p:nvSpPr>
          <p:spPr>
            <a:xfrm>
              <a:off x="388907" y="2760071"/>
              <a:ext cx="9278254" cy="1328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GLRCWLQFYRNGNAHNVFAIMPERNVLYGESSFRRVWVRFMTSSKRVQDRSREKRVQELEIATEKWKIASKVIFLMEVLKGERDM</a:t>
              </a:r>
              <a:r>
                <a:rPr lang="en-US" sz="2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MTVRSFEQYRRQINLPKPHKISDFIRKSPKLFELYKDQRGVLWCGLTEGGEDLLDEHDKLLEENGDKAAEHVTRCLMMSVDKKLPLDKIVHFR</a:t>
              </a:r>
              <a:r>
                <a:rPr lang="en-US" sz="2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</a:t>
              </a:r>
              <a:r>
                <a:rPr lang="en-US" sz="2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r>
                <a:rPr lang="en-US" sz="2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GLPLDFRINWVYNFPQHFKVVKLGDGEEYLELVSWNPAWAITELEKKTLGITEDCEHKPGMLSLAFPMKFPPSYKKMYRYRGKIEHFQKRSYLSPYADARGLEAGSKEFDKRAIAVMHELLSFTLEKRLVTDHLTHFRREFVMPQKLMRIFLKHCGIFYVSERGKRFSVFLTEGYEGPELIEKCPLILWKEKLLKFTGYRGRKRDIQTYSDTLDMEERELLESGSGDEDLSVGFEKDGDYDDVVTDDDEMDIGEVNDAYEENSKV</a:t>
              </a:r>
              <a:endParaRPr lang="en-US" sz="2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171519B-9810-42A3-936B-687A6EC3B4F2}"/>
                </a:ext>
              </a:extLst>
            </p:cNvPr>
            <p:cNvSpPr txBox="1"/>
            <p:nvPr/>
          </p:nvSpPr>
          <p:spPr>
            <a:xfrm>
              <a:off x="390066" y="2886090"/>
              <a:ext cx="9418320" cy="1740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GLRCWLQFYRNGNAHNVFAIMPERNVLYGESSFRRVWVRFMTSSKRVQDRSRE</a:t>
              </a:r>
              <a:r>
                <a:rPr lang="en-US" sz="2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VQELEIATEKWKIASKVIFLMEVLKGERDMIMTVRSFEQYRRQINLPKPHKISDFIRKSPKLFELYKDQRGVLWCGLTEGGEDLLDEHDKLLEENGDKAAEHVTRCLMMSVDKKLPLDKIVHFRRDFGLPLDFRINWVYNFPQHFKVVKLGDGEEYLELVSWNPAWAITELEKKTLGITEDCEHKPGMLSLAFPMKFPPSYKKMYRYRGKIEHFQKRSYLSPYADARGLEAGSKEFDKRAIAVMHELLSFTLEKRLVTDHLTHFRREFVMPQKLMRIFLKHCGIFYVSERGKRFSVFLTEGYEGPELIEKCPLILWKEKLLKFTGY</a:t>
              </a:r>
              <a:r>
                <a:rPr lang="en-US" sz="2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GRKRDIQTYSDTLDMEERELLESGSGDEDLSVGFEKDGDYDDVVTDDDEMDIGEVNDAYEENSKV</a:t>
              </a:r>
              <a:endParaRPr lang="en-US" sz="2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87B649EF-EADA-4C7D-AAC0-4FE2997C511A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06" t="10802" r="4827" b="11895"/>
            <a:stretch/>
          </p:blipFill>
          <p:spPr>
            <a:xfrm>
              <a:off x="361047" y="595522"/>
              <a:ext cx="8723827" cy="3534327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0" y="34333"/>
              <a:ext cx="9133896" cy="6669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5G21970.1 or .2: UBIQUITIN CARBOXYL-TERMINAL HYDROLASE family protein; 449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27341" y="52564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105162" y="98485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02690" y="146850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113697" y="1952732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04507" y="247421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62401" y="2965312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133191" y="3407802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352023" y="4046057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230472" y="4048989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72982" y="2097044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03101" y="4190886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29505" y="5396326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356732" y="5069863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2138228" y="5439943"/>
              <a:ext cx="180136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361047" y="4405304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7036" y="470886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-7772" y="486439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79" name="Rectangle 278">
              <a:extLst>
                <a:ext uri="{FF2B5EF4-FFF2-40B4-BE49-F238E27FC236}">
                  <a16:creationId xmlns:a16="http://schemas.microsoft.com/office/drawing/2014/main" id="{F274DA5E-3DD4-46C9-AAAC-5399892470E0}"/>
                </a:ext>
              </a:extLst>
            </p:cNvPr>
            <p:cNvSpPr/>
            <p:nvPr/>
          </p:nvSpPr>
          <p:spPr>
            <a:xfrm>
              <a:off x="2140609" y="4769085"/>
              <a:ext cx="181965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1DFE38B-62B4-4C18-A728-F8B9C09E5EFD}"/>
                </a:ext>
              </a:extLst>
            </p:cNvPr>
            <p:cNvSpPr txBox="1"/>
            <p:nvPr/>
          </p:nvSpPr>
          <p:spPr>
            <a:xfrm>
              <a:off x="3906176" y="468168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2135847" y="4981506"/>
              <a:ext cx="18288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3903739" y="4888534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43692" y="3896574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140738" y="405194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122803" y="405064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4053886" y="405215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030822" y="404865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5979063" y="406037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6954459" y="40557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650170" y="583994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345388" y="753271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27122F1-4845-4919-B558-9FC9DC9F9B59}"/>
                </a:ext>
              </a:extLst>
            </p:cNvPr>
            <p:cNvSpPr txBox="1"/>
            <p:nvPr/>
          </p:nvSpPr>
          <p:spPr>
            <a:xfrm>
              <a:off x="7912958" y="405666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A7BD8AB-3437-4183-93B3-8E2DA18A0741}"/>
                </a:ext>
              </a:extLst>
            </p:cNvPr>
            <p:cNvSpPr txBox="1"/>
            <p:nvPr/>
          </p:nvSpPr>
          <p:spPr>
            <a:xfrm>
              <a:off x="2295044" y="3776317"/>
              <a:ext cx="47700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/>
                <a:t>Plant organelle RNA recognition domain family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677D3AB-9D22-4E6A-A056-94EACEFA1E95}"/>
                </a:ext>
              </a:extLst>
            </p:cNvPr>
            <p:cNvSpPr/>
            <p:nvPr/>
          </p:nvSpPr>
          <p:spPr>
            <a:xfrm>
              <a:off x="1528764" y="2563522"/>
              <a:ext cx="6248400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653164B0-39B8-4EEA-B23E-CE982DF07A5B}"/>
                </a:ext>
              </a:extLst>
            </p:cNvPr>
            <p:cNvSpPr/>
            <p:nvPr/>
          </p:nvSpPr>
          <p:spPr>
            <a:xfrm>
              <a:off x="475012" y="2564826"/>
              <a:ext cx="8566593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5CBCF85E-0FEA-4A78-9362-784192CA82E6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5</a:t>
            </a:r>
          </a:p>
        </p:txBody>
      </p:sp>
    </p:spTree>
    <p:extLst>
      <p:ext uri="{BB962C8B-B14F-4D97-AF65-F5344CB8AC3E}">
        <p14:creationId xmlns:p14="http://schemas.microsoft.com/office/powerpoint/2010/main" val="416767625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09471152-BD12-4101-9EE6-66D712C59BCD}"/>
              </a:ext>
            </a:extLst>
          </p:cNvPr>
          <p:cNvGrpSpPr/>
          <p:nvPr/>
        </p:nvGrpSpPr>
        <p:grpSpPr>
          <a:xfrm>
            <a:off x="-73335" y="295108"/>
            <a:ext cx="9578521" cy="6245050"/>
            <a:chOff x="-73335" y="198852"/>
            <a:chExt cx="9578521" cy="6245050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ED52359-709C-496B-B4B5-61B472020D1E}"/>
                </a:ext>
              </a:extLst>
            </p:cNvPr>
            <p:cNvSpPr txBox="1"/>
            <p:nvPr/>
          </p:nvSpPr>
          <p:spPr>
            <a:xfrm>
              <a:off x="568198" y="3057310"/>
              <a:ext cx="8936988" cy="1522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VFVKSSKSNAYFKRYQVKFRRRRDGKTDYRARIRLINQDKNKYNTPKYRFVVRFTNKDIVAQIVSASIAGDIVKASAYAHELPQYGLTVGLTNYAAAYCTGLLLAR</a:t>
              </a:r>
              <a:r>
                <a:rPr lang="en-US" sz="3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VLKMLEMD</a:t>
              </a:r>
              <a:r>
                <a:rPr lang="en-US" sz="360" dirty="0">
                  <a:effectLst/>
                  <a:highlight>
                    <a:srgbClr val="D3D3D3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YEG</a:t>
              </a:r>
              <a:r>
                <a:rPr lang="en-US" sz="3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VEATGEDFSVEPTDSRRPFRALLDVGLIRTTTGNRVFGALKGALDGG</a:t>
              </a:r>
              <a:r>
                <a:rPr lang="en-US" sz="3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</a:t>
              </a:r>
              <a:r>
                <a:rPr lang="en-US" sz="3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r>
                <a:rPr lang="en-US" sz="3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PHSD</a:t>
              </a:r>
              <a:r>
                <a:rPr lang="en-US" sz="3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FAGFHKENK</a:t>
              </a:r>
              <a:r>
                <a:rPr lang="en-US" sz="3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LD</a:t>
              </a:r>
              <a:r>
                <a:rPr lang="en-US" sz="3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EIH</a:t>
              </a:r>
              <a:r>
                <a:rPr lang="en-US" sz="36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NY</a:t>
              </a:r>
              <a:r>
                <a:rPr lang="en-US" sz="3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YGGHVSNYMKLLGE</a:t>
              </a:r>
              <a:r>
                <a:rPr lang="en-US" sz="36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P</a:t>
              </a:r>
              <a:r>
                <a:rPr lang="en-US" sz="3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KLQTHFSAYIKKGVEAESIEEMYKKVHAAIRAEPN</a:t>
              </a:r>
              <a:r>
                <a:rPr lang="en-US" sz="3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HK</a:t>
              </a:r>
              <a:r>
                <a:rPr lang="en-US" sz="3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</a:t>
              </a:r>
              <a:r>
                <a:rPr lang="en-US" sz="36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360" dirty="0">
                  <a:effectLst/>
                  <a:highlight>
                    <a:srgbClr val="D3D3D3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en-US" sz="3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SAPKEHKRYNLKKLTYEER</a:t>
              </a: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NKLIERVKALNGAGGDDDDE</a:t>
              </a:r>
              <a:r>
                <a:rPr lang="en-US" sz="36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DE</a:t>
              </a: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endParaRPr lang="en-US" sz="36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5A30D68-D60B-450E-BF7A-A3571417652A}"/>
                </a:ext>
              </a:extLst>
            </p:cNvPr>
            <p:cNvSpPr txBox="1"/>
            <p:nvPr/>
          </p:nvSpPr>
          <p:spPr>
            <a:xfrm>
              <a:off x="568197" y="3453453"/>
              <a:ext cx="8778240" cy="2098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VFVKSSKSNAYF</a:t>
              </a:r>
              <a:r>
                <a:rPr lang="en-US" sz="3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YQVKFRRRRDGKTDYRARIRLINQDKNKYNTPKYRFVVRFTNKDIVAQIVSASIAGDIVKASAYAHELPQYGLTVGLTNYAAAYCTGLLLARRVLKMLEMDDEYEGNVEATGEDFSVEPTDSRRPFRALLDVGLIRTTTGNRVFGALKGALDGGLDIPHS</a:t>
              </a: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KRFAGFHKENKQLDAEIHRNYIYGGHVSNYMKLLGEDEPEKLQTHFSAYIKKGVEAES</a:t>
              </a:r>
              <a:r>
                <a:rPr lang="en-US" sz="3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EEMYKKVHAAIRAEPNHKKTEKSAPKEHKRYNLKKLTYEERKNKLIERVKALN</a:t>
              </a:r>
              <a:r>
                <a:rPr lang="en-US" sz="3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GGDDDDEDDEE</a:t>
              </a:r>
              <a:endParaRPr lang="en-US" sz="36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 descr="Chart&#10;&#10;Description automatically generated">
              <a:extLst>
                <a:ext uri="{FF2B5EF4-FFF2-40B4-BE49-F238E27FC236}">
                  <a16:creationId xmlns:a16="http://schemas.microsoft.com/office/drawing/2014/main" id="{AD51A48B-947E-49F9-88CC-15417F247078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48" t="11077" r="4504" b="11504"/>
            <a:stretch/>
          </p:blipFill>
          <p:spPr>
            <a:xfrm>
              <a:off x="568199" y="542694"/>
              <a:ext cx="8297195" cy="3539553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73335" y="198852"/>
              <a:ext cx="8253670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5G39740.1, OR .2: </a:t>
              </a:r>
              <a:r>
                <a:rPr lang="it-IT" sz="1867" dirty="0"/>
                <a:t>OLIGOCELLULA 7, RIBOSOMAL PROTEIN L5 B; </a:t>
              </a:r>
              <a:r>
                <a:rPr lang="en-US" sz="1867" dirty="0"/>
                <a:t>301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351716" y="120067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00733" y="1573740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360546" y="196002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91968" y="236598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360024" y="273108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30451" y="3116468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05752" y="3490783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291860" y="827370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504626" y="3996606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798733" y="3980285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54045" y="204209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675081" y="4149233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79782" y="5843777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36194" y="611684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6376713" y="6234310"/>
              <a:ext cx="237744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543997" y="5553808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3794298" y="5899933"/>
              <a:ext cx="376732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5205842" y="5985589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6</a:t>
              </a:r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505D75FF-2114-4A6A-BDD3-8A9BAD955226}"/>
                </a:ext>
              </a:extLst>
            </p:cNvPr>
            <p:cNvSpPr/>
            <p:nvPr/>
          </p:nvSpPr>
          <p:spPr>
            <a:xfrm>
              <a:off x="3553560" y="6074674"/>
              <a:ext cx="171907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>
              <a:off x="7495599" y="5806456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6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8678588" y="6146448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7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546927" y="4353540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54647" y="462617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85112" y="5443313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7E2E0FAE-55D3-4451-9C5A-052C4A520375}"/>
                </a:ext>
              </a:extLst>
            </p:cNvPr>
            <p:cNvSpPr txBox="1"/>
            <p:nvPr/>
          </p:nvSpPr>
          <p:spPr>
            <a:xfrm>
              <a:off x="8043956" y="4772525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1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3923815" y="4722093"/>
              <a:ext cx="351129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7363861" y="4618236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2</a:t>
              </a:r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3951766" y="5022532"/>
              <a:ext cx="348386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2B1323B2-DB74-44CC-9874-F13EBB63A30E}"/>
                </a:ext>
              </a:extLst>
            </p:cNvPr>
            <p:cNvSpPr/>
            <p:nvPr/>
          </p:nvSpPr>
          <p:spPr>
            <a:xfrm>
              <a:off x="5704118" y="5182639"/>
              <a:ext cx="243230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5225298" y="5509733"/>
              <a:ext cx="228600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968C584B-562E-43FF-B33B-E3B34B614107}"/>
                </a:ext>
              </a:extLst>
            </p:cNvPr>
            <p:cNvSpPr txBox="1"/>
            <p:nvPr/>
          </p:nvSpPr>
          <p:spPr>
            <a:xfrm>
              <a:off x="7450423" y="5404477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C6A08A1-E439-4B38-BC6D-EDDAA2F95175}"/>
                </a:ext>
              </a:extLst>
            </p:cNvPr>
            <p:cNvSpPr txBox="1"/>
            <p:nvPr/>
          </p:nvSpPr>
          <p:spPr>
            <a:xfrm>
              <a:off x="7358502" y="4932499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9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364562" y="466666"/>
              <a:ext cx="364731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255496" y="3883888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113713" y="397372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482050" y="397221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828788" y="396399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191386" y="396069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8544947" y="396248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285146" y="526511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980364" y="695788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70A60FC1-9C53-450E-A83A-84BAC8C752AB}"/>
                </a:ext>
              </a:extLst>
            </p:cNvPr>
            <p:cNvSpPr/>
            <p:nvPr/>
          </p:nvSpPr>
          <p:spPr>
            <a:xfrm>
              <a:off x="5704118" y="4868420"/>
              <a:ext cx="240487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431EE56F-B7B5-4D47-85F4-7448781B77BD}"/>
                </a:ext>
              </a:extLst>
            </p:cNvPr>
            <p:cNvSpPr/>
            <p:nvPr/>
          </p:nvSpPr>
          <p:spPr>
            <a:xfrm>
              <a:off x="5891811" y="5337536"/>
              <a:ext cx="165506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3BFB583-D88F-4B95-8F4B-4E3D2B2F86BA}"/>
                </a:ext>
              </a:extLst>
            </p:cNvPr>
            <p:cNvSpPr txBox="1"/>
            <p:nvPr/>
          </p:nvSpPr>
          <p:spPr>
            <a:xfrm>
              <a:off x="8065484" y="5076650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7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29C00EA-4C65-46C1-9FC9-7B9B1226D359}"/>
                </a:ext>
              </a:extLst>
            </p:cNvPr>
            <p:cNvSpPr txBox="1"/>
            <p:nvPr/>
          </p:nvSpPr>
          <p:spPr>
            <a:xfrm>
              <a:off x="6851476" y="3270627"/>
              <a:ext cx="1762175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Ribosomal L18 C-terminal region domain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39A1138-7423-40D5-A351-38CB9F28C306}"/>
                </a:ext>
              </a:extLst>
            </p:cNvPr>
            <p:cNvSpPr/>
            <p:nvPr/>
          </p:nvSpPr>
          <p:spPr>
            <a:xfrm>
              <a:off x="1012030" y="2824457"/>
              <a:ext cx="4371976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1B99A27-FE72-4BEF-A923-F39106123E88}"/>
                </a:ext>
              </a:extLst>
            </p:cNvPr>
            <p:cNvSpPr txBox="1"/>
            <p:nvPr/>
          </p:nvSpPr>
          <p:spPr>
            <a:xfrm>
              <a:off x="1508262" y="3519597"/>
              <a:ext cx="3482365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Ribosomal large subunit proteins 60S LS, and 50S L18 family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972BE4C0-C4B1-44B9-BAA6-2D55DB79497E}"/>
                </a:ext>
              </a:extLst>
            </p:cNvPr>
            <p:cNvSpPr/>
            <p:nvPr/>
          </p:nvSpPr>
          <p:spPr>
            <a:xfrm>
              <a:off x="6974681" y="2824554"/>
              <a:ext cx="1457325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BB97CCC3-98C7-462F-984F-5B586F2B071D}"/>
                </a:ext>
              </a:extLst>
            </p:cNvPr>
            <p:cNvSpPr/>
            <p:nvPr/>
          </p:nvSpPr>
          <p:spPr>
            <a:xfrm>
              <a:off x="651227" y="2824385"/>
              <a:ext cx="813796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FB409E58-854D-4DE5-AE6F-9B8D993C10FA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6</a:t>
            </a:r>
          </a:p>
        </p:txBody>
      </p:sp>
    </p:spTree>
    <p:extLst>
      <p:ext uri="{BB962C8B-B14F-4D97-AF65-F5344CB8AC3E}">
        <p14:creationId xmlns:p14="http://schemas.microsoft.com/office/powerpoint/2010/main" val="405097518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DAFE8B4-B7A8-404B-93DD-68233FD19907}"/>
              </a:ext>
            </a:extLst>
          </p:cNvPr>
          <p:cNvGrpSpPr/>
          <p:nvPr/>
        </p:nvGrpSpPr>
        <p:grpSpPr>
          <a:xfrm>
            <a:off x="-63822" y="235320"/>
            <a:ext cx="10325059" cy="5382211"/>
            <a:chOff x="-63822" y="235320"/>
            <a:chExt cx="10325059" cy="5382211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A0458CE4-E8C0-4330-8A61-0FE848F72D37}"/>
                </a:ext>
              </a:extLst>
            </p:cNvPr>
            <p:cNvSpPr txBox="1"/>
            <p:nvPr/>
          </p:nvSpPr>
          <p:spPr>
            <a:xfrm>
              <a:off x="663659" y="3169332"/>
              <a:ext cx="8686800" cy="1609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KKKSKVTEPESQNDESQTIFSTLFSGEVESSGFASLFSADNPFRRKQPQEIKESSIPDEKKGDKRNAENEEEEEETDLPVKTKKSKKEKKLTDSGDEKETISEAVEESGLVSKRKKRKRDEIENEYETKKYGSVEMKEKKVGEKRKKADEVADTMVSKEGFDDESKLLRT</a:t>
              </a:r>
              <a:r>
                <a:rPr lang="en-US" sz="2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FVGNLPLKVKKKVILKEFSKFGEVESVRIRSVPIVD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KRTRKGAIMLKQINEKASSVHAYVVFETEQSAAASLAHNMSLIDGNHVRVDRACPPRKKQKGHDDTHLYDPKRT</a:t>
              </a:r>
              <a:r>
                <a:rPr lang="en-US" sz="2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FMGNLPFDVKDEEVYQLFTGKSNLENSIEAVRVIRDPHLNIGKGIAYVLFKTREAANLVLKKGYLKLRERE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RISRVKPDTPSKRKSNPSEAYSPAQKRLQKDKVVTPTPTGKANLSYQGVRASKSGDDKKTPYQKSSAQTKMRPRGSSSNDNKKSGNNSASKERSQKRPAVAARKAKANAKGSKESGGKRFAGTKRKQENRTPESFSKKKKTKRF</a:t>
              </a:r>
              <a:endParaRPr lang="en-US" sz="2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0ED7074-2C37-4141-8E08-D8DDAD7BA744}"/>
                </a:ext>
              </a:extLst>
            </p:cNvPr>
            <p:cNvSpPr txBox="1"/>
            <p:nvPr/>
          </p:nvSpPr>
          <p:spPr>
            <a:xfrm>
              <a:off x="681669" y="3303326"/>
              <a:ext cx="9579568" cy="1279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KKKSKVTEPESQNDESQTIFSTLFSGEVESSGFASLFSADN</a:t>
              </a:r>
              <a:r>
                <a:rPr lang="en-US" sz="21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FRRKQPQEIKESSIPDEKKGDKRNAENEEEEEETDLPVKTKKSKKEKKLTDSGDEKETISEAVEESGLVSK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KKRKRDEIENEYETKKYGSVEMKEKKVGEKRKKADEVADTMVSKEGFDDESKLLRTVFVGNLPLKVKKKVILKEFSKFGEVESVRIRSVPIVDSKRTRKGAIMLKQINEKASSVHAYVVFETEQSAAASLAHNMSLIDGNHVRVDRACPPRKKQKGHDDTHLYDPKRTVFMGNLPFDVKDEEVYQLFT</a:t>
              </a:r>
              <a:r>
                <a:rPr lang="en-US" sz="2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KSNLENSIEAVRVIRDPHLNIGKGIAYVLFKTREAANLVLKKGYLKL</a:t>
              </a:r>
              <a:r>
                <a:rPr lang="en-US" sz="2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RELRISRVKPDTPSKRKSNPSEAYSPAQKRLQKDKVVTPTPTGKANLSYQGVRASKSGDDKKTPYQKSSAQTKMRPRGSSSNDNKKSGNNSASKERSQKRPAVAARKAKANAKGSKESGGKRFAGTKRKQENRTPESFSKKKKTKRF</a:t>
              </a:r>
              <a:endParaRPr lang="en-US" sz="2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5E99761C-C20B-496D-8541-DF8A826A28A9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85" t="11134" r="4534" b="11633"/>
            <a:stretch/>
          </p:blipFill>
          <p:spPr>
            <a:xfrm>
              <a:off x="681469" y="601928"/>
              <a:ext cx="8119631" cy="3531141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35320"/>
              <a:ext cx="8531951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5G46840.1: RNA-BINDING (RRM/RBD/RNP MOTIFS) family protein; 501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78176" y="123958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07737" y="1632108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96734" y="199893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08700" y="240490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76756" y="279619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47183" y="3155380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32212" y="3529695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398864" y="866282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31086" y="4035517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2119744" y="4028924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76222" y="204209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21286" y="4190349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23469" y="529769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54391" y="5034829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8A0873A-F8FD-4145-9021-3ACE4A37BAE7}"/>
                </a:ext>
              </a:extLst>
            </p:cNvPr>
            <p:cNvSpPr txBox="1"/>
            <p:nvPr/>
          </p:nvSpPr>
          <p:spPr>
            <a:xfrm>
              <a:off x="2524624" y="532007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1</a:t>
              </a:r>
            </a:p>
          </p:txBody>
        </p:sp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C2F98FBF-DA76-4FFF-A746-27A705A0BA3A}"/>
                </a:ext>
              </a:extLst>
            </p:cNvPr>
            <p:cNvSpPr/>
            <p:nvPr/>
          </p:nvSpPr>
          <p:spPr>
            <a:xfrm>
              <a:off x="1458026" y="5406262"/>
              <a:ext cx="114300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54310" y="4449116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25781" y="467232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50596" y="4932121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5602952" y="4762478"/>
              <a:ext cx="75895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6282416" y="4659925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5</a:t>
              </a:r>
            </a:p>
          </p:txBody>
        </p:sp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CBE04FC4-979A-4662-A436-AE5681E9E219}"/>
                </a:ext>
              </a:extLst>
            </p:cNvPr>
            <p:cNvSpPr/>
            <p:nvPr/>
          </p:nvSpPr>
          <p:spPr>
            <a:xfrm>
              <a:off x="5607479" y="4937267"/>
              <a:ext cx="74980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481294" y="505578"/>
              <a:ext cx="364731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62500" y="3922800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735876" y="403188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5337473" y="403038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6955979" y="402215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8551637" y="401886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351695" y="568796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046913" y="738073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FE471B8-E7E7-47BF-B010-F5B3A4A756BA}"/>
                </a:ext>
              </a:extLst>
            </p:cNvPr>
            <p:cNvSpPr txBox="1"/>
            <p:nvPr/>
          </p:nvSpPr>
          <p:spPr>
            <a:xfrm>
              <a:off x="3272839" y="3578018"/>
              <a:ext cx="3322033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RNA recognition motif (a.k.a. RRM, RBD, or RNP domain)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ABD697BB-8697-4648-B4E6-7DF716FC4E9D}"/>
                </a:ext>
              </a:extLst>
            </p:cNvPr>
            <p:cNvSpPr/>
            <p:nvPr/>
          </p:nvSpPr>
          <p:spPr>
            <a:xfrm>
              <a:off x="3483768" y="2877001"/>
              <a:ext cx="588169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07697D69-312F-4840-85A3-E0489BD099D4}"/>
                </a:ext>
              </a:extLst>
            </p:cNvPr>
            <p:cNvSpPr/>
            <p:nvPr/>
          </p:nvSpPr>
          <p:spPr>
            <a:xfrm>
              <a:off x="5262563" y="2876415"/>
              <a:ext cx="1143000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4105B84-FC93-47AE-A147-C23CEF4CFCB7}"/>
                </a:ext>
              </a:extLst>
            </p:cNvPr>
            <p:cNvSpPr/>
            <p:nvPr/>
          </p:nvSpPr>
          <p:spPr>
            <a:xfrm>
              <a:off x="765527" y="2879154"/>
              <a:ext cx="796651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1DFCF013-76C9-4770-8D69-AC1C25C8FB4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493B37-ECD6-0318-9387-716C95DECA50}"/>
              </a:ext>
            </a:extLst>
          </p:cNvPr>
          <p:cNvSpPr txBox="1"/>
          <p:nvPr/>
        </p:nvSpPr>
        <p:spPr>
          <a:xfrm>
            <a:off x="997662" y="6407314"/>
            <a:ext cx="79983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chemeClr val="bg1">
                    <a:lumMod val="50000"/>
                  </a:schemeClr>
                </a:solidFill>
              </a:rPr>
              <a:t>Only the LEA14 binding regions are also valid for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T5G46840.2 (364aa)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46B326D-FF96-C9E8-1FDB-853E30023EAF}"/>
              </a:ext>
            </a:extLst>
          </p:cNvPr>
          <p:cNvSpPr/>
          <p:nvPr/>
        </p:nvSpPr>
        <p:spPr>
          <a:xfrm>
            <a:off x="803775" y="6311099"/>
            <a:ext cx="2167128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8BCD52-251E-0882-F645-7ADE387271AD}"/>
              </a:ext>
            </a:extLst>
          </p:cNvPr>
          <p:cNvSpPr txBox="1"/>
          <p:nvPr/>
        </p:nvSpPr>
        <p:spPr>
          <a:xfrm>
            <a:off x="496734" y="6040541"/>
            <a:ext cx="3121688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137 aa deletion 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92045664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1">
            <a:extLst>
              <a:ext uri="{FF2B5EF4-FFF2-40B4-BE49-F238E27FC236}">
                <a16:creationId xmlns:a16="http://schemas.microsoft.com/office/drawing/2014/main" id="{C8E0F42B-9D4F-83FE-849E-74C4D66E38C8}"/>
              </a:ext>
            </a:extLst>
          </p:cNvPr>
          <p:cNvSpPr txBox="1"/>
          <p:nvPr/>
        </p:nvSpPr>
        <p:spPr>
          <a:xfrm>
            <a:off x="655400" y="3396594"/>
            <a:ext cx="8840292" cy="2371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SEKKGRKEEVITREYTINLHRRLHKCTFKKKAP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AIKEIRKFAEKAMGTKDVRVD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VKLN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QIWSKGIRGPPRR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IRVRVARKRNDDEDA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900" kern="1200" dirty="0">
                <a:solidFill>
                  <a:srgbClr val="000000"/>
                </a:solidFill>
                <a:effectLst/>
                <a:highlight>
                  <a:srgbClr val="00FF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EFFSLVTVAEIPAEGLSGLGTKVIEEED</a:t>
            </a:r>
            <a:endParaRPr lang="en-US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520795D-076C-404C-A66E-5AB117684409}"/>
              </a:ext>
            </a:extLst>
          </p:cNvPr>
          <p:cNvGrpSpPr/>
          <p:nvPr/>
        </p:nvGrpSpPr>
        <p:grpSpPr>
          <a:xfrm>
            <a:off x="-63822" y="462436"/>
            <a:ext cx="10046021" cy="5429489"/>
            <a:chOff x="-63822" y="245860"/>
            <a:chExt cx="10046021" cy="5429489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EC917CE-5070-4B63-B7DA-4884983EA4D5}"/>
                </a:ext>
              </a:extLst>
            </p:cNvPr>
            <p:cNvSpPr txBox="1"/>
            <p:nvPr/>
          </p:nvSpPr>
          <p:spPr>
            <a:xfrm>
              <a:off x="636638" y="3382285"/>
              <a:ext cx="9345561" cy="23814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EKKGRKEEVITREYTINLHRRLHKCTFKKKAP</a:t>
              </a:r>
              <a:r>
                <a:rPr lang="en-US" sz="9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AIKEIRKFAEKAMGTKDVRVD</a:t>
              </a:r>
              <a:r>
                <a:rPr lang="en-US" sz="90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LN</a:t>
              </a:r>
              <a:r>
                <a:rPr lang="en-US" sz="9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QIWSKGIRGPPRR</a:t>
              </a:r>
              <a:r>
                <a:rPr lang="en-US" sz="90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RVRVARKRNDDEDAKEEFFSLVTVAEIPAEGLSGLGTKVIEEED</a:t>
              </a:r>
              <a:endPara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177F2BE-7798-442C-9C7F-213FF212C928}"/>
                </a:ext>
              </a:extLst>
            </p:cNvPr>
            <p:cNvSpPr txBox="1"/>
            <p:nvPr/>
          </p:nvSpPr>
          <p:spPr>
            <a:xfrm>
              <a:off x="638223" y="3235607"/>
              <a:ext cx="9343976" cy="23814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EKKGRKE</a:t>
              </a:r>
              <a:r>
                <a:rPr lang="en-US" sz="90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VITREYTINLHRRLHKCTFKKKAPKAIKEIRKFAEKAMGTKDVRVDVKLNKQIWSKGIRGPPRRIRVRVARKRNDDEDAKE</a:t>
              </a:r>
              <a:r>
                <a:rPr lang="en-US" sz="90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FFSLVTVAEIPAEGLSGLGTKVIEEED</a:t>
              </a:r>
              <a:endPara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 descr="Chart&#10;&#10;Description automatically generated">
              <a:extLst>
                <a:ext uri="{FF2B5EF4-FFF2-40B4-BE49-F238E27FC236}">
                  <a16:creationId xmlns:a16="http://schemas.microsoft.com/office/drawing/2014/main" id="{51E57E67-AC79-48D7-B26E-EECEC966C52A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38" t="10665" r="4219" b="11835"/>
            <a:stretch/>
          </p:blipFill>
          <p:spPr>
            <a:xfrm>
              <a:off x="647666" y="561581"/>
              <a:ext cx="8315359" cy="3543300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45860"/>
              <a:ext cx="7322774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5G56710.1: RIBOSOMAL PROTEIN L31E family protein; 119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26901" y="95383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75918" y="145072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45662" y="192273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57628" y="2423951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25684" y="292001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96111" y="3412555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90462" y="3882120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367045" y="475757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599267" y="400734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849191" y="4000755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08244" y="204209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93836" y="4153469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34117" y="543012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09339" y="5097127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4555333" y="5473286"/>
              <a:ext cx="429768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8783328" y="5377894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08032" y="4426128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-5713" y="4608052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37208" y="495837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3047523" y="4801320"/>
              <a:ext cx="273405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5713265" y="4702761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723542" y="4983416"/>
              <a:ext cx="2395728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3235910" y="4003715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4618025" y="4002414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5997188" y="3994190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7345599" y="4009947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84696" y="556557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79914" y="725834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63E4C85-0EDB-48DC-A06D-E9B9F1F0F306}"/>
                </a:ext>
              </a:extLst>
            </p:cNvPr>
            <p:cNvSpPr txBox="1"/>
            <p:nvPr/>
          </p:nvSpPr>
          <p:spPr>
            <a:xfrm>
              <a:off x="2360499" y="3727675"/>
              <a:ext cx="331972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Ribosomal protein L31e family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A1E0355B-A4BF-4AA1-A6FA-EC7C2B2BF058}"/>
                </a:ext>
              </a:extLst>
            </p:cNvPr>
            <p:cNvSpPr/>
            <p:nvPr/>
          </p:nvSpPr>
          <p:spPr>
            <a:xfrm>
              <a:off x="1341592" y="3033954"/>
              <a:ext cx="5602906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7964FCDF-658A-4BD3-8B44-60FC3521D37E}"/>
                </a:ext>
              </a:extLst>
            </p:cNvPr>
            <p:cNvSpPr/>
            <p:nvPr/>
          </p:nvSpPr>
          <p:spPr>
            <a:xfrm>
              <a:off x="720283" y="3036318"/>
              <a:ext cx="8137967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4DBFE623-12E9-4DDA-AAC9-7B3A3AB9E2A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589364-8F75-8114-8372-A2E206D8DF30}"/>
              </a:ext>
            </a:extLst>
          </p:cNvPr>
          <p:cNvSpPr txBox="1"/>
          <p:nvPr/>
        </p:nvSpPr>
        <p:spPr>
          <a:xfrm>
            <a:off x="997662" y="6407314"/>
            <a:ext cx="79983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chemeClr val="bg1">
                    <a:lumMod val="50000"/>
                  </a:schemeClr>
                </a:solidFill>
              </a:rPr>
              <a:t>Only the LEA14 binding regions are also valid for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T5G56710.2 (85aa).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E16111C-1D64-1376-1E06-B171B61319DB}"/>
              </a:ext>
            </a:extLst>
          </p:cNvPr>
          <p:cNvSpPr/>
          <p:nvPr/>
        </p:nvSpPr>
        <p:spPr>
          <a:xfrm>
            <a:off x="4586097" y="6302306"/>
            <a:ext cx="2295144" cy="109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DAC776-93CC-A88A-8AAB-34FA30EC82CF}"/>
              </a:ext>
            </a:extLst>
          </p:cNvPr>
          <p:cNvSpPr txBox="1"/>
          <p:nvPr/>
        </p:nvSpPr>
        <p:spPr>
          <a:xfrm>
            <a:off x="4165426" y="6054715"/>
            <a:ext cx="3035126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dirty="0">
                <a:solidFill>
                  <a:schemeClr val="bg1">
                    <a:lumMod val="50000"/>
                  </a:schemeClr>
                </a:solidFill>
              </a:rPr>
              <a:t>34 aa deletion  due to alternative splicing</a:t>
            </a:r>
          </a:p>
        </p:txBody>
      </p:sp>
    </p:spTree>
    <p:extLst>
      <p:ext uri="{BB962C8B-B14F-4D97-AF65-F5344CB8AC3E}">
        <p14:creationId xmlns:p14="http://schemas.microsoft.com/office/powerpoint/2010/main" val="412425369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444C06AB-C291-4B5D-BC52-288364EE6C71}"/>
              </a:ext>
            </a:extLst>
          </p:cNvPr>
          <p:cNvGrpSpPr/>
          <p:nvPr/>
        </p:nvGrpSpPr>
        <p:grpSpPr>
          <a:xfrm>
            <a:off x="-48122" y="231132"/>
            <a:ext cx="10268413" cy="5569534"/>
            <a:chOff x="-48122" y="231132"/>
            <a:chExt cx="10268413" cy="5569534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A911513-FB49-447D-9C97-6309B5397866}"/>
                </a:ext>
              </a:extLst>
            </p:cNvPr>
            <p:cNvSpPr txBox="1"/>
            <p:nvPr/>
          </p:nvSpPr>
          <p:spPr>
            <a:xfrm>
              <a:off x="711318" y="2945199"/>
              <a:ext cx="9508973" cy="1328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EILHIQGGQCGNQIGAKFWEVVCAEHGIDPTGRYTGDSDLQLERINVYYNEASCGRFVPRAVLMDLEPGTMDSLRSGPYGQTFRPDNFVFGQSGAGNNWAKGHYTEGAELIDSVLDVVRKEAENCDCLQGFQVCHSLGGGTGSGMGTLLISKIREEYPDRMMLTFSVFPSPKVSDTVVEPYNATLSVHQLVENADECMVLDNEALYDICFRTLKLTTPSFGDLNHLISA</a:t>
              </a:r>
              <a:r>
                <a:rPr lang="en-US" sz="2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MSGVTCCLRFPGQLNSDLRKLAVNLIPFPRLHFFMVGFAPLTSRGSQQYRSLTVPELT</a:t>
              </a:r>
              <a:r>
                <a:rPr lang="en-US" sz="2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Q</a:t>
              </a:r>
              <a:r>
                <a:rPr lang="en-US" sz="2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2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W</a:t>
              </a:r>
              <a:r>
                <a:rPr lang="en-US" sz="2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SKNMMCAADPRHGRYLTASAMFRGKMSTKEVDEQMLNVQNKNSS</a:t>
              </a:r>
              <a:r>
                <a:rPr lang="en-US" sz="23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YFVEWIP</a:t>
              </a:r>
              <a:r>
                <a:rPr lang="en-US" sz="2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NVKSTVCDIPPTGLKMASTFIGNSTSIQEMFRRVSEQFTAMFRRKAFLHWYTGEG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DEMEFTEAESNMNDLVSEYQQYQDATADEEGDYEDEEEGEYQQEEEY</a:t>
              </a:r>
              <a:endParaRPr lang="en-US" sz="2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0004866-D929-40AF-914F-C1E499EA7FD5}"/>
                </a:ext>
              </a:extLst>
            </p:cNvPr>
            <p:cNvSpPr txBox="1"/>
            <p:nvPr/>
          </p:nvSpPr>
          <p:spPr>
            <a:xfrm>
              <a:off x="712445" y="3114757"/>
              <a:ext cx="8686800" cy="16754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</a:t>
              </a:r>
              <a:r>
                <a:rPr lang="en-US" sz="2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ILHIQGGQCGNQIGAKFWEVVCAEHGIDPTGRYTGDSDLQLERINVYYNEASCGRFVPRAVLMDLEPGTMDSLRSGPYGQTFRPDNFVFGQSGAGNNWAKGHYTEGAELIDSVLDVVRKEAENCDCLQGFQVCHSLGGGTGSGMGTLLISKIREEYPDRMMLTFSVFPSPKVSDTVVEPYNATLSVHQLVENADECMVLDNEALYDIC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RTLKLTTPSFGDLNHLISATMSGVTCCLRFPGQLNSDLRKLAVNLIPF</a:t>
              </a:r>
              <a:r>
                <a:rPr lang="en-US" sz="2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LHFFMVGFAPLTSRGSQQYRSLTVPELTQQMWDSKNMMCAADPRHGRYLTASAMFRGKMSTKEVDEQMLNVQNKNSSYFVEWIPNNVKSTVCDIPPTGLKMASTFIGNSTSIQEMFRRVS</a:t>
              </a:r>
              <a:r>
                <a:rPr lang="en-US" sz="2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QFTAMFRRKAFLHWYTGEGMDEMEFTEAESNMNDLVSEYQQYQDATADEEGDYEDEEEGEYQQEEEY</a:t>
              </a:r>
              <a:endParaRPr lang="en-US" sz="2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773F636C-C7CA-471D-A847-C06A08FD0697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08" t="11061" r="4510" b="11925"/>
            <a:stretch/>
          </p:blipFill>
          <p:spPr>
            <a:xfrm>
              <a:off x="711355" y="596557"/>
              <a:ext cx="8030129" cy="3521117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48122" y="231132"/>
              <a:ext cx="5496441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5G62700: TUBULIN BETA CHAIN 3; 450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85146" y="90491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19045" y="132186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515315" y="178528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18735" y="2208349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29521" y="2642370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82856" y="3052834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75249" y="3495517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420108" y="489171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67941" y="4020795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456566" y="4031288"/>
              <a:ext cx="357790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66176" y="2195854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08961" y="4183140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221228" y="520774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221135" y="544780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5902242" y="5361957"/>
              <a:ext cx="192024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76960ACD-A54D-4697-BC7F-7550072E877B}"/>
                </a:ext>
              </a:extLst>
            </p:cNvPr>
            <p:cNvSpPr/>
            <p:nvPr/>
          </p:nvSpPr>
          <p:spPr>
            <a:xfrm>
              <a:off x="4836251" y="5690938"/>
              <a:ext cx="111556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80889" y="4994314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7736434" y="5438752"/>
              <a:ext cx="617477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00+</a:t>
              </a:r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B6C7952F-CBF3-43EE-87BC-2A1429C154B5}"/>
                </a:ext>
              </a:extLst>
            </p:cNvPr>
            <p:cNvSpPr/>
            <p:nvPr/>
          </p:nvSpPr>
          <p:spPr>
            <a:xfrm>
              <a:off x="5919345" y="5527768"/>
              <a:ext cx="190195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82241" y="4369995"/>
              <a:ext cx="438094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221602" y="459638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221415" y="480500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4837220" y="4688410"/>
              <a:ext cx="1883664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6643568" y="459438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</a:t>
              </a:r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5866729" y="4858133"/>
              <a:ext cx="978408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82263" y="3888622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311661" y="403424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188588" y="402570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4068184" y="403465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4938950" y="402194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5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5822671" y="402425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7580147" y="402060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286981" y="568849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982199" y="738126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BADE558-B38F-4EEF-B022-7A36EF490C79}"/>
                </a:ext>
              </a:extLst>
            </p:cNvPr>
            <p:cNvSpPr txBox="1"/>
            <p:nvPr/>
          </p:nvSpPr>
          <p:spPr>
            <a:xfrm>
              <a:off x="6697846" y="4024082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5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C9C7033-FF78-4D05-AF1A-7E99E8909239}"/>
                </a:ext>
              </a:extLst>
            </p:cNvPr>
            <p:cNvSpPr txBox="1"/>
            <p:nvPr/>
          </p:nvSpPr>
          <p:spPr>
            <a:xfrm>
              <a:off x="8427755" y="402288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5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EEB715D-041E-45BC-AFDE-A2B94D66126B}"/>
                </a:ext>
              </a:extLst>
            </p:cNvPr>
            <p:cNvSpPr txBox="1"/>
            <p:nvPr/>
          </p:nvSpPr>
          <p:spPr>
            <a:xfrm>
              <a:off x="1565803" y="3583186"/>
              <a:ext cx="2352603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Tubulin/</a:t>
              </a:r>
              <a:r>
                <a:rPr lang="en-US" dirty="0" err="1"/>
                <a:t>FtsZ</a:t>
              </a:r>
              <a:r>
                <a:rPr lang="en-US" dirty="0"/>
                <a:t> family, GTPase domain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4F66B5B6-171B-4BFC-A138-4CA377D08899}"/>
                </a:ext>
              </a:extLst>
            </p:cNvPr>
            <p:cNvSpPr/>
            <p:nvPr/>
          </p:nvSpPr>
          <p:spPr>
            <a:xfrm>
              <a:off x="838200" y="2737820"/>
              <a:ext cx="3650456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A696F9EF-45CD-46E4-A3DF-E6D1673EF665}"/>
                </a:ext>
              </a:extLst>
            </p:cNvPr>
            <p:cNvSpPr/>
            <p:nvPr/>
          </p:nvSpPr>
          <p:spPr>
            <a:xfrm>
              <a:off x="5343525" y="2747759"/>
              <a:ext cx="2131219" cy="10972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A68BF8F-A61E-48ED-880E-C0A96182F073}"/>
                </a:ext>
              </a:extLst>
            </p:cNvPr>
            <p:cNvSpPr txBox="1"/>
            <p:nvPr/>
          </p:nvSpPr>
          <p:spPr>
            <a:xfrm>
              <a:off x="5437469" y="3583236"/>
              <a:ext cx="2031484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Tubulin C-terminal domain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19779039-495D-42EB-97E9-B2E5BCE10333}"/>
                </a:ext>
              </a:extLst>
            </p:cNvPr>
            <p:cNvSpPr/>
            <p:nvPr/>
          </p:nvSpPr>
          <p:spPr>
            <a:xfrm>
              <a:off x="796482" y="2738661"/>
              <a:ext cx="7873649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F7B25DFD-4956-427B-9C3E-5558AB0D137C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9</a:t>
            </a:r>
          </a:p>
        </p:txBody>
      </p:sp>
    </p:spTree>
    <p:extLst>
      <p:ext uri="{BB962C8B-B14F-4D97-AF65-F5344CB8AC3E}">
        <p14:creationId xmlns:p14="http://schemas.microsoft.com/office/powerpoint/2010/main" val="13332926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>
            <a:extLst>
              <a:ext uri="{FF2B5EF4-FFF2-40B4-BE49-F238E27FC236}">
                <a16:creationId xmlns:a16="http://schemas.microsoft.com/office/drawing/2014/main" id="{7B3C1819-089C-4D13-8629-67E11F1D3289}"/>
              </a:ext>
            </a:extLst>
          </p:cNvPr>
          <p:cNvGrpSpPr/>
          <p:nvPr/>
        </p:nvGrpSpPr>
        <p:grpSpPr>
          <a:xfrm>
            <a:off x="2185851" y="770438"/>
            <a:ext cx="6886570" cy="5713766"/>
            <a:chOff x="2185851" y="418013"/>
            <a:chExt cx="6886570" cy="571376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761AC2A-C953-4E5D-B7FF-9D75693270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283"/>
            <a:stretch/>
          </p:blipFill>
          <p:spPr>
            <a:xfrm>
              <a:off x="2214421" y="2335309"/>
              <a:ext cx="6858000" cy="1806024"/>
            </a:xfrm>
            <a:prstGeom prst="rect">
              <a:avLst/>
            </a:prstGeom>
          </p:spPr>
        </p:pic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3D0CCB49-FF49-466B-AF19-3ABE365CA877}"/>
                </a:ext>
              </a:extLst>
            </p:cNvPr>
            <p:cNvCxnSpPr/>
            <p:nvPr/>
          </p:nvCxnSpPr>
          <p:spPr>
            <a:xfrm>
              <a:off x="2671233" y="4141334"/>
              <a:ext cx="159944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C85F54-90DB-469C-82DE-0FADD8E4F967}"/>
                </a:ext>
              </a:extLst>
            </p:cNvPr>
            <p:cNvSpPr txBox="1"/>
            <p:nvPr/>
          </p:nvSpPr>
          <p:spPr>
            <a:xfrm>
              <a:off x="2552898" y="3836504"/>
              <a:ext cx="1812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nd forward rea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AF10299-528B-4460-975D-04DA477078D7}"/>
                </a:ext>
              </a:extLst>
            </p:cNvPr>
            <p:cNvSpPr txBox="1"/>
            <p:nvPr/>
          </p:nvSpPr>
          <p:spPr>
            <a:xfrm>
              <a:off x="7310977" y="3836504"/>
              <a:ext cx="17614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nd reverse read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3CC9088E-E86E-4917-B0C9-4AD18459E93C}"/>
                </a:ext>
              </a:extLst>
            </p:cNvPr>
            <p:cNvCxnSpPr/>
            <p:nvPr/>
          </p:nvCxnSpPr>
          <p:spPr>
            <a:xfrm rot="10800000">
              <a:off x="7682412" y="4145826"/>
              <a:ext cx="128016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8711C5E4-39F4-4B58-894E-7138AE28E350}"/>
                </a:ext>
              </a:extLst>
            </p:cNvPr>
            <p:cNvGrpSpPr/>
            <p:nvPr/>
          </p:nvGrpSpPr>
          <p:grpSpPr>
            <a:xfrm>
              <a:off x="2185851" y="4325754"/>
              <a:ext cx="6858000" cy="1806025"/>
              <a:chOff x="2185851" y="4229955"/>
              <a:chExt cx="6858000" cy="1806025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E123E8A3-A97E-46EA-A494-93224C95A9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283"/>
              <a:stretch/>
            </p:blipFill>
            <p:spPr>
              <a:xfrm>
                <a:off x="2185851" y="4229955"/>
                <a:ext cx="6858000" cy="1806025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60FC2585-F673-4115-B9B8-EEAE42C26A96}"/>
                  </a:ext>
                </a:extLst>
              </p:cNvPr>
              <p:cNvSpPr/>
              <p:nvPr/>
            </p:nvSpPr>
            <p:spPr>
              <a:xfrm>
                <a:off x="8760821" y="4238657"/>
                <a:ext cx="192215" cy="154844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941050B7-2A14-45C4-B2E7-E1951455088C}"/>
                </a:ext>
              </a:extLst>
            </p:cNvPr>
            <p:cNvGrpSpPr/>
            <p:nvPr/>
          </p:nvGrpSpPr>
          <p:grpSpPr>
            <a:xfrm>
              <a:off x="2206635" y="418013"/>
              <a:ext cx="6858000" cy="1878786"/>
              <a:chOff x="20784" y="468124"/>
              <a:chExt cx="6858000" cy="1878786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9C7B1E8-BA2D-40BC-AFAB-3115C4FCB907}"/>
                  </a:ext>
                </a:extLst>
              </p:cNvPr>
              <p:cNvGrpSpPr/>
              <p:nvPr/>
            </p:nvGrpSpPr>
            <p:grpSpPr>
              <a:xfrm>
                <a:off x="20784" y="468124"/>
                <a:ext cx="6858000" cy="1797419"/>
                <a:chOff x="0" y="4354613"/>
                <a:chExt cx="6858000" cy="1797419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18FDAA99-DDE8-4E9E-9F5E-3621F0A7FF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0663"/>
                <a:stretch/>
              </p:blipFill>
              <p:spPr>
                <a:xfrm>
                  <a:off x="0" y="4354613"/>
                  <a:ext cx="6858000" cy="1797419"/>
                </a:xfrm>
                <a:prstGeom prst="rect">
                  <a:avLst/>
                </a:prstGeom>
              </p:spPr>
            </p:pic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296BFA9C-AE77-4B00-B4F8-A9C6185BC6D5}"/>
                    </a:ext>
                  </a:extLst>
                </p:cNvPr>
                <p:cNvSpPr/>
                <p:nvPr/>
              </p:nvSpPr>
              <p:spPr>
                <a:xfrm>
                  <a:off x="2356609" y="5087496"/>
                  <a:ext cx="146304" cy="825192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7D497BE2-6EE4-4EA9-963B-2339CD2FD80E}"/>
                    </a:ext>
                  </a:extLst>
                </p:cNvPr>
                <p:cNvSpPr/>
                <p:nvPr/>
              </p:nvSpPr>
              <p:spPr>
                <a:xfrm>
                  <a:off x="2500517" y="5048921"/>
                  <a:ext cx="155448" cy="865723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678439CE-87EC-48BC-BFF9-7E82BEC4BDD9}"/>
                    </a:ext>
                  </a:extLst>
                </p:cNvPr>
                <p:cNvSpPr/>
                <p:nvPr/>
              </p:nvSpPr>
              <p:spPr>
                <a:xfrm>
                  <a:off x="2211215" y="5049502"/>
                  <a:ext cx="146304" cy="865723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A2D42ECF-D14C-4EBF-B9B3-86B065DADA4C}"/>
                    </a:ext>
                  </a:extLst>
                </p:cNvPr>
                <p:cNvSpPr/>
                <p:nvPr/>
              </p:nvSpPr>
              <p:spPr>
                <a:xfrm>
                  <a:off x="2064043" y="5088079"/>
                  <a:ext cx="146304" cy="825192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77CE68FE-9918-4955-8BB8-3650E8A28678}"/>
                    </a:ext>
                  </a:extLst>
                </p:cNvPr>
                <p:cNvSpPr/>
                <p:nvPr/>
              </p:nvSpPr>
              <p:spPr>
                <a:xfrm>
                  <a:off x="1772972" y="5090142"/>
                  <a:ext cx="146304" cy="825192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CDB40282-A403-4928-8E78-40AE4AB8B6F1}"/>
                    </a:ext>
                  </a:extLst>
                </p:cNvPr>
                <p:cNvSpPr/>
                <p:nvPr/>
              </p:nvSpPr>
              <p:spPr>
                <a:xfrm>
                  <a:off x="1918631" y="5050083"/>
                  <a:ext cx="146304" cy="865723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AB8AE09B-5484-4DEE-B9B9-312538829DA2}"/>
                    </a:ext>
                  </a:extLst>
                </p:cNvPr>
                <p:cNvSpPr/>
                <p:nvPr/>
              </p:nvSpPr>
              <p:spPr>
                <a:xfrm>
                  <a:off x="1623498" y="5047397"/>
                  <a:ext cx="148598" cy="865723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9900CC"/>
                    </a:solidFill>
                  </a:endParaRP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959E3717-A8F0-4C85-B512-7351E5B096E9}"/>
                    </a:ext>
                  </a:extLst>
                </p:cNvPr>
                <p:cNvSpPr txBox="1"/>
                <p:nvPr/>
              </p:nvSpPr>
              <p:spPr>
                <a:xfrm>
                  <a:off x="1500661" y="4752972"/>
                  <a:ext cx="38664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M</a:t>
                  </a:r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2BCD09BA-4D45-4E1D-A88D-1E6622375646}"/>
                    </a:ext>
                  </a:extLst>
                </p:cNvPr>
                <p:cNvSpPr/>
                <p:nvPr/>
              </p:nvSpPr>
              <p:spPr>
                <a:xfrm>
                  <a:off x="1700739" y="4753118"/>
                  <a:ext cx="28245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L</a:t>
                  </a:r>
                  <a:endParaRPr lang="en-US" b="1" dirty="0"/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804BE821-B059-4605-B186-CEC65BDFAE60}"/>
                    </a:ext>
                  </a:extLst>
                </p:cNvPr>
                <p:cNvSpPr/>
                <p:nvPr/>
              </p:nvSpPr>
              <p:spPr>
                <a:xfrm>
                  <a:off x="1827886" y="4755361"/>
                  <a:ext cx="33054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G</a:t>
                  </a:r>
                  <a:endParaRPr lang="en-US" b="1" dirty="0"/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BB90377D-F6DE-4C1C-9656-9C82649EF07C}"/>
                    </a:ext>
                  </a:extLst>
                </p:cNvPr>
                <p:cNvSpPr/>
                <p:nvPr/>
              </p:nvSpPr>
              <p:spPr>
                <a:xfrm>
                  <a:off x="1986008" y="4759576"/>
                  <a:ext cx="33054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D</a:t>
                  </a:r>
                  <a:endParaRPr lang="en-US" b="1" dirty="0"/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0602A7AE-297F-409D-B6E7-E601A674DC68}"/>
                    </a:ext>
                  </a:extLst>
                </p:cNvPr>
                <p:cNvSpPr/>
                <p:nvPr/>
              </p:nvSpPr>
              <p:spPr>
                <a:xfrm>
                  <a:off x="2147695" y="4759576"/>
                  <a:ext cx="308098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P</a:t>
                  </a:r>
                  <a:endParaRPr lang="en-US" b="1" dirty="0"/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917D74EA-8E38-4A43-94D9-DD9783EFD721}"/>
                    </a:ext>
                  </a:extLst>
                </p:cNvPr>
                <p:cNvSpPr/>
                <p:nvPr/>
              </p:nvSpPr>
              <p:spPr>
                <a:xfrm>
                  <a:off x="2278322" y="4759001"/>
                  <a:ext cx="333746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N</a:t>
                  </a:r>
                  <a:endParaRPr lang="en-US" b="1" dirty="0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87B7DCA9-61B2-45F0-B305-4B167368DBC7}"/>
                    </a:ext>
                  </a:extLst>
                </p:cNvPr>
                <p:cNvSpPr/>
                <p:nvPr/>
              </p:nvSpPr>
              <p:spPr>
                <a:xfrm>
                  <a:off x="2448800" y="4764646"/>
                  <a:ext cx="29367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S</a:t>
                  </a:r>
                  <a:endParaRPr lang="en-US" b="1" dirty="0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A651A93C-EF32-4FBD-97D7-F2BB2DDF3992}"/>
                    </a:ext>
                  </a:extLst>
                </p:cNvPr>
                <p:cNvSpPr/>
                <p:nvPr/>
              </p:nvSpPr>
              <p:spPr>
                <a:xfrm>
                  <a:off x="2655965" y="5089670"/>
                  <a:ext cx="149284" cy="825192"/>
                </a:xfrm>
                <a:prstGeom prst="rect">
                  <a:avLst/>
                </a:prstGeom>
                <a:noFill/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F250E03C-9907-4A16-8483-22003D8A3914}"/>
                    </a:ext>
                  </a:extLst>
                </p:cNvPr>
                <p:cNvSpPr/>
                <p:nvPr/>
              </p:nvSpPr>
              <p:spPr>
                <a:xfrm>
                  <a:off x="2581052" y="4764071"/>
                  <a:ext cx="29367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>
                      <a:solidFill>
                        <a:srgbClr val="7030A0"/>
                      </a:solidFill>
                    </a:rPr>
                    <a:t>S</a:t>
                  </a:r>
                  <a:endParaRPr lang="en-US" b="1" dirty="0"/>
                </a:p>
              </p:txBody>
            </p:sp>
          </p:grp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98F82739-91BF-4368-953C-1B05E1A8A2A4}"/>
                  </a:ext>
                </a:extLst>
              </p:cNvPr>
              <p:cNvSpPr/>
              <p:nvPr/>
            </p:nvSpPr>
            <p:spPr>
              <a:xfrm>
                <a:off x="2332261" y="1200340"/>
                <a:ext cx="297367" cy="89231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2273FB7-A1AF-4C1C-AB13-BF20F19E34DE}"/>
                  </a:ext>
                </a:extLst>
              </p:cNvPr>
              <p:cNvSpPr txBox="1"/>
              <p:nvPr/>
            </p:nvSpPr>
            <p:spPr>
              <a:xfrm>
                <a:off x="2185824" y="2039133"/>
                <a:ext cx="58150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EcoRI</a:t>
                </a:r>
                <a:endParaRPr lang="en-US" sz="1400" dirty="0"/>
              </a:p>
            </p:txBody>
          </p:sp>
        </p:grp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4CF84AF8-1891-4501-8B0D-E9B9056EE55E}"/>
              </a:ext>
            </a:extLst>
          </p:cNvPr>
          <p:cNvSpPr txBox="1"/>
          <p:nvPr/>
        </p:nvSpPr>
        <p:spPr>
          <a:xfrm>
            <a:off x="-68263" y="52333"/>
            <a:ext cx="2462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E03D013-553B-4FAB-9594-9AC4AFC2AD17}"/>
              </a:ext>
            </a:extLst>
          </p:cNvPr>
          <p:cNvSpPr txBox="1"/>
          <p:nvPr/>
        </p:nvSpPr>
        <p:spPr>
          <a:xfrm>
            <a:off x="-90804" y="2824259"/>
            <a:ext cx="218585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Mapping over a gap using the paired end reads. The forward read matches the reverse read (AT5G62690).</a:t>
            </a:r>
          </a:p>
        </p:txBody>
      </p:sp>
    </p:spTree>
    <p:extLst>
      <p:ext uri="{BB962C8B-B14F-4D97-AF65-F5344CB8AC3E}">
        <p14:creationId xmlns:p14="http://schemas.microsoft.com/office/powerpoint/2010/main" val="2462372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64AFE386-EF6A-482A-99A9-08555228AFEC}"/>
              </a:ext>
            </a:extLst>
          </p:cNvPr>
          <p:cNvGrpSpPr/>
          <p:nvPr/>
        </p:nvGrpSpPr>
        <p:grpSpPr>
          <a:xfrm>
            <a:off x="-53465" y="274484"/>
            <a:ext cx="9174639" cy="5757758"/>
            <a:chOff x="-53465" y="274484"/>
            <a:chExt cx="9174639" cy="5757758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FDCCACB-0058-4E05-83E9-639CD68D1F7C}"/>
                </a:ext>
              </a:extLst>
            </p:cNvPr>
            <p:cNvSpPr txBox="1"/>
            <p:nvPr/>
          </p:nvSpPr>
          <p:spPr>
            <a:xfrm>
              <a:off x="497540" y="3092159"/>
              <a:ext cx="8623634" cy="1166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QANEKEEEERHEEAAGEKESFEESKEKAAEMSRKEKRKAMKKLKRKQVRKEIAAKEREEAKAKLNDPAEQERLKAIEEEDARRREKELKDFEESERAWREAMEIKRKKEEEEEAKREEEERRWKDLEELRKLEASGNDECGEDEDGEYEYIEEGPPEIIFQGNEIILKKNKVRVPKKSVVQVDGHESSNAEFVLQISDRPTSNPLPPGSEASANYQNVSSAQQILESVAQEVPNFGTEQDKA</a:t>
              </a:r>
              <a:r>
                <a:rPr lang="en-US" sz="1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HCPFHLKTGACRFGQRCSRVH</a:t>
              </a: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YPNKSCTLLMKNMYNGPGITWEQDEGLEYTDEEAELCYEEFYEDVHTEFLKYGELVNFKVCRNGSFHLKGNVYVHYRSLESAILAYQSINGRYFAGKQ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</a:t>
              </a:r>
              <a:r>
                <a:rPr lang="en-US" sz="15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FVNISR</a:t>
              </a:r>
              <a:r>
                <a:rPr lang="en-US" sz="15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WKVAICGEYMKSRLKTCSRGSACNFIHC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RNPGGDYEW</a:t>
              </a:r>
              <a:r>
                <a:rPr lang="en-US" sz="1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15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HDRPPPRFWIHKMTSLFGYSDEKHMEHESSGSLNDSISDLSTDS</a:t>
              </a:r>
              <a:r>
                <a:rPr lang="en-US" sz="15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HRQPSRRSRSRDHDHANVG</a:t>
              </a:r>
              <a:r>
                <a:rPr lang="en-US" sz="15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PSYRSRKYHGDTQDSTREDKLRRHAENCHDGDDSPSRDGSLEREMYKERRYAKDTLHRDSRWSEHSPGHRVG</a:t>
              </a: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KRIHGRYSDDDSADGDDYGRRGTGHKRKPRRGTDSGVQEQMDNE</a:t>
              </a:r>
              <a:r>
                <a:rPr lang="en-US" sz="15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DRKTHRSSRKHSREGSSADKEEGHEHDRVHTVSDKSHRERSKHRHERSSSRYSHEED</a:t>
              </a:r>
              <a:r>
                <a:rPr lang="en-US" sz="15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ESRHHQHKESDKKRSVETSPVGYQSDKDRDRSKQRQRYKSDDPESDQSRKGKRQSEENSDRETHKERRHRHRKRRRTQNSDDQNPKESEEVEEEIERWRPV</a:t>
              </a:r>
              <a:endParaRPr lang="en-US" sz="1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Picture 6" descr="Chart&#10;&#10;Description automatically generated">
              <a:extLst>
                <a:ext uri="{FF2B5EF4-FFF2-40B4-BE49-F238E27FC236}">
                  <a16:creationId xmlns:a16="http://schemas.microsoft.com/office/drawing/2014/main" id="{36AC6EC6-6B65-442C-806A-79A0793BD2B2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94" t="10280" r="4600" b="11862"/>
            <a:stretch/>
          </p:blipFill>
          <p:spPr>
            <a:xfrm>
              <a:off x="531864" y="680318"/>
              <a:ext cx="8550224" cy="3559519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3465" y="274484"/>
              <a:ext cx="824039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1G10320.1: ZINC FINGER C-X8-C-X5-C-X3-H TYPE family protein; 757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279817" y="135705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218202" y="173544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286839" y="212704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214753" y="2511746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282809" y="290303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174500" y="3278173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228537" y="3657804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219961" y="978443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436235" y="4177766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465089" y="4171173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730413" y="2327845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15397" y="4358890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58332" y="557121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59279" y="5734787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480924" y="5386745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6627307" y="5253510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02A03CD-01C2-4541-B492-31CED09EDF31}"/>
                </a:ext>
              </a:extLst>
            </p:cNvPr>
            <p:cNvSpPr txBox="1"/>
            <p:nvPr/>
          </p:nvSpPr>
          <p:spPr>
            <a:xfrm>
              <a:off x="7775985" y="557602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54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477571" y="4551972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86657" y="485117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50622" y="508020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C382A876-7E66-43CD-A500-32E846143E07}"/>
                </a:ext>
              </a:extLst>
            </p:cNvPr>
            <p:cNvSpPr txBox="1"/>
            <p:nvPr/>
          </p:nvSpPr>
          <p:spPr>
            <a:xfrm>
              <a:off x="5812214" y="4745071"/>
              <a:ext cx="445956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0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5818239" y="5087691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297979" y="607107"/>
              <a:ext cx="364731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167649" y="4029645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579792" y="417413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694100" y="417172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4802354" y="417413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933685" y="417615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7043648" y="4171725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8152394" y="417245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579388" y="699072"/>
              <a:ext cx="1495346" cy="338554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/>
            <a:p>
              <a:r>
                <a:rPr lang="en-US" sz="1600" dirty="0"/>
                <a:t> Hopp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274606" y="868349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4642203" y="5006316"/>
              <a:ext cx="1029935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9926488F-47A1-4B89-9827-8B3B6B81EF96}"/>
                </a:ext>
              </a:extLst>
            </p:cNvPr>
            <p:cNvSpPr/>
            <p:nvPr/>
          </p:nvSpPr>
          <p:spPr>
            <a:xfrm>
              <a:off x="4641056" y="4844639"/>
              <a:ext cx="124063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5171775" y="5347677"/>
              <a:ext cx="1543350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4AED5639-49BD-4483-8F91-1DDA9501014E}"/>
                </a:ext>
              </a:extLst>
            </p:cNvPr>
            <p:cNvSpPr/>
            <p:nvPr/>
          </p:nvSpPr>
          <p:spPr>
            <a:xfrm>
              <a:off x="5169393" y="5179519"/>
              <a:ext cx="72237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7212806" y="5671878"/>
              <a:ext cx="644801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EB6EF510-42DF-44BF-96A1-FA834FE792CF}"/>
                </a:ext>
              </a:extLst>
            </p:cNvPr>
            <p:cNvSpPr/>
            <p:nvPr/>
          </p:nvSpPr>
          <p:spPr>
            <a:xfrm>
              <a:off x="4645362" y="5817705"/>
              <a:ext cx="1248231" cy="106672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02973-08C1-4E5E-A15D-9FA13F5CFF6E}"/>
                </a:ext>
              </a:extLst>
            </p:cNvPr>
            <p:cNvSpPr txBox="1"/>
            <p:nvPr/>
          </p:nvSpPr>
          <p:spPr>
            <a:xfrm>
              <a:off x="1813590" y="3860126"/>
              <a:ext cx="51251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Zinc finger C-x8-C-x5-C-x3-H type (and similar) family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C9B1D0FC-D8EE-4061-B6A6-3AC305C0183D}"/>
                </a:ext>
              </a:extLst>
            </p:cNvPr>
            <p:cNvSpPr/>
            <p:nvPr/>
          </p:nvSpPr>
          <p:spPr>
            <a:xfrm>
              <a:off x="3301648" y="2999109"/>
              <a:ext cx="228600" cy="100584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5AECC96-2433-421C-A66D-DFE33556E446}"/>
                </a:ext>
              </a:extLst>
            </p:cNvPr>
            <p:cNvSpPr/>
            <p:nvPr/>
          </p:nvSpPr>
          <p:spPr>
            <a:xfrm>
              <a:off x="4747085" y="2999104"/>
              <a:ext cx="310689" cy="100584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EBDD78BA-B554-49C4-9A0D-566F0B9C6E6F}"/>
                </a:ext>
              </a:extLst>
            </p:cNvPr>
            <p:cNvSpPr/>
            <p:nvPr/>
          </p:nvSpPr>
          <p:spPr>
            <a:xfrm>
              <a:off x="583547" y="2995543"/>
              <a:ext cx="8431866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A90984A5-8C1B-4987-98C0-1ECF168BB59B}"/>
              </a:ext>
            </a:extLst>
          </p:cNvPr>
          <p:cNvSpPr txBox="1"/>
          <p:nvPr/>
        </p:nvSpPr>
        <p:spPr>
          <a:xfrm>
            <a:off x="0" y="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5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A9220D5-0F04-1B1E-34DF-F62AEE124DB6}"/>
              </a:ext>
            </a:extLst>
          </p:cNvPr>
          <p:cNvGrpSpPr/>
          <p:nvPr/>
        </p:nvGrpSpPr>
        <p:grpSpPr>
          <a:xfrm>
            <a:off x="497410" y="6135481"/>
            <a:ext cx="8666336" cy="646286"/>
            <a:chOff x="497410" y="6135481"/>
            <a:chExt cx="8666336" cy="646286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58EFF4B-9A43-4FB3-212C-899752F0C852}"/>
                </a:ext>
              </a:extLst>
            </p:cNvPr>
            <p:cNvSpPr txBox="1"/>
            <p:nvPr/>
          </p:nvSpPr>
          <p:spPr>
            <a:xfrm>
              <a:off x="497410" y="6443213"/>
              <a:ext cx="8666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>
                      <a:lumMod val="50000"/>
                    </a:schemeClr>
                  </a:solidFill>
                </a:rPr>
                <a:t>Binding regions are also valid for AT1G10320.2 (748 aa).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12B36F4-F3D9-8480-7B71-9B4A17706FC8}"/>
                </a:ext>
              </a:extLst>
            </p:cNvPr>
            <p:cNvSpPr/>
            <p:nvPr/>
          </p:nvSpPr>
          <p:spPr>
            <a:xfrm>
              <a:off x="2683599" y="6363250"/>
              <a:ext cx="91440" cy="106672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6130554-0DD2-68E9-957C-BB2529F276CB}"/>
                </a:ext>
              </a:extLst>
            </p:cNvPr>
            <p:cNvSpPr txBox="1"/>
            <p:nvPr/>
          </p:nvSpPr>
          <p:spPr>
            <a:xfrm>
              <a:off x="2585790" y="6135481"/>
              <a:ext cx="291009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bg1">
                      <a:lumMod val="50000"/>
                    </a:schemeClr>
                  </a:solidFill>
                </a:rPr>
                <a:t>9 aa deletion due to alternative splicin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5873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7CB55D8-A123-4402-A3CD-D6F0D8681620}"/>
              </a:ext>
            </a:extLst>
          </p:cNvPr>
          <p:cNvGrpSpPr/>
          <p:nvPr/>
        </p:nvGrpSpPr>
        <p:grpSpPr>
          <a:xfrm>
            <a:off x="-53465" y="295146"/>
            <a:ext cx="9516032" cy="5639109"/>
            <a:chOff x="-53465" y="295146"/>
            <a:chExt cx="9516032" cy="5639109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28DE82D-30E5-4BDD-8743-D28CBC8B514F}"/>
                </a:ext>
              </a:extLst>
            </p:cNvPr>
            <p:cNvSpPr txBox="1"/>
            <p:nvPr/>
          </p:nvSpPr>
          <p:spPr>
            <a:xfrm>
              <a:off x="660015" y="3094956"/>
              <a:ext cx="8587948" cy="1668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P</a:t>
              </a:r>
              <a:r>
                <a:rPr lang="en-US" sz="4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4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KRTPKVNRNPDLIRGVGKYSRSQMYHKRGLWAIKAKNGGVFPRHDAQPKVDAPVEKP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KFY</a:t>
              </a:r>
              <a:r>
                <a:rPr lang="en-US" sz="4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EDVKKPLVNRRKPKPTKLKA</a:t>
              </a:r>
              <a:r>
                <a:rPr lang="en-US" sz="46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TPGTV</a:t>
              </a:r>
              <a:r>
                <a:rPr lang="en-US" sz="4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IILAGRFKGKRVVFLKQLSSGLLLVTGPFK</a:t>
              </a:r>
              <a:r>
                <a:rPr lang="en-US" sz="46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GVPLRRVNQAYVIGTSTKIDISGVNTEKFDDKYFGKVAEKKKKKTEGEFFEAEKEEKKEIPQEKKEDQKTVDAALIKSIEAVPELKVYLGARFSLSQGMKPHELVF</a:t>
              </a:r>
              <a:endParaRPr lang="en-US" sz="46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4F37026-4CAE-438C-BE49-93C28B455AC1}"/>
                </a:ext>
              </a:extLst>
            </p:cNvPr>
            <p:cNvSpPr txBox="1"/>
            <p:nvPr/>
          </p:nvSpPr>
          <p:spPr>
            <a:xfrm>
              <a:off x="663899" y="3120808"/>
              <a:ext cx="8798668" cy="1668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P</a:t>
              </a:r>
              <a:r>
                <a:rPr lang="en-US" sz="4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46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4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TPKVNRNPDLIRGVGKYSRSQMYHKRGLWAIKAKN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GVFPRHDAQPKVDAPVEKPAKFY</a:t>
              </a:r>
              <a:r>
                <a:rPr lang="en-US" sz="46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EDVKKPLVNRRKPKPTKLKA</a:t>
              </a:r>
              <a:r>
                <a:rPr lang="en-US" sz="46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</a:t>
              </a:r>
              <a:r>
                <a:rPr lang="en-US" sz="46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TPGTV</a:t>
              </a:r>
              <a:r>
                <a:rPr lang="en-US" sz="46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IILAGRFKGKRVVFLKQLSSGLLLVTGPFKINGVPLRRVNQAYVIGTSTKIDISGVNTEKFDDKYFGKVAEKKKKKTEGEFFEAEKEEKKEIPQEKKEDQKTVDAALIKSIEAVPELKVYLGARFSLSQGMKPHELVF</a:t>
              </a:r>
              <a:endParaRPr lang="en-US" sz="46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36964FCB-0451-4C03-9DC1-D799C36566DE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02" t="10156" r="4782" b="11219"/>
            <a:stretch/>
          </p:blipFill>
          <p:spPr>
            <a:xfrm>
              <a:off x="723015" y="680787"/>
              <a:ext cx="8226239" cy="3557016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53465" y="295146"/>
              <a:ext cx="6901185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1G18540: RIBOSOMAL PROTEIN L6 family protein; 233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52161" y="1354671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401178" y="1719195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80447" y="209692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92413" y="2494352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60469" y="2885643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47988" y="3244831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06197" y="3619146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85A3D30-7297-4021-BD7F-87209A81379C}"/>
                </a:ext>
              </a:extLst>
            </p:cNvPr>
            <p:cNvSpPr txBox="1"/>
            <p:nvPr/>
          </p:nvSpPr>
          <p:spPr>
            <a:xfrm>
              <a:off x="392305" y="981371"/>
              <a:ext cx="515525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.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24527" y="4127332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4006489" y="4141344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592509" y="2302467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388632" y="4309838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B9FBE55-EBF6-4176-AC07-3C19B00016DD}"/>
                </a:ext>
              </a:extLst>
            </p:cNvPr>
            <p:cNvSpPr txBox="1"/>
            <p:nvPr/>
          </p:nvSpPr>
          <p:spPr>
            <a:xfrm>
              <a:off x="237356" y="5674612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48479" y="5382805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09CC5A8-CC0A-4C6F-A04A-94C489C61234}"/>
                </a:ext>
              </a:extLst>
            </p:cNvPr>
            <p:cNvSpPr txBox="1"/>
            <p:nvPr/>
          </p:nvSpPr>
          <p:spPr>
            <a:xfrm>
              <a:off x="3760175" y="5636800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50291" y="4579465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42728" y="4865193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208332" y="500884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3759391" y="5003117"/>
              <a:ext cx="359393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FE192AA-DF98-4E9C-91A0-3A8C462594B1}"/>
                </a:ext>
              </a:extLst>
            </p:cNvPr>
            <p:cNvSpPr txBox="1"/>
            <p:nvPr/>
          </p:nvSpPr>
          <p:spPr>
            <a:xfrm>
              <a:off x="465007" y="603575"/>
              <a:ext cx="364731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3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38849" y="4012251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7536452" y="413324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2293592" y="4130678"/>
              <a:ext cx="357790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758650" y="413576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2192688" y="4928524"/>
              <a:ext cx="184129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826969" y="5106730"/>
              <a:ext cx="2999232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826969" y="5287467"/>
              <a:ext cx="223113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2451F93B-2472-4E30-B102-3B07D2746539}"/>
                </a:ext>
              </a:extLst>
            </p:cNvPr>
            <p:cNvSpPr/>
            <p:nvPr/>
          </p:nvSpPr>
          <p:spPr>
            <a:xfrm>
              <a:off x="865407" y="5730189"/>
              <a:ext cx="2962656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80FE2C7-B455-4DE2-B0D1-A6D475F3F04B}"/>
                </a:ext>
              </a:extLst>
            </p:cNvPr>
            <p:cNvSpPr txBox="1"/>
            <p:nvPr/>
          </p:nvSpPr>
          <p:spPr>
            <a:xfrm>
              <a:off x="7500396" y="704593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600AC139-DD3A-4B04-9A8E-E87517C78753}"/>
                </a:ext>
              </a:extLst>
            </p:cNvPr>
            <p:cNvCxnSpPr>
              <a:cxnSpLocks/>
              <a:endCxn id="71" idx="1"/>
            </p:cNvCxnSpPr>
            <p:nvPr/>
          </p:nvCxnSpPr>
          <p:spPr>
            <a:xfrm>
              <a:off x="7195614" y="873870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FE877285-93E3-4375-9B30-B0C5EB35FD0D}"/>
                </a:ext>
              </a:extLst>
            </p:cNvPr>
            <p:cNvSpPr/>
            <p:nvPr/>
          </p:nvSpPr>
          <p:spPr>
            <a:xfrm>
              <a:off x="5121269" y="2987938"/>
              <a:ext cx="3772699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33D6C6B0-F13A-488E-92A8-6E1B6474E767}"/>
                </a:ext>
              </a:extLst>
            </p:cNvPr>
            <p:cNvSpPr/>
            <p:nvPr/>
          </p:nvSpPr>
          <p:spPr>
            <a:xfrm>
              <a:off x="859273" y="2987932"/>
              <a:ext cx="2022039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74510C2-F290-4E3E-83ED-6312D3DE3948}"/>
                </a:ext>
              </a:extLst>
            </p:cNvPr>
            <p:cNvSpPr/>
            <p:nvPr/>
          </p:nvSpPr>
          <p:spPr>
            <a:xfrm>
              <a:off x="745471" y="2983638"/>
              <a:ext cx="8155641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F154504-5EBB-4158-B4FC-CDA2D9D7CEF8}"/>
                </a:ext>
              </a:extLst>
            </p:cNvPr>
            <p:cNvSpPr txBox="1"/>
            <p:nvPr/>
          </p:nvSpPr>
          <p:spPr>
            <a:xfrm>
              <a:off x="6000691" y="3661399"/>
              <a:ext cx="1975415" cy="557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Ribosomal protein L6e family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C594F15-39DE-4864-8C62-2DF309811097}"/>
                </a:ext>
              </a:extLst>
            </p:cNvPr>
            <p:cNvSpPr txBox="1"/>
            <p:nvPr/>
          </p:nvSpPr>
          <p:spPr>
            <a:xfrm>
              <a:off x="927194" y="3425021"/>
              <a:ext cx="1753307" cy="788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Ribosomal protein L6, N-terminal family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EE0A6756-5843-4A88-9FBF-0E650E5578F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6</a:t>
            </a:r>
          </a:p>
        </p:txBody>
      </p:sp>
    </p:spTree>
    <p:extLst>
      <p:ext uri="{BB962C8B-B14F-4D97-AF65-F5344CB8AC3E}">
        <p14:creationId xmlns:p14="http://schemas.microsoft.com/office/powerpoint/2010/main" val="32357523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29D3594-32FC-4AAC-80C8-EDA9881BCE09}"/>
              </a:ext>
            </a:extLst>
          </p:cNvPr>
          <p:cNvGrpSpPr/>
          <p:nvPr/>
        </p:nvGrpSpPr>
        <p:grpSpPr>
          <a:xfrm>
            <a:off x="-63822" y="259896"/>
            <a:ext cx="10191635" cy="5457436"/>
            <a:chOff x="-63822" y="259896"/>
            <a:chExt cx="10191635" cy="545743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C1FD11A-BE8A-465D-AAAA-1CB9A8A1BD6A}"/>
                </a:ext>
              </a:extLst>
            </p:cNvPr>
            <p:cNvSpPr txBox="1"/>
            <p:nvPr/>
          </p:nvSpPr>
          <p:spPr>
            <a:xfrm>
              <a:off x="597595" y="2275009"/>
              <a:ext cx="9530218" cy="1717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9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49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GITL</a:t>
              </a:r>
              <a:r>
                <a:rPr lang="en-US" sz="49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DTVPNLEVETTHDKFKLHDYFANSWTVLFSHPGDFTPVCTTELGAMAKYAHEFDKRGVKLLGLSCDDVQSHKDWIKDIEAFNHGSKVNYPIIADPNKEIIPQLNMIDPIENGPSRALHIVGPDSKIK</a:t>
              </a:r>
              <a:r>
                <a:rPr lang="en-US" sz="49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SFLYPSTTGRNMDEVLRALDSLL</a:t>
              </a:r>
              <a:r>
                <a:rPr lang="en-US" sz="49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SKHNNKIATPVNWKPDQPVVISPAVSDEEAKKMFPQG</a:t>
              </a:r>
              <a:r>
                <a:rPr lang="en-US" sz="49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KTADLPSKKGYLRHTEVS</a:t>
              </a:r>
              <a:endParaRPr lang="en-US" sz="49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8A5ED95-C42D-4F86-B885-09B538D19197}"/>
                </a:ext>
              </a:extLst>
            </p:cNvPr>
            <p:cNvSpPr txBox="1"/>
            <p:nvPr/>
          </p:nvSpPr>
          <p:spPr>
            <a:xfrm>
              <a:off x="592879" y="2434325"/>
              <a:ext cx="9331398" cy="1717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49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49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GITLGDTVPNLE</a:t>
              </a:r>
              <a:r>
                <a:rPr lang="en-US" sz="49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ETTHDKFKLHDYFANSWTVLFSHPGDFTPVCT</a:t>
              </a:r>
              <a:r>
                <a:rPr lang="en-US" sz="49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49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ELGAMAKYAHEF</a:t>
              </a:r>
              <a:r>
                <a:rPr lang="en-US" sz="49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r>
                <a:rPr lang="en-US" sz="49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RGVKLLGLSCDDVQSHKDWIKDIEAFNHGSKVNYPI</a:t>
              </a:r>
              <a:r>
                <a:rPr lang="en-US" sz="49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49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DPN</a:t>
              </a:r>
              <a:r>
                <a:rPr lang="en-US" sz="49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KEIIPQLNMIDPIENGPSRALHIVGPDSKIKLSFLYPSTTGRNMDEVLRALDSLLMASKHNNKIATPVNWKPDQPVVISPAVSDEEAKKMFPQGFKTADLPSKKGYLRHTEVS</a:t>
              </a:r>
              <a:endParaRPr lang="en-US" sz="49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59896"/>
              <a:ext cx="6050439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AT1G48130: 1-CYSTEINE PEROXIREDOXIN 1; 216 amino acids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18768" y="598487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388512" y="1150698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310003" y="1739650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378059" y="2311415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248486" y="2899205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323787" y="3466025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551642" y="4170698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4250535" y="4175078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74919" y="2318323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394475" y="4343544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98949" y="5376505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507927" y="5169131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8A0873A-F8FD-4145-9021-3ACE4A37BAE7}"/>
                </a:ext>
              </a:extLst>
            </p:cNvPr>
            <p:cNvSpPr txBox="1"/>
            <p:nvPr/>
          </p:nvSpPr>
          <p:spPr>
            <a:xfrm>
              <a:off x="4383118" y="541987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103343" y="4781384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133402" y="5030898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4524202" y="4823777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3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273531" y="4027575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8093124" y="4190469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pic>
          <p:nvPicPr>
            <p:cNvPr id="3" name="Picture 2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9A3877A4-B25B-457E-8DB2-BB0CE3B9BEBF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03" t="10919" r="4491" b="11754"/>
            <a:stretch/>
          </p:blipFill>
          <p:spPr>
            <a:xfrm>
              <a:off x="630235" y="705437"/>
              <a:ext cx="8363746" cy="3557016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3B6C365F-D287-409A-BB7C-D26C47B0BD25}"/>
                </a:ext>
              </a:extLst>
            </p:cNvPr>
            <p:cNvSpPr txBox="1"/>
            <p:nvPr/>
          </p:nvSpPr>
          <p:spPr>
            <a:xfrm>
              <a:off x="2380127" y="4187598"/>
              <a:ext cx="357790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5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21D7C894-F034-4091-8D9C-4158A7FFF995}"/>
                </a:ext>
              </a:extLst>
            </p:cNvPr>
            <p:cNvSpPr txBox="1"/>
            <p:nvPr/>
          </p:nvSpPr>
          <p:spPr>
            <a:xfrm>
              <a:off x="6165545" y="4178100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50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1216902" y="4918117"/>
              <a:ext cx="3394965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4" name="Rectangle 273">
              <a:extLst>
                <a:ext uri="{FF2B5EF4-FFF2-40B4-BE49-F238E27FC236}">
                  <a16:creationId xmlns:a16="http://schemas.microsoft.com/office/drawing/2014/main" id="{1BD01AFB-87C9-434D-833F-33B76F25A60D}"/>
                </a:ext>
              </a:extLst>
            </p:cNvPr>
            <p:cNvSpPr/>
            <p:nvPr/>
          </p:nvSpPr>
          <p:spPr>
            <a:xfrm>
              <a:off x="728326" y="5094087"/>
              <a:ext cx="2274430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2474421" y="5518233"/>
              <a:ext cx="1990350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C0590DA-23C8-4AEB-8109-76CD0EF43975}"/>
                </a:ext>
              </a:extLst>
            </p:cNvPr>
            <p:cNvSpPr txBox="1"/>
            <p:nvPr/>
          </p:nvSpPr>
          <p:spPr>
            <a:xfrm>
              <a:off x="6420385" y="692987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9E377D7F-5586-4B40-9603-A6654F86BC56}"/>
                </a:ext>
              </a:extLst>
            </p:cNvPr>
            <p:cNvCxnSpPr>
              <a:cxnSpLocks/>
              <a:endCxn id="73" idx="1"/>
            </p:cNvCxnSpPr>
            <p:nvPr/>
          </p:nvCxnSpPr>
          <p:spPr>
            <a:xfrm>
              <a:off x="6115603" y="862264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583151" y="4572498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27C86BD8-0B32-4C65-8709-172ABDE85189}"/>
                </a:ext>
              </a:extLst>
            </p:cNvPr>
            <p:cNvSpPr/>
            <p:nvPr/>
          </p:nvSpPr>
          <p:spPr>
            <a:xfrm>
              <a:off x="6708935" y="2436290"/>
              <a:ext cx="1487328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1542D652-508B-4E5A-A810-637AA861FC1F}"/>
                </a:ext>
              </a:extLst>
            </p:cNvPr>
            <p:cNvSpPr/>
            <p:nvPr/>
          </p:nvSpPr>
          <p:spPr>
            <a:xfrm>
              <a:off x="918355" y="2437096"/>
              <a:ext cx="4877607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5C97876-FDEA-4F70-934C-8CCFB7D0A2AE}"/>
                </a:ext>
              </a:extLst>
            </p:cNvPr>
            <p:cNvSpPr/>
            <p:nvPr/>
          </p:nvSpPr>
          <p:spPr>
            <a:xfrm>
              <a:off x="674037" y="2433565"/>
              <a:ext cx="8243745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9A9FFBE-5688-41A4-9374-6A3CB644795E}"/>
                </a:ext>
              </a:extLst>
            </p:cNvPr>
            <p:cNvSpPr txBox="1"/>
            <p:nvPr/>
          </p:nvSpPr>
          <p:spPr>
            <a:xfrm>
              <a:off x="2332513" y="3885947"/>
              <a:ext cx="17466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AhpC</a:t>
              </a:r>
              <a:r>
                <a:rPr lang="en-US" dirty="0"/>
                <a:t>/TSA family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AC96020-66A4-4E88-9AE2-0DC631039775}"/>
                </a:ext>
              </a:extLst>
            </p:cNvPr>
            <p:cNvSpPr txBox="1"/>
            <p:nvPr/>
          </p:nvSpPr>
          <p:spPr>
            <a:xfrm>
              <a:off x="6382157" y="3465977"/>
              <a:ext cx="2153389" cy="788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C-terminal domain of 1-Cys peroxiredoxin family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93E94FF1-4D57-40A8-8DAD-2B2CFFDA4352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7</a:t>
            </a:r>
          </a:p>
        </p:txBody>
      </p:sp>
    </p:spTree>
    <p:extLst>
      <p:ext uri="{BB962C8B-B14F-4D97-AF65-F5344CB8AC3E}">
        <p14:creationId xmlns:p14="http://schemas.microsoft.com/office/powerpoint/2010/main" val="2602958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CB3B695-AD9A-4063-AE8D-C1AAFEDA67FD}"/>
              </a:ext>
            </a:extLst>
          </p:cNvPr>
          <p:cNvGrpSpPr/>
          <p:nvPr/>
        </p:nvGrpSpPr>
        <p:grpSpPr>
          <a:xfrm>
            <a:off x="-70557" y="280102"/>
            <a:ext cx="9906153" cy="5841923"/>
            <a:chOff x="-70557" y="280102"/>
            <a:chExt cx="9906153" cy="5841923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6EB1891-A9DF-4E12-B836-DE347CBC84B9}"/>
                </a:ext>
              </a:extLst>
            </p:cNvPr>
            <p:cNvSpPr txBox="1"/>
            <p:nvPr/>
          </p:nvSpPr>
          <p:spPr>
            <a:xfrm>
              <a:off x="686259" y="2864578"/>
              <a:ext cx="9149337" cy="1123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VKFTADELRRIMDYK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HNIRNMSVIAHVDHGKSTLTDSLVAAAGIIAQEVAGDVRMTDTRADEAERGITIKSTGISLYYEMTDESLKSFTGARDGNEYLINLIDSPGHVDFSSEVTAALRITDGALVVVDCIEGVCVQTETVLRQALGERIRPVLTVNKMDRCFLELQVDGEEAYQTFSRVIENANVIMATYEDPLLGDVQVYPEKGTVAFSAGLHGWAFTLTNFAKMYASKFGVVESKMMERLWGENFFDPATRKWSGKNTGSPTCKRGFVQFCYEPIKQIIATCMNDQKDKLWPMLAKLGVSMKNDEKELMGKPLMKRVMQTWLPASTALLEMMIFHLPS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PHTAQRYRVENLYEGPLDDQYANAIRNCDPNGPLMLYVSKMIPASDKGRFF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AFGRVFAGKVSTGMKVRIMGPNYIPGEKKDLYTKSVQRTVIWMGKRQETVEDVPCGNTVAMVGLDQFITKNATL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TNEKEVDAHPIRAMKFSVS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PVVRVAVQCKVASDLPKLVEGLKRLAKSDPMVVCTMEESGEHIVAGAGELHLEICLKDLQDDF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GGAEIIKSDPVVSFRETVCDRSTRTVMSKSPNKHNRLYMEARPMEEGLAEAIDDGRI</a:t>
              </a:r>
              <a:r>
                <a:rPr lang="en-US" sz="13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GPR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DDPKIRSKILAEEFGWDKDLAKKIWAFGPETTGPNMVVDMCKGVQYLNEIKDSVVAGFQWASKEGPLAEENMRGICFEVCDVVLHSDAIHRGGGQVIPTARRVIYASQITA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KP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RLLEPVYMVEIQAPEGALGGIYSVLNQKRGHVFEEMQRPGTPLYNIKAYLPVVESFGFSSQLRAATSGQAFPQCVFDHWEMMSSDPL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EPGTQASVLVADIRKRK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G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LKEAMTPLSEFEDKL</a:t>
              </a:r>
              <a:endParaRPr lang="en-US" sz="13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0D7F8F7-7D9C-4DC8-AF4F-6D5D507E4023}"/>
                </a:ext>
              </a:extLst>
            </p:cNvPr>
            <p:cNvSpPr txBox="1"/>
            <p:nvPr/>
          </p:nvSpPr>
          <p:spPr>
            <a:xfrm>
              <a:off x="684316" y="2576763"/>
              <a:ext cx="9149337" cy="1134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VKFTADELRRIMDYKHNIRNMSVIAHVDHGKSTLTDSLVAAAGIIAQEVAGDVRMTDTRADEAERGITIKSTGISLYYEMTDESLKSFTGARDGNEYLINLIDSPGHVDFSSEVTAALRITDGALVVVDCIEGVCVQTETVLRQALGERIRPVLTVNKMDRCFLELQVDGEEAYQTFSRVIENANVIMATYEDPLLGDVQVYPEKGTVAFSAGLHGWAFTLTNFAKMYASKFGV</a:t>
              </a:r>
              <a:r>
                <a:rPr lang="en-US" sz="130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ESKMMERLWGENFFDPATRKWSGKNTGSPTCKRGFVQFCYEPIKQIIATCMNDQKDKLWPMLAKLGVSMKNDEKELMGK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LMKRVMQTWLPASTALLEMMIFHLPSPHTAQRYRVENLYEGPLDDQYANAIRNCDPNGPLMLYVSKMIPASDKGRFFAFGRVFAGKVSTGMKVRIMGPNYIPGEKKDLYTKSVQRTVIWMGKRQETVEDVPCGNTVAMVGLDQFITKNATLTNEKEVDAHPIRAMKFSVSPVVRVAVQCKVASDLPKLVEGLKRLAKSDPMVVCTMEESGEHIVAGAGELHLEICLKDLQDDFMGGAEIIKSDPVVSFRETVCDRSTRTVMSKSPNKHNRLYMEARPMEEGLAEAIDDGRI</a:t>
              </a:r>
              <a:r>
                <a:rPr lang="en-US" sz="130" dirty="0">
                  <a:effectLst/>
                  <a:highlight>
                    <a:srgbClr val="FF00FF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PRDDPKIRSKILAEEFGWDKDLAKKIWAFGPETTGPNMVVDMCKGVQYLNEIKDSVVAGFQWASKEGPLAEE</a:t>
              </a:r>
              <a:r>
                <a:rPr lang="en-US" sz="13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NMRGICFEVCDVVLHSDAIHRGGGQVIPTARRVIYASQITAKPRLLEPVYMVEI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QAPEGALG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IY</a:t>
              </a:r>
              <a:r>
                <a:rPr lang="en-US" sz="13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VLNQKRGHVFEEMQRPGTPLYNIKAYLPVVESF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SSQLRAATSGQAFPQCVFDHWEMMS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S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PLEPGTQASVLVADIRKRK</a:t>
              </a:r>
              <a:r>
                <a:rPr lang="en-US" sz="13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</a:t>
              </a:r>
              <a:r>
                <a:rPr lang="en-US" sz="130" dirty="0">
                  <a:effectLst/>
                  <a:highlight>
                    <a:srgbClr val="FF0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LKEAMTPLSEFEDKL</a:t>
              </a:r>
              <a:endParaRPr lang="en-US" sz="13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Picture 3" descr="Chart&#10;&#10;Description automatically generated">
              <a:extLst>
                <a:ext uri="{FF2B5EF4-FFF2-40B4-BE49-F238E27FC236}">
                  <a16:creationId xmlns:a16="http://schemas.microsoft.com/office/drawing/2014/main" id="{10FAAE74-8896-4D08-8358-700149354885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7" t="11011" r="4244" b="11738"/>
            <a:stretch/>
          </p:blipFill>
          <p:spPr>
            <a:xfrm>
              <a:off x="670027" y="725163"/>
              <a:ext cx="8242992" cy="3557016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70557" y="280102"/>
              <a:ext cx="9594037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30" dirty="0"/>
                <a:t>AT1G56070.1, .2 or 3:LOW EXPRESSION OF OSMOTICALLY RESPONSIVE GENES 1; 843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462940" y="607954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394189" y="1099772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444289" y="1586422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401637" y="2098952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443889" y="261796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347879" y="3096041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405153" y="3569136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633668" y="4190789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494403" y="4193174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627294" y="2365948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403246" y="4395248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218116" y="569206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658679" y="5514239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8722309" y="5664316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8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662575" y="4680683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218116" y="4870049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A7028B0-6976-439C-AAEE-E05D4E7ED419}"/>
                </a:ext>
              </a:extLst>
            </p:cNvPr>
            <p:cNvSpPr txBox="1"/>
            <p:nvPr/>
          </p:nvSpPr>
          <p:spPr>
            <a:xfrm>
              <a:off x="236539" y="5176149"/>
              <a:ext cx="512833" cy="2051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60960" tIns="0" rIns="60960" bIns="0" rtlCol="0">
              <a:spAutoFit/>
            </a:bodyPr>
            <a:lstStyle/>
            <a:p>
              <a:r>
                <a:rPr lang="en-US" sz="1333" dirty="0">
                  <a:solidFill>
                    <a:schemeClr val="accent6">
                      <a:lumMod val="75000"/>
                    </a:schemeClr>
                  </a:solidFill>
                </a:rPr>
                <a:t>Rep 2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218116" y="534480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968C584B-562E-43FF-B33B-E3B34B614107}"/>
                </a:ext>
              </a:extLst>
            </p:cNvPr>
            <p:cNvSpPr txBox="1"/>
            <p:nvPr/>
          </p:nvSpPr>
          <p:spPr>
            <a:xfrm>
              <a:off x="3701965" y="5153638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F21D0150-A6D5-4D3D-93D0-2D5B4D992045}"/>
                </a:ext>
              </a:extLst>
            </p:cNvPr>
            <p:cNvSpPr txBox="1"/>
            <p:nvPr/>
          </p:nvSpPr>
          <p:spPr>
            <a:xfrm>
              <a:off x="7181305" y="5273630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336507" y="4068141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453562" y="4187601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405848" y="419320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4362384" y="4196098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5315648" y="420325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6265332" y="419320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7218348" y="420260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D93B493-29C9-4AD2-A879-61E98C002977}"/>
                </a:ext>
              </a:extLst>
            </p:cNvPr>
            <p:cNvSpPr txBox="1"/>
            <p:nvPr/>
          </p:nvSpPr>
          <p:spPr>
            <a:xfrm>
              <a:off x="8197763" y="419260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437197" y="707960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7132415" y="877237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D10D690-DAEA-4C58-8CE1-2514C7E605EC}"/>
                </a:ext>
              </a:extLst>
            </p:cNvPr>
            <p:cNvSpPr txBox="1"/>
            <p:nvPr/>
          </p:nvSpPr>
          <p:spPr>
            <a:xfrm>
              <a:off x="8719655" y="5824571"/>
              <a:ext cx="359394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1819BCE4-7A47-440C-AE6E-3AB05D8C6A0D}"/>
                </a:ext>
              </a:extLst>
            </p:cNvPr>
            <p:cNvSpPr/>
            <p:nvPr/>
          </p:nvSpPr>
          <p:spPr>
            <a:xfrm>
              <a:off x="3018476" y="5233475"/>
              <a:ext cx="751042" cy="10667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60FFD7C9-68B4-43DF-9EE6-C57BAA2A9C46}"/>
                </a:ext>
              </a:extLst>
            </p:cNvPr>
            <p:cNvSpPr/>
            <p:nvPr/>
          </p:nvSpPr>
          <p:spPr>
            <a:xfrm>
              <a:off x="6558943" y="5371665"/>
              <a:ext cx="694346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F4DBDB1B-473C-4DD2-BFA6-B6765861A4D6}"/>
                </a:ext>
              </a:extLst>
            </p:cNvPr>
            <p:cNvSpPr/>
            <p:nvPr/>
          </p:nvSpPr>
          <p:spPr>
            <a:xfrm>
              <a:off x="7768527" y="5759508"/>
              <a:ext cx="1037336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54198549-927D-47E1-BBEC-7175C19A0718}"/>
                </a:ext>
              </a:extLst>
            </p:cNvPr>
            <p:cNvSpPr/>
            <p:nvPr/>
          </p:nvSpPr>
          <p:spPr>
            <a:xfrm>
              <a:off x="7872411" y="5921534"/>
              <a:ext cx="93345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8577300" y="4855598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5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7843381" y="5105587"/>
              <a:ext cx="619581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26247940-E066-4B5A-A0D7-CE0FB65203D2}"/>
                </a:ext>
              </a:extLst>
            </p:cNvPr>
            <p:cNvSpPr/>
            <p:nvPr/>
          </p:nvSpPr>
          <p:spPr>
            <a:xfrm>
              <a:off x="7837519" y="4947173"/>
              <a:ext cx="815742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27709CE8-ADE3-4468-AA68-65547555FF83}"/>
                </a:ext>
              </a:extLst>
            </p:cNvPr>
            <p:cNvSpPr/>
            <p:nvPr/>
          </p:nvSpPr>
          <p:spPr>
            <a:xfrm>
              <a:off x="934558" y="2705926"/>
              <a:ext cx="3104042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31894151-F84E-43ED-AD70-3D0400D23130}"/>
                </a:ext>
              </a:extLst>
            </p:cNvPr>
            <p:cNvSpPr/>
            <p:nvPr/>
          </p:nvSpPr>
          <p:spPr>
            <a:xfrm>
              <a:off x="4523819" y="2705666"/>
              <a:ext cx="705406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FCEAD141-17EF-4C9E-B594-2E24B069B53A}"/>
                </a:ext>
              </a:extLst>
            </p:cNvPr>
            <p:cNvSpPr/>
            <p:nvPr/>
          </p:nvSpPr>
          <p:spPr>
            <a:xfrm>
              <a:off x="5409543" y="2707186"/>
              <a:ext cx="600732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C0C7DE9-FA07-4985-AE0A-CD0324CEA8ED}"/>
                </a:ext>
              </a:extLst>
            </p:cNvPr>
            <p:cNvSpPr/>
            <p:nvPr/>
          </p:nvSpPr>
          <p:spPr>
            <a:xfrm>
              <a:off x="6587804" y="2706377"/>
              <a:ext cx="1058389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35220DDF-45D9-499E-ADDB-2C3B945D90F8}"/>
                </a:ext>
              </a:extLst>
            </p:cNvPr>
            <p:cNvSpPr/>
            <p:nvPr/>
          </p:nvSpPr>
          <p:spPr>
            <a:xfrm>
              <a:off x="7664208" y="2705427"/>
              <a:ext cx="829711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7D6FD5E8-F34E-4A8B-B399-96259A02C007}"/>
                </a:ext>
              </a:extLst>
            </p:cNvPr>
            <p:cNvSpPr/>
            <p:nvPr/>
          </p:nvSpPr>
          <p:spPr>
            <a:xfrm>
              <a:off x="766905" y="2702645"/>
              <a:ext cx="8046720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0AC0E6D-0DB6-4881-80CC-4DB27EE0FC32}"/>
                </a:ext>
              </a:extLst>
            </p:cNvPr>
            <p:cNvSpPr txBox="1"/>
            <p:nvPr/>
          </p:nvSpPr>
          <p:spPr>
            <a:xfrm>
              <a:off x="1046590" y="3748660"/>
              <a:ext cx="2695341" cy="557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Elongation factor Tu GTP binding domain family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10CD794-DC99-4C9B-BC04-49EB8790CAF5}"/>
                </a:ext>
              </a:extLst>
            </p:cNvPr>
            <p:cNvSpPr txBox="1"/>
            <p:nvPr/>
          </p:nvSpPr>
          <p:spPr>
            <a:xfrm>
              <a:off x="6711405" y="3735891"/>
              <a:ext cx="951295" cy="557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EFG IV family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BCF5A89-1F65-471D-A244-1297568F9F96}"/>
                </a:ext>
              </a:extLst>
            </p:cNvPr>
            <p:cNvSpPr txBox="1"/>
            <p:nvPr/>
          </p:nvSpPr>
          <p:spPr>
            <a:xfrm>
              <a:off x="5126492" y="3278582"/>
              <a:ext cx="1289247" cy="10188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Elongation factor G, domain III family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FB3A37B-056A-415F-9B8C-E91506889ADE}"/>
                </a:ext>
              </a:extLst>
            </p:cNvPr>
            <p:cNvSpPr txBox="1"/>
            <p:nvPr/>
          </p:nvSpPr>
          <p:spPr>
            <a:xfrm>
              <a:off x="4212883" y="3669125"/>
              <a:ext cx="1268852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GTP </a:t>
              </a:r>
              <a:r>
                <a:rPr lang="en-US" dirty="0" err="1"/>
                <a:t>EFTu</a:t>
              </a:r>
              <a:r>
                <a:rPr lang="en-US" dirty="0"/>
                <a:t> D2 family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A9FC5C9-B0FD-4A87-85D8-0D268F8E1B1F}"/>
                </a:ext>
              </a:extLst>
            </p:cNvPr>
            <p:cNvSpPr txBox="1"/>
            <p:nvPr/>
          </p:nvSpPr>
          <p:spPr>
            <a:xfrm>
              <a:off x="7535735" y="3513100"/>
              <a:ext cx="1137636" cy="788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EFG C-terminus family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E62CEFB1-20B5-4B28-8B28-774955E7A731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8</a:t>
            </a:r>
          </a:p>
        </p:txBody>
      </p:sp>
    </p:spTree>
    <p:extLst>
      <p:ext uri="{BB962C8B-B14F-4D97-AF65-F5344CB8AC3E}">
        <p14:creationId xmlns:p14="http://schemas.microsoft.com/office/powerpoint/2010/main" val="24724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D3E55E28-4CDE-0749-39F7-B86342456328}"/>
              </a:ext>
            </a:extLst>
          </p:cNvPr>
          <p:cNvSpPr txBox="1"/>
          <p:nvPr/>
        </p:nvSpPr>
        <p:spPr>
          <a:xfrm>
            <a:off x="880416" y="2904186"/>
            <a:ext cx="8964384" cy="1085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" kern="12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ARLIIPCRSSSLARVNLLGLLSRAPVPVRSSCLRSSANRLTQHRPFLTSEAICLRKNRFLPHSVDTHKQNSRRLICSVATESVPDKAEDSKMDAPKEIFLKNYTKPDYYFETVDLSFSLGEEKTIVSSKIKVSPRVKGSSAALVLDGHDLKLLSVKVEGKLLKEGDYQLDSRHLTLPSLPAEESFVLEIDTEIYPHKNTSLEGLYKSSGNFCTQCEAEGFRKITFYQDRPDIMAKYTCRVEGDKTLYPVLLSNGNLISQGDIEGGRHYALWEDPFKKPCYLFALVAGQLVSRDDTFTTRSGRQVSLKIWTPAEDLPKTAHAMYSLKAAMKWDEDVFGLEYDLDLFNIVAVPDFNMGAMENKSLNIFNSKLVLASPETATDADYAAILGVIGHEYFHNWTGNRVTCRDWFQLSLKEGLTVFRDQEFSSDMGSRTVKRIADVSKLRIYQFPQDAGPMAHPVRPHSYIKMDNFYTVTVYEKGAEVVRMYKTLLGTQGFRKGIDLYFERHDEQAVTCEDFFAAMRDANNADFANFLQWYSQAGTPVVKVVSSYNADARTFSLKFSQEIPPTPGQPTKEPTFIPVVVGLLDSSGKDITLSSVHHDGTVQTISGSSTILRVTKKEEEFVFSDIPERPVPSLFRGFSAPVRVETDLSNDDLFFLLAHDSDEFNRWEAGQVLARKLMLNLVSDFQQNKPLALNPKFVQGLGSVLSDSSLDKEFI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KAITLPGEGEIMDMMAVADPDAVHAVRKFVRKQLASELKEELLKIVENNRSTEA</a:t>
            </a:r>
            <a:r>
              <a:rPr lang="en-US" sz="100" kern="12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YVFDHSNMARRALKNTALAYLASLEDPAYMELALNEYKMATNLTDQFAALAALSQNPGKTRDDILADFYNKWQDDYLVVNKWFLLQSTSDIPGNVENVKKLLDHPAFDLRNPN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00" kern="12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VYSLI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GFCGSPVNFHAKDGSGYKFL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IVVQLDKLNPQVASRMVSAFSRWKRY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00FF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TRQGLA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00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QLEMIMSANGLSENVFEIASKSLAA</a:t>
            </a:r>
            <a:endParaRPr lang="en-US" sz="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B368FB8-E2E0-4E8F-B07F-60274A0CE06B}"/>
              </a:ext>
            </a:extLst>
          </p:cNvPr>
          <p:cNvGrpSpPr/>
          <p:nvPr/>
        </p:nvGrpSpPr>
        <p:grpSpPr>
          <a:xfrm>
            <a:off x="-63822" y="283960"/>
            <a:ext cx="9976249" cy="5547724"/>
            <a:chOff x="-63822" y="283960"/>
            <a:chExt cx="9976249" cy="5547724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0EF799A-39B1-4854-BE1F-8BBDF199CCC6}"/>
                </a:ext>
              </a:extLst>
            </p:cNvPr>
            <p:cNvSpPr txBox="1"/>
            <p:nvPr/>
          </p:nvSpPr>
          <p:spPr>
            <a:xfrm>
              <a:off x="812789" y="2805943"/>
              <a:ext cx="9099638" cy="11015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RLIIPCRSSSLARVNLLGLLSRAPVPVRSSCLRSSANRLTQHRPFLTSEAICLRKNRFLPHSVDTHKQNSRRLICSVATESVPDKAEDSKMDAPKEIFLKNYTK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PDYYFETVDLSFSLGEEKTIVSSKIKVSPRVKGSSAALVLDGHDLKLLSVKVEGKLLKEGDYQLDSRHLTLPSLPAEESFVLEIDTEIYPHKNTSLEGLYKSSGNFCTQCEAEGFRKITFYQDRPDIMAKYTCRVEGDKTLYPVLLSNGNLISQGDIEGGRHYALWEDPFKKPCYL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LVAGQLVSRDDTFTTRSGRQVSLKIWTPAEDLPKTAHAM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YSLKAAMKWDEDVFGLEYDLDLFNIVAVPDFNMGAMENKSLNIFNSKLVLASPETATDADYAAILGVIGHEYFHNWTGNRVTCRDWFQLSLKEGLTVFRDQEFSSDMGSRTVKRIADVSKLRIYQFPQDAGPMAHPVRPHSYIKMDNFYTVTVYEKGAEVVRMYKTLLGTQGFRKGIDLYFERHDEQAVTCEDFFAAMRDANNADFANFLQ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WYSQA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GTPVVKVVSSYNADARTFSLKFSQEIPPTPGQPTKEPTFIPVVVGLLDSSGKDITLSSVHHDGTVQTISGSSTILRVTKKEEEFVFSDIPERPVPSLFRGFSAPVRVET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LSN</a:t>
              </a:r>
              <a:r>
                <a:rPr lang="en-US" sz="110" dirty="0">
                  <a:effectLst/>
                  <a:highlight>
                    <a:srgbClr val="808000"/>
                  </a:highlight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DDLFFLLAHDSDEFNRWEAGQVLARKLMLNLVSDFQQNKPLALNPKFVQGLGSVLSDSSLDKEFIAKAITLPGEGEIMDMMAVADPDAVHAVRKFVRKQLASELKEELLKIVENNRSTEAYVFDHSNMARRALKNTALAYLASLEDPAYMELALNEYKMATNLTDQFAALAALSQNPGKTRDDILADFYNKWQDDYLVVNKWFLLQSTSDIPGNVENVKKLLDHPAFDLRNPNKVYSLIGGFCGSPVNFHAKDGSGYKFLGDIVVQLDKLNPQVASRMVSAFSRWKRYDETRQGLAKAQLEMIMSANGLSENVFEIASKSLA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3D1D694-4267-4B25-8610-A0555F6DC565}"/>
                </a:ext>
              </a:extLst>
            </p:cNvPr>
            <p:cNvSpPr txBox="1"/>
            <p:nvPr/>
          </p:nvSpPr>
          <p:spPr>
            <a:xfrm>
              <a:off x="810855" y="3130532"/>
              <a:ext cx="8464114" cy="1092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MARLIIPCRSSSLARVNLLGLLSRAPVPVRSSCLRSSANRLTQHRPFLTSEAICLRKNRFLPHSVDTHKQNSRRLICSVATESVPDKAEDSKMDAPKEIFLKNYTKPDYYFETVDLSFSLGEEKTIVSSKIKVSPRVKGSSAALVLDGHDLKLLSVKVEGKLLKEGDYQLDSRHLTLPSLPAEESFVLEIDTEIYPHKNTSLEGLYKSSGNFCTQCEAEGFRKITFYQDRPDIMAKYTCRVEGDKTLYPVLLSNGNLISQGDIEGGRHYALWEDPFKKPCYLFALVAGQLVSRDDTFTTRSGRQVSLKIWTPAEDLPKTAHAMYSLKAAMKWDEDVFGLEYDLDLFNIVAVPDFNMGAMENKSLNIFNSKLVLASPETATDADYAAILGVIGHEYFHNWTGNRVTCRDWFQLSLKEGLTVFRDQEFSSDMGSRTVKRIADVSKLRIYQFPQDAGPMAHPVRPHSYIKMDNFYTVTVYEKGAEVVRMYKTLLGTQGFRKGIDLYFERHDEQAVTCEDFFAAMRDANNADFANFLQWYSQAGTPVVKVVSSYNADARTFSLKFSQEIPPTPGQPTKEPTFIPVVVGLLDSSGKDITLSSVHHDGTVQTISGSSTILRVTKKEEEFVFSDIPERPVPSLFRGFSAPVRVETDLSNDDLFFLLAHDSDEFNRWEAGQVLARKLMLNLVSDFQQNKPLALNPKFVQGLGSVLSDSSLDKEFI</a:t>
              </a:r>
              <a:r>
                <a:rPr lang="en-US" sz="1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AKAITLPGEGEIMDMMAVADPDAVHAVRKFVRKQLASELKEELLKIVENNRSTEA</a:t>
              </a:r>
              <a:r>
                <a:rPr lang="en-US" sz="110" dirty="0">
                  <a:effectLst/>
                  <a:latin typeface="Courier New" panose="02070309020205020404" pitchFamily="49" charset="0"/>
                  <a:ea typeface="Calibri" panose="020F0502020204030204" pitchFamily="34" charset="0"/>
                </a:rPr>
                <a:t>YVFDHSNMARRALKNTALAYLASLEDPAYMELALNEYKMATNLTDQFAALAALSQNPGKTRDDILADFYNKWQDDYLVVNKWFLLQSTSDIPGNVENVKKLLDHPAFDLRNPNKVYSLI</a:t>
              </a:r>
              <a:r>
                <a:rPr lang="en-US" sz="1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GGFCGSPVNFHAKDGSGYKFLGDIVVQLDKLNPQVASRMVSAFSRWKRYDETRQGLA</a:t>
              </a:r>
              <a:r>
                <a:rPr lang="en-US" sz="110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K</a:t>
              </a:r>
              <a:r>
                <a:rPr lang="en-US" sz="11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libri" panose="020F0502020204030204" pitchFamily="34" charset="0"/>
                </a:rPr>
                <a:t>AQLEMIMSANGLSENVFEIASKSLAA</a:t>
              </a:r>
              <a:endParaRPr lang="en-US" sz="110" dirty="0"/>
            </a:p>
          </p:txBody>
        </p:sp>
        <p:pic>
          <p:nvPicPr>
            <p:cNvPr id="3" name="Picture 2" descr="Chart&#10;&#10;Description automatically generated">
              <a:extLst>
                <a:ext uri="{FF2B5EF4-FFF2-40B4-BE49-F238E27FC236}">
                  <a16:creationId xmlns:a16="http://schemas.microsoft.com/office/drawing/2014/main" id="{77801AA2-C73A-4E92-9C2A-862EEBF26F4B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40" t="11019" r="4554" b="11357"/>
            <a:stretch/>
          </p:blipFill>
          <p:spPr>
            <a:xfrm>
              <a:off x="834782" y="664688"/>
              <a:ext cx="7885356" cy="3548985"/>
            </a:xfrm>
            <a:prstGeom prst="rect">
              <a:avLst/>
            </a:prstGeom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260D0E5C-706F-4FF0-8746-20D3F475925B}"/>
                </a:ext>
              </a:extLst>
            </p:cNvPr>
            <p:cNvSpPr txBox="1"/>
            <p:nvPr/>
          </p:nvSpPr>
          <p:spPr>
            <a:xfrm>
              <a:off x="-63822" y="283960"/>
              <a:ext cx="8091403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dirty="0"/>
                <a:t>AT1G63770.5, or .6: PEPTIDASE M1 family protein; 975 amino acid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27375DE-0BE7-4A29-95B2-4C4D7BB29E39}"/>
                </a:ext>
              </a:extLst>
            </p:cNvPr>
            <p:cNvSpPr txBox="1"/>
            <p:nvPr/>
          </p:nvSpPr>
          <p:spPr>
            <a:xfrm>
              <a:off x="578007" y="599897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317B04D6-7657-4F34-A595-3B510AB1F16E}"/>
                </a:ext>
              </a:extLst>
            </p:cNvPr>
            <p:cNvSpPr txBox="1"/>
            <p:nvPr/>
          </p:nvSpPr>
          <p:spPr>
            <a:xfrm>
              <a:off x="525850" y="1054518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.5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7B31341E-CBBB-447D-9D2C-7CA4E3703C10}"/>
                </a:ext>
              </a:extLst>
            </p:cNvPr>
            <p:cNvSpPr txBox="1"/>
            <p:nvPr/>
          </p:nvSpPr>
          <p:spPr>
            <a:xfrm>
              <a:off x="578090" y="1512059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1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CC67E57-6938-4197-BB82-D9A3C121FD62}"/>
                </a:ext>
              </a:extLst>
            </p:cNvPr>
            <p:cNvSpPr txBox="1"/>
            <p:nvPr/>
          </p:nvSpPr>
          <p:spPr>
            <a:xfrm>
              <a:off x="525850" y="2038824"/>
              <a:ext cx="464229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.5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7D61E6-87CC-40F2-AF3D-4E5BB6EAE4FA}"/>
                </a:ext>
              </a:extLst>
            </p:cNvPr>
            <p:cNvSpPr txBox="1"/>
            <p:nvPr/>
          </p:nvSpPr>
          <p:spPr>
            <a:xfrm>
              <a:off x="596623" y="2528896"/>
              <a:ext cx="333853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8698889-D2C5-4ADB-A8BC-34D556B8C496}"/>
                </a:ext>
              </a:extLst>
            </p:cNvPr>
            <p:cNvSpPr txBox="1"/>
            <p:nvPr/>
          </p:nvSpPr>
          <p:spPr>
            <a:xfrm>
              <a:off x="474554" y="3032549"/>
              <a:ext cx="515525" cy="297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0.5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B40C9032-1B63-49DC-9778-7A48C6A8F367}"/>
                </a:ext>
              </a:extLst>
            </p:cNvPr>
            <p:cNvSpPr txBox="1"/>
            <p:nvPr/>
          </p:nvSpPr>
          <p:spPr>
            <a:xfrm>
              <a:off x="522047" y="3499468"/>
              <a:ext cx="385149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3536D16-058C-4DC2-A0CC-E831C536FE61}"/>
                </a:ext>
              </a:extLst>
            </p:cNvPr>
            <p:cNvSpPr txBox="1"/>
            <p:nvPr/>
          </p:nvSpPr>
          <p:spPr>
            <a:xfrm>
              <a:off x="767109" y="4091930"/>
              <a:ext cx="27122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8C282AB0-EDE9-4B3F-9317-1F532881BC30}"/>
                </a:ext>
              </a:extLst>
            </p:cNvPr>
            <p:cNvSpPr txBox="1"/>
            <p:nvPr/>
          </p:nvSpPr>
          <p:spPr>
            <a:xfrm>
              <a:off x="1456919" y="4106748"/>
              <a:ext cx="444352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C9CD7D3-0E94-4D74-83EF-2F5827E3B4C4}"/>
                </a:ext>
              </a:extLst>
            </p:cNvPr>
            <p:cNvSpPr txBox="1"/>
            <p:nvPr/>
          </p:nvSpPr>
          <p:spPr>
            <a:xfrm rot="16200000">
              <a:off x="-451764" y="2299796"/>
              <a:ext cx="1833323" cy="27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333"/>
                </a:lnSpc>
              </a:pPr>
              <a:r>
                <a:rPr lang="en-US" sz="1600" dirty="0"/>
                <a:t>Hydrophilicity index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531F24F5-A0B8-4CB4-88B6-92334840F476}"/>
                </a:ext>
              </a:extLst>
            </p:cNvPr>
            <p:cNvSpPr txBox="1"/>
            <p:nvPr/>
          </p:nvSpPr>
          <p:spPr>
            <a:xfrm>
              <a:off x="3565232" y="4307067"/>
              <a:ext cx="2524474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rotein length (amino acids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65D3BBA-1258-4163-8642-4A4E98824D38}"/>
                </a:ext>
              </a:extLst>
            </p:cNvPr>
            <p:cNvSpPr txBox="1"/>
            <p:nvPr/>
          </p:nvSpPr>
          <p:spPr>
            <a:xfrm>
              <a:off x="271975" y="5328308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93FB5C87-2E0F-407F-A1E0-B5FFFA709DCF}"/>
                </a:ext>
              </a:extLst>
            </p:cNvPr>
            <p:cNvSpPr txBox="1"/>
            <p:nvPr/>
          </p:nvSpPr>
          <p:spPr>
            <a:xfrm>
              <a:off x="271975" y="5516001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FD794FB-0584-42B1-A29E-0FCC91E3401E}"/>
                </a:ext>
              </a:extLst>
            </p:cNvPr>
            <p:cNvSpPr txBox="1"/>
            <p:nvPr/>
          </p:nvSpPr>
          <p:spPr>
            <a:xfrm>
              <a:off x="788508" y="5063960"/>
              <a:ext cx="4858126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Glyma04g009900 replicates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6E63DC9A-4FCA-47BA-B5C4-9B896D62EF45}"/>
                </a:ext>
              </a:extLst>
            </p:cNvPr>
            <p:cNvSpPr txBox="1"/>
            <p:nvPr/>
          </p:nvSpPr>
          <p:spPr>
            <a:xfrm>
              <a:off x="8353405" y="5534230"/>
              <a:ext cx="532518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139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A68FB3A-21D1-4EAB-9A6D-1F1923C345FD}"/>
                </a:ext>
              </a:extLst>
            </p:cNvPr>
            <p:cNvSpPr txBox="1"/>
            <p:nvPr/>
          </p:nvSpPr>
          <p:spPr>
            <a:xfrm>
              <a:off x="8353405" y="5376055"/>
              <a:ext cx="359393" cy="297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X4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BD43DA8-6A76-46D9-996E-B00464B16920}"/>
                </a:ext>
              </a:extLst>
            </p:cNvPr>
            <p:cNvSpPr txBox="1"/>
            <p:nvPr/>
          </p:nvSpPr>
          <p:spPr>
            <a:xfrm>
              <a:off x="788508" y="4554305"/>
              <a:ext cx="4268733" cy="379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67" dirty="0"/>
                <a:t>Binding region from AT2G21490 replicates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D46BD0B-32BA-4DF6-B920-F1A2E7EB1032}"/>
                </a:ext>
              </a:extLst>
            </p:cNvPr>
            <p:cNvSpPr txBox="1"/>
            <p:nvPr/>
          </p:nvSpPr>
          <p:spPr>
            <a:xfrm>
              <a:off x="264746" y="4740922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1">
                      <a:lumMod val="50000"/>
                    </a:schemeClr>
                  </a:solidFill>
                </a:rPr>
                <a:t>Rep 1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C7302551-ADF7-4C45-991A-BFE4E52C6CC0}"/>
                </a:ext>
              </a:extLst>
            </p:cNvPr>
            <p:cNvSpPr txBox="1"/>
            <p:nvPr/>
          </p:nvSpPr>
          <p:spPr>
            <a:xfrm>
              <a:off x="264481" y="4922313"/>
              <a:ext cx="574388" cy="297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>
                  <a:solidFill>
                    <a:schemeClr val="accent4">
                      <a:lumMod val="50000"/>
                    </a:schemeClr>
                  </a:solidFill>
                </a:rPr>
                <a:t>Rep 3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7C8BFC50-B2EE-4C6D-A67D-D1555144E235}"/>
                </a:ext>
              </a:extLst>
            </p:cNvPr>
            <p:cNvSpPr txBox="1"/>
            <p:nvPr/>
          </p:nvSpPr>
          <p:spPr>
            <a:xfrm>
              <a:off x="6950846" y="4808969"/>
              <a:ext cx="445956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X2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5EBB84A2-740A-47E0-B872-324A2C5654E5}"/>
                </a:ext>
              </a:extLst>
            </p:cNvPr>
            <p:cNvSpPr txBox="1"/>
            <p:nvPr/>
          </p:nvSpPr>
          <p:spPr>
            <a:xfrm>
              <a:off x="481191" y="3953558"/>
              <a:ext cx="484345" cy="29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33" dirty="0"/>
                <a:t>-1.5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C1808B4-924E-4D85-81EC-78FAE7881B9E}"/>
                </a:ext>
              </a:extLst>
            </p:cNvPr>
            <p:cNvSpPr txBox="1"/>
            <p:nvPr/>
          </p:nvSpPr>
          <p:spPr>
            <a:xfrm>
              <a:off x="2250706" y="409854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200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CBE4AA6-7300-490B-947F-4CDE80528FF0}"/>
                </a:ext>
              </a:extLst>
            </p:cNvPr>
            <p:cNvSpPr txBox="1"/>
            <p:nvPr/>
          </p:nvSpPr>
          <p:spPr>
            <a:xfrm>
              <a:off x="3058892" y="409804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30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BEB38F1-E0F4-48AD-BD72-D0E2214FA77B}"/>
                </a:ext>
              </a:extLst>
            </p:cNvPr>
            <p:cNvSpPr txBox="1"/>
            <p:nvPr/>
          </p:nvSpPr>
          <p:spPr>
            <a:xfrm>
              <a:off x="3847310" y="409881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4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032DC2D-38D7-4DDF-A001-A30FCE5D25CC}"/>
                </a:ext>
              </a:extLst>
            </p:cNvPr>
            <p:cNvSpPr txBox="1"/>
            <p:nvPr/>
          </p:nvSpPr>
          <p:spPr>
            <a:xfrm>
              <a:off x="4648200" y="409451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50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35FE6C2-83A5-4473-BE07-F983B2AF5C94}"/>
                </a:ext>
              </a:extLst>
            </p:cNvPr>
            <p:cNvSpPr txBox="1"/>
            <p:nvPr/>
          </p:nvSpPr>
          <p:spPr>
            <a:xfrm>
              <a:off x="5450927" y="4097846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60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C755165-85F7-4EFF-992B-1767560531D9}"/>
                </a:ext>
              </a:extLst>
            </p:cNvPr>
            <p:cNvSpPr txBox="1"/>
            <p:nvPr/>
          </p:nvSpPr>
          <p:spPr>
            <a:xfrm>
              <a:off x="6237631" y="409451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70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4260EF3-C36A-4078-B05F-A6D6D3E42369}"/>
                </a:ext>
              </a:extLst>
            </p:cNvPr>
            <p:cNvSpPr txBox="1"/>
            <p:nvPr/>
          </p:nvSpPr>
          <p:spPr>
            <a:xfrm>
              <a:off x="7042211" y="4097553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80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D2D7490-3430-4864-B746-20AA00E1B160}"/>
                </a:ext>
              </a:extLst>
            </p:cNvPr>
            <p:cNvSpPr txBox="1"/>
            <p:nvPr/>
          </p:nvSpPr>
          <p:spPr>
            <a:xfrm>
              <a:off x="7842709" y="4098044"/>
              <a:ext cx="444352" cy="29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3" dirty="0"/>
                <a:t>900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3D165928-33DE-4171-994A-A042D0D8B678}"/>
                </a:ext>
              </a:extLst>
            </p:cNvPr>
            <p:cNvCxnSpPr>
              <a:cxnSpLocks/>
              <a:endCxn id="288" idx="1"/>
            </p:cNvCxnSpPr>
            <p:nvPr/>
          </p:nvCxnSpPr>
          <p:spPr>
            <a:xfrm>
              <a:off x="6984604" y="812738"/>
              <a:ext cx="304782" cy="0"/>
            </a:xfrm>
            <a:prstGeom prst="line">
              <a:avLst/>
            </a:prstGeom>
            <a:ln w="19050">
              <a:solidFill>
                <a:srgbClr val="D45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C82ADEA3-5051-4EDF-A2CF-15D20CE77B8E}"/>
                </a:ext>
              </a:extLst>
            </p:cNvPr>
            <p:cNvSpPr txBox="1"/>
            <p:nvPr/>
          </p:nvSpPr>
          <p:spPr>
            <a:xfrm>
              <a:off x="7289386" y="643461"/>
              <a:ext cx="14488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Hopp</a:t>
              </a:r>
              <a:r>
                <a:rPr lang="en-US" sz="1600" dirty="0"/>
                <a:t> &amp; Woods</a:t>
              </a:r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4EEEFEFA-B45E-4EE1-8D74-3DC29B4E7AC2}"/>
                </a:ext>
              </a:extLst>
            </p:cNvPr>
            <p:cNvSpPr/>
            <p:nvPr/>
          </p:nvSpPr>
          <p:spPr>
            <a:xfrm>
              <a:off x="6596669" y="4906866"/>
              <a:ext cx="437543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47FB02D5-95D1-45F6-8248-5A6FB1433ADF}"/>
                </a:ext>
              </a:extLst>
            </p:cNvPr>
            <p:cNvSpPr/>
            <p:nvPr/>
          </p:nvSpPr>
          <p:spPr>
            <a:xfrm>
              <a:off x="7978257" y="4904238"/>
              <a:ext cx="670443" cy="106672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5169CF11-60C7-41B7-87FE-1FEA54D3A269}"/>
                </a:ext>
              </a:extLst>
            </p:cNvPr>
            <p:cNvSpPr/>
            <p:nvPr/>
          </p:nvSpPr>
          <p:spPr>
            <a:xfrm>
              <a:off x="7977468" y="5630607"/>
              <a:ext cx="459105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BB13D936-B3E3-4E75-9FCF-4086B3505287}"/>
                </a:ext>
              </a:extLst>
            </p:cNvPr>
            <p:cNvSpPr/>
            <p:nvPr/>
          </p:nvSpPr>
          <p:spPr>
            <a:xfrm>
              <a:off x="7976946" y="5470120"/>
              <a:ext cx="459105" cy="109728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8E3E592-3074-4D00-BBC5-6FD96BF76BFC}"/>
                </a:ext>
              </a:extLst>
            </p:cNvPr>
            <p:cNvSpPr/>
            <p:nvPr/>
          </p:nvSpPr>
          <p:spPr>
            <a:xfrm>
              <a:off x="7975284" y="5061071"/>
              <a:ext cx="459105" cy="109728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B0C6EAD-C700-4D3A-8AB7-31BA5942CADE}"/>
                </a:ext>
              </a:extLst>
            </p:cNvPr>
            <p:cNvSpPr txBox="1"/>
            <p:nvPr/>
          </p:nvSpPr>
          <p:spPr>
            <a:xfrm>
              <a:off x="3255269" y="3650766"/>
              <a:ext cx="2052265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Peptidase family M1 domai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CB7C03B-E9B5-4F98-9A9B-2D6D357CE0E9}"/>
                </a:ext>
              </a:extLst>
            </p:cNvPr>
            <p:cNvSpPr txBox="1"/>
            <p:nvPr/>
          </p:nvSpPr>
          <p:spPr>
            <a:xfrm>
              <a:off x="1216128" y="3416112"/>
              <a:ext cx="2233293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Peptidase M1 N-terminal domain family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CE104C3-980B-4A1C-8104-9BDCEB7365CB}"/>
                </a:ext>
              </a:extLst>
            </p:cNvPr>
            <p:cNvSpPr txBox="1"/>
            <p:nvPr/>
          </p:nvSpPr>
          <p:spPr>
            <a:xfrm>
              <a:off x="5026699" y="3416112"/>
              <a:ext cx="1268852" cy="7880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DUF3458, Ig-like fold family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A866683-A851-4D5E-8862-10B00176EA49}"/>
                </a:ext>
              </a:extLst>
            </p:cNvPr>
            <p:cNvSpPr txBox="1"/>
            <p:nvPr/>
          </p:nvSpPr>
          <p:spPr>
            <a:xfrm>
              <a:off x="6248870" y="3657541"/>
              <a:ext cx="2240220" cy="5572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/>
                <a:t>DUF3458 C, ARM repeat family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03149328-48D7-4A0D-9D5F-C85762574B06}"/>
                </a:ext>
              </a:extLst>
            </p:cNvPr>
            <p:cNvSpPr/>
            <p:nvPr/>
          </p:nvSpPr>
          <p:spPr>
            <a:xfrm>
              <a:off x="1747633" y="2626011"/>
              <a:ext cx="1395617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215F0A2C-5948-465F-BDCE-61FE227E612E}"/>
                </a:ext>
              </a:extLst>
            </p:cNvPr>
            <p:cNvSpPr/>
            <p:nvPr/>
          </p:nvSpPr>
          <p:spPr>
            <a:xfrm>
              <a:off x="3466996" y="2624679"/>
              <a:ext cx="1681267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D48EFDE-0108-4586-9C78-B8E49B5EC129}"/>
                </a:ext>
              </a:extLst>
            </p:cNvPr>
            <p:cNvSpPr/>
            <p:nvPr/>
          </p:nvSpPr>
          <p:spPr>
            <a:xfrm>
              <a:off x="5181600" y="2631043"/>
              <a:ext cx="866775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117828A3-50DA-4392-AB60-AABB3DAE1359}"/>
                </a:ext>
              </a:extLst>
            </p:cNvPr>
            <p:cNvSpPr/>
            <p:nvPr/>
          </p:nvSpPr>
          <p:spPr>
            <a:xfrm>
              <a:off x="6081712" y="2631753"/>
              <a:ext cx="2555081" cy="1066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352AA62A-8BDC-4CF3-B246-40DD62B5857D}"/>
                </a:ext>
              </a:extLst>
            </p:cNvPr>
            <p:cNvSpPr/>
            <p:nvPr/>
          </p:nvSpPr>
          <p:spPr>
            <a:xfrm>
              <a:off x="895493" y="2626447"/>
              <a:ext cx="7757970" cy="1066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05697A89-8119-4E5D-89DA-F394784BE6E9}"/>
              </a:ext>
            </a:extLst>
          </p:cNvPr>
          <p:cNvSpPr txBox="1"/>
          <p:nvPr/>
        </p:nvSpPr>
        <p:spPr>
          <a:xfrm>
            <a:off x="10104" y="8980"/>
            <a:ext cx="2803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C71A1D-D6FF-28FE-F222-0C3C19193FED}"/>
              </a:ext>
            </a:extLst>
          </p:cNvPr>
          <p:cNvSpPr txBox="1"/>
          <p:nvPr/>
        </p:nvSpPr>
        <p:spPr>
          <a:xfrm>
            <a:off x="123825" y="6181187"/>
            <a:ext cx="88069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Binding regions are also valid for AT1G63770.3, .4, and .7 (987, 895, and 883 amino acids, respectively).</a:t>
            </a:r>
          </a:p>
          <a:p>
            <a:r>
              <a:rPr lang="en-US" sz="1600" dirty="0">
                <a:solidFill>
                  <a:schemeClr val="bg1">
                    <a:lumMod val="50000"/>
                  </a:schemeClr>
                </a:solidFill>
              </a:rPr>
              <a:t>See Supplemental Information for the alignment of the isoforms for other amino acid differences.</a:t>
            </a:r>
          </a:p>
          <a:p>
            <a:endParaRPr lang="en-US" sz="16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819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44a327f-4c77-4059-bb07-e278862d87f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033184CEB11F648BBD0F70F1BE6A53E" ma:contentTypeVersion="18" ma:contentTypeDescription="Create a new document." ma:contentTypeScope="" ma:versionID="c9e355ac817f79c63ee0e7f7d58d5df2">
  <xsd:schema xmlns:xsd="http://www.w3.org/2001/XMLSchema" xmlns:xs="http://www.w3.org/2001/XMLSchema" xmlns:p="http://schemas.microsoft.com/office/2006/metadata/properties" xmlns:ns3="7fa3c9fb-ef78-47d6-a04f-8ab7fe78f626" xmlns:ns4="a44a327f-4c77-4059-bb07-e278862d87fb" targetNamespace="http://schemas.microsoft.com/office/2006/metadata/properties" ma:root="true" ma:fieldsID="5f52998402472a80dce8f2eb0d31dca0" ns3:_="" ns4:_="">
    <xsd:import namespace="7fa3c9fb-ef78-47d6-a04f-8ab7fe78f626"/>
    <xsd:import namespace="a44a327f-4c77-4059-bb07-e278862d87f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DateTaken" minOccurs="0"/>
                <xsd:element ref="ns4:MediaServiceOCR" minOccurs="0"/>
                <xsd:element ref="ns4:MediaServiceLocation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a3c9fb-ef78-47d6-a04f-8ab7fe78f62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44a327f-4c77-4059-bb07-e278862d87f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6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CD429F5-4FE8-42A2-B5C5-00EB2B97ADB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E40F0D2-54FD-446B-A30A-38AD29A68394}">
  <ds:schemaRefs>
    <ds:schemaRef ds:uri="http://schemas.microsoft.com/office/2006/metadata/properties"/>
    <ds:schemaRef ds:uri="7fa3c9fb-ef78-47d6-a04f-8ab7fe78f626"/>
    <ds:schemaRef ds:uri="http://schemas.microsoft.com/office/2006/documentManagement/types"/>
    <ds:schemaRef ds:uri="a44a327f-4c77-4059-bb07-e278862d87fb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A61DB06F-0945-4F40-B071-E28C80A36D7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fa3c9fb-ef78-47d6-a04f-8ab7fe78f626"/>
    <ds:schemaRef ds:uri="a44a327f-4c77-4059-bb07-e278862d87f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28</TotalTime>
  <Words>3428</Words>
  <Application>Microsoft Office PowerPoint</Application>
  <PresentationFormat>On-screen Show (4:3)</PresentationFormat>
  <Paragraphs>1367</Paragraphs>
  <Slides>3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9</vt:i4>
      </vt:variant>
    </vt:vector>
  </HeadingPairs>
  <TitlesOfParts>
    <vt:vector size="44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wnie, Allan B</dc:creator>
  <cp:lastModifiedBy>anonymous</cp:lastModifiedBy>
  <cp:revision>386</cp:revision>
  <cp:lastPrinted>2021-06-07T17:52:06Z</cp:lastPrinted>
  <dcterms:created xsi:type="dcterms:W3CDTF">2016-12-15T13:11:11Z</dcterms:created>
  <dcterms:modified xsi:type="dcterms:W3CDTF">2024-09-14T18:18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33184CEB11F648BBD0F70F1BE6A53E</vt:lpwstr>
  </property>
</Properties>
</file>